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94" r:id="rId2"/>
    <p:sldId id="265" r:id="rId3"/>
    <p:sldId id="298" r:id="rId4"/>
    <p:sldId id="299" r:id="rId5"/>
    <p:sldId id="301" r:id="rId6"/>
    <p:sldId id="283" r:id="rId7"/>
    <p:sldId id="284" r:id="rId8"/>
    <p:sldId id="292" r:id="rId9"/>
  </p:sldIdLst>
  <p:sldSz cx="12192000" cy="6858000"/>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Main Figures" id="{290C07AF-F6B2-4EC1-B754-A8ADEC89C2A0}">
          <p14:sldIdLst/>
        </p14:section>
        <p14:section name="Supplementary Figures" id="{CDF584B6-4A0E-4CD4-9F2C-DBF3DD2776AF}">
          <p14:sldIdLst>
            <p14:sldId id="294"/>
            <p14:sldId id="265"/>
            <p14:sldId id="298"/>
            <p14:sldId id="299"/>
            <p14:sldId id="301"/>
            <p14:sldId id="283"/>
            <p14:sldId id="284"/>
            <p14:sldId id="292"/>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71E6B69-3E29-4E74-97DE-FED31F216FDA}" v="96" dt="2024-12-04T02:31:05.76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25" autoAdjust="0"/>
    <p:restoredTop sz="89429" autoAdjust="0"/>
  </p:normalViewPr>
  <p:slideViewPr>
    <p:cSldViewPr snapToGrid="0">
      <p:cViewPr varScale="1">
        <p:scale>
          <a:sx n="103" d="100"/>
          <a:sy n="103" d="100"/>
        </p:scale>
        <p:origin x="738" y="12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20"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ennifer Koh" userId="f9e5c760-747b-4877-856a-bb6123371f09" providerId="ADAL" clId="{6AEE6365-D318-4BF7-BA47-CF37CAACDB03}"/>
    <pc:docChg chg="modSld">
      <pc:chgData name="Jennifer Koh" userId="f9e5c760-747b-4877-856a-bb6123371f09" providerId="ADAL" clId="{6AEE6365-D318-4BF7-BA47-CF37CAACDB03}" dt="2024-06-17T04:53:51.821" v="1" actId="20577"/>
      <pc:docMkLst>
        <pc:docMk/>
      </pc:docMkLst>
      <pc:sldChg chg="modNotesTx">
        <pc:chgData name="Jennifer Koh" userId="f9e5c760-747b-4877-856a-bb6123371f09" providerId="ADAL" clId="{6AEE6365-D318-4BF7-BA47-CF37CAACDB03}" dt="2024-06-17T04:46:07.116" v="0" actId="20577"/>
        <pc:sldMkLst>
          <pc:docMk/>
          <pc:sldMk cId="3379817359" sldId="294"/>
        </pc:sldMkLst>
      </pc:sldChg>
      <pc:sldChg chg="modNotesTx">
        <pc:chgData name="Jennifer Koh" userId="f9e5c760-747b-4877-856a-bb6123371f09" providerId="ADAL" clId="{6AEE6365-D318-4BF7-BA47-CF37CAACDB03}" dt="2024-06-17T04:53:51.821" v="1" actId="20577"/>
        <pc:sldMkLst>
          <pc:docMk/>
          <pc:sldMk cId="2432896475" sldId="296"/>
        </pc:sldMkLst>
      </pc:sldChg>
    </pc:docChg>
  </pc:docChgLst>
  <pc:docChgLst>
    <pc:chgData name="Jennifer Koh" userId="f9e5c760-747b-4877-856a-bb6123371f09" providerId="ADAL" clId="{580D4376-88C9-4CDB-BD9F-6765A65A9B64}"/>
    <pc:docChg chg="undo custSel modSld sldOrd modSection">
      <pc:chgData name="Jennifer Koh" userId="f9e5c760-747b-4877-856a-bb6123371f09" providerId="ADAL" clId="{580D4376-88C9-4CDB-BD9F-6765A65A9B64}" dt="2024-05-02T01:35:19.376" v="270" actId="20577"/>
      <pc:docMkLst>
        <pc:docMk/>
      </pc:docMkLst>
      <pc:sldChg chg="modNotesTx">
        <pc:chgData name="Jennifer Koh" userId="f9e5c760-747b-4877-856a-bb6123371f09" providerId="ADAL" clId="{580D4376-88C9-4CDB-BD9F-6765A65A9B64}" dt="2024-05-02T01:34:39.549" v="260" actId="20577"/>
        <pc:sldMkLst>
          <pc:docMk/>
          <pc:sldMk cId="286440889" sldId="265"/>
        </pc:sldMkLst>
      </pc:sldChg>
      <pc:sldChg chg="addSp delSp modSp mod modNotesTx">
        <pc:chgData name="Jennifer Koh" userId="f9e5c760-747b-4877-856a-bb6123371f09" providerId="ADAL" clId="{580D4376-88C9-4CDB-BD9F-6765A65A9B64}" dt="2024-05-02T01:34:22.349" v="254" actId="20577"/>
        <pc:sldMkLst>
          <pc:docMk/>
          <pc:sldMk cId="4175903602" sldId="274"/>
        </pc:sldMkLst>
        <pc:spChg chg="mod">
          <ac:chgData name="Jennifer Koh" userId="f9e5c760-747b-4877-856a-bb6123371f09" providerId="ADAL" clId="{580D4376-88C9-4CDB-BD9F-6765A65A9B64}" dt="2024-05-01T05:41:43.722" v="208" actId="165"/>
          <ac:spMkLst>
            <pc:docMk/>
            <pc:sldMk cId="4175903602" sldId="274"/>
            <ac:spMk id="9" creationId="{5E3552DB-C306-1A31-0CD4-247546581F43}"/>
          </ac:spMkLst>
        </pc:spChg>
        <pc:grpChg chg="add del mod">
          <ac:chgData name="Jennifer Koh" userId="f9e5c760-747b-4877-856a-bb6123371f09" providerId="ADAL" clId="{580D4376-88C9-4CDB-BD9F-6765A65A9B64}" dt="2024-05-01T05:41:43.722" v="208" actId="165"/>
          <ac:grpSpMkLst>
            <pc:docMk/>
            <pc:sldMk cId="4175903602" sldId="274"/>
            <ac:grpSpMk id="5" creationId="{0DE65D9A-55E8-BCE6-83FA-87D842BAC138}"/>
          </ac:grpSpMkLst>
        </pc:grpChg>
        <pc:grpChg chg="add mod">
          <ac:chgData name="Jennifer Koh" userId="f9e5c760-747b-4877-856a-bb6123371f09" providerId="ADAL" clId="{580D4376-88C9-4CDB-BD9F-6765A65A9B64}" dt="2024-05-01T05:43:00.426" v="220" actId="164"/>
          <ac:grpSpMkLst>
            <pc:docMk/>
            <pc:sldMk cId="4175903602" sldId="274"/>
            <ac:grpSpMk id="7" creationId="{21DA1ABC-A7C5-9A90-CF68-5810BF5830DB}"/>
          </ac:grpSpMkLst>
        </pc:grpChg>
        <pc:grpChg chg="add mod">
          <ac:chgData name="Jennifer Koh" userId="f9e5c760-747b-4877-856a-bb6123371f09" providerId="ADAL" clId="{580D4376-88C9-4CDB-BD9F-6765A65A9B64}" dt="2024-04-11T04:29:46.501" v="47" actId="164"/>
          <ac:grpSpMkLst>
            <pc:docMk/>
            <pc:sldMk cId="4175903602" sldId="274"/>
            <ac:grpSpMk id="8" creationId="{8E018135-6C52-FCEC-961E-0D112A031CE4}"/>
          </ac:grpSpMkLst>
        </pc:grpChg>
        <pc:grpChg chg="add del mod topLvl">
          <ac:chgData name="Jennifer Koh" userId="f9e5c760-747b-4877-856a-bb6123371f09" providerId="ADAL" clId="{580D4376-88C9-4CDB-BD9F-6765A65A9B64}" dt="2024-05-01T05:43:00.426" v="220" actId="164"/>
          <ac:grpSpMkLst>
            <pc:docMk/>
            <pc:sldMk cId="4175903602" sldId="274"/>
            <ac:grpSpMk id="11" creationId="{C98D4CF6-1E27-0DF5-C11F-35FECA780192}"/>
          </ac:grpSpMkLst>
        </pc:grpChg>
        <pc:grpChg chg="add del">
          <ac:chgData name="Jennifer Koh" userId="f9e5c760-747b-4877-856a-bb6123371f09" providerId="ADAL" clId="{580D4376-88C9-4CDB-BD9F-6765A65A9B64}" dt="2024-04-11T04:26:55.228" v="7" actId="478"/>
          <ac:grpSpMkLst>
            <pc:docMk/>
            <pc:sldMk cId="4175903602" sldId="274"/>
            <ac:grpSpMk id="12" creationId="{9340C589-D696-F94C-48F2-4C14CF2832EB}"/>
          </ac:grpSpMkLst>
        </pc:grpChg>
        <pc:grpChg chg="add del mod">
          <ac:chgData name="Jennifer Koh" userId="f9e5c760-747b-4877-856a-bb6123371f09" providerId="ADAL" clId="{580D4376-88C9-4CDB-BD9F-6765A65A9B64}" dt="2024-04-26T05:10:15.063" v="132" actId="165"/>
          <ac:grpSpMkLst>
            <pc:docMk/>
            <pc:sldMk cId="4175903602" sldId="274"/>
            <ac:grpSpMk id="13" creationId="{609CAA64-650F-9405-CA23-3F4156629E8D}"/>
          </ac:grpSpMkLst>
        </pc:grpChg>
        <pc:picChg chg="add del mod ord topLvl modCrop">
          <ac:chgData name="Jennifer Koh" userId="f9e5c760-747b-4877-856a-bb6123371f09" providerId="ADAL" clId="{580D4376-88C9-4CDB-BD9F-6765A65A9B64}" dt="2024-05-01T05:41:46.528" v="209" actId="478"/>
          <ac:picMkLst>
            <pc:docMk/>
            <pc:sldMk cId="4175903602" sldId="274"/>
            <ac:picMk id="4" creationId="{4641416A-151A-E4E0-4865-7BA4C7913ADB}"/>
          </ac:picMkLst>
        </pc:picChg>
        <pc:picChg chg="add del mod ord">
          <ac:chgData name="Jennifer Koh" userId="f9e5c760-747b-4877-856a-bb6123371f09" providerId="ADAL" clId="{580D4376-88C9-4CDB-BD9F-6765A65A9B64}" dt="2024-04-11T04:27:38.383" v="18" actId="478"/>
          <ac:picMkLst>
            <pc:docMk/>
            <pc:sldMk cId="4175903602" sldId="274"/>
            <ac:picMk id="4" creationId="{6741DE32-8894-A71B-3768-4F0800E8F8DD}"/>
          </ac:picMkLst>
        </pc:picChg>
        <pc:picChg chg="add del mod ord topLvl modCrop">
          <ac:chgData name="Jennifer Koh" userId="f9e5c760-747b-4877-856a-bb6123371f09" providerId="ADAL" clId="{580D4376-88C9-4CDB-BD9F-6765A65A9B64}" dt="2024-04-26T05:10:25.117" v="135" actId="478"/>
          <ac:picMkLst>
            <pc:docMk/>
            <pc:sldMk cId="4175903602" sldId="274"/>
            <ac:picMk id="6" creationId="{E6322FAB-4AA2-F947-BBFC-0C5D58E44707}"/>
          </ac:picMkLst>
        </pc:picChg>
        <pc:picChg chg="add mod ord modCrop">
          <ac:chgData name="Jennifer Koh" userId="f9e5c760-747b-4877-856a-bb6123371f09" providerId="ADAL" clId="{580D4376-88C9-4CDB-BD9F-6765A65A9B64}" dt="2024-05-01T05:43:00.426" v="220" actId="164"/>
          <ac:picMkLst>
            <pc:docMk/>
            <pc:sldMk cId="4175903602" sldId="274"/>
            <ac:picMk id="6" creationId="{EA52B5D6-28E5-D3AA-4D34-17D3C6E3CFE5}"/>
          </ac:picMkLst>
        </pc:picChg>
        <pc:picChg chg="del topLvl">
          <ac:chgData name="Jennifer Koh" userId="f9e5c760-747b-4877-856a-bb6123371f09" providerId="ADAL" clId="{580D4376-88C9-4CDB-BD9F-6765A65A9B64}" dt="2024-04-11T04:26:55.228" v="7" actId="478"/>
          <ac:picMkLst>
            <pc:docMk/>
            <pc:sldMk cId="4175903602" sldId="274"/>
            <ac:picMk id="7" creationId="{68DC75A1-63EF-C999-324D-B341B722F12F}"/>
          </ac:picMkLst>
        </pc:picChg>
        <pc:cxnChg chg="mod">
          <ac:chgData name="Jennifer Koh" userId="f9e5c760-747b-4877-856a-bb6123371f09" providerId="ADAL" clId="{580D4376-88C9-4CDB-BD9F-6765A65A9B64}" dt="2024-05-01T05:41:43.722" v="208" actId="165"/>
          <ac:cxnSpMkLst>
            <pc:docMk/>
            <pc:sldMk cId="4175903602" sldId="274"/>
            <ac:cxnSpMk id="10" creationId="{7F18568B-A533-0C42-8316-36788472125F}"/>
          </ac:cxnSpMkLst>
        </pc:cxnChg>
      </pc:sldChg>
      <pc:sldChg chg="addSp delSp modSp mod modNotesTx">
        <pc:chgData name="Jennifer Koh" userId="f9e5c760-747b-4877-856a-bb6123371f09" providerId="ADAL" clId="{580D4376-88C9-4CDB-BD9F-6765A65A9B64}" dt="2024-05-02T01:33:26.334" v="242" actId="20577"/>
        <pc:sldMkLst>
          <pc:docMk/>
          <pc:sldMk cId="3674379232" sldId="278"/>
        </pc:sldMkLst>
        <pc:picChg chg="add mod ord">
          <ac:chgData name="Jennifer Koh" userId="f9e5c760-747b-4877-856a-bb6123371f09" providerId="ADAL" clId="{580D4376-88C9-4CDB-BD9F-6765A65A9B64}" dt="2024-04-10T04:47:09.235" v="4" actId="167"/>
          <ac:picMkLst>
            <pc:docMk/>
            <pc:sldMk cId="3674379232" sldId="278"/>
            <ac:picMk id="3" creationId="{5B52AB2C-B14E-2D6C-F3BC-4A64C02CED69}"/>
          </ac:picMkLst>
        </pc:picChg>
        <pc:picChg chg="del">
          <ac:chgData name="Jennifer Koh" userId="f9e5c760-747b-4877-856a-bb6123371f09" providerId="ADAL" clId="{580D4376-88C9-4CDB-BD9F-6765A65A9B64}" dt="2024-04-10T04:47:04.259" v="0" actId="478"/>
          <ac:picMkLst>
            <pc:docMk/>
            <pc:sldMk cId="3674379232" sldId="278"/>
            <ac:picMk id="4" creationId="{DBF80D09-68F2-1D31-33F7-7067C165B9EC}"/>
          </ac:picMkLst>
        </pc:picChg>
      </pc:sldChg>
      <pc:sldChg chg="modNotesTx">
        <pc:chgData name="Jennifer Koh" userId="f9e5c760-747b-4877-856a-bb6123371f09" providerId="ADAL" clId="{580D4376-88C9-4CDB-BD9F-6765A65A9B64}" dt="2024-05-02T01:34:47.890" v="263" actId="20577"/>
        <pc:sldMkLst>
          <pc:docMk/>
          <pc:sldMk cId="1214462485" sldId="283"/>
        </pc:sldMkLst>
      </pc:sldChg>
      <pc:sldChg chg="addSp delSp modSp mod ord modNotesTx">
        <pc:chgData name="Jennifer Koh" userId="f9e5c760-747b-4877-856a-bb6123371f09" providerId="ADAL" clId="{580D4376-88C9-4CDB-BD9F-6765A65A9B64}" dt="2024-05-02T01:35:01.436" v="266" actId="20577"/>
        <pc:sldMkLst>
          <pc:docMk/>
          <pc:sldMk cId="2654949521" sldId="284"/>
        </pc:sldMkLst>
        <pc:spChg chg="mod">
          <ac:chgData name="Jennifer Koh" userId="f9e5c760-747b-4877-856a-bb6123371f09" providerId="ADAL" clId="{580D4376-88C9-4CDB-BD9F-6765A65A9B64}" dt="2024-05-01T05:40:55.931" v="195" actId="165"/>
          <ac:spMkLst>
            <pc:docMk/>
            <pc:sldMk cId="2654949521" sldId="284"/>
            <ac:spMk id="4" creationId="{05965431-C262-98A6-85FA-04FEF33150F7}"/>
          </ac:spMkLst>
        </pc:spChg>
        <pc:grpChg chg="add mod">
          <ac:chgData name="Jennifer Koh" userId="f9e5c760-747b-4877-856a-bb6123371f09" providerId="ADAL" clId="{580D4376-88C9-4CDB-BD9F-6765A65A9B64}" dt="2024-05-01T05:41:37.954" v="207" actId="164"/>
          <ac:grpSpMkLst>
            <pc:docMk/>
            <pc:sldMk cId="2654949521" sldId="284"/>
            <ac:grpSpMk id="5" creationId="{56572FF7-C770-C9E8-8F44-DA9D5A6EC220}"/>
          </ac:grpSpMkLst>
        </pc:grpChg>
        <pc:grpChg chg="add del mod ord topLvl">
          <ac:chgData name="Jennifer Koh" userId="f9e5c760-747b-4877-856a-bb6123371f09" providerId="ADAL" clId="{580D4376-88C9-4CDB-BD9F-6765A65A9B64}" dt="2024-05-01T05:41:37.954" v="207" actId="164"/>
          <ac:grpSpMkLst>
            <pc:docMk/>
            <pc:sldMk cId="2654949521" sldId="284"/>
            <ac:grpSpMk id="7" creationId="{64DB76CD-7F89-E96D-CB15-8B66BC4E07EE}"/>
          </ac:grpSpMkLst>
        </pc:grpChg>
        <pc:grpChg chg="del">
          <ac:chgData name="Jennifer Koh" userId="f9e5c760-747b-4877-856a-bb6123371f09" providerId="ADAL" clId="{580D4376-88C9-4CDB-BD9F-6765A65A9B64}" dt="2024-04-11T04:30:20.744" v="66" actId="478"/>
          <ac:grpSpMkLst>
            <pc:docMk/>
            <pc:sldMk cId="2654949521" sldId="284"/>
            <ac:grpSpMk id="8" creationId="{49266AD6-D08D-6E57-3031-5711BFFE2274}"/>
          </ac:grpSpMkLst>
        </pc:grpChg>
        <pc:grpChg chg="add del mod ord">
          <ac:chgData name="Jennifer Koh" userId="f9e5c760-747b-4877-856a-bb6123371f09" providerId="ADAL" clId="{580D4376-88C9-4CDB-BD9F-6765A65A9B64}" dt="2024-04-26T05:11:44.811" v="158" actId="165"/>
          <ac:grpSpMkLst>
            <pc:docMk/>
            <pc:sldMk cId="2654949521" sldId="284"/>
            <ac:grpSpMk id="10" creationId="{A764D64B-7310-1D25-82F6-A25E1E7BC8E7}"/>
          </ac:grpSpMkLst>
        </pc:grpChg>
        <pc:grpChg chg="add del mod">
          <ac:chgData name="Jennifer Koh" userId="f9e5c760-747b-4877-856a-bb6123371f09" providerId="ADAL" clId="{580D4376-88C9-4CDB-BD9F-6765A65A9B64}" dt="2024-05-01T05:40:55.931" v="195" actId="165"/>
          <ac:grpSpMkLst>
            <pc:docMk/>
            <pc:sldMk cId="2654949521" sldId="284"/>
            <ac:grpSpMk id="12" creationId="{39DE842D-759D-88CC-D273-2D06646269EE}"/>
          </ac:grpSpMkLst>
        </pc:grpChg>
        <pc:picChg chg="add mod">
          <ac:chgData name="Jennifer Koh" userId="f9e5c760-747b-4877-856a-bb6123371f09" providerId="ADAL" clId="{580D4376-88C9-4CDB-BD9F-6765A65A9B64}" dt="2024-04-26T05:11:53.200" v="160"/>
          <ac:picMkLst>
            <pc:docMk/>
            <pc:sldMk cId="2654949521" sldId="284"/>
            <ac:picMk id="3" creationId="{077F1243-D57D-CBDB-EFE1-F148ACE57DFA}"/>
          </ac:picMkLst>
        </pc:picChg>
        <pc:picChg chg="add mod ord modCrop">
          <ac:chgData name="Jennifer Koh" userId="f9e5c760-747b-4877-856a-bb6123371f09" providerId="ADAL" clId="{580D4376-88C9-4CDB-BD9F-6765A65A9B64}" dt="2024-05-01T05:41:37.954" v="207" actId="164"/>
          <ac:picMkLst>
            <pc:docMk/>
            <pc:sldMk cId="2654949521" sldId="284"/>
            <ac:picMk id="3" creationId="{61841F34-266B-5161-BE1E-0DD60C9FC147}"/>
          </ac:picMkLst>
        </pc:picChg>
        <pc:picChg chg="del topLvl">
          <ac:chgData name="Jennifer Koh" userId="f9e5c760-747b-4877-856a-bb6123371f09" providerId="ADAL" clId="{580D4376-88C9-4CDB-BD9F-6765A65A9B64}" dt="2024-04-11T04:30:20.744" v="66" actId="478"/>
          <ac:picMkLst>
            <pc:docMk/>
            <pc:sldMk cId="2654949521" sldId="284"/>
            <ac:picMk id="3" creationId="{B2B5BC2F-2261-FF91-BFBB-7B59AC0E8F2A}"/>
          </ac:picMkLst>
        </pc:picChg>
        <pc:picChg chg="add del mod ord topLvl modCrop">
          <ac:chgData name="Jennifer Koh" userId="f9e5c760-747b-4877-856a-bb6123371f09" providerId="ADAL" clId="{580D4376-88C9-4CDB-BD9F-6765A65A9B64}" dt="2024-04-26T05:11:59.540" v="162" actId="478"/>
          <ac:picMkLst>
            <pc:docMk/>
            <pc:sldMk cId="2654949521" sldId="284"/>
            <ac:picMk id="5" creationId="{2E155934-6D85-919F-51B5-A531E8D17EA2}"/>
          </ac:picMkLst>
        </pc:picChg>
        <pc:picChg chg="add del mod ord topLvl modCrop">
          <ac:chgData name="Jennifer Koh" userId="f9e5c760-747b-4877-856a-bb6123371f09" providerId="ADAL" clId="{580D4376-88C9-4CDB-BD9F-6765A65A9B64}" dt="2024-05-01T05:40:58.591" v="196" actId="478"/>
          <ac:picMkLst>
            <pc:docMk/>
            <pc:sldMk cId="2654949521" sldId="284"/>
            <ac:picMk id="11" creationId="{22993FEA-3B02-698A-E556-C21B0FC56FF7}"/>
          </ac:picMkLst>
        </pc:picChg>
        <pc:cxnChg chg="mod">
          <ac:chgData name="Jennifer Koh" userId="f9e5c760-747b-4877-856a-bb6123371f09" providerId="ADAL" clId="{580D4376-88C9-4CDB-BD9F-6765A65A9B64}" dt="2024-05-01T05:40:55.931" v="195" actId="165"/>
          <ac:cxnSpMkLst>
            <pc:docMk/>
            <pc:sldMk cId="2654949521" sldId="284"/>
            <ac:cxnSpMk id="6" creationId="{0EFC13AE-08CC-48DE-CAC6-C2DD42305672}"/>
          </ac:cxnSpMkLst>
        </pc:cxnChg>
      </pc:sldChg>
      <pc:sldChg chg="modNotesTx">
        <pc:chgData name="Jennifer Koh" userId="f9e5c760-747b-4877-856a-bb6123371f09" providerId="ADAL" clId="{580D4376-88C9-4CDB-BD9F-6765A65A9B64}" dt="2024-05-02T01:33:44.801" v="248" actId="20577"/>
        <pc:sldMkLst>
          <pc:docMk/>
          <pc:sldMk cId="3335036171" sldId="287"/>
        </pc:sldMkLst>
      </pc:sldChg>
      <pc:sldChg chg="modNotesTx">
        <pc:chgData name="Jennifer Koh" userId="f9e5c760-747b-4877-856a-bb6123371f09" providerId="ADAL" clId="{580D4376-88C9-4CDB-BD9F-6765A65A9B64}" dt="2024-05-02T01:35:19.376" v="270" actId="20577"/>
        <pc:sldMkLst>
          <pc:docMk/>
          <pc:sldMk cId="1974422890" sldId="292"/>
        </pc:sldMkLst>
      </pc:sldChg>
      <pc:sldChg chg="modNotesTx">
        <pc:chgData name="Jennifer Koh" userId="f9e5c760-747b-4877-856a-bb6123371f09" providerId="ADAL" clId="{580D4376-88C9-4CDB-BD9F-6765A65A9B64}" dt="2024-05-02T01:34:30.716" v="257" actId="20577"/>
        <pc:sldMkLst>
          <pc:docMk/>
          <pc:sldMk cId="3379817359" sldId="294"/>
        </pc:sldMkLst>
      </pc:sldChg>
      <pc:sldChg chg="modNotesTx">
        <pc:chgData name="Jennifer Koh" userId="f9e5c760-747b-4877-856a-bb6123371f09" providerId="ADAL" clId="{580D4376-88C9-4CDB-BD9F-6765A65A9B64}" dt="2024-05-02T01:33:42.413" v="247" actId="20577"/>
        <pc:sldMkLst>
          <pc:docMk/>
          <pc:sldMk cId="3937723648" sldId="295"/>
        </pc:sldMkLst>
      </pc:sldChg>
      <pc:sldChg chg="modNotesTx">
        <pc:chgData name="Jennifer Koh" userId="f9e5c760-747b-4877-856a-bb6123371f09" providerId="ADAL" clId="{580D4376-88C9-4CDB-BD9F-6765A65A9B64}" dt="2024-05-02T01:33:56.563" v="251" actId="20577"/>
        <pc:sldMkLst>
          <pc:docMk/>
          <pc:sldMk cId="2432896475" sldId="296"/>
        </pc:sldMkLst>
      </pc:sldChg>
    </pc:docChg>
  </pc:docChgLst>
  <pc:docChgLst>
    <pc:chgData name="Jennifer Koh" userId="f9e5c760-747b-4877-856a-bb6123371f09" providerId="ADAL" clId="{171E6B69-3E29-4E74-97DE-FED31F216FDA}"/>
    <pc:docChg chg="undo custSel addSld delSld modSld sldOrd modSection modNotesMaster">
      <pc:chgData name="Jennifer Koh" userId="f9e5c760-747b-4877-856a-bb6123371f09" providerId="ADAL" clId="{171E6B69-3E29-4E74-97DE-FED31F216FDA}" dt="2024-12-04T02:31:14.344" v="1246" actId="12789"/>
      <pc:docMkLst>
        <pc:docMk/>
      </pc:docMkLst>
      <pc:sldChg chg="addSp delSp modSp mod">
        <pc:chgData name="Jennifer Koh" userId="f9e5c760-747b-4877-856a-bb6123371f09" providerId="ADAL" clId="{171E6B69-3E29-4E74-97DE-FED31F216FDA}" dt="2024-12-04T02:11:19.336" v="1179" actId="14100"/>
        <pc:sldMkLst>
          <pc:docMk/>
          <pc:sldMk cId="286440889" sldId="265"/>
        </pc:sldMkLst>
        <pc:spChg chg="add mod">
          <ac:chgData name="Jennifer Koh" userId="f9e5c760-747b-4877-856a-bb6123371f09" providerId="ADAL" clId="{171E6B69-3E29-4E74-97DE-FED31F216FDA}" dt="2024-12-04T02:11:19.336" v="1179" actId="14100"/>
          <ac:spMkLst>
            <pc:docMk/>
            <pc:sldMk cId="286440889" sldId="265"/>
            <ac:spMk id="2" creationId="{7A006F79-AB70-3CCF-8D9D-EB58CD5065DB}"/>
          </ac:spMkLst>
        </pc:spChg>
        <pc:spChg chg="del">
          <ac:chgData name="Jennifer Koh" userId="f9e5c760-747b-4877-856a-bb6123371f09" providerId="ADAL" clId="{171E6B69-3E29-4E74-97DE-FED31F216FDA}" dt="2024-12-04T02:11:11.340" v="1175" actId="478"/>
          <ac:spMkLst>
            <pc:docMk/>
            <pc:sldMk cId="286440889" sldId="265"/>
            <ac:spMk id="4" creationId="{EA4500C7-3E01-0F78-0E26-DB4AAA385BEE}"/>
          </ac:spMkLst>
        </pc:spChg>
      </pc:sldChg>
      <pc:sldChg chg="addSp delSp modSp mod">
        <pc:chgData name="Jennifer Koh" userId="f9e5c760-747b-4877-856a-bb6123371f09" providerId="ADAL" clId="{171E6B69-3E29-4E74-97DE-FED31F216FDA}" dt="2024-12-04T02:10:45.135" v="1165" actId="20577"/>
        <pc:sldMkLst>
          <pc:docMk/>
          <pc:sldMk cId="4175903602" sldId="274"/>
        </pc:sldMkLst>
        <pc:spChg chg="add mod">
          <ac:chgData name="Jennifer Koh" userId="f9e5c760-747b-4877-856a-bb6123371f09" providerId="ADAL" clId="{171E6B69-3E29-4E74-97DE-FED31F216FDA}" dt="2024-11-29T00:10:24.098" v="53" actId="1076"/>
          <ac:spMkLst>
            <pc:docMk/>
            <pc:sldMk cId="4175903602" sldId="274"/>
            <ac:spMk id="2" creationId="{FA0CFF57-695C-B35B-E665-F8BCC371370E}"/>
          </ac:spMkLst>
        </pc:spChg>
        <pc:spChg chg="del ord">
          <ac:chgData name="Jennifer Koh" userId="f9e5c760-747b-4877-856a-bb6123371f09" providerId="ADAL" clId="{171E6B69-3E29-4E74-97DE-FED31F216FDA}" dt="2024-12-04T02:10:42.561" v="1162" actId="478"/>
          <ac:spMkLst>
            <pc:docMk/>
            <pc:sldMk cId="4175903602" sldId="274"/>
            <ac:spMk id="3" creationId="{99061550-9EF1-2B0D-8A2C-B526BF52A1F5}"/>
          </ac:spMkLst>
        </pc:spChg>
        <pc:spChg chg="mod">
          <ac:chgData name="Jennifer Koh" userId="f9e5c760-747b-4877-856a-bb6123371f09" providerId="ADAL" clId="{171E6B69-3E29-4E74-97DE-FED31F216FDA}" dt="2024-12-03T03:19:37.768" v="747" actId="1035"/>
          <ac:spMkLst>
            <pc:docMk/>
            <pc:sldMk cId="4175903602" sldId="274"/>
            <ac:spMk id="7" creationId="{50567C71-90D3-5227-2142-FBED7B752D65}"/>
          </ac:spMkLst>
        </pc:spChg>
        <pc:spChg chg="mod">
          <ac:chgData name="Jennifer Koh" userId="f9e5c760-747b-4877-856a-bb6123371f09" providerId="ADAL" clId="{171E6B69-3E29-4E74-97DE-FED31F216FDA}" dt="2024-12-03T03:19:37.768" v="747" actId="1035"/>
          <ac:spMkLst>
            <pc:docMk/>
            <pc:sldMk cId="4175903602" sldId="274"/>
            <ac:spMk id="9" creationId="{5E3552DB-C306-1A31-0CD4-247546581F43}"/>
          </ac:spMkLst>
        </pc:spChg>
        <pc:spChg chg="mod">
          <ac:chgData name="Jennifer Koh" userId="f9e5c760-747b-4877-856a-bb6123371f09" providerId="ADAL" clId="{171E6B69-3E29-4E74-97DE-FED31F216FDA}" dt="2024-12-03T03:19:37.768" v="747" actId="1035"/>
          <ac:spMkLst>
            <pc:docMk/>
            <pc:sldMk cId="4175903602" sldId="274"/>
            <ac:spMk id="13" creationId="{41FB0087-746C-7F65-BE28-A7000BA92540}"/>
          </ac:spMkLst>
        </pc:spChg>
        <pc:spChg chg="mod">
          <ac:chgData name="Jennifer Koh" userId="f9e5c760-747b-4877-856a-bb6123371f09" providerId="ADAL" clId="{171E6B69-3E29-4E74-97DE-FED31F216FDA}" dt="2024-11-29T00:13:54.590" v="97" actId="165"/>
          <ac:spMkLst>
            <pc:docMk/>
            <pc:sldMk cId="4175903602" sldId="274"/>
            <ac:spMk id="16" creationId="{7D232C1C-B2BD-E980-032E-E1AD955C3863}"/>
          </ac:spMkLst>
        </pc:spChg>
        <pc:spChg chg="mod">
          <ac:chgData name="Jennifer Koh" userId="f9e5c760-747b-4877-856a-bb6123371f09" providerId="ADAL" clId="{171E6B69-3E29-4E74-97DE-FED31F216FDA}" dt="2024-11-29T00:13:54.590" v="97" actId="165"/>
          <ac:spMkLst>
            <pc:docMk/>
            <pc:sldMk cId="4175903602" sldId="274"/>
            <ac:spMk id="19" creationId="{739D33AB-AFFF-9E01-88C4-6F103B131C85}"/>
          </ac:spMkLst>
        </pc:spChg>
        <pc:spChg chg="mod">
          <ac:chgData name="Jennifer Koh" userId="f9e5c760-747b-4877-856a-bb6123371f09" providerId="ADAL" clId="{171E6B69-3E29-4E74-97DE-FED31F216FDA}" dt="2024-11-29T00:13:54.590" v="97" actId="165"/>
          <ac:spMkLst>
            <pc:docMk/>
            <pc:sldMk cId="4175903602" sldId="274"/>
            <ac:spMk id="22" creationId="{743E9BCB-F6CF-2832-2A88-B4CD14392371}"/>
          </ac:spMkLst>
        </pc:spChg>
        <pc:spChg chg="add mod">
          <ac:chgData name="Jennifer Koh" userId="f9e5c760-747b-4877-856a-bb6123371f09" providerId="ADAL" clId="{171E6B69-3E29-4E74-97DE-FED31F216FDA}" dt="2024-12-04T02:10:45.135" v="1165" actId="20577"/>
          <ac:spMkLst>
            <pc:docMk/>
            <pc:sldMk cId="4175903602" sldId="274"/>
            <ac:spMk id="24" creationId="{A6248C10-E9B5-80BD-48DE-363CEB1C0165}"/>
          </ac:spMkLst>
        </pc:spChg>
        <pc:spChg chg="mod">
          <ac:chgData name="Jennifer Koh" userId="f9e5c760-747b-4877-856a-bb6123371f09" providerId="ADAL" clId="{171E6B69-3E29-4E74-97DE-FED31F216FDA}" dt="2024-11-29T00:11:50.526" v="63"/>
          <ac:spMkLst>
            <pc:docMk/>
            <pc:sldMk cId="4175903602" sldId="274"/>
            <ac:spMk id="25" creationId="{9FCCC618-38BA-79F3-6D47-3B3E407794F9}"/>
          </ac:spMkLst>
        </pc:spChg>
        <pc:spChg chg="mod">
          <ac:chgData name="Jennifer Koh" userId="f9e5c760-747b-4877-856a-bb6123371f09" providerId="ADAL" clId="{171E6B69-3E29-4E74-97DE-FED31F216FDA}" dt="2024-11-29T00:11:50.526" v="63"/>
          <ac:spMkLst>
            <pc:docMk/>
            <pc:sldMk cId="4175903602" sldId="274"/>
            <ac:spMk id="28" creationId="{C1093985-6219-8A45-07C0-A92AFB011215}"/>
          </ac:spMkLst>
        </pc:spChg>
        <pc:spChg chg="mod">
          <ac:chgData name="Jennifer Koh" userId="f9e5c760-747b-4877-856a-bb6123371f09" providerId="ADAL" clId="{171E6B69-3E29-4E74-97DE-FED31F216FDA}" dt="2024-11-29T00:11:50.526" v="63"/>
          <ac:spMkLst>
            <pc:docMk/>
            <pc:sldMk cId="4175903602" sldId="274"/>
            <ac:spMk id="31" creationId="{F1E82ADB-E1D7-0224-23A9-44A36A523CAE}"/>
          </ac:spMkLst>
        </pc:spChg>
        <pc:spChg chg="mod">
          <ac:chgData name="Jennifer Koh" userId="f9e5c760-747b-4877-856a-bb6123371f09" providerId="ADAL" clId="{171E6B69-3E29-4E74-97DE-FED31F216FDA}" dt="2024-12-03T03:19:27.640" v="746" actId="1035"/>
          <ac:spMkLst>
            <pc:docMk/>
            <pc:sldMk cId="4175903602" sldId="274"/>
            <ac:spMk id="34" creationId="{417646EB-A747-8AA1-1D29-4EA25CDC9CFF}"/>
          </ac:spMkLst>
        </pc:spChg>
        <pc:spChg chg="mod">
          <ac:chgData name="Jennifer Koh" userId="f9e5c760-747b-4877-856a-bb6123371f09" providerId="ADAL" clId="{171E6B69-3E29-4E74-97DE-FED31F216FDA}" dt="2024-12-03T03:19:27.640" v="746" actId="1035"/>
          <ac:spMkLst>
            <pc:docMk/>
            <pc:sldMk cId="4175903602" sldId="274"/>
            <ac:spMk id="37" creationId="{31D2ACFB-4D33-FF2F-D0F7-FF007C705AFD}"/>
          </ac:spMkLst>
        </pc:spChg>
        <pc:spChg chg="mod">
          <ac:chgData name="Jennifer Koh" userId="f9e5c760-747b-4877-856a-bb6123371f09" providerId="ADAL" clId="{171E6B69-3E29-4E74-97DE-FED31F216FDA}" dt="2024-12-03T03:19:27.640" v="746" actId="1035"/>
          <ac:spMkLst>
            <pc:docMk/>
            <pc:sldMk cId="4175903602" sldId="274"/>
            <ac:spMk id="40" creationId="{F3F90772-3DF0-6168-20F9-A7F9863EE4BC}"/>
          </ac:spMkLst>
        </pc:spChg>
        <pc:grpChg chg="del">
          <ac:chgData name="Jennifer Koh" userId="f9e5c760-747b-4877-856a-bb6123371f09" providerId="ADAL" clId="{171E6B69-3E29-4E74-97DE-FED31F216FDA}" dt="2024-11-29T00:07:50.681" v="38" actId="165"/>
          <ac:grpSpMkLst>
            <pc:docMk/>
            <pc:sldMk cId="4175903602" sldId="274"/>
            <ac:grpSpMk id="5" creationId="{618AE5A7-401C-DA40-0443-EB836762909D}"/>
          </ac:grpSpMkLst>
        </pc:grpChg>
        <pc:grpChg chg="add mod topLvl">
          <ac:chgData name="Jennifer Koh" userId="f9e5c760-747b-4877-856a-bb6123371f09" providerId="ADAL" clId="{171E6B69-3E29-4E74-97DE-FED31F216FDA}" dt="2024-11-29T00:14:35.324" v="99" actId="164"/>
          <ac:grpSpMkLst>
            <pc:docMk/>
            <pc:sldMk cId="4175903602" sldId="274"/>
            <ac:grpSpMk id="6" creationId="{6004A1E5-DA3A-1123-6DFC-01ED1382B401}"/>
          </ac:grpSpMkLst>
        </pc:grpChg>
        <pc:grpChg chg="mod topLvl">
          <ac:chgData name="Jennifer Koh" userId="f9e5c760-747b-4877-856a-bb6123371f09" providerId="ADAL" clId="{171E6B69-3E29-4E74-97DE-FED31F216FDA}" dt="2024-11-29T00:14:35.324" v="99" actId="164"/>
          <ac:grpSpMkLst>
            <pc:docMk/>
            <pc:sldMk cId="4175903602" sldId="274"/>
            <ac:grpSpMk id="11" creationId="{C98D4CF6-1E27-0DF5-C11F-35FECA780192}"/>
          </ac:grpSpMkLst>
        </pc:grpChg>
        <pc:grpChg chg="add mod topLvl">
          <ac:chgData name="Jennifer Koh" userId="f9e5c760-747b-4877-856a-bb6123371f09" providerId="ADAL" clId="{171E6B69-3E29-4E74-97DE-FED31F216FDA}" dt="2024-11-29T00:14:35.324" v="99" actId="164"/>
          <ac:grpSpMkLst>
            <pc:docMk/>
            <pc:sldMk cId="4175903602" sldId="274"/>
            <ac:grpSpMk id="12" creationId="{EA9FFCEA-D38D-4E93-DA2F-954AD82562A8}"/>
          </ac:grpSpMkLst>
        </pc:grpChg>
        <pc:grpChg chg="add mod topLvl">
          <ac:chgData name="Jennifer Koh" userId="f9e5c760-747b-4877-856a-bb6123371f09" providerId="ADAL" clId="{171E6B69-3E29-4E74-97DE-FED31F216FDA}" dt="2024-11-29T00:14:35.324" v="99" actId="164"/>
          <ac:grpSpMkLst>
            <pc:docMk/>
            <pc:sldMk cId="4175903602" sldId="274"/>
            <ac:grpSpMk id="15" creationId="{27084E45-891C-A4BD-2082-E65204ED916A}"/>
          </ac:grpSpMkLst>
        </pc:grpChg>
        <pc:grpChg chg="add mod topLvl">
          <ac:chgData name="Jennifer Koh" userId="f9e5c760-747b-4877-856a-bb6123371f09" providerId="ADAL" clId="{171E6B69-3E29-4E74-97DE-FED31F216FDA}" dt="2024-11-29T00:14:35.324" v="99" actId="164"/>
          <ac:grpSpMkLst>
            <pc:docMk/>
            <pc:sldMk cId="4175903602" sldId="274"/>
            <ac:grpSpMk id="18" creationId="{EECFEB22-CFAA-2F0E-8B7F-0EB65DFF0210}"/>
          </ac:grpSpMkLst>
        </pc:grpChg>
        <pc:grpChg chg="add mod topLvl">
          <ac:chgData name="Jennifer Koh" userId="f9e5c760-747b-4877-856a-bb6123371f09" providerId="ADAL" clId="{171E6B69-3E29-4E74-97DE-FED31F216FDA}" dt="2024-11-29T00:14:35.324" v="99" actId="164"/>
          <ac:grpSpMkLst>
            <pc:docMk/>
            <pc:sldMk cId="4175903602" sldId="274"/>
            <ac:grpSpMk id="21" creationId="{F5221EEC-CCA4-3B65-56A3-03741A501F20}"/>
          </ac:grpSpMkLst>
        </pc:grpChg>
        <pc:grpChg chg="add mod">
          <ac:chgData name="Jennifer Koh" userId="f9e5c760-747b-4877-856a-bb6123371f09" providerId="ADAL" clId="{171E6B69-3E29-4E74-97DE-FED31F216FDA}" dt="2024-11-29T00:11:50.526" v="63"/>
          <ac:grpSpMkLst>
            <pc:docMk/>
            <pc:sldMk cId="4175903602" sldId="274"/>
            <ac:grpSpMk id="24" creationId="{282A2D24-9FF1-A8CE-0CCC-D89D339AFE54}"/>
          </ac:grpSpMkLst>
        </pc:grpChg>
        <pc:grpChg chg="add mod">
          <ac:chgData name="Jennifer Koh" userId="f9e5c760-747b-4877-856a-bb6123371f09" providerId="ADAL" clId="{171E6B69-3E29-4E74-97DE-FED31F216FDA}" dt="2024-11-29T00:11:50.526" v="63"/>
          <ac:grpSpMkLst>
            <pc:docMk/>
            <pc:sldMk cId="4175903602" sldId="274"/>
            <ac:grpSpMk id="27" creationId="{1697C3D7-F9C1-73F0-C999-2804D2095483}"/>
          </ac:grpSpMkLst>
        </pc:grpChg>
        <pc:grpChg chg="add mod">
          <ac:chgData name="Jennifer Koh" userId="f9e5c760-747b-4877-856a-bb6123371f09" providerId="ADAL" clId="{171E6B69-3E29-4E74-97DE-FED31F216FDA}" dt="2024-11-29T00:11:50.526" v="63"/>
          <ac:grpSpMkLst>
            <pc:docMk/>
            <pc:sldMk cId="4175903602" sldId="274"/>
            <ac:grpSpMk id="30" creationId="{D1F83008-D6F3-01F6-67FF-370E4B339C97}"/>
          </ac:grpSpMkLst>
        </pc:grpChg>
        <pc:grpChg chg="add mod topLvl">
          <ac:chgData name="Jennifer Koh" userId="f9e5c760-747b-4877-856a-bb6123371f09" providerId="ADAL" clId="{171E6B69-3E29-4E74-97DE-FED31F216FDA}" dt="2024-11-29T00:14:35.324" v="99" actId="164"/>
          <ac:grpSpMkLst>
            <pc:docMk/>
            <pc:sldMk cId="4175903602" sldId="274"/>
            <ac:grpSpMk id="33" creationId="{DB382D6B-F263-A023-F380-07331B5EDF05}"/>
          </ac:grpSpMkLst>
        </pc:grpChg>
        <pc:grpChg chg="add mod topLvl">
          <ac:chgData name="Jennifer Koh" userId="f9e5c760-747b-4877-856a-bb6123371f09" providerId="ADAL" clId="{171E6B69-3E29-4E74-97DE-FED31F216FDA}" dt="2024-11-29T00:14:35.324" v="99" actId="164"/>
          <ac:grpSpMkLst>
            <pc:docMk/>
            <pc:sldMk cId="4175903602" sldId="274"/>
            <ac:grpSpMk id="36" creationId="{5F05503C-B746-030B-3061-A9067265BFD0}"/>
          </ac:grpSpMkLst>
        </pc:grpChg>
        <pc:grpChg chg="add mod topLvl">
          <ac:chgData name="Jennifer Koh" userId="f9e5c760-747b-4877-856a-bb6123371f09" providerId="ADAL" clId="{171E6B69-3E29-4E74-97DE-FED31F216FDA}" dt="2024-11-29T00:14:35.324" v="99" actId="164"/>
          <ac:grpSpMkLst>
            <pc:docMk/>
            <pc:sldMk cId="4175903602" sldId="274"/>
            <ac:grpSpMk id="39" creationId="{B05BF1F4-07FB-462A-0D25-8B1CC6B78951}"/>
          </ac:grpSpMkLst>
        </pc:grpChg>
        <pc:grpChg chg="add del mod">
          <ac:chgData name="Jennifer Koh" userId="f9e5c760-747b-4877-856a-bb6123371f09" providerId="ADAL" clId="{171E6B69-3E29-4E74-97DE-FED31F216FDA}" dt="2024-11-29T00:13:54.590" v="97" actId="165"/>
          <ac:grpSpMkLst>
            <pc:docMk/>
            <pc:sldMk cId="4175903602" sldId="274"/>
            <ac:grpSpMk id="42" creationId="{C56E86D0-78DF-F988-4935-B18EB2D0F2D9}"/>
          </ac:grpSpMkLst>
        </pc:grpChg>
        <pc:grpChg chg="add del mod">
          <ac:chgData name="Jennifer Koh" userId="f9e5c760-747b-4877-856a-bb6123371f09" providerId="ADAL" clId="{171E6B69-3E29-4E74-97DE-FED31F216FDA}" dt="2024-12-03T04:25:12.816" v="879" actId="478"/>
          <ac:grpSpMkLst>
            <pc:docMk/>
            <pc:sldMk cId="4175903602" sldId="274"/>
            <ac:grpSpMk id="43" creationId="{A2372481-6F5C-1CAC-5BCD-1E95E79865E7}"/>
          </ac:grpSpMkLst>
        </pc:grpChg>
        <pc:picChg chg="mod topLvl">
          <ac:chgData name="Jennifer Koh" userId="f9e5c760-747b-4877-856a-bb6123371f09" providerId="ADAL" clId="{171E6B69-3E29-4E74-97DE-FED31F216FDA}" dt="2024-11-29T00:14:35.324" v="99" actId="164"/>
          <ac:picMkLst>
            <pc:docMk/>
            <pc:sldMk cId="4175903602" sldId="274"/>
            <ac:picMk id="4" creationId="{026F90B5-6854-15D3-1050-E7229A57D05C}"/>
          </ac:picMkLst>
        </pc:picChg>
        <pc:picChg chg="add mod ord modCrop">
          <ac:chgData name="Jennifer Koh" userId="f9e5c760-747b-4877-856a-bb6123371f09" providerId="ADAL" clId="{171E6B69-3E29-4E74-97DE-FED31F216FDA}" dt="2024-12-03T04:33:45.673" v="909" actId="167"/>
          <ac:picMkLst>
            <pc:docMk/>
            <pc:sldMk cId="4175903602" sldId="274"/>
            <ac:picMk id="5" creationId="{1EDC614E-2D7E-4CD4-D26F-21A6D1340FAF}"/>
          </ac:picMkLst>
        </pc:picChg>
        <pc:cxnChg chg="mod">
          <ac:chgData name="Jennifer Koh" userId="f9e5c760-747b-4877-856a-bb6123371f09" providerId="ADAL" clId="{171E6B69-3E29-4E74-97DE-FED31F216FDA}" dt="2024-11-29T00:13:54.590" v="97" actId="165"/>
          <ac:cxnSpMkLst>
            <pc:docMk/>
            <pc:sldMk cId="4175903602" sldId="274"/>
            <ac:cxnSpMk id="8" creationId="{29A853C6-3A4E-7C4F-F425-556C5559B531}"/>
          </ac:cxnSpMkLst>
        </pc:cxnChg>
        <pc:cxnChg chg="mod">
          <ac:chgData name="Jennifer Koh" userId="f9e5c760-747b-4877-856a-bb6123371f09" providerId="ADAL" clId="{171E6B69-3E29-4E74-97DE-FED31F216FDA}" dt="2024-11-29T00:13:54.590" v="97" actId="165"/>
          <ac:cxnSpMkLst>
            <pc:docMk/>
            <pc:sldMk cId="4175903602" sldId="274"/>
            <ac:cxnSpMk id="10" creationId="{7F18568B-A533-0C42-8316-36788472125F}"/>
          </ac:cxnSpMkLst>
        </pc:cxnChg>
        <pc:cxnChg chg="mod">
          <ac:chgData name="Jennifer Koh" userId="f9e5c760-747b-4877-856a-bb6123371f09" providerId="ADAL" clId="{171E6B69-3E29-4E74-97DE-FED31F216FDA}" dt="2024-11-29T00:13:54.590" v="97" actId="165"/>
          <ac:cxnSpMkLst>
            <pc:docMk/>
            <pc:sldMk cId="4175903602" sldId="274"/>
            <ac:cxnSpMk id="14" creationId="{06C08C6C-D4F1-2552-9D51-FC24A687B7F4}"/>
          </ac:cxnSpMkLst>
        </pc:cxnChg>
        <pc:cxnChg chg="mod">
          <ac:chgData name="Jennifer Koh" userId="f9e5c760-747b-4877-856a-bb6123371f09" providerId="ADAL" clId="{171E6B69-3E29-4E74-97DE-FED31F216FDA}" dt="2024-11-29T00:13:54.590" v="97" actId="165"/>
          <ac:cxnSpMkLst>
            <pc:docMk/>
            <pc:sldMk cId="4175903602" sldId="274"/>
            <ac:cxnSpMk id="17" creationId="{0D1BCCF3-D9F2-55F6-54E9-764D54D24E93}"/>
          </ac:cxnSpMkLst>
        </pc:cxnChg>
        <pc:cxnChg chg="mod">
          <ac:chgData name="Jennifer Koh" userId="f9e5c760-747b-4877-856a-bb6123371f09" providerId="ADAL" clId="{171E6B69-3E29-4E74-97DE-FED31F216FDA}" dt="2024-11-29T00:13:54.590" v="97" actId="165"/>
          <ac:cxnSpMkLst>
            <pc:docMk/>
            <pc:sldMk cId="4175903602" sldId="274"/>
            <ac:cxnSpMk id="20" creationId="{7C20DB00-44B4-E622-81C1-0DCF7A901598}"/>
          </ac:cxnSpMkLst>
        </pc:cxnChg>
        <pc:cxnChg chg="mod">
          <ac:chgData name="Jennifer Koh" userId="f9e5c760-747b-4877-856a-bb6123371f09" providerId="ADAL" clId="{171E6B69-3E29-4E74-97DE-FED31F216FDA}" dt="2024-11-29T00:13:54.590" v="97" actId="165"/>
          <ac:cxnSpMkLst>
            <pc:docMk/>
            <pc:sldMk cId="4175903602" sldId="274"/>
            <ac:cxnSpMk id="23" creationId="{530CB6E3-2BF9-6AA6-78BF-71E2E56F67FE}"/>
          </ac:cxnSpMkLst>
        </pc:cxnChg>
        <pc:cxnChg chg="mod">
          <ac:chgData name="Jennifer Koh" userId="f9e5c760-747b-4877-856a-bb6123371f09" providerId="ADAL" clId="{171E6B69-3E29-4E74-97DE-FED31F216FDA}" dt="2024-11-29T00:11:50.526" v="63"/>
          <ac:cxnSpMkLst>
            <pc:docMk/>
            <pc:sldMk cId="4175903602" sldId="274"/>
            <ac:cxnSpMk id="26" creationId="{57451DD3-41D6-660C-4997-A08CA0127E65}"/>
          </ac:cxnSpMkLst>
        </pc:cxnChg>
        <pc:cxnChg chg="mod">
          <ac:chgData name="Jennifer Koh" userId="f9e5c760-747b-4877-856a-bb6123371f09" providerId="ADAL" clId="{171E6B69-3E29-4E74-97DE-FED31F216FDA}" dt="2024-11-29T00:11:50.526" v="63"/>
          <ac:cxnSpMkLst>
            <pc:docMk/>
            <pc:sldMk cId="4175903602" sldId="274"/>
            <ac:cxnSpMk id="29" creationId="{2A0201AD-835F-4E5C-9BC6-CD896D56A414}"/>
          </ac:cxnSpMkLst>
        </pc:cxnChg>
        <pc:cxnChg chg="mod">
          <ac:chgData name="Jennifer Koh" userId="f9e5c760-747b-4877-856a-bb6123371f09" providerId="ADAL" clId="{171E6B69-3E29-4E74-97DE-FED31F216FDA}" dt="2024-11-29T00:11:50.526" v="63"/>
          <ac:cxnSpMkLst>
            <pc:docMk/>
            <pc:sldMk cId="4175903602" sldId="274"/>
            <ac:cxnSpMk id="32" creationId="{B1C332D3-3E5F-02DD-329B-33A2D5C07511}"/>
          </ac:cxnSpMkLst>
        </pc:cxnChg>
        <pc:cxnChg chg="mod">
          <ac:chgData name="Jennifer Koh" userId="f9e5c760-747b-4877-856a-bb6123371f09" providerId="ADAL" clId="{171E6B69-3E29-4E74-97DE-FED31F216FDA}" dt="2024-11-29T00:13:54.590" v="97" actId="165"/>
          <ac:cxnSpMkLst>
            <pc:docMk/>
            <pc:sldMk cId="4175903602" sldId="274"/>
            <ac:cxnSpMk id="35" creationId="{B48C17AB-B76E-B941-9C20-B16A66A3AC43}"/>
          </ac:cxnSpMkLst>
        </pc:cxnChg>
        <pc:cxnChg chg="mod">
          <ac:chgData name="Jennifer Koh" userId="f9e5c760-747b-4877-856a-bb6123371f09" providerId="ADAL" clId="{171E6B69-3E29-4E74-97DE-FED31F216FDA}" dt="2024-11-29T00:13:54.590" v="97" actId="165"/>
          <ac:cxnSpMkLst>
            <pc:docMk/>
            <pc:sldMk cId="4175903602" sldId="274"/>
            <ac:cxnSpMk id="38" creationId="{991B1B4E-F086-AEAF-9899-98D43644A539}"/>
          </ac:cxnSpMkLst>
        </pc:cxnChg>
        <pc:cxnChg chg="mod">
          <ac:chgData name="Jennifer Koh" userId="f9e5c760-747b-4877-856a-bb6123371f09" providerId="ADAL" clId="{171E6B69-3E29-4E74-97DE-FED31F216FDA}" dt="2024-12-03T03:19:27.640" v="746" actId="1035"/>
          <ac:cxnSpMkLst>
            <pc:docMk/>
            <pc:sldMk cId="4175903602" sldId="274"/>
            <ac:cxnSpMk id="41" creationId="{FC43EF6B-2044-E7CA-D33E-1E395F47E147}"/>
          </ac:cxnSpMkLst>
        </pc:cxnChg>
      </pc:sldChg>
      <pc:sldChg chg="addSp delSp modSp mod modNotesTx">
        <pc:chgData name="Jennifer Koh" userId="f9e5c760-747b-4877-856a-bb6123371f09" providerId="ADAL" clId="{171E6B69-3E29-4E74-97DE-FED31F216FDA}" dt="2024-12-04T02:10:10.554" v="1147" actId="20577"/>
        <pc:sldMkLst>
          <pc:docMk/>
          <pc:sldMk cId="3674379232" sldId="278"/>
        </pc:sldMkLst>
        <pc:spChg chg="add mod">
          <ac:chgData name="Jennifer Koh" userId="f9e5c760-747b-4877-856a-bb6123371f09" providerId="ADAL" clId="{171E6B69-3E29-4E74-97DE-FED31F216FDA}" dt="2024-12-04T02:10:10.554" v="1147" actId="20577"/>
          <ac:spMkLst>
            <pc:docMk/>
            <pc:sldMk cId="3674379232" sldId="278"/>
            <ac:spMk id="5" creationId="{E64B3139-CD22-1325-66E4-E9F60A038575}"/>
          </ac:spMkLst>
        </pc:spChg>
        <pc:spChg chg="del mod">
          <ac:chgData name="Jennifer Koh" userId="f9e5c760-747b-4877-856a-bb6123371f09" providerId="ADAL" clId="{171E6B69-3E29-4E74-97DE-FED31F216FDA}" dt="2024-12-04T02:10:05.321" v="1139" actId="478"/>
          <ac:spMkLst>
            <pc:docMk/>
            <pc:sldMk cId="3674379232" sldId="278"/>
            <ac:spMk id="6" creationId="{E2B458BD-1F41-A38B-852C-31B8E4E22F8E}"/>
          </ac:spMkLst>
        </pc:spChg>
        <pc:picChg chg="del">
          <ac:chgData name="Jennifer Koh" userId="f9e5c760-747b-4877-856a-bb6123371f09" providerId="ADAL" clId="{171E6B69-3E29-4E74-97DE-FED31F216FDA}" dt="2024-12-02T23:02:37.823" v="433" actId="478"/>
          <ac:picMkLst>
            <pc:docMk/>
            <pc:sldMk cId="3674379232" sldId="278"/>
            <ac:picMk id="3" creationId="{5B52AB2C-B14E-2D6C-F3BC-4A64C02CED69}"/>
          </ac:picMkLst>
        </pc:picChg>
        <pc:picChg chg="add mod">
          <ac:chgData name="Jennifer Koh" userId="f9e5c760-747b-4877-856a-bb6123371f09" providerId="ADAL" clId="{171E6B69-3E29-4E74-97DE-FED31F216FDA}" dt="2024-12-02T23:02:47.205" v="438" actId="12789"/>
          <ac:picMkLst>
            <pc:docMk/>
            <pc:sldMk cId="3674379232" sldId="278"/>
            <ac:picMk id="4" creationId="{36076565-A750-9849-5858-C2F30A1BA897}"/>
          </ac:picMkLst>
        </pc:picChg>
      </pc:sldChg>
      <pc:sldChg chg="addSp delSp modSp mod modNotesTx">
        <pc:chgData name="Jennifer Koh" userId="f9e5c760-747b-4877-856a-bb6123371f09" providerId="ADAL" clId="{171E6B69-3E29-4E74-97DE-FED31F216FDA}" dt="2024-12-04T02:13:30.014" v="1213" actId="20577"/>
        <pc:sldMkLst>
          <pc:docMk/>
          <pc:sldMk cId="1214462485" sldId="283"/>
        </pc:sldMkLst>
        <pc:spChg chg="add mod">
          <ac:chgData name="Jennifer Koh" userId="f9e5c760-747b-4877-856a-bb6123371f09" providerId="ADAL" clId="{171E6B69-3E29-4E74-97DE-FED31F216FDA}" dt="2024-12-04T02:12:27.304" v="1196" actId="20577"/>
          <ac:spMkLst>
            <pc:docMk/>
            <pc:sldMk cId="1214462485" sldId="283"/>
            <ac:spMk id="2" creationId="{4871C192-E8C2-9607-A8D4-C3DEBF59FEF8}"/>
          </ac:spMkLst>
        </pc:spChg>
        <pc:spChg chg="del mod">
          <ac:chgData name="Jennifer Koh" userId="f9e5c760-747b-4877-856a-bb6123371f09" providerId="ADAL" clId="{171E6B69-3E29-4E74-97DE-FED31F216FDA}" dt="2024-12-04T02:12:23.949" v="1193" actId="478"/>
          <ac:spMkLst>
            <pc:docMk/>
            <pc:sldMk cId="1214462485" sldId="283"/>
            <ac:spMk id="6" creationId="{119E6A17-1B5D-A4B8-3F49-124EAB0EEAF9}"/>
          </ac:spMkLst>
        </pc:spChg>
      </pc:sldChg>
      <pc:sldChg chg="addSp delSp modSp mod modNotesTx">
        <pc:chgData name="Jennifer Koh" userId="f9e5c760-747b-4877-856a-bb6123371f09" providerId="ADAL" clId="{171E6B69-3E29-4E74-97DE-FED31F216FDA}" dt="2024-12-04T02:13:34.418" v="1215" actId="20577"/>
        <pc:sldMkLst>
          <pc:docMk/>
          <pc:sldMk cId="2654949521" sldId="284"/>
        </pc:sldMkLst>
        <pc:spChg chg="mod">
          <ac:chgData name="Jennifer Koh" userId="f9e5c760-747b-4877-856a-bb6123371f09" providerId="ADAL" clId="{171E6B69-3E29-4E74-97DE-FED31F216FDA}" dt="2024-11-29T00:14:14.178" v="98"/>
          <ac:spMkLst>
            <pc:docMk/>
            <pc:sldMk cId="2654949521" sldId="284"/>
            <ac:spMk id="3" creationId="{AEE4F3CC-8D1D-E3B5-1DC6-936C2EB03872}"/>
          </ac:spMkLst>
        </pc:spChg>
        <pc:spChg chg="del mod topLvl">
          <ac:chgData name="Jennifer Koh" userId="f9e5c760-747b-4877-856a-bb6123371f09" providerId="ADAL" clId="{171E6B69-3E29-4E74-97DE-FED31F216FDA}" dt="2024-12-03T03:40:23.596" v="822" actId="478"/>
          <ac:spMkLst>
            <pc:docMk/>
            <pc:sldMk cId="2654949521" sldId="284"/>
            <ac:spMk id="4" creationId="{05965431-C262-98A6-85FA-04FEF33150F7}"/>
          </ac:spMkLst>
        </pc:spChg>
        <pc:spChg chg="add del mod">
          <ac:chgData name="Jennifer Koh" userId="f9e5c760-747b-4877-856a-bb6123371f09" providerId="ADAL" clId="{171E6B69-3E29-4E74-97DE-FED31F216FDA}" dt="2024-12-03T03:30:28.884" v="775" actId="478"/>
          <ac:spMkLst>
            <pc:docMk/>
            <pc:sldMk cId="2654949521" sldId="284"/>
            <ac:spMk id="5" creationId="{B25B5FEE-506E-EF88-11FF-5AA4B9EE9044}"/>
          </ac:spMkLst>
        </pc:spChg>
        <pc:spChg chg="del mod ord topLvl">
          <ac:chgData name="Jennifer Koh" userId="f9e5c760-747b-4877-856a-bb6123371f09" providerId="ADAL" clId="{171E6B69-3E29-4E74-97DE-FED31F216FDA}" dt="2024-12-04T02:12:31.879" v="1197" actId="478"/>
          <ac:spMkLst>
            <pc:docMk/>
            <pc:sldMk cId="2654949521" sldId="284"/>
            <ac:spMk id="9" creationId="{2D77EE81-EC0E-7229-1A8C-611C9453E17D}"/>
          </ac:spMkLst>
        </pc:spChg>
        <pc:spChg chg="add del mod">
          <ac:chgData name="Jennifer Koh" userId="f9e5c760-747b-4877-856a-bb6123371f09" providerId="ADAL" clId="{171E6B69-3E29-4E74-97DE-FED31F216FDA}" dt="2024-12-03T03:30:33.757" v="776" actId="478"/>
          <ac:spMkLst>
            <pc:docMk/>
            <pc:sldMk cId="2654949521" sldId="284"/>
            <ac:spMk id="10" creationId="{49CD1C9C-2E00-F55E-D0EC-A75106082150}"/>
          </ac:spMkLst>
        </pc:spChg>
        <pc:spChg chg="add del mod">
          <ac:chgData name="Jennifer Koh" userId="f9e5c760-747b-4877-856a-bb6123371f09" providerId="ADAL" clId="{171E6B69-3E29-4E74-97DE-FED31F216FDA}" dt="2024-12-03T03:30:35.500" v="777" actId="478"/>
          <ac:spMkLst>
            <pc:docMk/>
            <pc:sldMk cId="2654949521" sldId="284"/>
            <ac:spMk id="12" creationId="{0D7367C3-0FF0-0AAD-1976-0F62544C38A3}"/>
          </ac:spMkLst>
        </pc:spChg>
        <pc:spChg chg="mod">
          <ac:chgData name="Jennifer Koh" userId="f9e5c760-747b-4877-856a-bb6123371f09" providerId="ADAL" clId="{171E6B69-3E29-4E74-97DE-FED31F216FDA}" dt="2024-11-29T00:14:14.178" v="98"/>
          <ac:spMkLst>
            <pc:docMk/>
            <pc:sldMk cId="2654949521" sldId="284"/>
            <ac:spMk id="12" creationId="{745D4355-A03F-E170-9D60-4AF9878A448B}"/>
          </ac:spMkLst>
        </pc:spChg>
        <pc:spChg chg="add mod">
          <ac:chgData name="Jennifer Koh" userId="f9e5c760-747b-4877-856a-bb6123371f09" providerId="ADAL" clId="{171E6B69-3E29-4E74-97DE-FED31F216FDA}" dt="2024-12-03T03:32:07.895" v="779"/>
          <ac:spMkLst>
            <pc:docMk/>
            <pc:sldMk cId="2654949521" sldId="284"/>
            <ac:spMk id="13" creationId="{5F1D92F5-695D-8496-8EDD-801F7CCE3E44}"/>
          </ac:spMkLst>
        </pc:spChg>
        <pc:spChg chg="add mod">
          <ac:chgData name="Jennifer Koh" userId="f9e5c760-747b-4877-856a-bb6123371f09" providerId="ADAL" clId="{171E6B69-3E29-4E74-97DE-FED31F216FDA}" dt="2024-12-03T03:32:07.895" v="779"/>
          <ac:spMkLst>
            <pc:docMk/>
            <pc:sldMk cId="2654949521" sldId="284"/>
            <ac:spMk id="14" creationId="{F186E7A1-816A-B71D-4D73-3161348F6087}"/>
          </ac:spMkLst>
        </pc:spChg>
        <pc:spChg chg="mod">
          <ac:chgData name="Jennifer Koh" userId="f9e5c760-747b-4877-856a-bb6123371f09" providerId="ADAL" clId="{171E6B69-3E29-4E74-97DE-FED31F216FDA}" dt="2024-11-29T00:14:14.178" v="98"/>
          <ac:spMkLst>
            <pc:docMk/>
            <pc:sldMk cId="2654949521" sldId="284"/>
            <ac:spMk id="15" creationId="{53044D5F-44A7-E5AB-E801-100A2FDCAE7F}"/>
          </ac:spMkLst>
        </pc:spChg>
        <pc:spChg chg="add mod">
          <ac:chgData name="Jennifer Koh" userId="f9e5c760-747b-4877-856a-bb6123371f09" providerId="ADAL" clId="{171E6B69-3E29-4E74-97DE-FED31F216FDA}" dt="2024-12-03T03:32:07.895" v="779"/>
          <ac:spMkLst>
            <pc:docMk/>
            <pc:sldMk cId="2654949521" sldId="284"/>
            <ac:spMk id="15" creationId="{9153A01D-37E8-6138-6FFD-43AC25F42089}"/>
          </ac:spMkLst>
        </pc:spChg>
        <pc:spChg chg="del mod topLvl">
          <ac:chgData name="Jennifer Koh" userId="f9e5c760-747b-4877-856a-bb6123371f09" providerId="ADAL" clId="{171E6B69-3E29-4E74-97DE-FED31F216FDA}" dt="2024-12-03T03:42:00.663" v="840" actId="478"/>
          <ac:spMkLst>
            <pc:docMk/>
            <pc:sldMk cId="2654949521" sldId="284"/>
            <ac:spMk id="17" creationId="{C6013D8E-3100-E77D-DEBB-39C390782102}"/>
          </ac:spMkLst>
        </pc:spChg>
        <pc:spChg chg="mod">
          <ac:chgData name="Jennifer Koh" userId="f9e5c760-747b-4877-856a-bb6123371f09" providerId="ADAL" clId="{171E6B69-3E29-4E74-97DE-FED31F216FDA}" dt="2024-11-29T00:14:14.178" v="98"/>
          <ac:spMkLst>
            <pc:docMk/>
            <pc:sldMk cId="2654949521" sldId="284"/>
            <ac:spMk id="18" creationId="{4FCA013E-89DA-A298-033E-7025EE0FE944}"/>
          </ac:spMkLst>
        </pc:spChg>
        <pc:spChg chg="del mod topLvl">
          <ac:chgData name="Jennifer Koh" userId="f9e5c760-747b-4877-856a-bb6123371f09" providerId="ADAL" clId="{171E6B69-3E29-4E74-97DE-FED31F216FDA}" dt="2024-12-03T03:42:03.824" v="842" actId="478"/>
          <ac:spMkLst>
            <pc:docMk/>
            <pc:sldMk cId="2654949521" sldId="284"/>
            <ac:spMk id="20" creationId="{5B18B2C6-1D85-EA20-4BBC-0CB6C98CE498}"/>
          </ac:spMkLst>
        </pc:spChg>
        <pc:spChg chg="mod">
          <ac:chgData name="Jennifer Koh" userId="f9e5c760-747b-4877-856a-bb6123371f09" providerId="ADAL" clId="{171E6B69-3E29-4E74-97DE-FED31F216FDA}" dt="2024-11-29T00:14:14.178" v="98"/>
          <ac:spMkLst>
            <pc:docMk/>
            <pc:sldMk cId="2654949521" sldId="284"/>
            <ac:spMk id="21" creationId="{68E04E1C-267C-B979-0F54-48DF429E1D8A}"/>
          </ac:spMkLst>
        </pc:spChg>
        <pc:spChg chg="mod">
          <ac:chgData name="Jennifer Koh" userId="f9e5c760-747b-4877-856a-bb6123371f09" providerId="ADAL" clId="{171E6B69-3E29-4E74-97DE-FED31F216FDA}" dt="2024-12-03T03:40:12.741" v="815" actId="165"/>
          <ac:spMkLst>
            <pc:docMk/>
            <pc:sldMk cId="2654949521" sldId="284"/>
            <ac:spMk id="23" creationId="{AE01694B-A933-C3EA-5465-DDEA4CF6B77C}"/>
          </ac:spMkLst>
        </pc:spChg>
        <pc:spChg chg="mod">
          <ac:chgData name="Jennifer Koh" userId="f9e5c760-747b-4877-856a-bb6123371f09" providerId="ADAL" clId="{171E6B69-3E29-4E74-97DE-FED31F216FDA}" dt="2024-11-29T00:14:14.178" v="98"/>
          <ac:spMkLst>
            <pc:docMk/>
            <pc:sldMk cId="2654949521" sldId="284"/>
            <ac:spMk id="24" creationId="{13F7313C-0A19-A3C5-E634-3435A878D238}"/>
          </ac:spMkLst>
        </pc:spChg>
        <pc:spChg chg="mod">
          <ac:chgData name="Jennifer Koh" userId="f9e5c760-747b-4877-856a-bb6123371f09" providerId="ADAL" clId="{171E6B69-3E29-4E74-97DE-FED31F216FDA}" dt="2024-11-29T00:14:14.178" v="98"/>
          <ac:spMkLst>
            <pc:docMk/>
            <pc:sldMk cId="2654949521" sldId="284"/>
            <ac:spMk id="27" creationId="{5D80804B-1F62-53AC-80CA-D6FA014248CA}"/>
          </ac:spMkLst>
        </pc:spChg>
        <pc:spChg chg="mod">
          <ac:chgData name="Jennifer Koh" userId="f9e5c760-747b-4877-856a-bb6123371f09" providerId="ADAL" clId="{171E6B69-3E29-4E74-97DE-FED31F216FDA}" dt="2024-12-03T03:40:28.810" v="824"/>
          <ac:spMkLst>
            <pc:docMk/>
            <pc:sldMk cId="2654949521" sldId="284"/>
            <ac:spMk id="29" creationId="{C6ECE3BC-FC42-5CBC-C25A-AC2E31609049}"/>
          </ac:spMkLst>
        </pc:spChg>
        <pc:spChg chg="mod">
          <ac:chgData name="Jennifer Koh" userId="f9e5c760-747b-4877-856a-bb6123371f09" providerId="ADAL" clId="{171E6B69-3E29-4E74-97DE-FED31F216FDA}" dt="2024-11-29T00:14:14.178" v="98"/>
          <ac:spMkLst>
            <pc:docMk/>
            <pc:sldMk cId="2654949521" sldId="284"/>
            <ac:spMk id="30" creationId="{3675144D-8C32-FB74-9C74-564EAC30E5C1}"/>
          </ac:spMkLst>
        </pc:spChg>
        <pc:spChg chg="mod">
          <ac:chgData name="Jennifer Koh" userId="f9e5c760-747b-4877-856a-bb6123371f09" providerId="ADAL" clId="{171E6B69-3E29-4E74-97DE-FED31F216FDA}" dt="2024-12-03T03:41:01.117" v="833" actId="1076"/>
          <ac:spMkLst>
            <pc:docMk/>
            <pc:sldMk cId="2654949521" sldId="284"/>
            <ac:spMk id="32" creationId="{BF534C33-463E-87FC-E27C-B6FD95366ADB}"/>
          </ac:spMkLst>
        </pc:spChg>
        <pc:spChg chg="mod">
          <ac:chgData name="Jennifer Koh" userId="f9e5c760-747b-4877-856a-bb6123371f09" providerId="ADAL" clId="{171E6B69-3E29-4E74-97DE-FED31F216FDA}" dt="2024-11-29T00:14:14.178" v="98"/>
          <ac:spMkLst>
            <pc:docMk/>
            <pc:sldMk cId="2654949521" sldId="284"/>
            <ac:spMk id="33" creationId="{5704CA5F-E7E3-C93C-DE8B-580A2D7F58BF}"/>
          </ac:spMkLst>
        </pc:spChg>
        <pc:spChg chg="del mod topLvl">
          <ac:chgData name="Jennifer Koh" userId="f9e5c760-747b-4877-856a-bb6123371f09" providerId="ADAL" clId="{171E6B69-3E29-4E74-97DE-FED31F216FDA}" dt="2024-12-03T03:40:21.534" v="821" actId="478"/>
          <ac:spMkLst>
            <pc:docMk/>
            <pc:sldMk cId="2654949521" sldId="284"/>
            <ac:spMk id="36" creationId="{DC238969-CC7B-472A-FCB3-4922B948205F}"/>
          </ac:spMkLst>
        </pc:spChg>
        <pc:spChg chg="del mod topLvl">
          <ac:chgData name="Jennifer Koh" userId="f9e5c760-747b-4877-856a-bb6123371f09" providerId="ADAL" clId="{171E6B69-3E29-4E74-97DE-FED31F216FDA}" dt="2024-12-03T03:40:15.901" v="816" actId="478"/>
          <ac:spMkLst>
            <pc:docMk/>
            <pc:sldMk cId="2654949521" sldId="284"/>
            <ac:spMk id="39" creationId="{0CBC3F0A-C9A2-3D4F-D7B7-050925004792}"/>
          </ac:spMkLst>
        </pc:spChg>
        <pc:spChg chg="mod">
          <ac:chgData name="Jennifer Koh" userId="f9e5c760-747b-4877-856a-bb6123371f09" providerId="ADAL" clId="{171E6B69-3E29-4E74-97DE-FED31F216FDA}" dt="2024-12-03T03:41:14.302" v="835"/>
          <ac:spMkLst>
            <pc:docMk/>
            <pc:sldMk cId="2654949521" sldId="284"/>
            <ac:spMk id="41" creationId="{D34399F2-CC65-C7EF-3F30-43707B0CCE76}"/>
          </ac:spMkLst>
        </pc:spChg>
        <pc:spChg chg="mod">
          <ac:chgData name="Jennifer Koh" userId="f9e5c760-747b-4877-856a-bb6123371f09" providerId="ADAL" clId="{171E6B69-3E29-4E74-97DE-FED31F216FDA}" dt="2024-11-29T00:16:30.609" v="126"/>
          <ac:spMkLst>
            <pc:docMk/>
            <pc:sldMk cId="2654949521" sldId="284"/>
            <ac:spMk id="42" creationId="{700A0DC6-4823-2F10-5E3D-16A3C8A5233F}"/>
          </ac:spMkLst>
        </pc:spChg>
        <pc:spChg chg="mod">
          <ac:chgData name="Jennifer Koh" userId="f9e5c760-747b-4877-856a-bb6123371f09" providerId="ADAL" clId="{171E6B69-3E29-4E74-97DE-FED31F216FDA}" dt="2024-12-03T03:42:10.170" v="845"/>
          <ac:spMkLst>
            <pc:docMk/>
            <pc:sldMk cId="2654949521" sldId="284"/>
            <ac:spMk id="44" creationId="{D4454BC5-392B-D555-D44D-4D1D548B79C8}"/>
          </ac:spMkLst>
        </pc:spChg>
        <pc:spChg chg="mod">
          <ac:chgData name="Jennifer Koh" userId="f9e5c760-747b-4877-856a-bb6123371f09" providerId="ADAL" clId="{171E6B69-3E29-4E74-97DE-FED31F216FDA}" dt="2024-11-29T00:16:30.609" v="126"/>
          <ac:spMkLst>
            <pc:docMk/>
            <pc:sldMk cId="2654949521" sldId="284"/>
            <ac:spMk id="45" creationId="{D26666B2-9E3D-7B9C-9769-BAB5D1CB6AEB}"/>
          </ac:spMkLst>
        </pc:spChg>
        <pc:spChg chg="mod">
          <ac:chgData name="Jennifer Koh" userId="f9e5c760-747b-4877-856a-bb6123371f09" providerId="ADAL" clId="{171E6B69-3E29-4E74-97DE-FED31F216FDA}" dt="2024-12-03T03:42:45.288" v="852" actId="1076"/>
          <ac:spMkLst>
            <pc:docMk/>
            <pc:sldMk cId="2654949521" sldId="284"/>
            <ac:spMk id="47" creationId="{EB032772-2103-4793-2C9E-206633F7CFF1}"/>
          </ac:spMkLst>
        </pc:spChg>
        <pc:spChg chg="mod">
          <ac:chgData name="Jennifer Koh" userId="f9e5c760-747b-4877-856a-bb6123371f09" providerId="ADAL" clId="{171E6B69-3E29-4E74-97DE-FED31F216FDA}" dt="2024-11-29T00:16:30.609" v="126"/>
          <ac:spMkLst>
            <pc:docMk/>
            <pc:sldMk cId="2654949521" sldId="284"/>
            <ac:spMk id="48" creationId="{4E7125D2-B20E-97EE-D505-B2D8B7D5D5F2}"/>
          </ac:spMkLst>
        </pc:spChg>
        <pc:spChg chg="mod">
          <ac:chgData name="Jennifer Koh" userId="f9e5c760-747b-4877-856a-bb6123371f09" providerId="ADAL" clId="{171E6B69-3E29-4E74-97DE-FED31F216FDA}" dt="2024-12-03T03:43:12.826" v="859"/>
          <ac:spMkLst>
            <pc:docMk/>
            <pc:sldMk cId="2654949521" sldId="284"/>
            <ac:spMk id="50" creationId="{014C40A0-FEB2-4E7F-4E43-94C66D08C1CD}"/>
          </ac:spMkLst>
        </pc:spChg>
        <pc:spChg chg="mod">
          <ac:chgData name="Jennifer Koh" userId="f9e5c760-747b-4877-856a-bb6123371f09" providerId="ADAL" clId="{171E6B69-3E29-4E74-97DE-FED31F216FDA}" dt="2024-11-29T00:16:36.452" v="129"/>
          <ac:spMkLst>
            <pc:docMk/>
            <pc:sldMk cId="2654949521" sldId="284"/>
            <ac:spMk id="51" creationId="{CF7031F2-3C66-461A-34E0-F354831077F1}"/>
          </ac:spMkLst>
        </pc:spChg>
        <pc:spChg chg="mod">
          <ac:chgData name="Jennifer Koh" userId="f9e5c760-747b-4877-856a-bb6123371f09" providerId="ADAL" clId="{171E6B69-3E29-4E74-97DE-FED31F216FDA}" dt="2024-12-03T03:43:26.960" v="860"/>
          <ac:spMkLst>
            <pc:docMk/>
            <pc:sldMk cId="2654949521" sldId="284"/>
            <ac:spMk id="53" creationId="{EF2A8B03-44BF-FA9B-9746-4E46BAFF4423}"/>
          </ac:spMkLst>
        </pc:spChg>
        <pc:spChg chg="mod">
          <ac:chgData name="Jennifer Koh" userId="f9e5c760-747b-4877-856a-bb6123371f09" providerId="ADAL" clId="{171E6B69-3E29-4E74-97DE-FED31F216FDA}" dt="2024-11-29T00:16:36.452" v="129"/>
          <ac:spMkLst>
            <pc:docMk/>
            <pc:sldMk cId="2654949521" sldId="284"/>
            <ac:spMk id="54" creationId="{E3DA0CCA-323B-1834-9E90-81846992C45A}"/>
          </ac:spMkLst>
        </pc:spChg>
        <pc:spChg chg="mod">
          <ac:chgData name="Jennifer Koh" userId="f9e5c760-747b-4877-856a-bb6123371f09" providerId="ADAL" clId="{171E6B69-3E29-4E74-97DE-FED31F216FDA}" dt="2024-11-29T00:16:36.452" v="129"/>
          <ac:spMkLst>
            <pc:docMk/>
            <pc:sldMk cId="2654949521" sldId="284"/>
            <ac:spMk id="57" creationId="{77E79A39-9A50-E138-239C-FC36E3609F8A}"/>
          </ac:spMkLst>
        </pc:spChg>
        <pc:spChg chg="add mod">
          <ac:chgData name="Jennifer Koh" userId="f9e5c760-747b-4877-856a-bb6123371f09" providerId="ADAL" clId="{171E6B69-3E29-4E74-97DE-FED31F216FDA}" dt="2024-12-04T02:12:34.472" v="1200" actId="20577"/>
          <ac:spMkLst>
            <pc:docMk/>
            <pc:sldMk cId="2654949521" sldId="284"/>
            <ac:spMk id="58" creationId="{0B2916CC-356A-289E-4326-035D690B21D1}"/>
          </ac:spMkLst>
        </pc:spChg>
        <pc:spChg chg="mod">
          <ac:chgData name="Jennifer Koh" userId="f9e5c760-747b-4877-856a-bb6123371f09" providerId="ADAL" clId="{171E6B69-3E29-4E74-97DE-FED31F216FDA}" dt="2024-12-03T03:40:12.741" v="815" actId="165"/>
          <ac:spMkLst>
            <pc:docMk/>
            <pc:sldMk cId="2654949521" sldId="284"/>
            <ac:spMk id="60" creationId="{CFDCD073-F6F5-2242-C77B-4F2FB3C7FE0E}"/>
          </ac:spMkLst>
        </pc:spChg>
        <pc:spChg chg="mod">
          <ac:chgData name="Jennifer Koh" userId="f9e5c760-747b-4877-856a-bb6123371f09" providerId="ADAL" clId="{171E6B69-3E29-4E74-97DE-FED31F216FDA}" dt="2024-12-03T03:40:12.741" v="815" actId="165"/>
          <ac:spMkLst>
            <pc:docMk/>
            <pc:sldMk cId="2654949521" sldId="284"/>
            <ac:spMk id="63" creationId="{D83600D1-5523-F119-27DC-41D5B4FDBCDC}"/>
          </ac:spMkLst>
        </pc:spChg>
        <pc:spChg chg="mod">
          <ac:chgData name="Jennifer Koh" userId="f9e5c760-747b-4877-856a-bb6123371f09" providerId="ADAL" clId="{171E6B69-3E29-4E74-97DE-FED31F216FDA}" dt="2024-12-03T03:40:12.741" v="815" actId="165"/>
          <ac:spMkLst>
            <pc:docMk/>
            <pc:sldMk cId="2654949521" sldId="284"/>
            <ac:spMk id="66" creationId="{653DE753-0BBF-49D6-C934-D9E51DA99D6B}"/>
          </ac:spMkLst>
        </pc:spChg>
        <pc:spChg chg="del mod">
          <ac:chgData name="Jennifer Koh" userId="f9e5c760-747b-4877-856a-bb6123371f09" providerId="ADAL" clId="{171E6B69-3E29-4E74-97DE-FED31F216FDA}" dt="2024-12-03T03:29:33.181" v="769" actId="478"/>
          <ac:spMkLst>
            <pc:docMk/>
            <pc:sldMk cId="2654949521" sldId="284"/>
            <ac:spMk id="69" creationId="{34B98415-20B3-2F14-BEB2-DADA824B8777}"/>
          </ac:spMkLst>
        </pc:spChg>
        <pc:spChg chg="del mod">
          <ac:chgData name="Jennifer Koh" userId="f9e5c760-747b-4877-856a-bb6123371f09" providerId="ADAL" clId="{171E6B69-3E29-4E74-97DE-FED31F216FDA}" dt="2024-12-03T03:29:33.181" v="769" actId="478"/>
          <ac:spMkLst>
            <pc:docMk/>
            <pc:sldMk cId="2654949521" sldId="284"/>
            <ac:spMk id="72" creationId="{4ECDC6BF-389D-A49E-4152-8D5A4D8B48E8}"/>
          </ac:spMkLst>
        </pc:spChg>
        <pc:spChg chg="del mod">
          <ac:chgData name="Jennifer Koh" userId="f9e5c760-747b-4877-856a-bb6123371f09" providerId="ADAL" clId="{171E6B69-3E29-4E74-97DE-FED31F216FDA}" dt="2024-12-03T03:29:33.181" v="769" actId="478"/>
          <ac:spMkLst>
            <pc:docMk/>
            <pc:sldMk cId="2654949521" sldId="284"/>
            <ac:spMk id="75" creationId="{5452E09A-23EF-D3F5-4B03-9B2CD14EFD5A}"/>
          </ac:spMkLst>
        </pc:spChg>
        <pc:grpChg chg="add mod">
          <ac:chgData name="Jennifer Koh" userId="f9e5c760-747b-4877-856a-bb6123371f09" providerId="ADAL" clId="{171E6B69-3E29-4E74-97DE-FED31F216FDA}" dt="2024-11-29T00:14:14.178" v="98"/>
          <ac:grpSpMkLst>
            <pc:docMk/>
            <pc:sldMk cId="2654949521" sldId="284"/>
            <ac:grpSpMk id="2" creationId="{5FDA78A7-2FEC-A484-96C9-E2F571E93DDD}"/>
          </ac:grpSpMkLst>
        </pc:grpChg>
        <pc:grpChg chg="add del mod">
          <ac:chgData name="Jennifer Koh" userId="f9e5c760-747b-4877-856a-bb6123371f09" providerId="ADAL" clId="{171E6B69-3E29-4E74-97DE-FED31F216FDA}" dt="2024-12-02T23:15:36.958" v="516" actId="165"/>
          <ac:grpSpMkLst>
            <pc:docMk/>
            <pc:sldMk cId="2654949521" sldId="284"/>
            <ac:grpSpMk id="2" creationId="{CAA8ED00-4E43-63F6-6721-FA1CE81B418B}"/>
          </ac:grpSpMkLst>
        </pc:grpChg>
        <pc:grpChg chg="add del mod">
          <ac:chgData name="Jennifer Koh" userId="f9e5c760-747b-4877-856a-bb6123371f09" providerId="ADAL" clId="{171E6B69-3E29-4E74-97DE-FED31F216FDA}" dt="2024-12-03T03:32:26.938" v="780" actId="165"/>
          <ac:grpSpMkLst>
            <pc:docMk/>
            <pc:sldMk cId="2654949521" sldId="284"/>
            <ac:grpSpMk id="3" creationId="{1EAA4DD5-24B4-BDAA-981B-AF644D15DA0A}"/>
          </ac:grpSpMkLst>
        </pc:grpChg>
        <pc:grpChg chg="del mod topLvl">
          <ac:chgData name="Jennifer Koh" userId="f9e5c760-747b-4877-856a-bb6123371f09" providerId="ADAL" clId="{171E6B69-3E29-4E74-97DE-FED31F216FDA}" dt="2024-12-03T03:40:23.596" v="822" actId="478"/>
          <ac:grpSpMkLst>
            <pc:docMk/>
            <pc:sldMk cId="2654949521" sldId="284"/>
            <ac:grpSpMk id="7" creationId="{64DB76CD-7F89-E96D-CB15-8B66BC4E07EE}"/>
          </ac:grpSpMkLst>
        </pc:grpChg>
        <pc:grpChg chg="del">
          <ac:chgData name="Jennifer Koh" userId="f9e5c760-747b-4877-856a-bb6123371f09" providerId="ADAL" clId="{171E6B69-3E29-4E74-97DE-FED31F216FDA}" dt="2024-11-29T00:15:57.873" v="110" actId="165"/>
          <ac:grpSpMkLst>
            <pc:docMk/>
            <pc:sldMk cId="2654949521" sldId="284"/>
            <ac:grpSpMk id="10" creationId="{BCB1DCB0-213D-E95B-1423-91B0A089F1EA}"/>
          </ac:grpSpMkLst>
        </pc:grpChg>
        <pc:grpChg chg="add mod">
          <ac:chgData name="Jennifer Koh" userId="f9e5c760-747b-4877-856a-bb6123371f09" providerId="ADAL" clId="{171E6B69-3E29-4E74-97DE-FED31F216FDA}" dt="2024-11-29T00:14:14.178" v="98"/>
          <ac:grpSpMkLst>
            <pc:docMk/>
            <pc:sldMk cId="2654949521" sldId="284"/>
            <ac:grpSpMk id="11" creationId="{794277B7-525F-65AC-5EE7-B80735913E0C}"/>
          </ac:grpSpMkLst>
        </pc:grpChg>
        <pc:grpChg chg="add mod">
          <ac:chgData name="Jennifer Koh" userId="f9e5c760-747b-4877-856a-bb6123371f09" providerId="ADAL" clId="{171E6B69-3E29-4E74-97DE-FED31F216FDA}" dt="2024-11-29T00:14:14.178" v="98"/>
          <ac:grpSpMkLst>
            <pc:docMk/>
            <pc:sldMk cId="2654949521" sldId="284"/>
            <ac:grpSpMk id="14" creationId="{3921AD74-6C69-0B92-2CF9-1EB3B1CD8C1A}"/>
          </ac:grpSpMkLst>
        </pc:grpChg>
        <pc:grpChg chg="add del mod topLvl">
          <ac:chgData name="Jennifer Koh" userId="f9e5c760-747b-4877-856a-bb6123371f09" providerId="ADAL" clId="{171E6B69-3E29-4E74-97DE-FED31F216FDA}" dt="2024-12-03T03:42:00.663" v="840" actId="478"/>
          <ac:grpSpMkLst>
            <pc:docMk/>
            <pc:sldMk cId="2654949521" sldId="284"/>
            <ac:grpSpMk id="16" creationId="{7ED29F7D-3673-D9E4-7956-4388E949DA72}"/>
          </ac:grpSpMkLst>
        </pc:grpChg>
        <pc:grpChg chg="add mod">
          <ac:chgData name="Jennifer Koh" userId="f9e5c760-747b-4877-856a-bb6123371f09" providerId="ADAL" clId="{171E6B69-3E29-4E74-97DE-FED31F216FDA}" dt="2024-11-29T00:14:14.178" v="98"/>
          <ac:grpSpMkLst>
            <pc:docMk/>
            <pc:sldMk cId="2654949521" sldId="284"/>
            <ac:grpSpMk id="17" creationId="{91C78FB2-2263-2411-AFDA-4A33F9F8CD7C}"/>
          </ac:grpSpMkLst>
        </pc:grpChg>
        <pc:grpChg chg="add del mod topLvl">
          <ac:chgData name="Jennifer Koh" userId="f9e5c760-747b-4877-856a-bb6123371f09" providerId="ADAL" clId="{171E6B69-3E29-4E74-97DE-FED31F216FDA}" dt="2024-12-03T03:42:03.824" v="842" actId="478"/>
          <ac:grpSpMkLst>
            <pc:docMk/>
            <pc:sldMk cId="2654949521" sldId="284"/>
            <ac:grpSpMk id="19" creationId="{6FD0AB7C-8740-EDA8-6B76-32E44D1696D6}"/>
          </ac:grpSpMkLst>
        </pc:grpChg>
        <pc:grpChg chg="add mod">
          <ac:chgData name="Jennifer Koh" userId="f9e5c760-747b-4877-856a-bb6123371f09" providerId="ADAL" clId="{171E6B69-3E29-4E74-97DE-FED31F216FDA}" dt="2024-11-29T00:14:14.178" v="98"/>
          <ac:grpSpMkLst>
            <pc:docMk/>
            <pc:sldMk cId="2654949521" sldId="284"/>
            <ac:grpSpMk id="20" creationId="{9A335FB7-1B3B-0F61-5A1C-C8CBCC5BD9DB}"/>
          </ac:grpSpMkLst>
        </pc:grpChg>
        <pc:grpChg chg="add del mod topLvl">
          <ac:chgData name="Jennifer Koh" userId="f9e5c760-747b-4877-856a-bb6123371f09" providerId="ADAL" clId="{171E6B69-3E29-4E74-97DE-FED31F216FDA}" dt="2024-12-03T03:42:05.408" v="844" actId="478"/>
          <ac:grpSpMkLst>
            <pc:docMk/>
            <pc:sldMk cId="2654949521" sldId="284"/>
            <ac:grpSpMk id="22" creationId="{F1B7FB44-A810-11CF-690A-D6A1CF8FD0FF}"/>
          </ac:grpSpMkLst>
        </pc:grpChg>
        <pc:grpChg chg="add mod">
          <ac:chgData name="Jennifer Koh" userId="f9e5c760-747b-4877-856a-bb6123371f09" providerId="ADAL" clId="{171E6B69-3E29-4E74-97DE-FED31F216FDA}" dt="2024-11-29T00:14:14.178" v="98"/>
          <ac:grpSpMkLst>
            <pc:docMk/>
            <pc:sldMk cId="2654949521" sldId="284"/>
            <ac:grpSpMk id="23" creationId="{4650ACEB-6F09-7F96-68D8-ED33298DF670}"/>
          </ac:grpSpMkLst>
        </pc:grpChg>
        <pc:grpChg chg="add del mod">
          <ac:chgData name="Jennifer Koh" userId="f9e5c760-747b-4877-856a-bb6123371f09" providerId="ADAL" clId="{171E6B69-3E29-4E74-97DE-FED31F216FDA}" dt="2024-12-03T03:38:00.197" v="808" actId="165"/>
          <ac:grpSpMkLst>
            <pc:docMk/>
            <pc:sldMk cId="2654949521" sldId="284"/>
            <ac:grpSpMk id="25" creationId="{57ED7BFE-F9EA-F129-E39E-D353456A5351}"/>
          </ac:grpSpMkLst>
        </pc:grpChg>
        <pc:grpChg chg="add del mod">
          <ac:chgData name="Jennifer Koh" userId="f9e5c760-747b-4877-856a-bb6123371f09" providerId="ADAL" clId="{171E6B69-3E29-4E74-97DE-FED31F216FDA}" dt="2024-12-03T03:38:54.705" v="812" actId="165"/>
          <ac:grpSpMkLst>
            <pc:docMk/>
            <pc:sldMk cId="2654949521" sldId="284"/>
            <ac:grpSpMk id="26" creationId="{0734B4F2-36CC-80F5-BDBA-5710C7711190}"/>
          </ac:grpSpMkLst>
        </pc:grpChg>
        <pc:grpChg chg="add mod">
          <ac:chgData name="Jennifer Koh" userId="f9e5c760-747b-4877-856a-bb6123371f09" providerId="ADAL" clId="{171E6B69-3E29-4E74-97DE-FED31F216FDA}" dt="2024-11-29T00:14:14.178" v="98"/>
          <ac:grpSpMkLst>
            <pc:docMk/>
            <pc:sldMk cId="2654949521" sldId="284"/>
            <ac:grpSpMk id="26" creationId="{36C7AC38-4786-34BC-EE93-020A4D534EEF}"/>
          </ac:grpSpMkLst>
        </pc:grpChg>
        <pc:grpChg chg="add del mod">
          <ac:chgData name="Jennifer Koh" userId="f9e5c760-747b-4877-856a-bb6123371f09" providerId="ADAL" clId="{171E6B69-3E29-4E74-97DE-FED31F216FDA}" dt="2024-12-03T03:40:12.741" v="815" actId="165"/>
          <ac:grpSpMkLst>
            <pc:docMk/>
            <pc:sldMk cId="2654949521" sldId="284"/>
            <ac:grpSpMk id="27" creationId="{1BFF0FDC-E4AC-0CC5-2C2F-E242E973D652}"/>
          </ac:grpSpMkLst>
        </pc:grpChg>
        <pc:grpChg chg="add mod">
          <ac:chgData name="Jennifer Koh" userId="f9e5c760-747b-4877-856a-bb6123371f09" providerId="ADAL" clId="{171E6B69-3E29-4E74-97DE-FED31F216FDA}" dt="2024-12-03T03:44:20.032" v="864" actId="164"/>
          <ac:grpSpMkLst>
            <pc:docMk/>
            <pc:sldMk cId="2654949521" sldId="284"/>
            <ac:grpSpMk id="28" creationId="{E7ADE157-8070-7091-4A4F-F1A7A786D261}"/>
          </ac:grpSpMkLst>
        </pc:grpChg>
        <pc:grpChg chg="add mod">
          <ac:chgData name="Jennifer Koh" userId="f9e5c760-747b-4877-856a-bb6123371f09" providerId="ADAL" clId="{171E6B69-3E29-4E74-97DE-FED31F216FDA}" dt="2024-11-29T00:14:14.178" v="98"/>
          <ac:grpSpMkLst>
            <pc:docMk/>
            <pc:sldMk cId="2654949521" sldId="284"/>
            <ac:grpSpMk id="29" creationId="{C0E86D4C-CF27-A1AB-8710-F6A9992B3A98}"/>
          </ac:grpSpMkLst>
        </pc:grpChg>
        <pc:grpChg chg="add mod">
          <ac:chgData name="Jennifer Koh" userId="f9e5c760-747b-4877-856a-bb6123371f09" providerId="ADAL" clId="{171E6B69-3E29-4E74-97DE-FED31F216FDA}" dt="2024-12-03T03:44:20.032" v="864" actId="164"/>
          <ac:grpSpMkLst>
            <pc:docMk/>
            <pc:sldMk cId="2654949521" sldId="284"/>
            <ac:grpSpMk id="31" creationId="{A5367709-2D4A-B8FF-CE74-139A2F26BDD0}"/>
          </ac:grpSpMkLst>
        </pc:grpChg>
        <pc:grpChg chg="add mod">
          <ac:chgData name="Jennifer Koh" userId="f9e5c760-747b-4877-856a-bb6123371f09" providerId="ADAL" clId="{171E6B69-3E29-4E74-97DE-FED31F216FDA}" dt="2024-11-29T00:14:14.178" v="98"/>
          <ac:grpSpMkLst>
            <pc:docMk/>
            <pc:sldMk cId="2654949521" sldId="284"/>
            <ac:grpSpMk id="32" creationId="{49203788-2250-254F-A9F4-976224E5AA1C}"/>
          </ac:grpSpMkLst>
        </pc:grpChg>
        <pc:grpChg chg="add mod">
          <ac:chgData name="Jennifer Koh" userId="f9e5c760-747b-4877-856a-bb6123371f09" providerId="ADAL" clId="{171E6B69-3E29-4E74-97DE-FED31F216FDA}" dt="2024-12-03T03:44:20.032" v="864" actId="164"/>
          <ac:grpSpMkLst>
            <pc:docMk/>
            <pc:sldMk cId="2654949521" sldId="284"/>
            <ac:grpSpMk id="34" creationId="{7F2B9AA8-6AA9-1ED6-13D1-F2D47967A8D1}"/>
          </ac:grpSpMkLst>
        </pc:grpChg>
        <pc:grpChg chg="add del mod topLvl">
          <ac:chgData name="Jennifer Koh" userId="f9e5c760-747b-4877-856a-bb6123371f09" providerId="ADAL" clId="{171E6B69-3E29-4E74-97DE-FED31F216FDA}" dt="2024-12-03T03:40:19.960" v="819" actId="478"/>
          <ac:grpSpMkLst>
            <pc:docMk/>
            <pc:sldMk cId="2654949521" sldId="284"/>
            <ac:grpSpMk id="35" creationId="{C6B2214A-AFD1-5D31-9ED9-ABE6F68404B1}"/>
          </ac:grpSpMkLst>
        </pc:grpChg>
        <pc:grpChg chg="add del mod topLvl">
          <ac:chgData name="Jennifer Koh" userId="f9e5c760-747b-4877-856a-bb6123371f09" providerId="ADAL" clId="{171E6B69-3E29-4E74-97DE-FED31F216FDA}" dt="2024-12-03T03:40:15.901" v="816" actId="478"/>
          <ac:grpSpMkLst>
            <pc:docMk/>
            <pc:sldMk cId="2654949521" sldId="284"/>
            <ac:grpSpMk id="38" creationId="{FB3BDE1C-D47C-8B15-8B77-EA769AE7E295}"/>
          </ac:grpSpMkLst>
        </pc:grpChg>
        <pc:grpChg chg="add mod">
          <ac:chgData name="Jennifer Koh" userId="f9e5c760-747b-4877-856a-bb6123371f09" providerId="ADAL" clId="{171E6B69-3E29-4E74-97DE-FED31F216FDA}" dt="2024-11-29T00:16:30.609" v="126"/>
          <ac:grpSpMkLst>
            <pc:docMk/>
            <pc:sldMk cId="2654949521" sldId="284"/>
            <ac:grpSpMk id="41" creationId="{4DB0CA69-9EE3-2EC9-45C3-F057441F8FA3}"/>
          </ac:grpSpMkLst>
        </pc:grpChg>
        <pc:grpChg chg="add mod">
          <ac:chgData name="Jennifer Koh" userId="f9e5c760-747b-4877-856a-bb6123371f09" providerId="ADAL" clId="{171E6B69-3E29-4E74-97DE-FED31F216FDA}" dt="2024-12-03T03:44:20.032" v="864" actId="164"/>
          <ac:grpSpMkLst>
            <pc:docMk/>
            <pc:sldMk cId="2654949521" sldId="284"/>
            <ac:grpSpMk id="43" creationId="{D7A653BA-2910-E24D-88DF-0D447FB00FE5}"/>
          </ac:grpSpMkLst>
        </pc:grpChg>
        <pc:grpChg chg="add mod">
          <ac:chgData name="Jennifer Koh" userId="f9e5c760-747b-4877-856a-bb6123371f09" providerId="ADAL" clId="{171E6B69-3E29-4E74-97DE-FED31F216FDA}" dt="2024-11-29T00:16:30.609" v="126"/>
          <ac:grpSpMkLst>
            <pc:docMk/>
            <pc:sldMk cId="2654949521" sldId="284"/>
            <ac:grpSpMk id="44" creationId="{268B4A08-1C1D-8406-86B5-5ACE670E2960}"/>
          </ac:grpSpMkLst>
        </pc:grpChg>
        <pc:grpChg chg="add mod">
          <ac:chgData name="Jennifer Koh" userId="f9e5c760-747b-4877-856a-bb6123371f09" providerId="ADAL" clId="{171E6B69-3E29-4E74-97DE-FED31F216FDA}" dt="2024-12-03T03:44:20.032" v="864" actId="164"/>
          <ac:grpSpMkLst>
            <pc:docMk/>
            <pc:sldMk cId="2654949521" sldId="284"/>
            <ac:grpSpMk id="46" creationId="{8CA3EC08-A5AC-2535-C98F-074CBC08E16B}"/>
          </ac:grpSpMkLst>
        </pc:grpChg>
        <pc:grpChg chg="add mod">
          <ac:chgData name="Jennifer Koh" userId="f9e5c760-747b-4877-856a-bb6123371f09" providerId="ADAL" clId="{171E6B69-3E29-4E74-97DE-FED31F216FDA}" dt="2024-11-29T00:16:30.609" v="126"/>
          <ac:grpSpMkLst>
            <pc:docMk/>
            <pc:sldMk cId="2654949521" sldId="284"/>
            <ac:grpSpMk id="47" creationId="{CF213ECD-1B86-45B4-1E81-C8AB01AC6AAC}"/>
          </ac:grpSpMkLst>
        </pc:grpChg>
        <pc:grpChg chg="add mod">
          <ac:chgData name="Jennifer Koh" userId="f9e5c760-747b-4877-856a-bb6123371f09" providerId="ADAL" clId="{171E6B69-3E29-4E74-97DE-FED31F216FDA}" dt="2024-12-03T03:43:12.826" v="859"/>
          <ac:grpSpMkLst>
            <pc:docMk/>
            <pc:sldMk cId="2654949521" sldId="284"/>
            <ac:grpSpMk id="49" creationId="{FD55ACC0-85C0-2B6C-839C-0487EBDB2F24}"/>
          </ac:grpSpMkLst>
        </pc:grpChg>
        <pc:grpChg chg="add mod">
          <ac:chgData name="Jennifer Koh" userId="f9e5c760-747b-4877-856a-bb6123371f09" providerId="ADAL" clId="{171E6B69-3E29-4E74-97DE-FED31F216FDA}" dt="2024-11-29T00:16:36.452" v="129"/>
          <ac:grpSpMkLst>
            <pc:docMk/>
            <pc:sldMk cId="2654949521" sldId="284"/>
            <ac:grpSpMk id="50" creationId="{9FD642D2-AFAA-4E7F-EF3B-0D3B437BF401}"/>
          </ac:grpSpMkLst>
        </pc:grpChg>
        <pc:grpChg chg="add mod">
          <ac:chgData name="Jennifer Koh" userId="f9e5c760-747b-4877-856a-bb6123371f09" providerId="ADAL" clId="{171E6B69-3E29-4E74-97DE-FED31F216FDA}" dt="2024-12-03T03:44:20.032" v="864" actId="164"/>
          <ac:grpSpMkLst>
            <pc:docMk/>
            <pc:sldMk cId="2654949521" sldId="284"/>
            <ac:grpSpMk id="52" creationId="{9096A78E-6602-98F2-52D7-E5BF4C5BBBDF}"/>
          </ac:grpSpMkLst>
        </pc:grpChg>
        <pc:grpChg chg="add mod">
          <ac:chgData name="Jennifer Koh" userId="f9e5c760-747b-4877-856a-bb6123371f09" providerId="ADAL" clId="{171E6B69-3E29-4E74-97DE-FED31F216FDA}" dt="2024-11-29T00:16:36.452" v="129"/>
          <ac:grpSpMkLst>
            <pc:docMk/>
            <pc:sldMk cId="2654949521" sldId="284"/>
            <ac:grpSpMk id="53" creationId="{A12912DC-F328-A259-B926-A20FFD7AAE31}"/>
          </ac:grpSpMkLst>
        </pc:grpChg>
        <pc:grpChg chg="add del mod">
          <ac:chgData name="Jennifer Koh" userId="f9e5c760-747b-4877-856a-bb6123371f09" providerId="ADAL" clId="{171E6B69-3E29-4E74-97DE-FED31F216FDA}" dt="2024-12-03T04:24:05.800" v="870" actId="478"/>
          <ac:grpSpMkLst>
            <pc:docMk/>
            <pc:sldMk cId="2654949521" sldId="284"/>
            <ac:grpSpMk id="55" creationId="{250C0214-0DDA-7502-7AE4-D0E713A11709}"/>
          </ac:grpSpMkLst>
        </pc:grpChg>
        <pc:grpChg chg="add mod">
          <ac:chgData name="Jennifer Koh" userId="f9e5c760-747b-4877-856a-bb6123371f09" providerId="ADAL" clId="{171E6B69-3E29-4E74-97DE-FED31F216FDA}" dt="2024-11-29T00:16:36.452" v="129"/>
          <ac:grpSpMkLst>
            <pc:docMk/>
            <pc:sldMk cId="2654949521" sldId="284"/>
            <ac:grpSpMk id="56" creationId="{99E63513-619E-540D-0587-B1641263436C}"/>
          </ac:grpSpMkLst>
        </pc:grpChg>
        <pc:grpChg chg="add mod topLvl">
          <ac:chgData name="Jennifer Koh" userId="f9e5c760-747b-4877-856a-bb6123371f09" providerId="ADAL" clId="{171E6B69-3E29-4E74-97DE-FED31F216FDA}" dt="2024-12-03T03:44:20.032" v="864" actId="164"/>
          <ac:grpSpMkLst>
            <pc:docMk/>
            <pc:sldMk cId="2654949521" sldId="284"/>
            <ac:grpSpMk id="59" creationId="{9634E1C8-7A91-2F6F-A397-3BE89194F68D}"/>
          </ac:grpSpMkLst>
        </pc:grpChg>
        <pc:grpChg chg="add mod topLvl">
          <ac:chgData name="Jennifer Koh" userId="f9e5c760-747b-4877-856a-bb6123371f09" providerId="ADAL" clId="{171E6B69-3E29-4E74-97DE-FED31F216FDA}" dt="2024-12-03T03:44:20.032" v="864" actId="164"/>
          <ac:grpSpMkLst>
            <pc:docMk/>
            <pc:sldMk cId="2654949521" sldId="284"/>
            <ac:grpSpMk id="62" creationId="{B8A6CA3A-B213-D20E-66AB-FC3BD39DAD31}"/>
          </ac:grpSpMkLst>
        </pc:grpChg>
        <pc:grpChg chg="add mod topLvl">
          <ac:chgData name="Jennifer Koh" userId="f9e5c760-747b-4877-856a-bb6123371f09" providerId="ADAL" clId="{171E6B69-3E29-4E74-97DE-FED31F216FDA}" dt="2024-12-03T03:44:20.032" v="864" actId="164"/>
          <ac:grpSpMkLst>
            <pc:docMk/>
            <pc:sldMk cId="2654949521" sldId="284"/>
            <ac:grpSpMk id="65" creationId="{C9C02B0A-06F6-FA9B-1E29-0DE3076739B9}"/>
          </ac:grpSpMkLst>
        </pc:grpChg>
        <pc:grpChg chg="add del mod topLvl">
          <ac:chgData name="Jennifer Koh" userId="f9e5c760-747b-4877-856a-bb6123371f09" providerId="ADAL" clId="{171E6B69-3E29-4E74-97DE-FED31F216FDA}" dt="2024-12-03T03:29:33.181" v="769" actId="478"/>
          <ac:grpSpMkLst>
            <pc:docMk/>
            <pc:sldMk cId="2654949521" sldId="284"/>
            <ac:grpSpMk id="68" creationId="{5448A028-6BC4-A25A-12FA-93A21F4537BE}"/>
          </ac:grpSpMkLst>
        </pc:grpChg>
        <pc:grpChg chg="add del mod topLvl">
          <ac:chgData name="Jennifer Koh" userId="f9e5c760-747b-4877-856a-bb6123371f09" providerId="ADAL" clId="{171E6B69-3E29-4E74-97DE-FED31F216FDA}" dt="2024-12-03T03:29:33.181" v="769" actId="478"/>
          <ac:grpSpMkLst>
            <pc:docMk/>
            <pc:sldMk cId="2654949521" sldId="284"/>
            <ac:grpSpMk id="71" creationId="{CAA862DA-AD43-CB33-4523-B8DCB5358A1F}"/>
          </ac:grpSpMkLst>
        </pc:grpChg>
        <pc:grpChg chg="add del mod topLvl">
          <ac:chgData name="Jennifer Koh" userId="f9e5c760-747b-4877-856a-bb6123371f09" providerId="ADAL" clId="{171E6B69-3E29-4E74-97DE-FED31F216FDA}" dt="2024-12-03T03:29:33.181" v="769" actId="478"/>
          <ac:grpSpMkLst>
            <pc:docMk/>
            <pc:sldMk cId="2654949521" sldId="284"/>
            <ac:grpSpMk id="74" creationId="{A90D3D4C-6F72-6B39-4542-4453038D16FC}"/>
          </ac:grpSpMkLst>
        </pc:grpChg>
        <pc:picChg chg="del mod topLvl">
          <ac:chgData name="Jennifer Koh" userId="f9e5c760-747b-4877-856a-bb6123371f09" providerId="ADAL" clId="{171E6B69-3E29-4E74-97DE-FED31F216FDA}" dt="2024-12-03T04:24:01.224" v="869" actId="478"/>
          <ac:picMkLst>
            <pc:docMk/>
            <pc:sldMk cId="2654949521" sldId="284"/>
            <ac:picMk id="8" creationId="{71099B9E-3D99-48D0-E952-353B4D1D3F9A}"/>
          </ac:picMkLst>
        </pc:picChg>
        <pc:picChg chg="add mod modCrop">
          <ac:chgData name="Jennifer Koh" userId="f9e5c760-747b-4877-856a-bb6123371f09" providerId="ADAL" clId="{171E6B69-3E29-4E74-97DE-FED31F216FDA}" dt="2024-12-03T04:30:48.688" v="888" actId="12789"/>
          <ac:picMkLst>
            <pc:docMk/>
            <pc:sldMk cId="2654949521" sldId="284"/>
            <ac:picMk id="57" creationId="{482FEB16-E586-6ADA-B4B3-3BB4D017B49C}"/>
          </ac:picMkLst>
        </pc:picChg>
        <pc:cxnChg chg="mod">
          <ac:chgData name="Jennifer Koh" userId="f9e5c760-747b-4877-856a-bb6123371f09" providerId="ADAL" clId="{171E6B69-3E29-4E74-97DE-FED31F216FDA}" dt="2024-11-29T00:14:14.178" v="98"/>
          <ac:cxnSpMkLst>
            <pc:docMk/>
            <pc:sldMk cId="2654949521" sldId="284"/>
            <ac:cxnSpMk id="5" creationId="{5353F1D8-3BAA-37D2-1A8D-148BB48362B7}"/>
          </ac:cxnSpMkLst>
        </pc:cxnChg>
        <pc:cxnChg chg="del mod topLvl">
          <ac:chgData name="Jennifer Koh" userId="f9e5c760-747b-4877-856a-bb6123371f09" providerId="ADAL" clId="{171E6B69-3E29-4E74-97DE-FED31F216FDA}" dt="2024-12-03T03:40:25.258" v="823" actId="478"/>
          <ac:cxnSpMkLst>
            <pc:docMk/>
            <pc:sldMk cId="2654949521" sldId="284"/>
            <ac:cxnSpMk id="6" creationId="{0EFC13AE-08CC-48DE-CAC6-C2DD42305672}"/>
          </ac:cxnSpMkLst>
        </pc:cxnChg>
        <pc:cxnChg chg="add del mod">
          <ac:chgData name="Jennifer Koh" userId="f9e5c760-747b-4877-856a-bb6123371f09" providerId="ADAL" clId="{171E6B69-3E29-4E74-97DE-FED31F216FDA}" dt="2024-12-03T03:31:58.389" v="778" actId="478"/>
          <ac:cxnSpMkLst>
            <pc:docMk/>
            <pc:sldMk cId="2654949521" sldId="284"/>
            <ac:cxnSpMk id="11" creationId="{2DAF2A89-1355-069B-0E59-BF52A3C61AF4}"/>
          </ac:cxnSpMkLst>
        </pc:cxnChg>
        <pc:cxnChg chg="mod">
          <ac:chgData name="Jennifer Koh" userId="f9e5c760-747b-4877-856a-bb6123371f09" providerId="ADAL" clId="{171E6B69-3E29-4E74-97DE-FED31F216FDA}" dt="2024-11-29T00:14:14.178" v="98"/>
          <ac:cxnSpMkLst>
            <pc:docMk/>
            <pc:sldMk cId="2654949521" sldId="284"/>
            <ac:cxnSpMk id="13" creationId="{44CFF29E-D8E0-13B3-7264-DDBCB2768A8B}"/>
          </ac:cxnSpMkLst>
        </pc:cxnChg>
        <pc:cxnChg chg="mod">
          <ac:chgData name="Jennifer Koh" userId="f9e5c760-747b-4877-856a-bb6123371f09" providerId="ADAL" clId="{171E6B69-3E29-4E74-97DE-FED31F216FDA}" dt="2024-11-29T00:14:14.178" v="98"/>
          <ac:cxnSpMkLst>
            <pc:docMk/>
            <pc:sldMk cId="2654949521" sldId="284"/>
            <ac:cxnSpMk id="16" creationId="{CEDEF4D4-05BA-6A55-EA9F-FA6C6D9568F6}"/>
          </ac:cxnSpMkLst>
        </pc:cxnChg>
        <pc:cxnChg chg="del mod topLvl">
          <ac:chgData name="Jennifer Koh" userId="f9e5c760-747b-4877-856a-bb6123371f09" providerId="ADAL" clId="{171E6B69-3E29-4E74-97DE-FED31F216FDA}" dt="2024-12-03T03:42:02.125" v="841" actId="478"/>
          <ac:cxnSpMkLst>
            <pc:docMk/>
            <pc:sldMk cId="2654949521" sldId="284"/>
            <ac:cxnSpMk id="18" creationId="{1BB04C2B-71B6-8ADF-EACA-068C8931DAFC}"/>
          </ac:cxnSpMkLst>
        </pc:cxnChg>
        <pc:cxnChg chg="mod">
          <ac:chgData name="Jennifer Koh" userId="f9e5c760-747b-4877-856a-bb6123371f09" providerId="ADAL" clId="{171E6B69-3E29-4E74-97DE-FED31F216FDA}" dt="2024-11-29T00:14:14.178" v="98"/>
          <ac:cxnSpMkLst>
            <pc:docMk/>
            <pc:sldMk cId="2654949521" sldId="284"/>
            <ac:cxnSpMk id="19" creationId="{9B389DA0-1101-AD95-ABB2-853C743CA019}"/>
          </ac:cxnSpMkLst>
        </pc:cxnChg>
        <pc:cxnChg chg="del mod topLvl">
          <ac:chgData name="Jennifer Koh" userId="f9e5c760-747b-4877-856a-bb6123371f09" providerId="ADAL" clId="{171E6B69-3E29-4E74-97DE-FED31F216FDA}" dt="2024-12-03T03:42:04.716" v="843" actId="478"/>
          <ac:cxnSpMkLst>
            <pc:docMk/>
            <pc:sldMk cId="2654949521" sldId="284"/>
            <ac:cxnSpMk id="21" creationId="{2CA77E91-75DC-C093-B2CF-83CA42F23791}"/>
          </ac:cxnSpMkLst>
        </pc:cxnChg>
        <pc:cxnChg chg="mod">
          <ac:chgData name="Jennifer Koh" userId="f9e5c760-747b-4877-856a-bb6123371f09" providerId="ADAL" clId="{171E6B69-3E29-4E74-97DE-FED31F216FDA}" dt="2024-11-29T00:14:14.178" v="98"/>
          <ac:cxnSpMkLst>
            <pc:docMk/>
            <pc:sldMk cId="2654949521" sldId="284"/>
            <ac:cxnSpMk id="22" creationId="{48474403-DF24-490C-38D9-9CBD54F06E7B}"/>
          </ac:cxnSpMkLst>
        </pc:cxnChg>
        <pc:cxnChg chg="mod">
          <ac:chgData name="Jennifer Koh" userId="f9e5c760-747b-4877-856a-bb6123371f09" providerId="ADAL" clId="{171E6B69-3E29-4E74-97DE-FED31F216FDA}" dt="2024-12-03T03:40:12.741" v="815" actId="165"/>
          <ac:cxnSpMkLst>
            <pc:docMk/>
            <pc:sldMk cId="2654949521" sldId="284"/>
            <ac:cxnSpMk id="24" creationId="{A360C188-371F-A9C5-4F6B-DF6700397E28}"/>
          </ac:cxnSpMkLst>
        </pc:cxnChg>
        <pc:cxnChg chg="mod">
          <ac:chgData name="Jennifer Koh" userId="f9e5c760-747b-4877-856a-bb6123371f09" providerId="ADAL" clId="{171E6B69-3E29-4E74-97DE-FED31F216FDA}" dt="2024-11-29T00:14:14.178" v="98"/>
          <ac:cxnSpMkLst>
            <pc:docMk/>
            <pc:sldMk cId="2654949521" sldId="284"/>
            <ac:cxnSpMk id="25" creationId="{6DCF5F6E-6208-5DFD-806E-D8DD03A2E0BC}"/>
          </ac:cxnSpMkLst>
        </pc:cxnChg>
        <pc:cxnChg chg="mod">
          <ac:chgData name="Jennifer Koh" userId="f9e5c760-747b-4877-856a-bb6123371f09" providerId="ADAL" clId="{171E6B69-3E29-4E74-97DE-FED31F216FDA}" dt="2024-11-29T00:14:14.178" v="98"/>
          <ac:cxnSpMkLst>
            <pc:docMk/>
            <pc:sldMk cId="2654949521" sldId="284"/>
            <ac:cxnSpMk id="28" creationId="{E32D69C3-6893-7A58-4C72-0D58D31F8EC7}"/>
          </ac:cxnSpMkLst>
        </pc:cxnChg>
        <pc:cxnChg chg="mod">
          <ac:chgData name="Jennifer Koh" userId="f9e5c760-747b-4877-856a-bb6123371f09" providerId="ADAL" clId="{171E6B69-3E29-4E74-97DE-FED31F216FDA}" dt="2024-12-03T03:40:28.810" v="824"/>
          <ac:cxnSpMkLst>
            <pc:docMk/>
            <pc:sldMk cId="2654949521" sldId="284"/>
            <ac:cxnSpMk id="30" creationId="{CB439C60-9D91-1E20-4DC1-209D37CF5757}"/>
          </ac:cxnSpMkLst>
        </pc:cxnChg>
        <pc:cxnChg chg="mod">
          <ac:chgData name="Jennifer Koh" userId="f9e5c760-747b-4877-856a-bb6123371f09" providerId="ADAL" clId="{171E6B69-3E29-4E74-97DE-FED31F216FDA}" dt="2024-11-29T00:14:14.178" v="98"/>
          <ac:cxnSpMkLst>
            <pc:docMk/>
            <pc:sldMk cId="2654949521" sldId="284"/>
            <ac:cxnSpMk id="31" creationId="{DAD04DA5-586B-99FC-6545-CAAF7AA4DD32}"/>
          </ac:cxnSpMkLst>
        </pc:cxnChg>
        <pc:cxnChg chg="mod">
          <ac:chgData name="Jennifer Koh" userId="f9e5c760-747b-4877-856a-bb6123371f09" providerId="ADAL" clId="{171E6B69-3E29-4E74-97DE-FED31F216FDA}" dt="2024-12-03T03:40:39.390" v="826"/>
          <ac:cxnSpMkLst>
            <pc:docMk/>
            <pc:sldMk cId="2654949521" sldId="284"/>
            <ac:cxnSpMk id="33" creationId="{904A18AB-32A9-C96A-B099-BBF5412663DF}"/>
          </ac:cxnSpMkLst>
        </pc:cxnChg>
        <pc:cxnChg chg="mod">
          <ac:chgData name="Jennifer Koh" userId="f9e5c760-747b-4877-856a-bb6123371f09" providerId="ADAL" clId="{171E6B69-3E29-4E74-97DE-FED31F216FDA}" dt="2024-11-29T00:14:14.178" v="98"/>
          <ac:cxnSpMkLst>
            <pc:docMk/>
            <pc:sldMk cId="2654949521" sldId="284"/>
            <ac:cxnSpMk id="34" creationId="{715F8744-779A-8F47-ECF8-6D050886DAF2}"/>
          </ac:cxnSpMkLst>
        </pc:cxnChg>
        <pc:cxnChg chg="del mod topLvl">
          <ac:chgData name="Jennifer Koh" userId="f9e5c760-747b-4877-856a-bb6123371f09" providerId="ADAL" clId="{171E6B69-3E29-4E74-97DE-FED31F216FDA}" dt="2024-12-03T03:40:19.960" v="819" actId="478"/>
          <ac:cxnSpMkLst>
            <pc:docMk/>
            <pc:sldMk cId="2654949521" sldId="284"/>
            <ac:cxnSpMk id="37" creationId="{A49455EC-FDA0-DDB1-4844-D8774B3DAA15}"/>
          </ac:cxnSpMkLst>
        </pc:cxnChg>
        <pc:cxnChg chg="del mod topLvl">
          <ac:chgData name="Jennifer Koh" userId="f9e5c760-747b-4877-856a-bb6123371f09" providerId="ADAL" clId="{171E6B69-3E29-4E74-97DE-FED31F216FDA}" dt="2024-12-03T03:40:17.066" v="817" actId="478"/>
          <ac:cxnSpMkLst>
            <pc:docMk/>
            <pc:sldMk cId="2654949521" sldId="284"/>
            <ac:cxnSpMk id="40" creationId="{140D47BB-8BFB-BE14-FF17-DB642F312708}"/>
          </ac:cxnSpMkLst>
        </pc:cxnChg>
        <pc:cxnChg chg="mod">
          <ac:chgData name="Jennifer Koh" userId="f9e5c760-747b-4877-856a-bb6123371f09" providerId="ADAL" clId="{171E6B69-3E29-4E74-97DE-FED31F216FDA}" dt="2024-12-03T03:41:14.302" v="835"/>
          <ac:cxnSpMkLst>
            <pc:docMk/>
            <pc:sldMk cId="2654949521" sldId="284"/>
            <ac:cxnSpMk id="42" creationId="{6295FF25-010B-1746-5883-63A6CD23C4E5}"/>
          </ac:cxnSpMkLst>
        </pc:cxnChg>
        <pc:cxnChg chg="mod">
          <ac:chgData name="Jennifer Koh" userId="f9e5c760-747b-4877-856a-bb6123371f09" providerId="ADAL" clId="{171E6B69-3E29-4E74-97DE-FED31F216FDA}" dt="2024-11-29T00:16:30.609" v="126"/>
          <ac:cxnSpMkLst>
            <pc:docMk/>
            <pc:sldMk cId="2654949521" sldId="284"/>
            <ac:cxnSpMk id="43" creationId="{F4738490-D3C8-C6A9-97B4-06F828F47431}"/>
          </ac:cxnSpMkLst>
        </pc:cxnChg>
        <pc:cxnChg chg="mod">
          <ac:chgData name="Jennifer Koh" userId="f9e5c760-747b-4877-856a-bb6123371f09" providerId="ADAL" clId="{171E6B69-3E29-4E74-97DE-FED31F216FDA}" dt="2024-12-03T03:42:10.170" v="845"/>
          <ac:cxnSpMkLst>
            <pc:docMk/>
            <pc:sldMk cId="2654949521" sldId="284"/>
            <ac:cxnSpMk id="45" creationId="{B4BBBA9B-2E34-4A50-AFEE-44D87ABFEDDD}"/>
          </ac:cxnSpMkLst>
        </pc:cxnChg>
        <pc:cxnChg chg="mod">
          <ac:chgData name="Jennifer Koh" userId="f9e5c760-747b-4877-856a-bb6123371f09" providerId="ADAL" clId="{171E6B69-3E29-4E74-97DE-FED31F216FDA}" dt="2024-11-29T00:16:30.609" v="126"/>
          <ac:cxnSpMkLst>
            <pc:docMk/>
            <pc:sldMk cId="2654949521" sldId="284"/>
            <ac:cxnSpMk id="46" creationId="{8F7196D3-7C05-12AF-D02B-996C95AFC6C3}"/>
          </ac:cxnSpMkLst>
        </pc:cxnChg>
        <pc:cxnChg chg="mod">
          <ac:chgData name="Jennifer Koh" userId="f9e5c760-747b-4877-856a-bb6123371f09" providerId="ADAL" clId="{171E6B69-3E29-4E74-97DE-FED31F216FDA}" dt="2024-12-03T03:42:33.084" v="848"/>
          <ac:cxnSpMkLst>
            <pc:docMk/>
            <pc:sldMk cId="2654949521" sldId="284"/>
            <ac:cxnSpMk id="48" creationId="{366E2256-E22E-5DFE-40ED-8C050FED34E5}"/>
          </ac:cxnSpMkLst>
        </pc:cxnChg>
        <pc:cxnChg chg="mod">
          <ac:chgData name="Jennifer Koh" userId="f9e5c760-747b-4877-856a-bb6123371f09" providerId="ADAL" clId="{171E6B69-3E29-4E74-97DE-FED31F216FDA}" dt="2024-11-29T00:16:30.609" v="126"/>
          <ac:cxnSpMkLst>
            <pc:docMk/>
            <pc:sldMk cId="2654949521" sldId="284"/>
            <ac:cxnSpMk id="49" creationId="{14408F2D-D1A2-DFDB-002D-E1652B6E9A99}"/>
          </ac:cxnSpMkLst>
        </pc:cxnChg>
        <pc:cxnChg chg="mod">
          <ac:chgData name="Jennifer Koh" userId="f9e5c760-747b-4877-856a-bb6123371f09" providerId="ADAL" clId="{171E6B69-3E29-4E74-97DE-FED31F216FDA}" dt="2024-12-03T03:43:12.826" v="859"/>
          <ac:cxnSpMkLst>
            <pc:docMk/>
            <pc:sldMk cId="2654949521" sldId="284"/>
            <ac:cxnSpMk id="51" creationId="{C3ADE8CC-2988-2D73-B693-636F0EF56C38}"/>
          </ac:cxnSpMkLst>
        </pc:cxnChg>
        <pc:cxnChg chg="mod">
          <ac:chgData name="Jennifer Koh" userId="f9e5c760-747b-4877-856a-bb6123371f09" providerId="ADAL" clId="{171E6B69-3E29-4E74-97DE-FED31F216FDA}" dt="2024-11-29T00:16:36.452" v="129"/>
          <ac:cxnSpMkLst>
            <pc:docMk/>
            <pc:sldMk cId="2654949521" sldId="284"/>
            <ac:cxnSpMk id="52" creationId="{446D821D-C1A7-04C7-C822-D4F192F3940D}"/>
          </ac:cxnSpMkLst>
        </pc:cxnChg>
        <pc:cxnChg chg="mod">
          <ac:chgData name="Jennifer Koh" userId="f9e5c760-747b-4877-856a-bb6123371f09" providerId="ADAL" clId="{171E6B69-3E29-4E74-97DE-FED31F216FDA}" dt="2024-12-03T03:43:26.960" v="860"/>
          <ac:cxnSpMkLst>
            <pc:docMk/>
            <pc:sldMk cId="2654949521" sldId="284"/>
            <ac:cxnSpMk id="54" creationId="{8C5A51B5-641C-421D-D0E3-4393A50D73EF}"/>
          </ac:cxnSpMkLst>
        </pc:cxnChg>
        <pc:cxnChg chg="mod">
          <ac:chgData name="Jennifer Koh" userId="f9e5c760-747b-4877-856a-bb6123371f09" providerId="ADAL" clId="{171E6B69-3E29-4E74-97DE-FED31F216FDA}" dt="2024-11-29T00:16:36.452" v="129"/>
          <ac:cxnSpMkLst>
            <pc:docMk/>
            <pc:sldMk cId="2654949521" sldId="284"/>
            <ac:cxnSpMk id="55" creationId="{76BE856F-7A83-3256-B5E4-AC97832E0D8B}"/>
          </ac:cxnSpMkLst>
        </pc:cxnChg>
        <pc:cxnChg chg="mod">
          <ac:chgData name="Jennifer Koh" userId="f9e5c760-747b-4877-856a-bb6123371f09" providerId="ADAL" clId="{171E6B69-3E29-4E74-97DE-FED31F216FDA}" dt="2024-11-29T00:16:36.452" v="129"/>
          <ac:cxnSpMkLst>
            <pc:docMk/>
            <pc:sldMk cId="2654949521" sldId="284"/>
            <ac:cxnSpMk id="58" creationId="{604DC519-342A-7E8A-5CAA-88EB400A6CD2}"/>
          </ac:cxnSpMkLst>
        </pc:cxnChg>
        <pc:cxnChg chg="mod">
          <ac:chgData name="Jennifer Koh" userId="f9e5c760-747b-4877-856a-bb6123371f09" providerId="ADAL" clId="{171E6B69-3E29-4E74-97DE-FED31F216FDA}" dt="2024-12-03T03:40:12.741" v="815" actId="165"/>
          <ac:cxnSpMkLst>
            <pc:docMk/>
            <pc:sldMk cId="2654949521" sldId="284"/>
            <ac:cxnSpMk id="61" creationId="{252114D4-4020-CC9B-4259-B6835EC75543}"/>
          </ac:cxnSpMkLst>
        </pc:cxnChg>
        <pc:cxnChg chg="mod">
          <ac:chgData name="Jennifer Koh" userId="f9e5c760-747b-4877-856a-bb6123371f09" providerId="ADAL" clId="{171E6B69-3E29-4E74-97DE-FED31F216FDA}" dt="2024-12-03T03:40:12.741" v="815" actId="165"/>
          <ac:cxnSpMkLst>
            <pc:docMk/>
            <pc:sldMk cId="2654949521" sldId="284"/>
            <ac:cxnSpMk id="64" creationId="{CA89D616-7BC8-CF8D-D3B9-59BFACEA9EA7}"/>
          </ac:cxnSpMkLst>
        </pc:cxnChg>
        <pc:cxnChg chg="mod">
          <ac:chgData name="Jennifer Koh" userId="f9e5c760-747b-4877-856a-bb6123371f09" providerId="ADAL" clId="{171E6B69-3E29-4E74-97DE-FED31F216FDA}" dt="2024-12-03T03:40:12.741" v="815" actId="165"/>
          <ac:cxnSpMkLst>
            <pc:docMk/>
            <pc:sldMk cId="2654949521" sldId="284"/>
            <ac:cxnSpMk id="67" creationId="{A17FE25D-BDEF-3521-0D8D-C8F9BDB7356C}"/>
          </ac:cxnSpMkLst>
        </pc:cxnChg>
        <pc:cxnChg chg="del mod">
          <ac:chgData name="Jennifer Koh" userId="f9e5c760-747b-4877-856a-bb6123371f09" providerId="ADAL" clId="{171E6B69-3E29-4E74-97DE-FED31F216FDA}" dt="2024-12-03T03:29:40.344" v="771" actId="478"/>
          <ac:cxnSpMkLst>
            <pc:docMk/>
            <pc:sldMk cId="2654949521" sldId="284"/>
            <ac:cxnSpMk id="70" creationId="{9AC81AB4-41BD-4EF2-75BE-C23F22E4F6E3}"/>
          </ac:cxnSpMkLst>
        </pc:cxnChg>
        <pc:cxnChg chg="del mod">
          <ac:chgData name="Jennifer Koh" userId="f9e5c760-747b-4877-856a-bb6123371f09" providerId="ADAL" clId="{171E6B69-3E29-4E74-97DE-FED31F216FDA}" dt="2024-12-03T03:29:37.802" v="770" actId="478"/>
          <ac:cxnSpMkLst>
            <pc:docMk/>
            <pc:sldMk cId="2654949521" sldId="284"/>
            <ac:cxnSpMk id="73" creationId="{57B986C1-DC93-A015-51ED-74AC88CDDA8D}"/>
          </ac:cxnSpMkLst>
        </pc:cxnChg>
        <pc:cxnChg chg="del mod">
          <ac:chgData name="Jennifer Koh" userId="f9e5c760-747b-4877-856a-bb6123371f09" providerId="ADAL" clId="{171E6B69-3E29-4E74-97DE-FED31F216FDA}" dt="2024-12-03T03:29:33.181" v="769" actId="478"/>
          <ac:cxnSpMkLst>
            <pc:docMk/>
            <pc:sldMk cId="2654949521" sldId="284"/>
            <ac:cxnSpMk id="76" creationId="{2AF1EBEB-0509-0183-4697-8C5FB40BF7C6}"/>
          </ac:cxnSpMkLst>
        </pc:cxnChg>
      </pc:sldChg>
      <pc:sldChg chg="addSp delSp modSp mod">
        <pc:chgData name="Jennifer Koh" userId="f9e5c760-747b-4877-856a-bb6123371f09" providerId="ADAL" clId="{171E6B69-3E29-4E74-97DE-FED31F216FDA}" dt="2024-12-04T02:31:14.344" v="1246" actId="12789"/>
        <pc:sldMkLst>
          <pc:docMk/>
          <pc:sldMk cId="3335036171" sldId="287"/>
        </pc:sldMkLst>
        <pc:spChg chg="del">
          <ac:chgData name="Jennifer Koh" userId="f9e5c760-747b-4877-856a-bb6123371f09" providerId="ADAL" clId="{171E6B69-3E29-4E74-97DE-FED31F216FDA}" dt="2024-12-04T02:10:17.105" v="1148" actId="478"/>
          <ac:spMkLst>
            <pc:docMk/>
            <pc:sldMk cId="3335036171" sldId="287"/>
            <ac:spMk id="3" creationId="{34A5B693-0C4E-1E39-A43C-AD5D61358235}"/>
          </ac:spMkLst>
        </pc:spChg>
        <pc:spChg chg="add mod">
          <ac:chgData name="Jennifer Koh" userId="f9e5c760-747b-4877-856a-bb6123371f09" providerId="ADAL" clId="{171E6B69-3E29-4E74-97DE-FED31F216FDA}" dt="2024-12-04T02:10:19.984" v="1151" actId="20577"/>
          <ac:spMkLst>
            <pc:docMk/>
            <pc:sldMk cId="3335036171" sldId="287"/>
            <ac:spMk id="4" creationId="{D0BD8AA2-720C-FA26-3B3D-6492FC3523D4}"/>
          </ac:spMkLst>
        </pc:spChg>
        <pc:grpChg chg="add mod">
          <ac:chgData name="Jennifer Koh" userId="f9e5c760-747b-4877-856a-bb6123371f09" providerId="ADAL" clId="{171E6B69-3E29-4E74-97DE-FED31F216FDA}" dt="2024-12-04T02:31:14.344" v="1246" actId="12789"/>
          <ac:grpSpMkLst>
            <pc:docMk/>
            <pc:sldMk cId="3335036171" sldId="287"/>
            <ac:grpSpMk id="9" creationId="{E11B29C3-2C22-FDD4-7D66-8460054BBBF5}"/>
          </ac:grpSpMkLst>
        </pc:grpChg>
        <pc:picChg chg="del">
          <ac:chgData name="Jennifer Koh" userId="f9e5c760-747b-4877-856a-bb6123371f09" providerId="ADAL" clId="{171E6B69-3E29-4E74-97DE-FED31F216FDA}" dt="2024-12-04T02:26:46.847" v="1218" actId="478"/>
          <ac:picMkLst>
            <pc:docMk/>
            <pc:sldMk cId="3335036171" sldId="287"/>
            <ac:picMk id="2" creationId="{CDE85236-55A0-D07A-9947-2FBC1DD4FEB5}"/>
          </ac:picMkLst>
        </pc:picChg>
        <pc:picChg chg="add mod modCrop">
          <ac:chgData name="Jennifer Koh" userId="f9e5c760-747b-4877-856a-bb6123371f09" providerId="ADAL" clId="{171E6B69-3E29-4E74-97DE-FED31F216FDA}" dt="2024-12-04T02:31:05.761" v="1244" actId="164"/>
          <ac:picMkLst>
            <pc:docMk/>
            <pc:sldMk cId="3335036171" sldId="287"/>
            <ac:picMk id="6" creationId="{4A2209DF-E91F-037D-DA26-72A50F100392}"/>
          </ac:picMkLst>
        </pc:picChg>
        <pc:picChg chg="add mod modCrop">
          <ac:chgData name="Jennifer Koh" userId="f9e5c760-747b-4877-856a-bb6123371f09" providerId="ADAL" clId="{171E6B69-3E29-4E74-97DE-FED31F216FDA}" dt="2024-12-04T02:31:05.761" v="1244" actId="164"/>
          <ac:picMkLst>
            <pc:docMk/>
            <pc:sldMk cId="3335036171" sldId="287"/>
            <ac:picMk id="8" creationId="{1E859E73-83B9-F985-63D3-851A26253E2A}"/>
          </ac:picMkLst>
        </pc:picChg>
      </pc:sldChg>
      <pc:sldChg chg="addSp delSp modSp mod modNotesTx">
        <pc:chgData name="Jennifer Koh" userId="f9e5c760-747b-4877-856a-bb6123371f09" providerId="ADAL" clId="{171E6B69-3E29-4E74-97DE-FED31F216FDA}" dt="2024-12-04T02:13:38.398" v="1217" actId="20577"/>
        <pc:sldMkLst>
          <pc:docMk/>
          <pc:sldMk cId="1974422890" sldId="292"/>
        </pc:sldMkLst>
        <pc:spChg chg="add mod">
          <ac:chgData name="Jennifer Koh" userId="f9e5c760-747b-4877-856a-bb6123371f09" providerId="ADAL" clId="{171E6B69-3E29-4E74-97DE-FED31F216FDA}" dt="2024-12-04T02:12:40.106" v="1204" actId="20577"/>
          <ac:spMkLst>
            <pc:docMk/>
            <pc:sldMk cId="1974422890" sldId="292"/>
            <ac:spMk id="2" creationId="{38A23A88-2AAA-7362-6302-28FA0BFA71A6}"/>
          </ac:spMkLst>
        </pc:spChg>
        <pc:spChg chg="del">
          <ac:chgData name="Jennifer Koh" userId="f9e5c760-747b-4877-856a-bb6123371f09" providerId="ADAL" clId="{171E6B69-3E29-4E74-97DE-FED31F216FDA}" dt="2024-12-04T02:12:38.176" v="1201" actId="478"/>
          <ac:spMkLst>
            <pc:docMk/>
            <pc:sldMk cId="1974422890" sldId="292"/>
            <ac:spMk id="17" creationId="{C275DB69-6715-6BF1-E3C3-4BF5F4763053}"/>
          </ac:spMkLst>
        </pc:spChg>
      </pc:sldChg>
      <pc:sldChg chg="addSp delSp modSp mod">
        <pc:chgData name="Jennifer Koh" userId="f9e5c760-747b-4877-856a-bb6123371f09" providerId="ADAL" clId="{171E6B69-3E29-4E74-97DE-FED31F216FDA}" dt="2024-12-04T02:11:06.494" v="1174" actId="20577"/>
        <pc:sldMkLst>
          <pc:docMk/>
          <pc:sldMk cId="3379817359" sldId="294"/>
        </pc:sldMkLst>
        <pc:spChg chg="add mod">
          <ac:chgData name="Jennifer Koh" userId="f9e5c760-747b-4877-856a-bb6123371f09" providerId="ADAL" clId="{171E6B69-3E29-4E74-97DE-FED31F216FDA}" dt="2024-12-04T02:11:06.494" v="1174" actId="20577"/>
          <ac:spMkLst>
            <pc:docMk/>
            <pc:sldMk cId="3379817359" sldId="294"/>
            <ac:spMk id="6" creationId="{13BE5911-D9A5-2D8D-4D5D-9454D5D6B17A}"/>
          </ac:spMkLst>
        </pc:spChg>
        <pc:spChg chg="del mod">
          <ac:chgData name="Jennifer Koh" userId="f9e5c760-747b-4877-856a-bb6123371f09" providerId="ADAL" clId="{171E6B69-3E29-4E74-97DE-FED31F216FDA}" dt="2024-12-04T02:10:59.993" v="1167" actId="478"/>
          <ac:spMkLst>
            <pc:docMk/>
            <pc:sldMk cId="3379817359" sldId="294"/>
            <ac:spMk id="9" creationId="{7CB8618E-2199-3AA8-55B4-591EB7DEFA46}"/>
          </ac:spMkLst>
        </pc:spChg>
      </pc:sldChg>
      <pc:sldChg chg="addSp delSp modSp mod">
        <pc:chgData name="Jennifer Koh" userId="f9e5c760-747b-4877-856a-bb6123371f09" providerId="ADAL" clId="{171E6B69-3E29-4E74-97DE-FED31F216FDA}" dt="2024-12-04T02:10:28.522" v="1157" actId="20577"/>
        <pc:sldMkLst>
          <pc:docMk/>
          <pc:sldMk cId="3937723648" sldId="295"/>
        </pc:sldMkLst>
        <pc:spChg chg="add mod">
          <ac:chgData name="Jennifer Koh" userId="f9e5c760-747b-4877-856a-bb6123371f09" providerId="ADAL" clId="{171E6B69-3E29-4E74-97DE-FED31F216FDA}" dt="2024-12-04T02:10:28.522" v="1157" actId="20577"/>
          <ac:spMkLst>
            <pc:docMk/>
            <pc:sldMk cId="3937723648" sldId="295"/>
            <ac:spMk id="2" creationId="{5FB054BA-130B-41B7-5EA3-72C085B38187}"/>
          </ac:spMkLst>
        </pc:spChg>
        <pc:spChg chg="del">
          <ac:chgData name="Jennifer Koh" userId="f9e5c760-747b-4877-856a-bb6123371f09" providerId="ADAL" clId="{171E6B69-3E29-4E74-97DE-FED31F216FDA}" dt="2024-12-04T02:10:24.416" v="1152" actId="478"/>
          <ac:spMkLst>
            <pc:docMk/>
            <pc:sldMk cId="3937723648" sldId="295"/>
            <ac:spMk id="5" creationId="{30644BF8-9CDC-1B73-18BC-F3044AE9BB66}"/>
          </ac:spMkLst>
        </pc:spChg>
      </pc:sldChg>
      <pc:sldChg chg="addSp delSp modSp mod">
        <pc:chgData name="Jennifer Koh" userId="f9e5c760-747b-4877-856a-bb6123371f09" providerId="ADAL" clId="{171E6B69-3E29-4E74-97DE-FED31F216FDA}" dt="2024-12-04T02:10:37.649" v="1161" actId="20577"/>
        <pc:sldMkLst>
          <pc:docMk/>
          <pc:sldMk cId="2604945875" sldId="297"/>
        </pc:sldMkLst>
        <pc:spChg chg="add mod">
          <ac:chgData name="Jennifer Koh" userId="f9e5c760-747b-4877-856a-bb6123371f09" providerId="ADAL" clId="{171E6B69-3E29-4E74-97DE-FED31F216FDA}" dt="2024-12-04T02:10:37.649" v="1161" actId="20577"/>
          <ac:spMkLst>
            <pc:docMk/>
            <pc:sldMk cId="2604945875" sldId="297"/>
            <ac:spMk id="4" creationId="{453A340C-7D9A-56F0-0DF7-6352FFE1BD0D}"/>
          </ac:spMkLst>
        </pc:spChg>
        <pc:spChg chg="del">
          <ac:chgData name="Jennifer Koh" userId="f9e5c760-747b-4877-856a-bb6123371f09" providerId="ADAL" clId="{171E6B69-3E29-4E74-97DE-FED31F216FDA}" dt="2024-12-04T02:10:34.761" v="1158" actId="478"/>
          <ac:spMkLst>
            <pc:docMk/>
            <pc:sldMk cId="2604945875" sldId="297"/>
            <ac:spMk id="5" creationId="{90BCF09B-CD4E-9B7D-F3A1-0C28F5226AD0}"/>
          </ac:spMkLst>
        </pc:spChg>
        <pc:picChg chg="mod">
          <ac:chgData name="Jennifer Koh" userId="f9e5c760-747b-4877-856a-bb6123371f09" providerId="ADAL" clId="{171E6B69-3E29-4E74-97DE-FED31F216FDA}" dt="2024-12-03T22:42:00.379" v="1090" actId="1038"/>
          <ac:picMkLst>
            <pc:docMk/>
            <pc:sldMk cId="2604945875" sldId="297"/>
            <ac:picMk id="13" creationId="{DEFC7279-5ACC-E7A5-9BEF-3DFD1BE109EA}"/>
          </ac:picMkLst>
        </pc:picChg>
      </pc:sldChg>
      <pc:sldChg chg="addSp delSp modSp add mod ord modNotesTx">
        <pc:chgData name="Jennifer Koh" userId="f9e5c760-747b-4877-856a-bb6123371f09" providerId="ADAL" clId="{171E6B69-3E29-4E74-97DE-FED31F216FDA}" dt="2024-12-04T02:13:14.700" v="1207" actId="20577"/>
        <pc:sldMkLst>
          <pc:docMk/>
          <pc:sldMk cId="876506885" sldId="298"/>
        </pc:sldMkLst>
        <pc:spChg chg="del mod ord">
          <ac:chgData name="Jennifer Koh" userId="f9e5c760-747b-4877-856a-bb6123371f09" providerId="ADAL" clId="{171E6B69-3E29-4E74-97DE-FED31F216FDA}" dt="2024-12-04T02:11:31.628" v="1180" actId="478"/>
          <ac:spMkLst>
            <pc:docMk/>
            <pc:sldMk cId="876506885" sldId="298"/>
            <ac:spMk id="5" creationId="{5C04B1D2-AD27-EF36-8B66-5B57C28EEB61}"/>
          </ac:spMkLst>
        </pc:spChg>
        <pc:spChg chg="mod topLvl">
          <ac:chgData name="Jennifer Koh" userId="f9e5c760-747b-4877-856a-bb6123371f09" providerId="ADAL" clId="{171E6B69-3E29-4E74-97DE-FED31F216FDA}" dt="2024-12-04T02:11:57.552" v="1188" actId="164"/>
          <ac:spMkLst>
            <pc:docMk/>
            <pc:sldMk cId="876506885" sldId="298"/>
            <ac:spMk id="15" creationId="{A686B434-8B60-0426-084A-4631F809AF85}"/>
          </ac:spMkLst>
        </pc:spChg>
        <pc:spChg chg="mod topLvl">
          <ac:chgData name="Jennifer Koh" userId="f9e5c760-747b-4877-856a-bb6123371f09" providerId="ADAL" clId="{171E6B69-3E29-4E74-97DE-FED31F216FDA}" dt="2024-12-04T02:11:57.552" v="1188" actId="164"/>
          <ac:spMkLst>
            <pc:docMk/>
            <pc:sldMk cId="876506885" sldId="298"/>
            <ac:spMk id="16" creationId="{19FA973C-B153-2E64-D0FA-11012CFABB6F}"/>
          </ac:spMkLst>
        </pc:spChg>
        <pc:spChg chg="mod topLvl">
          <ac:chgData name="Jennifer Koh" userId="f9e5c760-747b-4877-856a-bb6123371f09" providerId="ADAL" clId="{171E6B69-3E29-4E74-97DE-FED31F216FDA}" dt="2024-12-04T02:11:57.552" v="1188" actId="164"/>
          <ac:spMkLst>
            <pc:docMk/>
            <pc:sldMk cId="876506885" sldId="298"/>
            <ac:spMk id="17" creationId="{8FEB6126-FAC6-BA77-BBAE-AA025CD63DAA}"/>
          </ac:spMkLst>
        </pc:spChg>
        <pc:spChg chg="add mod">
          <ac:chgData name="Jennifer Koh" userId="f9e5c760-747b-4877-856a-bb6123371f09" providerId="ADAL" clId="{171E6B69-3E29-4E74-97DE-FED31F216FDA}" dt="2024-12-04T02:11:34.502" v="1183" actId="20577"/>
          <ac:spMkLst>
            <pc:docMk/>
            <pc:sldMk cId="876506885" sldId="298"/>
            <ac:spMk id="42" creationId="{4A282469-FAA5-937A-2BDF-0926B2D76ECC}"/>
          </ac:spMkLst>
        </pc:spChg>
        <pc:grpChg chg="del mod topLvl">
          <ac:chgData name="Jennifer Koh" userId="f9e5c760-747b-4877-856a-bb6123371f09" providerId="ADAL" clId="{171E6B69-3E29-4E74-97DE-FED31F216FDA}" dt="2024-12-03T21:49:30.419" v="995" actId="478"/>
          <ac:grpSpMkLst>
            <pc:docMk/>
            <pc:sldMk cId="876506885" sldId="298"/>
            <ac:grpSpMk id="20" creationId="{41C56E58-3ABA-6B15-589F-A268DCC54130}"/>
          </ac:grpSpMkLst>
        </pc:grpChg>
        <pc:grpChg chg="del mod">
          <ac:chgData name="Jennifer Koh" userId="f9e5c760-747b-4877-856a-bb6123371f09" providerId="ADAL" clId="{171E6B69-3E29-4E74-97DE-FED31F216FDA}" dt="2024-12-03T21:44:50.310" v="953" actId="478"/>
          <ac:grpSpMkLst>
            <pc:docMk/>
            <pc:sldMk cId="876506885" sldId="298"/>
            <ac:grpSpMk id="22" creationId="{AB8C4FEB-360A-5336-3B84-F485B228DB49}"/>
          </ac:grpSpMkLst>
        </pc:grpChg>
        <pc:grpChg chg="mod">
          <ac:chgData name="Jennifer Koh" userId="f9e5c760-747b-4877-856a-bb6123371f09" providerId="ADAL" clId="{171E6B69-3E29-4E74-97DE-FED31F216FDA}" dt="2024-12-03T03:09:18.252" v="682" actId="165"/>
          <ac:grpSpMkLst>
            <pc:docMk/>
            <pc:sldMk cId="876506885" sldId="298"/>
            <ac:grpSpMk id="25" creationId="{9DB2097E-D554-BFCB-548C-FEC0FD23B750}"/>
          </ac:grpSpMkLst>
        </pc:grpChg>
        <pc:grpChg chg="add del mod topLvl">
          <ac:chgData name="Jennifer Koh" userId="f9e5c760-747b-4877-856a-bb6123371f09" providerId="ADAL" clId="{171E6B69-3E29-4E74-97DE-FED31F216FDA}" dt="2024-12-04T02:05:43.167" v="1110" actId="478"/>
          <ac:grpSpMkLst>
            <pc:docMk/>
            <pc:sldMk cId="876506885" sldId="298"/>
            <ac:grpSpMk id="26" creationId="{F3C35151-84C9-F241-068E-B3469F1AEBFA}"/>
          </ac:grpSpMkLst>
        </pc:grpChg>
        <pc:grpChg chg="mod topLvl">
          <ac:chgData name="Jennifer Koh" userId="f9e5c760-747b-4877-856a-bb6123371f09" providerId="ADAL" clId="{171E6B69-3E29-4E74-97DE-FED31F216FDA}" dt="2024-12-04T02:11:57.552" v="1188" actId="164"/>
          <ac:grpSpMkLst>
            <pc:docMk/>
            <pc:sldMk cId="876506885" sldId="298"/>
            <ac:grpSpMk id="27" creationId="{04CDBB49-AC0B-A7A5-8A64-EC7CD411AF12}"/>
          </ac:grpSpMkLst>
        </pc:grpChg>
        <pc:grpChg chg="add del mod topLvl">
          <ac:chgData name="Jennifer Koh" userId="f9e5c760-747b-4877-856a-bb6123371f09" providerId="ADAL" clId="{171E6B69-3E29-4E74-97DE-FED31F216FDA}" dt="2024-12-04T02:11:57.552" v="1188" actId="164"/>
          <ac:grpSpMkLst>
            <pc:docMk/>
            <pc:sldMk cId="876506885" sldId="298"/>
            <ac:grpSpMk id="29" creationId="{AF02479A-086F-F5B9-8214-7094B91328FE}"/>
          </ac:grpSpMkLst>
        </pc:grpChg>
        <pc:grpChg chg="del mod topLvl">
          <ac:chgData name="Jennifer Koh" userId="f9e5c760-747b-4877-856a-bb6123371f09" providerId="ADAL" clId="{171E6B69-3E29-4E74-97DE-FED31F216FDA}" dt="2024-12-03T03:09:18.252" v="682" actId="165"/>
          <ac:grpSpMkLst>
            <pc:docMk/>
            <pc:sldMk cId="876506885" sldId="298"/>
            <ac:grpSpMk id="32" creationId="{F9B50C95-B9DE-9BE7-2188-AB7815658361}"/>
          </ac:grpSpMkLst>
        </pc:grpChg>
        <pc:grpChg chg="add mod">
          <ac:chgData name="Jennifer Koh" userId="f9e5c760-747b-4877-856a-bb6123371f09" providerId="ADAL" clId="{171E6B69-3E29-4E74-97DE-FED31F216FDA}" dt="2024-12-04T02:11:57.552" v="1188" actId="164"/>
          <ac:grpSpMkLst>
            <pc:docMk/>
            <pc:sldMk cId="876506885" sldId="298"/>
            <ac:grpSpMk id="35" creationId="{16823DF0-C906-116E-9956-E353F8021C04}"/>
          </ac:grpSpMkLst>
        </pc:grpChg>
        <pc:grpChg chg="del mod topLvl">
          <ac:chgData name="Jennifer Koh" userId="f9e5c760-747b-4877-856a-bb6123371f09" providerId="ADAL" clId="{171E6B69-3E29-4E74-97DE-FED31F216FDA}" dt="2024-12-03T03:10:58.362" v="684" actId="165"/>
          <ac:grpSpMkLst>
            <pc:docMk/>
            <pc:sldMk cId="876506885" sldId="298"/>
            <ac:grpSpMk id="39" creationId="{EFF08E86-766F-BB48-24D8-1F4EA1FB131E}"/>
          </ac:grpSpMkLst>
        </pc:grpChg>
        <pc:grpChg chg="del mod topLvl">
          <ac:chgData name="Jennifer Koh" userId="f9e5c760-747b-4877-856a-bb6123371f09" providerId="ADAL" clId="{171E6B69-3E29-4E74-97DE-FED31F216FDA}" dt="2024-12-03T03:09:39.503" v="683" actId="165"/>
          <ac:grpSpMkLst>
            <pc:docMk/>
            <pc:sldMk cId="876506885" sldId="298"/>
            <ac:grpSpMk id="40" creationId="{51E3BC4E-A5E1-22B2-EECF-589146BF3641}"/>
          </ac:grpSpMkLst>
        </pc:grpChg>
        <pc:grpChg chg="del">
          <ac:chgData name="Jennifer Koh" userId="f9e5c760-747b-4877-856a-bb6123371f09" providerId="ADAL" clId="{171E6B69-3E29-4E74-97DE-FED31F216FDA}" dt="2024-12-02T23:32:49.513" v="681" actId="165"/>
          <ac:grpSpMkLst>
            <pc:docMk/>
            <pc:sldMk cId="876506885" sldId="298"/>
            <ac:grpSpMk id="41" creationId="{7E2D03CB-ADB2-2D9E-EB64-6486A3BA0C51}"/>
          </ac:grpSpMkLst>
        </pc:grpChg>
        <pc:grpChg chg="add mod">
          <ac:chgData name="Jennifer Koh" userId="f9e5c760-747b-4877-856a-bb6123371f09" providerId="ADAL" clId="{171E6B69-3E29-4E74-97DE-FED31F216FDA}" dt="2024-12-04T02:11:57.552" v="1188" actId="164"/>
          <ac:grpSpMkLst>
            <pc:docMk/>
            <pc:sldMk cId="876506885" sldId="298"/>
            <ac:grpSpMk id="43" creationId="{EF4189BE-62C0-52F6-A2C0-CB75D5A24FCB}"/>
          </ac:grpSpMkLst>
        </pc:grpChg>
        <pc:picChg chg="add del mod modCrop">
          <ac:chgData name="Jennifer Koh" userId="f9e5c760-747b-4877-856a-bb6123371f09" providerId="ADAL" clId="{171E6B69-3E29-4E74-97DE-FED31F216FDA}" dt="2024-12-03T03:11:37.350" v="691" actId="21"/>
          <ac:picMkLst>
            <pc:docMk/>
            <pc:sldMk cId="876506885" sldId="298"/>
            <ac:picMk id="3" creationId="{AC53EE67-ED88-3B79-0DDD-4A3F8326BCA3}"/>
          </ac:picMkLst>
        </pc:picChg>
        <pc:picChg chg="mod topLvl">
          <ac:chgData name="Jennifer Koh" userId="f9e5c760-747b-4877-856a-bb6123371f09" providerId="ADAL" clId="{171E6B69-3E29-4E74-97DE-FED31F216FDA}" dt="2024-12-03T03:15:30.562" v="724" actId="165"/>
          <ac:picMkLst>
            <pc:docMk/>
            <pc:sldMk cId="876506885" sldId="298"/>
            <ac:picMk id="4" creationId="{B4183119-95CE-BD6A-7A06-AE5CD34896AE}"/>
          </ac:picMkLst>
        </pc:picChg>
        <pc:picChg chg="del mod">
          <ac:chgData name="Jennifer Koh" userId="f9e5c760-747b-4877-856a-bb6123371f09" providerId="ADAL" clId="{171E6B69-3E29-4E74-97DE-FED31F216FDA}" dt="2024-12-03T21:44:50.310" v="953" actId="478"/>
          <ac:picMkLst>
            <pc:docMk/>
            <pc:sldMk cId="876506885" sldId="298"/>
            <ac:picMk id="6" creationId="{B3A74168-A548-3A8D-B0F7-A82B3BEE3BD0}"/>
          </ac:picMkLst>
        </pc:picChg>
        <pc:picChg chg="mod topLvl">
          <ac:chgData name="Jennifer Koh" userId="f9e5c760-747b-4877-856a-bb6123371f09" providerId="ADAL" clId="{171E6B69-3E29-4E74-97DE-FED31F216FDA}" dt="2024-12-04T02:11:57.552" v="1188" actId="164"/>
          <ac:picMkLst>
            <pc:docMk/>
            <pc:sldMk cId="876506885" sldId="298"/>
            <ac:picMk id="7" creationId="{A07F03A1-F125-42C9-854F-BEFBA0370D06}"/>
          </ac:picMkLst>
        </pc:picChg>
        <pc:picChg chg="mod topLvl">
          <ac:chgData name="Jennifer Koh" userId="f9e5c760-747b-4877-856a-bb6123371f09" providerId="ADAL" clId="{171E6B69-3E29-4E74-97DE-FED31F216FDA}" dt="2024-12-03T03:15:30.562" v="724" actId="165"/>
          <ac:picMkLst>
            <pc:docMk/>
            <pc:sldMk cId="876506885" sldId="298"/>
            <ac:picMk id="8" creationId="{04699CA4-54E6-D560-4901-F49C86EDBFC6}"/>
          </ac:picMkLst>
        </pc:picChg>
        <pc:picChg chg="mod">
          <ac:chgData name="Jennifer Koh" userId="f9e5c760-747b-4877-856a-bb6123371f09" providerId="ADAL" clId="{171E6B69-3E29-4E74-97DE-FED31F216FDA}" dt="2024-12-03T21:45:12.145" v="977" actId="1038"/>
          <ac:picMkLst>
            <pc:docMk/>
            <pc:sldMk cId="876506885" sldId="298"/>
            <ac:picMk id="9" creationId="{7E8EE9A9-EF29-3733-86A7-FA5B074CFB3F}"/>
          </ac:picMkLst>
        </pc:picChg>
        <pc:picChg chg="add del mod topLvl">
          <ac:chgData name="Jennifer Koh" userId="f9e5c760-747b-4877-856a-bb6123371f09" providerId="ADAL" clId="{171E6B69-3E29-4E74-97DE-FED31F216FDA}" dt="2024-12-04T02:05:43.167" v="1110" actId="478"/>
          <ac:picMkLst>
            <pc:docMk/>
            <pc:sldMk cId="876506885" sldId="298"/>
            <ac:picMk id="10" creationId="{3030148B-8636-20A7-052F-327100C3FAF8}"/>
          </ac:picMkLst>
        </pc:picChg>
        <pc:picChg chg="add del mod ord">
          <ac:chgData name="Jennifer Koh" userId="f9e5c760-747b-4877-856a-bb6123371f09" providerId="ADAL" clId="{171E6B69-3E29-4E74-97DE-FED31F216FDA}" dt="2024-12-03T03:15:34.602" v="727" actId="478"/>
          <ac:picMkLst>
            <pc:docMk/>
            <pc:sldMk cId="876506885" sldId="298"/>
            <ac:picMk id="11" creationId="{9FEBC99D-625E-1D8E-D77D-0FBFC29D7DEE}"/>
          </ac:picMkLst>
        </pc:picChg>
        <pc:picChg chg="del mod topLvl">
          <ac:chgData name="Jennifer Koh" userId="f9e5c760-747b-4877-856a-bb6123371f09" providerId="ADAL" clId="{171E6B69-3E29-4E74-97DE-FED31F216FDA}" dt="2024-12-03T21:49:30.419" v="995" actId="478"/>
          <ac:picMkLst>
            <pc:docMk/>
            <pc:sldMk cId="876506885" sldId="298"/>
            <ac:picMk id="12" creationId="{B47ACE5A-6604-C9E2-3E8C-050A6BB3B0C6}"/>
          </ac:picMkLst>
        </pc:picChg>
        <pc:picChg chg="add mod ord modCrop">
          <ac:chgData name="Jennifer Koh" userId="f9e5c760-747b-4877-856a-bb6123371f09" providerId="ADAL" clId="{171E6B69-3E29-4E74-97DE-FED31F216FDA}" dt="2024-12-04T02:11:57.552" v="1188" actId="164"/>
          <ac:picMkLst>
            <pc:docMk/>
            <pc:sldMk cId="876506885" sldId="298"/>
            <ac:picMk id="14" creationId="{576F9A3B-7062-9951-C58A-8342BE0F7496}"/>
          </ac:picMkLst>
        </pc:picChg>
        <pc:picChg chg="del mod topLvl">
          <ac:chgData name="Jennifer Koh" userId="f9e5c760-747b-4877-856a-bb6123371f09" providerId="ADAL" clId="{171E6B69-3E29-4E74-97DE-FED31F216FDA}" dt="2024-12-03T21:51:22.801" v="1011" actId="478"/>
          <ac:picMkLst>
            <pc:docMk/>
            <pc:sldMk cId="876506885" sldId="298"/>
            <ac:picMk id="19" creationId="{9BB39640-EFAC-E299-15AD-B27643CAF408}"/>
          </ac:picMkLst>
        </pc:picChg>
        <pc:picChg chg="mod">
          <ac:chgData name="Jennifer Koh" userId="f9e5c760-747b-4877-856a-bb6123371f09" providerId="ADAL" clId="{171E6B69-3E29-4E74-97DE-FED31F216FDA}" dt="2024-12-03T21:45:21.878" v="980" actId="1037"/>
          <ac:picMkLst>
            <pc:docMk/>
            <pc:sldMk cId="876506885" sldId="298"/>
            <ac:picMk id="21" creationId="{7A95A1D5-F846-8B18-2E2D-63599688EBB4}"/>
          </ac:picMkLst>
        </pc:picChg>
        <pc:picChg chg="add mod ord modCrop">
          <ac:chgData name="Jennifer Koh" userId="f9e5c760-747b-4877-856a-bb6123371f09" providerId="ADAL" clId="{171E6B69-3E29-4E74-97DE-FED31F216FDA}" dt="2024-12-03T21:52:47.482" v="1016" actId="164"/>
          <ac:picMkLst>
            <pc:docMk/>
            <pc:sldMk cId="876506885" sldId="298"/>
            <ac:picMk id="23" creationId="{653BA792-3517-5B19-C805-F8F8353E2701}"/>
          </ac:picMkLst>
        </pc:picChg>
        <pc:picChg chg="mod">
          <ac:chgData name="Jennifer Koh" userId="f9e5c760-747b-4877-856a-bb6123371f09" providerId="ADAL" clId="{171E6B69-3E29-4E74-97DE-FED31F216FDA}" dt="2024-12-03T21:45:02.602" v="974" actId="1035"/>
          <ac:picMkLst>
            <pc:docMk/>
            <pc:sldMk cId="876506885" sldId="298"/>
            <ac:picMk id="24" creationId="{EF5E2EEA-6C93-329E-0D7A-FED3A44D8780}"/>
          </ac:picMkLst>
        </pc:picChg>
        <pc:picChg chg="add mod ord modCrop">
          <ac:chgData name="Jennifer Koh" userId="f9e5c760-747b-4877-856a-bb6123371f09" providerId="ADAL" clId="{171E6B69-3E29-4E74-97DE-FED31F216FDA}" dt="2024-12-03T21:52:47.482" v="1016" actId="164"/>
          <ac:picMkLst>
            <pc:docMk/>
            <pc:sldMk cId="876506885" sldId="298"/>
            <ac:picMk id="30" creationId="{C4364322-7906-3279-1DB3-BEF002C6A9EC}"/>
          </ac:picMkLst>
        </pc:picChg>
        <pc:picChg chg="mod topLvl">
          <ac:chgData name="Jennifer Koh" userId="f9e5c760-747b-4877-856a-bb6123371f09" providerId="ADAL" clId="{171E6B69-3E29-4E74-97DE-FED31F216FDA}" dt="2024-12-03T21:52:47.482" v="1016" actId="164"/>
          <ac:picMkLst>
            <pc:docMk/>
            <pc:sldMk cId="876506885" sldId="298"/>
            <ac:picMk id="33" creationId="{4DE0EFE5-C404-9E91-D273-DD079F4BBFDF}"/>
          </ac:picMkLst>
        </pc:picChg>
        <pc:picChg chg="add mod ord modCrop">
          <ac:chgData name="Jennifer Koh" userId="f9e5c760-747b-4877-856a-bb6123371f09" providerId="ADAL" clId="{171E6B69-3E29-4E74-97DE-FED31F216FDA}" dt="2024-12-03T21:52:47.482" v="1016" actId="164"/>
          <ac:picMkLst>
            <pc:docMk/>
            <pc:sldMk cId="876506885" sldId="298"/>
            <ac:picMk id="34" creationId="{8DD1AB65-8065-B232-487A-26E7DDC8F700}"/>
          </ac:picMkLst>
        </pc:picChg>
        <pc:picChg chg="add mod ord modCrop">
          <ac:chgData name="Jennifer Koh" userId="f9e5c760-747b-4877-856a-bb6123371f09" providerId="ADAL" clId="{171E6B69-3E29-4E74-97DE-FED31F216FDA}" dt="2024-12-04T02:11:57.552" v="1188" actId="164"/>
          <ac:picMkLst>
            <pc:docMk/>
            <pc:sldMk cId="876506885" sldId="298"/>
            <ac:picMk id="37" creationId="{BAF3A9CF-062D-617E-13C5-D8C396113EC8}"/>
          </ac:picMkLst>
        </pc:picChg>
        <pc:picChg chg="del mod topLvl">
          <ac:chgData name="Jennifer Koh" userId="f9e5c760-747b-4877-856a-bb6123371f09" providerId="ADAL" clId="{171E6B69-3E29-4E74-97DE-FED31F216FDA}" dt="2024-12-03T21:50:33.844" v="1003" actId="478"/>
          <ac:picMkLst>
            <pc:docMk/>
            <pc:sldMk cId="876506885" sldId="298"/>
            <ac:picMk id="38" creationId="{2FB14728-8C87-28AB-744C-06B7B43BB165}"/>
          </ac:picMkLst>
        </pc:picChg>
      </pc:sldChg>
      <pc:sldChg chg="addSp delSp modSp add mod ord modNotesTx">
        <pc:chgData name="Jennifer Koh" userId="f9e5c760-747b-4877-856a-bb6123371f09" providerId="ADAL" clId="{171E6B69-3E29-4E74-97DE-FED31F216FDA}" dt="2024-12-04T02:13:19.950" v="1208" actId="20577"/>
        <pc:sldMkLst>
          <pc:docMk/>
          <pc:sldMk cId="1838733826" sldId="299"/>
        </pc:sldMkLst>
        <pc:spChg chg="del mod">
          <ac:chgData name="Jennifer Koh" userId="f9e5c760-747b-4877-856a-bb6123371f09" providerId="ADAL" clId="{171E6B69-3E29-4E74-97DE-FED31F216FDA}" dt="2024-12-04T02:09:15.332" v="1128" actId="478"/>
          <ac:spMkLst>
            <pc:docMk/>
            <pc:sldMk cId="1838733826" sldId="299"/>
            <ac:spMk id="5" creationId="{AA4EB855-EC69-8A1C-3ACC-DE870B535B8F}"/>
          </ac:spMkLst>
        </pc:spChg>
        <pc:spChg chg="mod topLvl">
          <ac:chgData name="Jennifer Koh" userId="f9e5c760-747b-4877-856a-bb6123371f09" providerId="ADAL" clId="{171E6B69-3E29-4E74-97DE-FED31F216FDA}" dt="2024-12-02T23:32:43.947" v="680" actId="165"/>
          <ac:spMkLst>
            <pc:docMk/>
            <pc:sldMk cId="1838733826" sldId="299"/>
            <ac:spMk id="15" creationId="{F1F913F5-E49D-B9FD-3AB8-1AB61B51C40D}"/>
          </ac:spMkLst>
        </pc:spChg>
        <pc:spChg chg="mod topLvl">
          <ac:chgData name="Jennifer Koh" userId="f9e5c760-747b-4877-856a-bb6123371f09" providerId="ADAL" clId="{171E6B69-3E29-4E74-97DE-FED31F216FDA}" dt="2024-12-02T23:32:43.947" v="680" actId="165"/>
          <ac:spMkLst>
            <pc:docMk/>
            <pc:sldMk cId="1838733826" sldId="299"/>
            <ac:spMk id="16" creationId="{B8170AAF-A1E4-F938-4DD9-DABD2927ED0D}"/>
          </ac:spMkLst>
        </pc:spChg>
        <pc:spChg chg="mod topLvl">
          <ac:chgData name="Jennifer Koh" userId="f9e5c760-747b-4877-856a-bb6123371f09" providerId="ADAL" clId="{171E6B69-3E29-4E74-97DE-FED31F216FDA}" dt="2024-12-02T23:32:43.947" v="680" actId="165"/>
          <ac:spMkLst>
            <pc:docMk/>
            <pc:sldMk cId="1838733826" sldId="299"/>
            <ac:spMk id="17" creationId="{EEDB2A39-D908-0551-F1F8-7D43DDDEA7D4}"/>
          </ac:spMkLst>
        </pc:spChg>
        <pc:spChg chg="add del mod">
          <ac:chgData name="Jennifer Koh" userId="f9e5c760-747b-4877-856a-bb6123371f09" providerId="ADAL" clId="{171E6B69-3E29-4E74-97DE-FED31F216FDA}" dt="2024-12-04T02:11:40.717" v="1184" actId="478"/>
          <ac:spMkLst>
            <pc:docMk/>
            <pc:sldMk cId="1838733826" sldId="299"/>
            <ac:spMk id="29" creationId="{A0292C27-B860-FCE8-9646-DC35870D6152}"/>
          </ac:spMkLst>
        </pc:spChg>
        <pc:spChg chg="add mod">
          <ac:chgData name="Jennifer Koh" userId="f9e5c760-747b-4877-856a-bb6123371f09" providerId="ADAL" clId="{171E6B69-3E29-4E74-97DE-FED31F216FDA}" dt="2024-12-04T02:11:44.352" v="1187" actId="20577"/>
          <ac:spMkLst>
            <pc:docMk/>
            <pc:sldMk cId="1838733826" sldId="299"/>
            <ac:spMk id="31" creationId="{D77C69F7-7855-1AB1-0DD5-293AB55D047E}"/>
          </ac:spMkLst>
        </pc:spChg>
        <pc:grpChg chg="del">
          <ac:chgData name="Jennifer Koh" userId="f9e5c760-747b-4877-856a-bb6123371f09" providerId="ADAL" clId="{171E6B69-3E29-4E74-97DE-FED31F216FDA}" dt="2024-12-02T23:32:43.947" v="680" actId="165"/>
          <ac:grpSpMkLst>
            <pc:docMk/>
            <pc:sldMk cId="1838733826" sldId="299"/>
            <ac:grpSpMk id="2" creationId="{BE7F0193-080D-E65B-0C31-0EAC80B41EF3}"/>
          </ac:grpSpMkLst>
        </pc:grpChg>
        <pc:grpChg chg="mod">
          <ac:chgData name="Jennifer Koh" userId="f9e5c760-747b-4877-856a-bb6123371f09" providerId="ADAL" clId="{171E6B69-3E29-4E74-97DE-FED31F216FDA}" dt="2024-12-02T23:32:43.947" v="680" actId="165"/>
          <ac:grpSpMkLst>
            <pc:docMk/>
            <pc:sldMk cId="1838733826" sldId="299"/>
            <ac:grpSpMk id="3" creationId="{F69EC248-A56E-C4D8-CC98-6BBB47ABAE48}"/>
          </ac:grpSpMkLst>
        </pc:grpChg>
        <pc:grpChg chg="del mod">
          <ac:chgData name="Jennifer Koh" userId="f9e5c760-747b-4877-856a-bb6123371f09" providerId="ADAL" clId="{171E6B69-3E29-4E74-97DE-FED31F216FDA}" dt="2024-12-03T22:00:20.712" v="1084" actId="478"/>
          <ac:grpSpMkLst>
            <pc:docMk/>
            <pc:sldMk cId="1838733826" sldId="299"/>
            <ac:grpSpMk id="22" creationId="{5EE5E97A-CE18-E913-D0C2-5BF5541A0F7B}"/>
          </ac:grpSpMkLst>
        </pc:grpChg>
        <pc:grpChg chg="mod topLvl">
          <ac:chgData name="Jennifer Koh" userId="f9e5c760-747b-4877-856a-bb6123371f09" providerId="ADAL" clId="{171E6B69-3E29-4E74-97DE-FED31F216FDA}" dt="2024-12-03T22:00:53.631" v="1085" actId="164"/>
          <ac:grpSpMkLst>
            <pc:docMk/>
            <pc:sldMk cId="1838733826" sldId="299"/>
            <ac:grpSpMk id="24" creationId="{753E0260-6AE8-F432-6754-594FCEDE9D6E}"/>
          </ac:grpSpMkLst>
        </pc:grpChg>
        <pc:grpChg chg="add mod">
          <ac:chgData name="Jennifer Koh" userId="f9e5c760-747b-4877-856a-bb6123371f09" providerId="ADAL" clId="{171E6B69-3E29-4E74-97DE-FED31F216FDA}" dt="2024-12-03T22:00:53.631" v="1085" actId="164"/>
          <ac:grpSpMkLst>
            <pc:docMk/>
            <pc:sldMk cId="1838733826" sldId="299"/>
            <ac:grpSpMk id="28" creationId="{7F9B5729-EC8D-9E74-0D64-28FC781731DF}"/>
          </ac:grpSpMkLst>
        </pc:grpChg>
        <pc:grpChg chg="mod">
          <ac:chgData name="Jennifer Koh" userId="f9e5c760-747b-4877-856a-bb6123371f09" providerId="ADAL" clId="{171E6B69-3E29-4E74-97DE-FED31F216FDA}" dt="2024-12-02T23:32:43.947" v="680" actId="165"/>
          <ac:grpSpMkLst>
            <pc:docMk/>
            <pc:sldMk cId="1838733826" sldId="299"/>
            <ac:grpSpMk id="42" creationId="{A19CA5D8-1E6C-E19D-39B2-73C56AE31699}"/>
          </ac:grpSpMkLst>
        </pc:grpChg>
        <pc:picChg chg="add mod ord modCrop">
          <ac:chgData name="Jennifer Koh" userId="f9e5c760-747b-4877-856a-bb6123371f09" providerId="ADAL" clId="{171E6B69-3E29-4E74-97DE-FED31F216FDA}" dt="2024-12-03T21:55:17.346" v="1030" actId="167"/>
          <ac:picMkLst>
            <pc:docMk/>
            <pc:sldMk cId="1838733826" sldId="299"/>
            <ac:picMk id="6" creationId="{21594CED-7EA0-55E8-0DCA-D6978950A065}"/>
          </ac:picMkLst>
        </pc:picChg>
        <pc:picChg chg="mod">
          <ac:chgData name="Jennifer Koh" userId="f9e5c760-747b-4877-856a-bb6123371f09" providerId="ADAL" clId="{171E6B69-3E29-4E74-97DE-FED31F216FDA}" dt="2024-12-02T23:32:43.947" v="680" actId="165"/>
          <ac:picMkLst>
            <pc:docMk/>
            <pc:sldMk cId="1838733826" sldId="299"/>
            <ac:picMk id="7" creationId="{5A5BC612-2FEE-672A-D6AD-C65DB6B1E104}"/>
          </ac:picMkLst>
        </pc:picChg>
        <pc:picChg chg="mod">
          <ac:chgData name="Jennifer Koh" userId="f9e5c760-747b-4877-856a-bb6123371f09" providerId="ADAL" clId="{171E6B69-3E29-4E74-97DE-FED31F216FDA}" dt="2024-12-03T21:57:49.066" v="1057" actId="1037"/>
          <ac:picMkLst>
            <pc:docMk/>
            <pc:sldMk cId="1838733826" sldId="299"/>
            <ac:picMk id="8" creationId="{5481FF5D-743D-A976-F22E-652FB83A7FE6}"/>
          </ac:picMkLst>
        </pc:picChg>
        <pc:picChg chg="add mod ord modCrop">
          <ac:chgData name="Jennifer Koh" userId="f9e5c760-747b-4877-856a-bb6123371f09" providerId="ADAL" clId="{171E6B69-3E29-4E74-97DE-FED31F216FDA}" dt="2024-12-03T21:57:19.649" v="1055" actId="167"/>
          <ac:picMkLst>
            <pc:docMk/>
            <pc:sldMk cId="1838733826" sldId="299"/>
            <ac:picMk id="10" creationId="{8BFF8798-A4AC-4E6B-E244-49F1C851A1C9}"/>
          </ac:picMkLst>
        </pc:picChg>
        <pc:picChg chg="del mod">
          <ac:chgData name="Jennifer Koh" userId="f9e5c760-747b-4877-856a-bb6123371f09" providerId="ADAL" clId="{171E6B69-3E29-4E74-97DE-FED31F216FDA}" dt="2024-12-03T21:55:20.213" v="1031" actId="478"/>
          <ac:picMkLst>
            <pc:docMk/>
            <pc:sldMk cId="1838733826" sldId="299"/>
            <ac:picMk id="11" creationId="{423F59D9-3A53-138F-168F-1F4E34FE5A1B}"/>
          </ac:picMkLst>
        </pc:picChg>
        <pc:picChg chg="mod">
          <ac:chgData name="Jennifer Koh" userId="f9e5c760-747b-4877-856a-bb6123371f09" providerId="ADAL" clId="{171E6B69-3E29-4E74-97DE-FED31F216FDA}" dt="2024-12-03T21:55:34.789" v="1042" actId="1038"/>
          <ac:picMkLst>
            <pc:docMk/>
            <pc:sldMk cId="1838733826" sldId="299"/>
            <ac:picMk id="13" creationId="{12E6280F-03CD-B61E-BA21-40FB239B1AC0}"/>
          </ac:picMkLst>
        </pc:picChg>
        <pc:picChg chg="add mod ord modCrop">
          <ac:chgData name="Jennifer Koh" userId="f9e5c760-747b-4877-856a-bb6123371f09" providerId="ADAL" clId="{171E6B69-3E29-4E74-97DE-FED31F216FDA}" dt="2024-12-03T22:00:53.631" v="1085" actId="164"/>
          <ac:picMkLst>
            <pc:docMk/>
            <pc:sldMk cId="1838733826" sldId="299"/>
            <ac:picMk id="14" creationId="{C6FA936F-721B-8C1F-0E33-2C1EC2E4351E}"/>
          </ac:picMkLst>
        </pc:picChg>
        <pc:picChg chg="mod">
          <ac:chgData name="Jennifer Koh" userId="f9e5c760-747b-4877-856a-bb6123371f09" providerId="ADAL" clId="{171E6B69-3E29-4E74-97DE-FED31F216FDA}" dt="2024-12-02T23:32:43.947" v="680" actId="165"/>
          <ac:picMkLst>
            <pc:docMk/>
            <pc:sldMk cId="1838733826" sldId="299"/>
            <ac:picMk id="18" creationId="{B6FCC32D-6174-37D8-56E5-C7DAF0F57079}"/>
          </ac:picMkLst>
        </pc:picChg>
        <pc:picChg chg="del mod">
          <ac:chgData name="Jennifer Koh" userId="f9e5c760-747b-4877-856a-bb6123371f09" providerId="ADAL" clId="{171E6B69-3E29-4E74-97DE-FED31F216FDA}" dt="2024-12-03T21:59:31.901" v="1076" actId="478"/>
          <ac:picMkLst>
            <pc:docMk/>
            <pc:sldMk cId="1838733826" sldId="299"/>
            <ac:picMk id="19" creationId="{DF14AA24-8E56-2EAA-9413-E60B71DDE8B8}"/>
          </ac:picMkLst>
        </pc:picChg>
        <pc:picChg chg="del mod">
          <ac:chgData name="Jennifer Koh" userId="f9e5c760-747b-4877-856a-bb6123371f09" providerId="ADAL" clId="{171E6B69-3E29-4E74-97DE-FED31F216FDA}" dt="2024-12-03T22:00:20.712" v="1084" actId="478"/>
          <ac:picMkLst>
            <pc:docMk/>
            <pc:sldMk cId="1838733826" sldId="299"/>
            <ac:picMk id="21" creationId="{0A1FF5DA-8C58-8E29-0092-C91CCB89AE27}"/>
          </ac:picMkLst>
        </pc:picChg>
        <pc:picChg chg="mod">
          <ac:chgData name="Jennifer Koh" userId="f9e5c760-747b-4877-856a-bb6123371f09" providerId="ADAL" clId="{171E6B69-3E29-4E74-97DE-FED31F216FDA}" dt="2024-12-03T21:55:28.152" v="1037" actId="1037"/>
          <ac:picMkLst>
            <pc:docMk/>
            <pc:sldMk cId="1838733826" sldId="299"/>
            <ac:picMk id="23" creationId="{CD0C0CA0-6F74-896D-02C6-0BEF74B720AF}"/>
          </ac:picMkLst>
        </pc:picChg>
        <pc:picChg chg="add mod ord modCrop">
          <ac:chgData name="Jennifer Koh" userId="f9e5c760-747b-4877-856a-bb6123371f09" providerId="ADAL" clId="{171E6B69-3E29-4E74-97DE-FED31F216FDA}" dt="2024-12-03T22:00:53.631" v="1085" actId="164"/>
          <ac:picMkLst>
            <pc:docMk/>
            <pc:sldMk cId="1838733826" sldId="299"/>
            <ac:picMk id="25" creationId="{1603CC21-0953-756C-2933-87B5A86D0EAA}"/>
          </ac:picMkLst>
        </pc:picChg>
        <pc:picChg chg="add mod ord modCrop">
          <ac:chgData name="Jennifer Koh" userId="f9e5c760-747b-4877-856a-bb6123371f09" providerId="ADAL" clId="{171E6B69-3E29-4E74-97DE-FED31F216FDA}" dt="2024-12-03T22:00:53.631" v="1085" actId="164"/>
          <ac:picMkLst>
            <pc:docMk/>
            <pc:sldMk cId="1838733826" sldId="299"/>
            <ac:picMk id="27" creationId="{87906B06-1FA1-4F40-5DD5-DF3B256BFA80}"/>
          </ac:picMkLst>
        </pc:picChg>
        <pc:picChg chg="del mod">
          <ac:chgData name="Jennifer Koh" userId="f9e5c760-747b-4877-856a-bb6123371f09" providerId="ADAL" clId="{171E6B69-3E29-4E74-97DE-FED31F216FDA}" dt="2024-12-03T21:58:49.420" v="1065" actId="478"/>
          <ac:picMkLst>
            <pc:docMk/>
            <pc:sldMk cId="1838733826" sldId="299"/>
            <ac:picMk id="30" creationId="{D550E379-3F61-1DE3-322C-FB7F952045A5}"/>
          </ac:picMkLst>
        </pc:picChg>
        <pc:picChg chg="mod">
          <ac:chgData name="Jennifer Koh" userId="f9e5c760-747b-4877-856a-bb6123371f09" providerId="ADAL" clId="{171E6B69-3E29-4E74-97DE-FED31F216FDA}" dt="2024-12-02T23:32:43.947" v="680" actId="165"/>
          <ac:picMkLst>
            <pc:docMk/>
            <pc:sldMk cId="1838733826" sldId="299"/>
            <ac:picMk id="33" creationId="{99F7FD2A-C0A7-0AC6-75B9-B535450CD8A4}"/>
          </ac:picMkLst>
        </pc:picChg>
        <pc:picChg chg="del mod">
          <ac:chgData name="Jennifer Koh" userId="f9e5c760-747b-4877-856a-bb6123371f09" providerId="ADAL" clId="{171E6B69-3E29-4E74-97DE-FED31F216FDA}" dt="2024-12-03T21:57:26.892" v="1056" actId="478"/>
          <ac:picMkLst>
            <pc:docMk/>
            <pc:sldMk cId="1838733826" sldId="299"/>
            <ac:picMk id="40" creationId="{834494B8-5477-7DD7-FA70-7AABBF35AE86}"/>
          </ac:picMkLst>
        </pc:picChg>
        <pc:picChg chg="mod">
          <ac:chgData name="Jennifer Koh" userId="f9e5c760-747b-4877-856a-bb6123371f09" providerId="ADAL" clId="{171E6B69-3E29-4E74-97DE-FED31F216FDA}" dt="2024-12-02T23:32:43.947" v="680" actId="165"/>
          <ac:picMkLst>
            <pc:docMk/>
            <pc:sldMk cId="1838733826" sldId="299"/>
            <ac:picMk id="41" creationId="{93C8A674-EAE5-3265-A053-1449030A8A12}"/>
          </ac:picMkLst>
        </pc:picChg>
      </pc:sldChg>
      <pc:sldChg chg="modSp add del mod">
        <pc:chgData name="Jennifer Koh" userId="f9e5c760-747b-4877-856a-bb6123371f09" providerId="ADAL" clId="{171E6B69-3E29-4E74-97DE-FED31F216FDA}" dt="2024-12-02T23:13:46.722" v="511" actId="47"/>
        <pc:sldMkLst>
          <pc:docMk/>
          <pc:sldMk cId="4022254053" sldId="300"/>
        </pc:sldMkLst>
        <pc:spChg chg="mod">
          <ac:chgData name="Jennifer Koh" userId="f9e5c760-747b-4877-856a-bb6123371f09" providerId="ADAL" clId="{171E6B69-3E29-4E74-97DE-FED31F216FDA}" dt="2024-12-02T01:08:03.408" v="159" actId="20577"/>
          <ac:spMkLst>
            <pc:docMk/>
            <pc:sldMk cId="4022254053" sldId="300"/>
            <ac:spMk id="3" creationId="{AA052C16-2C08-9A3A-4413-118ACC1680AC}"/>
          </ac:spMkLst>
        </pc:spChg>
      </pc:sldChg>
      <pc:sldChg chg="addSp delSp modSp add mod ord modNotesTx">
        <pc:chgData name="Jennifer Koh" userId="f9e5c760-747b-4877-856a-bb6123371f09" providerId="ADAL" clId="{171E6B69-3E29-4E74-97DE-FED31F216FDA}" dt="2024-12-04T02:13:25.298" v="1211" actId="20577"/>
        <pc:sldMkLst>
          <pc:docMk/>
          <pc:sldMk cId="2804018941" sldId="301"/>
        </pc:sldMkLst>
        <pc:spChg chg="del mod">
          <ac:chgData name="Jennifer Koh" userId="f9e5c760-747b-4877-856a-bb6123371f09" providerId="ADAL" clId="{171E6B69-3E29-4E74-97DE-FED31F216FDA}" dt="2024-12-04T02:09:24.026" v="1132" actId="478"/>
          <ac:spMkLst>
            <pc:docMk/>
            <pc:sldMk cId="2804018941" sldId="301"/>
            <ac:spMk id="3" creationId="{E97F22C1-CEFF-4655-083E-E19AB93037E6}"/>
          </ac:spMkLst>
        </pc:spChg>
        <pc:spChg chg="mod">
          <ac:chgData name="Jennifer Koh" userId="f9e5c760-747b-4877-856a-bb6123371f09" providerId="ADAL" clId="{171E6B69-3E29-4E74-97DE-FED31F216FDA}" dt="2024-12-03T03:17:40.336" v="745" actId="1035"/>
          <ac:spMkLst>
            <pc:docMk/>
            <pc:sldMk cId="2804018941" sldId="301"/>
            <ac:spMk id="7" creationId="{03B05657-D26F-6C46-BC80-8B4723E95F06}"/>
          </ac:spMkLst>
        </pc:spChg>
        <pc:spChg chg="mod">
          <ac:chgData name="Jennifer Koh" userId="f9e5c760-747b-4877-856a-bb6123371f09" providerId="ADAL" clId="{171E6B69-3E29-4E74-97DE-FED31F216FDA}" dt="2024-12-03T03:17:40.336" v="745" actId="1035"/>
          <ac:spMkLst>
            <pc:docMk/>
            <pc:sldMk cId="2804018941" sldId="301"/>
            <ac:spMk id="9" creationId="{10E1F4E0-AA10-594E-86B4-170C4A3BC4BA}"/>
          </ac:spMkLst>
        </pc:spChg>
        <pc:spChg chg="mod">
          <ac:chgData name="Jennifer Koh" userId="f9e5c760-747b-4877-856a-bb6123371f09" providerId="ADAL" clId="{171E6B69-3E29-4E74-97DE-FED31F216FDA}" dt="2024-12-03T03:17:40.336" v="745" actId="1035"/>
          <ac:spMkLst>
            <pc:docMk/>
            <pc:sldMk cId="2804018941" sldId="301"/>
            <ac:spMk id="13" creationId="{84312D94-7122-20BC-D5AF-0146DE7F870F}"/>
          </ac:spMkLst>
        </pc:spChg>
        <pc:spChg chg="mod">
          <ac:chgData name="Jennifer Koh" userId="f9e5c760-747b-4877-856a-bb6123371f09" providerId="ADAL" clId="{171E6B69-3E29-4E74-97DE-FED31F216FDA}" dt="2024-12-03T03:17:21.978" v="743" actId="1036"/>
          <ac:spMkLst>
            <pc:docMk/>
            <pc:sldMk cId="2804018941" sldId="301"/>
            <ac:spMk id="16" creationId="{127BFF64-2855-EF13-3B31-44A8DA20320A}"/>
          </ac:spMkLst>
        </pc:spChg>
        <pc:spChg chg="mod">
          <ac:chgData name="Jennifer Koh" userId="f9e5c760-747b-4877-856a-bb6123371f09" providerId="ADAL" clId="{171E6B69-3E29-4E74-97DE-FED31F216FDA}" dt="2024-12-03T03:17:21.978" v="743" actId="1036"/>
          <ac:spMkLst>
            <pc:docMk/>
            <pc:sldMk cId="2804018941" sldId="301"/>
            <ac:spMk id="19" creationId="{995A6A0F-8E88-31F3-8C38-8ED9AC05AA74}"/>
          </ac:spMkLst>
        </pc:spChg>
        <pc:spChg chg="mod">
          <ac:chgData name="Jennifer Koh" userId="f9e5c760-747b-4877-856a-bb6123371f09" providerId="ADAL" clId="{171E6B69-3E29-4E74-97DE-FED31F216FDA}" dt="2024-12-03T03:17:21.978" v="743" actId="1036"/>
          <ac:spMkLst>
            <pc:docMk/>
            <pc:sldMk cId="2804018941" sldId="301"/>
            <ac:spMk id="22" creationId="{F62FAAB6-4F65-8F82-E67F-1DA20394F6DE}"/>
          </ac:spMkLst>
        </pc:spChg>
        <pc:spChg chg="add del mod">
          <ac:chgData name="Jennifer Koh" userId="f9e5c760-747b-4877-856a-bb6123371f09" providerId="ADAL" clId="{171E6B69-3E29-4E74-97DE-FED31F216FDA}" dt="2024-12-04T02:12:12.343" v="1189" actId="478"/>
          <ac:spMkLst>
            <pc:docMk/>
            <pc:sldMk cId="2804018941" sldId="301"/>
            <ac:spMk id="27" creationId="{BE6FA2F8-159A-501A-13CC-B63E480B21C4}"/>
          </ac:spMkLst>
        </pc:spChg>
        <pc:spChg chg="add mod">
          <ac:chgData name="Jennifer Koh" userId="f9e5c760-747b-4877-856a-bb6123371f09" providerId="ADAL" clId="{171E6B69-3E29-4E74-97DE-FED31F216FDA}" dt="2024-12-04T02:12:14.847" v="1192" actId="20577"/>
          <ac:spMkLst>
            <pc:docMk/>
            <pc:sldMk cId="2804018941" sldId="301"/>
            <ac:spMk id="28" creationId="{A47900C7-3793-59F4-FB48-D8D1119E9812}"/>
          </ac:spMkLst>
        </pc:spChg>
        <pc:spChg chg="mod">
          <ac:chgData name="Jennifer Koh" userId="f9e5c760-747b-4877-856a-bb6123371f09" providerId="ADAL" clId="{171E6B69-3E29-4E74-97DE-FED31F216FDA}" dt="2024-12-03T03:16:43.992" v="733" actId="1035"/>
          <ac:spMkLst>
            <pc:docMk/>
            <pc:sldMk cId="2804018941" sldId="301"/>
            <ac:spMk id="34" creationId="{0AFFD6AE-5EAC-D966-EF29-AE2DD7D66089}"/>
          </ac:spMkLst>
        </pc:spChg>
        <pc:spChg chg="mod">
          <ac:chgData name="Jennifer Koh" userId="f9e5c760-747b-4877-856a-bb6123371f09" providerId="ADAL" clId="{171E6B69-3E29-4E74-97DE-FED31F216FDA}" dt="2024-12-03T03:16:43.992" v="733" actId="1035"/>
          <ac:spMkLst>
            <pc:docMk/>
            <pc:sldMk cId="2804018941" sldId="301"/>
            <ac:spMk id="37" creationId="{710F0AFE-0BFA-44AE-6004-F2461535AC88}"/>
          </ac:spMkLst>
        </pc:spChg>
        <pc:spChg chg="mod">
          <ac:chgData name="Jennifer Koh" userId="f9e5c760-747b-4877-856a-bb6123371f09" providerId="ADAL" clId="{171E6B69-3E29-4E74-97DE-FED31F216FDA}" dt="2024-12-03T03:16:43.992" v="733" actId="1035"/>
          <ac:spMkLst>
            <pc:docMk/>
            <pc:sldMk cId="2804018941" sldId="301"/>
            <ac:spMk id="40" creationId="{ED2F619F-1609-E81D-CBAC-538094A33599}"/>
          </ac:spMkLst>
        </pc:spChg>
        <pc:grpChg chg="mod topLvl">
          <ac:chgData name="Jennifer Koh" userId="f9e5c760-747b-4877-856a-bb6123371f09" providerId="ADAL" clId="{171E6B69-3E29-4E74-97DE-FED31F216FDA}" dt="2024-12-02T23:13:18.133" v="506" actId="164"/>
          <ac:grpSpMkLst>
            <pc:docMk/>
            <pc:sldMk cId="2804018941" sldId="301"/>
            <ac:grpSpMk id="6" creationId="{20AB2E84-22A3-3DED-AF17-EED23F6DEADB}"/>
          </ac:grpSpMkLst>
        </pc:grpChg>
        <pc:grpChg chg="mod topLvl">
          <ac:chgData name="Jennifer Koh" userId="f9e5c760-747b-4877-856a-bb6123371f09" providerId="ADAL" clId="{171E6B69-3E29-4E74-97DE-FED31F216FDA}" dt="2024-12-02T23:13:18.133" v="506" actId="164"/>
          <ac:grpSpMkLst>
            <pc:docMk/>
            <pc:sldMk cId="2804018941" sldId="301"/>
            <ac:grpSpMk id="11" creationId="{D96697B3-8638-5434-59D7-22BED38EE58A}"/>
          </ac:grpSpMkLst>
        </pc:grpChg>
        <pc:grpChg chg="mod topLvl">
          <ac:chgData name="Jennifer Koh" userId="f9e5c760-747b-4877-856a-bb6123371f09" providerId="ADAL" clId="{171E6B69-3E29-4E74-97DE-FED31F216FDA}" dt="2024-12-02T23:13:18.133" v="506" actId="164"/>
          <ac:grpSpMkLst>
            <pc:docMk/>
            <pc:sldMk cId="2804018941" sldId="301"/>
            <ac:grpSpMk id="12" creationId="{4E70B9C9-0E76-5964-BDC7-C38358539737}"/>
          </ac:grpSpMkLst>
        </pc:grpChg>
        <pc:grpChg chg="mod topLvl">
          <ac:chgData name="Jennifer Koh" userId="f9e5c760-747b-4877-856a-bb6123371f09" providerId="ADAL" clId="{171E6B69-3E29-4E74-97DE-FED31F216FDA}" dt="2024-12-02T23:13:18.133" v="506" actId="164"/>
          <ac:grpSpMkLst>
            <pc:docMk/>
            <pc:sldMk cId="2804018941" sldId="301"/>
            <ac:grpSpMk id="15" creationId="{850798C9-80AD-EAA4-F248-C6C63995DED8}"/>
          </ac:grpSpMkLst>
        </pc:grpChg>
        <pc:grpChg chg="mod topLvl">
          <ac:chgData name="Jennifer Koh" userId="f9e5c760-747b-4877-856a-bb6123371f09" providerId="ADAL" clId="{171E6B69-3E29-4E74-97DE-FED31F216FDA}" dt="2024-12-02T23:13:18.133" v="506" actId="164"/>
          <ac:grpSpMkLst>
            <pc:docMk/>
            <pc:sldMk cId="2804018941" sldId="301"/>
            <ac:grpSpMk id="18" creationId="{C5A213BF-D4DC-75E8-4809-69FA383715E0}"/>
          </ac:grpSpMkLst>
        </pc:grpChg>
        <pc:grpChg chg="mod topLvl">
          <ac:chgData name="Jennifer Koh" userId="f9e5c760-747b-4877-856a-bb6123371f09" providerId="ADAL" clId="{171E6B69-3E29-4E74-97DE-FED31F216FDA}" dt="2024-12-02T23:13:18.133" v="506" actId="164"/>
          <ac:grpSpMkLst>
            <pc:docMk/>
            <pc:sldMk cId="2804018941" sldId="301"/>
            <ac:grpSpMk id="21" creationId="{F103DFE2-BFB3-F441-0A00-E34F566ABA80}"/>
          </ac:grpSpMkLst>
        </pc:grpChg>
        <pc:grpChg chg="add del mod">
          <ac:chgData name="Jennifer Koh" userId="f9e5c760-747b-4877-856a-bb6123371f09" providerId="ADAL" clId="{171E6B69-3E29-4E74-97DE-FED31F216FDA}" dt="2024-12-03T04:24:44" v="875" actId="478"/>
          <ac:grpSpMkLst>
            <pc:docMk/>
            <pc:sldMk cId="2804018941" sldId="301"/>
            <ac:grpSpMk id="24" creationId="{4007ADC7-64C5-50DD-5CAB-B07D82A531F4}"/>
          </ac:grpSpMkLst>
        </pc:grpChg>
        <pc:grpChg chg="mod topLvl">
          <ac:chgData name="Jennifer Koh" userId="f9e5c760-747b-4877-856a-bb6123371f09" providerId="ADAL" clId="{171E6B69-3E29-4E74-97DE-FED31F216FDA}" dt="2024-12-02T23:13:18.133" v="506" actId="164"/>
          <ac:grpSpMkLst>
            <pc:docMk/>
            <pc:sldMk cId="2804018941" sldId="301"/>
            <ac:grpSpMk id="33" creationId="{C9EB5E12-9EC8-2753-9808-0B7697099460}"/>
          </ac:grpSpMkLst>
        </pc:grpChg>
        <pc:grpChg chg="mod topLvl">
          <ac:chgData name="Jennifer Koh" userId="f9e5c760-747b-4877-856a-bb6123371f09" providerId="ADAL" clId="{171E6B69-3E29-4E74-97DE-FED31F216FDA}" dt="2024-12-02T23:13:18.133" v="506" actId="164"/>
          <ac:grpSpMkLst>
            <pc:docMk/>
            <pc:sldMk cId="2804018941" sldId="301"/>
            <ac:grpSpMk id="36" creationId="{4121F4D7-B6C4-B0F6-5D42-A44605BA2744}"/>
          </ac:grpSpMkLst>
        </pc:grpChg>
        <pc:grpChg chg="mod topLvl">
          <ac:chgData name="Jennifer Koh" userId="f9e5c760-747b-4877-856a-bb6123371f09" providerId="ADAL" clId="{171E6B69-3E29-4E74-97DE-FED31F216FDA}" dt="2024-12-02T23:13:18.133" v="506" actId="164"/>
          <ac:grpSpMkLst>
            <pc:docMk/>
            <pc:sldMk cId="2804018941" sldId="301"/>
            <ac:grpSpMk id="39" creationId="{5748AE02-E5F5-3A23-A832-0F5CCA8FF102}"/>
          </ac:grpSpMkLst>
        </pc:grpChg>
        <pc:grpChg chg="del">
          <ac:chgData name="Jennifer Koh" userId="f9e5c760-747b-4877-856a-bb6123371f09" providerId="ADAL" clId="{171E6B69-3E29-4E74-97DE-FED31F216FDA}" dt="2024-12-02T23:09:54.258" v="440" actId="165"/>
          <ac:grpSpMkLst>
            <pc:docMk/>
            <pc:sldMk cId="2804018941" sldId="301"/>
            <ac:grpSpMk id="43" creationId="{4697562E-971C-C9E5-CCCF-65DEEF4EFD61}"/>
          </ac:grpSpMkLst>
        </pc:grpChg>
        <pc:picChg chg="del mod topLvl">
          <ac:chgData name="Jennifer Koh" userId="f9e5c760-747b-4877-856a-bb6123371f09" providerId="ADAL" clId="{171E6B69-3E29-4E74-97DE-FED31F216FDA}" dt="2024-12-02T23:09:59.195" v="441" actId="478"/>
          <ac:picMkLst>
            <pc:docMk/>
            <pc:sldMk cId="2804018941" sldId="301"/>
            <ac:picMk id="4" creationId="{2BCB49BC-CB98-50A4-518C-25711D264ACB}"/>
          </ac:picMkLst>
        </pc:picChg>
        <pc:picChg chg="add mod ord modCrop">
          <ac:chgData name="Jennifer Koh" userId="f9e5c760-747b-4877-856a-bb6123371f09" providerId="ADAL" clId="{171E6B69-3E29-4E74-97DE-FED31F216FDA}" dt="2024-12-02T23:13:18.133" v="506" actId="164"/>
          <ac:picMkLst>
            <pc:docMk/>
            <pc:sldMk cId="2804018941" sldId="301"/>
            <ac:picMk id="5" creationId="{E6E2D59D-63ED-FF4D-C0A9-EF977E4BB3DF}"/>
          </ac:picMkLst>
        </pc:picChg>
        <pc:picChg chg="add mod ord modCrop">
          <ac:chgData name="Jennifer Koh" userId="f9e5c760-747b-4877-856a-bb6123371f09" providerId="ADAL" clId="{171E6B69-3E29-4E74-97DE-FED31F216FDA}" dt="2024-12-03T04:32:15.384" v="898" actId="167"/>
          <ac:picMkLst>
            <pc:docMk/>
            <pc:sldMk cId="2804018941" sldId="301"/>
            <ac:picMk id="26" creationId="{B77D5203-6E37-1FDE-3322-CC6A7AAB2301}"/>
          </ac:picMkLst>
        </pc:picChg>
        <pc:cxnChg chg="mod">
          <ac:chgData name="Jennifer Koh" userId="f9e5c760-747b-4877-856a-bb6123371f09" providerId="ADAL" clId="{171E6B69-3E29-4E74-97DE-FED31F216FDA}" dt="2024-12-02T23:09:54.258" v="440" actId="165"/>
          <ac:cxnSpMkLst>
            <pc:docMk/>
            <pc:sldMk cId="2804018941" sldId="301"/>
            <ac:cxnSpMk id="8" creationId="{A85AAF93-E662-5D57-FEDD-01E71D82B35D}"/>
          </ac:cxnSpMkLst>
        </pc:cxnChg>
        <pc:cxnChg chg="mod">
          <ac:chgData name="Jennifer Koh" userId="f9e5c760-747b-4877-856a-bb6123371f09" providerId="ADAL" clId="{171E6B69-3E29-4E74-97DE-FED31F216FDA}" dt="2024-12-02T23:09:54.258" v="440" actId="165"/>
          <ac:cxnSpMkLst>
            <pc:docMk/>
            <pc:sldMk cId="2804018941" sldId="301"/>
            <ac:cxnSpMk id="10" creationId="{0B10A19E-721D-5788-8207-FED0F8743917}"/>
          </ac:cxnSpMkLst>
        </pc:cxnChg>
        <pc:cxnChg chg="mod">
          <ac:chgData name="Jennifer Koh" userId="f9e5c760-747b-4877-856a-bb6123371f09" providerId="ADAL" clId="{171E6B69-3E29-4E74-97DE-FED31F216FDA}" dt="2024-12-02T23:09:54.258" v="440" actId="165"/>
          <ac:cxnSpMkLst>
            <pc:docMk/>
            <pc:sldMk cId="2804018941" sldId="301"/>
            <ac:cxnSpMk id="14" creationId="{E7CF231F-3BA4-0C5B-AB6D-831692A6EEE7}"/>
          </ac:cxnSpMkLst>
        </pc:cxnChg>
        <pc:cxnChg chg="mod">
          <ac:chgData name="Jennifer Koh" userId="f9e5c760-747b-4877-856a-bb6123371f09" providerId="ADAL" clId="{171E6B69-3E29-4E74-97DE-FED31F216FDA}" dt="2024-12-02T23:09:54.258" v="440" actId="165"/>
          <ac:cxnSpMkLst>
            <pc:docMk/>
            <pc:sldMk cId="2804018941" sldId="301"/>
            <ac:cxnSpMk id="17" creationId="{690E7938-6A4A-AFE4-10C0-49D816C0E789}"/>
          </ac:cxnSpMkLst>
        </pc:cxnChg>
        <pc:cxnChg chg="mod">
          <ac:chgData name="Jennifer Koh" userId="f9e5c760-747b-4877-856a-bb6123371f09" providerId="ADAL" clId="{171E6B69-3E29-4E74-97DE-FED31F216FDA}" dt="2024-12-03T03:17:11.954" v="742" actId="1035"/>
          <ac:cxnSpMkLst>
            <pc:docMk/>
            <pc:sldMk cId="2804018941" sldId="301"/>
            <ac:cxnSpMk id="20" creationId="{60FEB7EC-D0BD-CF5D-C582-68E4F9662069}"/>
          </ac:cxnSpMkLst>
        </pc:cxnChg>
        <pc:cxnChg chg="mod">
          <ac:chgData name="Jennifer Koh" userId="f9e5c760-747b-4877-856a-bb6123371f09" providerId="ADAL" clId="{171E6B69-3E29-4E74-97DE-FED31F216FDA}" dt="2024-12-02T23:09:54.258" v="440" actId="165"/>
          <ac:cxnSpMkLst>
            <pc:docMk/>
            <pc:sldMk cId="2804018941" sldId="301"/>
            <ac:cxnSpMk id="23" creationId="{EEAE48C8-C896-AA72-F1F6-C138FA1B9FED}"/>
          </ac:cxnSpMkLst>
        </pc:cxnChg>
        <pc:cxnChg chg="mod">
          <ac:chgData name="Jennifer Koh" userId="f9e5c760-747b-4877-856a-bb6123371f09" providerId="ADAL" clId="{171E6B69-3E29-4E74-97DE-FED31F216FDA}" dt="2024-12-02T23:09:54.258" v="440" actId="165"/>
          <ac:cxnSpMkLst>
            <pc:docMk/>
            <pc:sldMk cId="2804018941" sldId="301"/>
            <ac:cxnSpMk id="35" creationId="{AB50675C-3A8B-3D19-9F71-D3492F28D80C}"/>
          </ac:cxnSpMkLst>
        </pc:cxnChg>
        <pc:cxnChg chg="mod">
          <ac:chgData name="Jennifer Koh" userId="f9e5c760-747b-4877-856a-bb6123371f09" providerId="ADAL" clId="{171E6B69-3E29-4E74-97DE-FED31F216FDA}" dt="2024-12-02T23:09:54.258" v="440" actId="165"/>
          <ac:cxnSpMkLst>
            <pc:docMk/>
            <pc:sldMk cId="2804018941" sldId="301"/>
            <ac:cxnSpMk id="38" creationId="{E3B295D5-9E85-57E6-D6A7-7179EB3B1300}"/>
          </ac:cxnSpMkLst>
        </pc:cxnChg>
        <pc:cxnChg chg="mod">
          <ac:chgData name="Jennifer Koh" userId="f9e5c760-747b-4877-856a-bb6123371f09" providerId="ADAL" clId="{171E6B69-3E29-4E74-97DE-FED31F216FDA}" dt="2024-12-02T23:09:54.258" v="440" actId="165"/>
          <ac:cxnSpMkLst>
            <pc:docMk/>
            <pc:sldMk cId="2804018941" sldId="301"/>
            <ac:cxnSpMk id="41" creationId="{DDC565A6-2F2F-73CF-8599-3ED1DED0B0F8}"/>
          </ac:cxnSpMkLst>
        </pc:cxnChg>
      </pc:sldChg>
    </pc:docChg>
  </pc:docChgLst>
  <pc:docChgLst>
    <pc:chgData name="Jennifer Koh" userId="f9e5c760-747b-4877-856a-bb6123371f09" providerId="ADAL" clId="{6A0A80BA-F599-47DB-90E7-745ADFED9E8B}"/>
    <pc:docChg chg="undo custSel addSld delSld modSld modSection">
      <pc:chgData name="Jennifer Koh" userId="f9e5c760-747b-4877-856a-bb6123371f09" providerId="ADAL" clId="{6A0A80BA-F599-47DB-90E7-745ADFED9E8B}" dt="2024-09-05T00:21:48.652" v="60" actId="20577"/>
      <pc:docMkLst>
        <pc:docMk/>
      </pc:docMkLst>
      <pc:sldChg chg="modNotesTx">
        <pc:chgData name="Jennifer Koh" userId="f9e5c760-747b-4877-856a-bb6123371f09" providerId="ADAL" clId="{6A0A80BA-F599-47DB-90E7-745ADFED9E8B}" dt="2024-09-04T02:49:54.550" v="52"/>
        <pc:sldMkLst>
          <pc:docMk/>
          <pc:sldMk cId="286440889" sldId="265"/>
        </pc:sldMkLst>
      </pc:sldChg>
      <pc:sldChg chg="del">
        <pc:chgData name="Jennifer Koh" userId="f9e5c760-747b-4877-856a-bb6123371f09" providerId="ADAL" clId="{6A0A80BA-F599-47DB-90E7-745ADFED9E8B}" dt="2024-09-04T02:45:32.512" v="49" actId="47"/>
        <pc:sldMkLst>
          <pc:docMk/>
          <pc:sldMk cId="1656151510" sldId="266"/>
        </pc:sldMkLst>
      </pc:sldChg>
      <pc:sldChg chg="addSp delSp modSp add del mod modNotesTx">
        <pc:chgData name="Jennifer Koh" userId="f9e5c760-747b-4877-856a-bb6123371f09" providerId="ADAL" clId="{6A0A80BA-F599-47DB-90E7-745ADFED9E8B}" dt="2024-09-05T00:21:38.816" v="58" actId="20577"/>
        <pc:sldMkLst>
          <pc:docMk/>
          <pc:sldMk cId="4175903602" sldId="274"/>
        </pc:sldMkLst>
        <pc:spChg chg="mod">
          <ac:chgData name="Jennifer Koh" userId="f9e5c760-747b-4877-856a-bb6123371f09" providerId="ADAL" clId="{6A0A80BA-F599-47DB-90E7-745ADFED9E8B}" dt="2024-09-04T01:49:42.452" v="21" actId="165"/>
          <ac:spMkLst>
            <pc:docMk/>
            <pc:sldMk cId="4175903602" sldId="274"/>
            <ac:spMk id="9" creationId="{5E3552DB-C306-1A31-0CD4-247546581F43}"/>
          </ac:spMkLst>
        </pc:spChg>
        <pc:grpChg chg="add mod">
          <ac:chgData name="Jennifer Koh" userId="f9e5c760-747b-4877-856a-bb6123371f09" providerId="ADAL" clId="{6A0A80BA-F599-47DB-90E7-745ADFED9E8B}" dt="2024-09-04T01:50:53.252" v="35" actId="12789"/>
          <ac:grpSpMkLst>
            <pc:docMk/>
            <pc:sldMk cId="4175903602" sldId="274"/>
            <ac:grpSpMk id="5" creationId="{618AE5A7-401C-DA40-0443-EB836762909D}"/>
          </ac:grpSpMkLst>
        </pc:grpChg>
        <pc:grpChg chg="add del">
          <ac:chgData name="Jennifer Koh" userId="f9e5c760-747b-4877-856a-bb6123371f09" providerId="ADAL" clId="{6A0A80BA-F599-47DB-90E7-745ADFED9E8B}" dt="2024-09-04T01:49:42.452" v="21" actId="165"/>
          <ac:grpSpMkLst>
            <pc:docMk/>
            <pc:sldMk cId="4175903602" sldId="274"/>
            <ac:grpSpMk id="7" creationId="{21DA1ABC-A7C5-9A90-CF68-5810BF5830DB}"/>
          </ac:grpSpMkLst>
        </pc:grpChg>
        <pc:grpChg chg="mod topLvl">
          <ac:chgData name="Jennifer Koh" userId="f9e5c760-747b-4877-856a-bb6123371f09" providerId="ADAL" clId="{6A0A80BA-F599-47DB-90E7-745ADFED9E8B}" dt="2024-09-04T01:50:31.705" v="33" actId="164"/>
          <ac:grpSpMkLst>
            <pc:docMk/>
            <pc:sldMk cId="4175903602" sldId="274"/>
            <ac:grpSpMk id="11" creationId="{C98D4CF6-1E27-0DF5-C11F-35FECA780192}"/>
          </ac:grpSpMkLst>
        </pc:grpChg>
        <pc:picChg chg="add mod ord modCrop">
          <ac:chgData name="Jennifer Koh" userId="f9e5c760-747b-4877-856a-bb6123371f09" providerId="ADAL" clId="{6A0A80BA-F599-47DB-90E7-745ADFED9E8B}" dt="2024-09-04T01:50:31.705" v="33" actId="164"/>
          <ac:picMkLst>
            <pc:docMk/>
            <pc:sldMk cId="4175903602" sldId="274"/>
            <ac:picMk id="4" creationId="{026F90B5-6854-15D3-1050-E7229A57D05C}"/>
          </ac:picMkLst>
        </pc:picChg>
        <pc:picChg chg="del mod topLvl">
          <ac:chgData name="Jennifer Koh" userId="f9e5c760-747b-4877-856a-bb6123371f09" providerId="ADAL" clId="{6A0A80BA-F599-47DB-90E7-745ADFED9E8B}" dt="2024-09-04T01:49:45.106" v="22" actId="478"/>
          <ac:picMkLst>
            <pc:docMk/>
            <pc:sldMk cId="4175903602" sldId="274"/>
            <ac:picMk id="6" creationId="{EA52B5D6-28E5-D3AA-4D34-17D3C6E3CFE5}"/>
          </ac:picMkLst>
        </pc:picChg>
        <pc:cxnChg chg="mod">
          <ac:chgData name="Jennifer Koh" userId="f9e5c760-747b-4877-856a-bb6123371f09" providerId="ADAL" clId="{6A0A80BA-F599-47DB-90E7-745ADFED9E8B}" dt="2024-09-04T01:49:42.452" v="21" actId="165"/>
          <ac:cxnSpMkLst>
            <pc:docMk/>
            <pc:sldMk cId="4175903602" sldId="274"/>
            <ac:cxnSpMk id="10" creationId="{7F18568B-A533-0C42-8316-36788472125F}"/>
          </ac:cxnSpMkLst>
        </pc:cxnChg>
      </pc:sldChg>
      <pc:sldChg chg="modNotesTx">
        <pc:chgData name="Jennifer Koh" userId="f9e5c760-747b-4877-856a-bb6123371f09" providerId="ADAL" clId="{6A0A80BA-F599-47DB-90E7-745ADFED9E8B}" dt="2024-09-04T02:40:06.852" v="42"/>
        <pc:sldMkLst>
          <pc:docMk/>
          <pc:sldMk cId="3674379232" sldId="278"/>
        </pc:sldMkLst>
      </pc:sldChg>
      <pc:sldChg chg="modNotesTx">
        <pc:chgData name="Jennifer Koh" userId="f9e5c760-747b-4877-856a-bb6123371f09" providerId="ADAL" clId="{6A0A80BA-F599-47DB-90E7-745ADFED9E8B}" dt="2024-09-04T02:51:12.415" v="53"/>
        <pc:sldMkLst>
          <pc:docMk/>
          <pc:sldMk cId="1214462485" sldId="283"/>
        </pc:sldMkLst>
      </pc:sldChg>
      <pc:sldChg chg="addSp delSp modSp mod modNotesTx">
        <pc:chgData name="Jennifer Koh" userId="f9e5c760-747b-4877-856a-bb6123371f09" providerId="ADAL" clId="{6A0A80BA-F599-47DB-90E7-745ADFED9E8B}" dt="2024-09-05T00:21:48.652" v="60" actId="20577"/>
        <pc:sldMkLst>
          <pc:docMk/>
          <pc:sldMk cId="2654949521" sldId="284"/>
        </pc:sldMkLst>
        <pc:spChg chg="mod">
          <ac:chgData name="Jennifer Koh" userId="f9e5c760-747b-4877-856a-bb6123371f09" providerId="ADAL" clId="{6A0A80BA-F599-47DB-90E7-745ADFED9E8B}" dt="2024-09-04T01:47:58.391" v="1" actId="165"/>
          <ac:spMkLst>
            <pc:docMk/>
            <pc:sldMk cId="2654949521" sldId="284"/>
            <ac:spMk id="4" creationId="{05965431-C262-98A6-85FA-04FEF33150F7}"/>
          </ac:spMkLst>
        </pc:spChg>
        <pc:grpChg chg="del">
          <ac:chgData name="Jennifer Koh" userId="f9e5c760-747b-4877-856a-bb6123371f09" providerId="ADAL" clId="{6A0A80BA-F599-47DB-90E7-745ADFED9E8B}" dt="2024-09-04T01:47:58.391" v="1" actId="165"/>
          <ac:grpSpMkLst>
            <pc:docMk/>
            <pc:sldMk cId="2654949521" sldId="284"/>
            <ac:grpSpMk id="5" creationId="{56572FF7-C770-C9E8-8F44-DA9D5A6EC220}"/>
          </ac:grpSpMkLst>
        </pc:grpChg>
        <pc:grpChg chg="mod topLvl">
          <ac:chgData name="Jennifer Koh" userId="f9e5c760-747b-4877-856a-bb6123371f09" providerId="ADAL" clId="{6A0A80BA-F599-47DB-90E7-745ADFED9E8B}" dt="2024-09-04T01:49:20.981" v="18" actId="164"/>
          <ac:grpSpMkLst>
            <pc:docMk/>
            <pc:sldMk cId="2654949521" sldId="284"/>
            <ac:grpSpMk id="7" creationId="{64DB76CD-7F89-E96D-CB15-8B66BC4E07EE}"/>
          </ac:grpSpMkLst>
        </pc:grpChg>
        <pc:grpChg chg="add mod">
          <ac:chgData name="Jennifer Koh" userId="f9e5c760-747b-4877-856a-bb6123371f09" providerId="ADAL" clId="{6A0A80BA-F599-47DB-90E7-745ADFED9E8B}" dt="2024-09-04T01:51:22.146" v="41" actId="12788"/>
          <ac:grpSpMkLst>
            <pc:docMk/>
            <pc:sldMk cId="2654949521" sldId="284"/>
            <ac:grpSpMk id="10" creationId="{BCB1DCB0-213D-E95B-1423-91B0A089F1EA}"/>
          </ac:grpSpMkLst>
        </pc:grpChg>
        <pc:picChg chg="del mod topLvl">
          <ac:chgData name="Jennifer Koh" userId="f9e5c760-747b-4877-856a-bb6123371f09" providerId="ADAL" clId="{6A0A80BA-F599-47DB-90E7-745ADFED9E8B}" dt="2024-09-04T01:48:01.950" v="2" actId="478"/>
          <ac:picMkLst>
            <pc:docMk/>
            <pc:sldMk cId="2654949521" sldId="284"/>
            <ac:picMk id="3" creationId="{61841F34-266B-5161-BE1E-0DD60C9FC147}"/>
          </ac:picMkLst>
        </pc:picChg>
        <pc:picChg chg="add mod ord modCrop">
          <ac:chgData name="Jennifer Koh" userId="f9e5c760-747b-4877-856a-bb6123371f09" providerId="ADAL" clId="{6A0A80BA-F599-47DB-90E7-745ADFED9E8B}" dt="2024-09-04T01:49:20.981" v="18" actId="164"/>
          <ac:picMkLst>
            <pc:docMk/>
            <pc:sldMk cId="2654949521" sldId="284"/>
            <ac:picMk id="8" creationId="{71099B9E-3D99-48D0-E952-353B4D1D3F9A}"/>
          </ac:picMkLst>
        </pc:picChg>
        <pc:cxnChg chg="mod">
          <ac:chgData name="Jennifer Koh" userId="f9e5c760-747b-4877-856a-bb6123371f09" providerId="ADAL" clId="{6A0A80BA-F599-47DB-90E7-745ADFED9E8B}" dt="2024-09-04T01:47:58.391" v="1" actId="165"/>
          <ac:cxnSpMkLst>
            <pc:docMk/>
            <pc:sldMk cId="2654949521" sldId="284"/>
            <ac:cxnSpMk id="6" creationId="{0EFC13AE-08CC-48DE-CAC6-C2DD42305672}"/>
          </ac:cxnSpMkLst>
        </pc:cxnChg>
      </pc:sldChg>
      <pc:sldChg chg="modNotesTx">
        <pc:chgData name="Jennifer Koh" userId="f9e5c760-747b-4877-856a-bb6123371f09" providerId="ADAL" clId="{6A0A80BA-F599-47DB-90E7-745ADFED9E8B}" dt="2024-09-04T02:41:03.157" v="43"/>
        <pc:sldMkLst>
          <pc:docMk/>
          <pc:sldMk cId="3335036171" sldId="287"/>
        </pc:sldMkLst>
      </pc:sldChg>
      <pc:sldChg chg="modNotesTx">
        <pc:chgData name="Jennifer Koh" userId="f9e5c760-747b-4877-856a-bb6123371f09" providerId="ADAL" clId="{6A0A80BA-F599-47DB-90E7-745ADFED9E8B}" dt="2024-09-04T02:52:33.690" v="56"/>
        <pc:sldMkLst>
          <pc:docMk/>
          <pc:sldMk cId="1974422890" sldId="292"/>
        </pc:sldMkLst>
      </pc:sldChg>
      <pc:sldChg chg="modNotesTx">
        <pc:chgData name="Jennifer Koh" userId="f9e5c760-747b-4877-856a-bb6123371f09" providerId="ADAL" clId="{6A0A80BA-F599-47DB-90E7-745ADFED9E8B}" dt="2024-09-04T02:48:49.113" v="51"/>
        <pc:sldMkLst>
          <pc:docMk/>
          <pc:sldMk cId="3379817359" sldId="294"/>
        </pc:sldMkLst>
      </pc:sldChg>
      <pc:sldChg chg="modNotesTx">
        <pc:chgData name="Jennifer Koh" userId="f9e5c760-747b-4877-856a-bb6123371f09" providerId="ADAL" clId="{6A0A80BA-F599-47DB-90E7-745ADFED9E8B}" dt="2024-09-04T02:42:17.833" v="45" actId="20577"/>
        <pc:sldMkLst>
          <pc:docMk/>
          <pc:sldMk cId="3937723648" sldId="295"/>
        </pc:sldMkLst>
      </pc:sldChg>
      <pc:sldChg chg="del">
        <pc:chgData name="Jennifer Koh" userId="f9e5c760-747b-4877-856a-bb6123371f09" providerId="ADAL" clId="{6A0A80BA-F599-47DB-90E7-745ADFED9E8B}" dt="2024-09-04T02:45:35.910" v="50" actId="47"/>
        <pc:sldMkLst>
          <pc:docMk/>
          <pc:sldMk cId="2432896475" sldId="296"/>
        </pc:sldMkLst>
      </pc:sldChg>
      <pc:sldChg chg="addSp modSp modNotesTx">
        <pc:chgData name="Jennifer Koh" userId="f9e5c760-747b-4877-856a-bb6123371f09" providerId="ADAL" clId="{6A0A80BA-F599-47DB-90E7-745ADFED9E8B}" dt="2024-09-04T02:43:16.271" v="47" actId="20577"/>
        <pc:sldMkLst>
          <pc:docMk/>
          <pc:sldMk cId="2604945875" sldId="297"/>
        </pc:sldMkLst>
        <pc:spChg chg="mod">
          <ac:chgData name="Jennifer Koh" userId="f9e5c760-747b-4877-856a-bb6123371f09" providerId="ADAL" clId="{6A0A80BA-F599-47DB-90E7-745ADFED9E8B}" dt="2024-09-04T01:32:23.220" v="0" actId="164"/>
          <ac:spMkLst>
            <pc:docMk/>
            <pc:sldMk cId="2604945875" sldId="297"/>
            <ac:spMk id="15" creationId="{67C6C9C7-D0E6-934A-5269-FC15D85DB932}"/>
          </ac:spMkLst>
        </pc:spChg>
        <pc:spChg chg="mod">
          <ac:chgData name="Jennifer Koh" userId="f9e5c760-747b-4877-856a-bb6123371f09" providerId="ADAL" clId="{6A0A80BA-F599-47DB-90E7-745ADFED9E8B}" dt="2024-09-04T01:32:23.220" v="0" actId="164"/>
          <ac:spMkLst>
            <pc:docMk/>
            <pc:sldMk cId="2604945875" sldId="297"/>
            <ac:spMk id="16" creationId="{9DD75E8F-49F1-8B67-7DFB-DEC162692E8C}"/>
          </ac:spMkLst>
        </pc:spChg>
        <pc:spChg chg="mod">
          <ac:chgData name="Jennifer Koh" userId="f9e5c760-747b-4877-856a-bb6123371f09" providerId="ADAL" clId="{6A0A80BA-F599-47DB-90E7-745ADFED9E8B}" dt="2024-09-04T01:32:23.220" v="0" actId="164"/>
          <ac:spMkLst>
            <pc:docMk/>
            <pc:sldMk cId="2604945875" sldId="297"/>
            <ac:spMk id="17" creationId="{6BA7909A-4798-D081-D1F6-E313E64B150F}"/>
          </ac:spMkLst>
        </pc:spChg>
        <pc:grpChg chg="add mod">
          <ac:chgData name="Jennifer Koh" userId="f9e5c760-747b-4877-856a-bb6123371f09" providerId="ADAL" clId="{6A0A80BA-F599-47DB-90E7-745ADFED9E8B}" dt="2024-09-04T01:32:23.220" v="0" actId="164"/>
          <ac:grpSpMkLst>
            <pc:docMk/>
            <pc:sldMk cId="2604945875" sldId="297"/>
            <ac:grpSpMk id="2" creationId="{CC989EBB-ABFB-3853-6D74-8C0DBFCCD76B}"/>
          </ac:grpSpMkLst>
        </pc:grpChg>
        <pc:grpChg chg="mod">
          <ac:chgData name="Jennifer Koh" userId="f9e5c760-747b-4877-856a-bb6123371f09" providerId="ADAL" clId="{6A0A80BA-F599-47DB-90E7-745ADFED9E8B}" dt="2024-09-04T01:32:23.220" v="0" actId="164"/>
          <ac:grpSpMkLst>
            <pc:docMk/>
            <pc:sldMk cId="2604945875" sldId="297"/>
            <ac:grpSpMk id="24" creationId="{564DDE79-95D7-424E-AC25-3DB68B3949D0}"/>
          </ac:grpSpMkLst>
        </pc:grpChg>
      </pc:sldChg>
    </pc:docChg>
  </pc:docChgLst>
  <pc:docChgLst>
    <pc:chgData name="Jennifer Koh" userId="f9e5c760-747b-4877-856a-bb6123371f09" providerId="ADAL" clId="{0DCC7193-8C08-4C99-8BAF-A7A4DAE92E9F}"/>
    <pc:docChg chg="undo custSel modSld">
      <pc:chgData name="Jennifer Koh" userId="f9e5c760-747b-4877-856a-bb6123371f09" providerId="ADAL" clId="{0DCC7193-8C08-4C99-8BAF-A7A4DAE92E9F}" dt="2024-06-27T01:25:32.778" v="287" actId="164"/>
      <pc:docMkLst>
        <pc:docMk/>
      </pc:docMkLst>
      <pc:sldChg chg="addSp delSp modSp mod modNotesTx">
        <pc:chgData name="Jennifer Koh" userId="f9e5c760-747b-4877-856a-bb6123371f09" providerId="ADAL" clId="{0DCC7193-8C08-4C99-8BAF-A7A4DAE92E9F}" dt="2024-06-14T05:49:08.316" v="24"/>
        <pc:sldMkLst>
          <pc:docMk/>
          <pc:sldMk cId="286440889" sldId="265"/>
        </pc:sldMkLst>
        <pc:picChg chg="add del mod">
          <ac:chgData name="Jennifer Koh" userId="f9e5c760-747b-4877-856a-bb6123371f09" providerId="ADAL" clId="{0DCC7193-8C08-4C99-8BAF-A7A4DAE92E9F}" dt="2024-06-13T23:16:49.766" v="19" actId="478"/>
          <ac:picMkLst>
            <pc:docMk/>
            <pc:sldMk cId="286440889" sldId="265"/>
            <ac:picMk id="3" creationId="{ABF80936-BFA2-6E51-C30D-7027D497F6B3}"/>
          </ac:picMkLst>
        </pc:picChg>
        <pc:picChg chg="del">
          <ac:chgData name="Jennifer Koh" userId="f9e5c760-747b-4877-856a-bb6123371f09" providerId="ADAL" clId="{0DCC7193-8C08-4C99-8BAF-A7A4DAE92E9F}" dt="2024-06-12T23:17:02.773" v="13" actId="478"/>
          <ac:picMkLst>
            <pc:docMk/>
            <pc:sldMk cId="286440889" sldId="265"/>
            <ac:picMk id="5" creationId="{7DBFF119-8EFD-169E-41DB-412E5BEB72BA}"/>
          </ac:picMkLst>
        </pc:picChg>
        <pc:picChg chg="add mod">
          <ac:chgData name="Jennifer Koh" userId="f9e5c760-747b-4877-856a-bb6123371f09" providerId="ADAL" clId="{0DCC7193-8C08-4C99-8BAF-A7A4DAE92E9F}" dt="2024-06-13T23:16:53.403" v="22" actId="962"/>
          <ac:picMkLst>
            <pc:docMk/>
            <pc:sldMk cId="286440889" sldId="265"/>
            <ac:picMk id="5" creationId="{8E2A258D-B8C8-0797-E1FE-B5A9D5E0D565}"/>
          </ac:picMkLst>
        </pc:picChg>
      </pc:sldChg>
      <pc:sldChg chg="addSp delSp modSp mod">
        <pc:chgData name="Jennifer Koh" userId="f9e5c760-747b-4877-856a-bb6123371f09" providerId="ADAL" clId="{0DCC7193-8C08-4C99-8BAF-A7A4DAE92E9F}" dt="2024-06-18T01:12:33.331" v="109" actId="478"/>
        <pc:sldMkLst>
          <pc:docMk/>
          <pc:sldMk cId="4175903602" sldId="274"/>
        </pc:sldMkLst>
        <pc:grpChg chg="add del">
          <ac:chgData name="Jennifer Koh" userId="f9e5c760-747b-4877-856a-bb6123371f09" providerId="ADAL" clId="{0DCC7193-8C08-4C99-8BAF-A7A4DAE92E9F}" dt="2024-06-18T01:12:33.331" v="109" actId="478"/>
          <ac:grpSpMkLst>
            <pc:docMk/>
            <pc:sldMk cId="4175903602" sldId="274"/>
            <ac:grpSpMk id="7" creationId="{21DA1ABC-A7C5-9A90-CF68-5810BF5830DB}"/>
          </ac:grpSpMkLst>
        </pc:grpChg>
        <pc:grpChg chg="topLvl">
          <ac:chgData name="Jennifer Koh" userId="f9e5c760-747b-4877-856a-bb6123371f09" providerId="ADAL" clId="{0DCC7193-8C08-4C99-8BAF-A7A4DAE92E9F}" dt="2024-06-18T01:12:21.129" v="101" actId="478"/>
          <ac:grpSpMkLst>
            <pc:docMk/>
            <pc:sldMk cId="4175903602" sldId="274"/>
            <ac:grpSpMk id="11" creationId="{C98D4CF6-1E27-0DF5-C11F-35FECA780192}"/>
          </ac:grpSpMkLst>
        </pc:grpChg>
        <pc:picChg chg="add mod ord">
          <ac:chgData name="Jennifer Koh" userId="f9e5c760-747b-4877-856a-bb6123371f09" providerId="ADAL" clId="{0DCC7193-8C08-4C99-8BAF-A7A4DAE92E9F}" dt="2024-06-18T01:12:32.645" v="108"/>
          <ac:picMkLst>
            <pc:docMk/>
            <pc:sldMk cId="4175903602" sldId="274"/>
            <ac:picMk id="4" creationId="{8EF0BBFB-8D1F-DEE7-C646-27F9D585FBA9}"/>
          </ac:picMkLst>
        </pc:picChg>
        <pc:picChg chg="add del topLvl">
          <ac:chgData name="Jennifer Koh" userId="f9e5c760-747b-4877-856a-bb6123371f09" providerId="ADAL" clId="{0DCC7193-8C08-4C99-8BAF-A7A4DAE92E9F}" dt="2024-06-18T01:12:33.331" v="109" actId="478"/>
          <ac:picMkLst>
            <pc:docMk/>
            <pc:sldMk cId="4175903602" sldId="274"/>
            <ac:picMk id="6" creationId="{EA52B5D6-28E5-D3AA-4D34-17D3C6E3CFE5}"/>
          </ac:picMkLst>
        </pc:picChg>
      </pc:sldChg>
      <pc:sldChg chg="modSp mod">
        <pc:chgData name="Jennifer Koh" userId="f9e5c760-747b-4877-856a-bb6123371f09" providerId="ADAL" clId="{0DCC7193-8C08-4C99-8BAF-A7A4DAE92E9F}" dt="2024-06-17T22:33:02.399" v="94" actId="1038"/>
        <pc:sldMkLst>
          <pc:docMk/>
          <pc:sldMk cId="1214462485" sldId="283"/>
        </pc:sldMkLst>
        <pc:spChg chg="mod">
          <ac:chgData name="Jennifer Koh" userId="f9e5c760-747b-4877-856a-bb6123371f09" providerId="ADAL" clId="{0DCC7193-8C08-4C99-8BAF-A7A4DAE92E9F}" dt="2024-06-17T22:32:31.438" v="72" actId="1038"/>
          <ac:spMkLst>
            <pc:docMk/>
            <pc:sldMk cId="1214462485" sldId="283"/>
            <ac:spMk id="7" creationId="{58E80A0B-A374-05D8-EA3F-2268E42743CE}"/>
          </ac:spMkLst>
        </pc:spChg>
        <pc:spChg chg="mod">
          <ac:chgData name="Jennifer Koh" userId="f9e5c760-747b-4877-856a-bb6123371f09" providerId="ADAL" clId="{0DCC7193-8C08-4C99-8BAF-A7A4DAE92E9F}" dt="2024-06-17T22:33:02.399" v="94" actId="1038"/>
          <ac:spMkLst>
            <pc:docMk/>
            <pc:sldMk cId="1214462485" sldId="283"/>
            <ac:spMk id="8" creationId="{655FFA7C-E3AE-C641-5AA7-BA17A5ABEA69}"/>
          </ac:spMkLst>
        </pc:spChg>
        <pc:spChg chg="mod">
          <ac:chgData name="Jennifer Koh" userId="f9e5c760-747b-4877-856a-bb6123371f09" providerId="ADAL" clId="{0DCC7193-8C08-4C99-8BAF-A7A4DAE92E9F}" dt="2024-06-17T22:32:48.041" v="90" actId="1038"/>
          <ac:spMkLst>
            <pc:docMk/>
            <pc:sldMk cId="1214462485" sldId="283"/>
            <ac:spMk id="9" creationId="{33BAF9EB-3B1C-6C5D-394B-45E6CE90B6E4}"/>
          </ac:spMkLst>
        </pc:spChg>
      </pc:sldChg>
      <pc:sldChg chg="addSp delSp modSp mod modNotesTx">
        <pc:chgData name="Jennifer Koh" userId="f9e5c760-747b-4877-856a-bb6123371f09" providerId="ADAL" clId="{0DCC7193-8C08-4C99-8BAF-A7A4DAE92E9F}" dt="2024-06-17T22:30:36.411" v="45" actId="1076"/>
        <pc:sldMkLst>
          <pc:docMk/>
          <pc:sldMk cId="3379817359" sldId="294"/>
        </pc:sldMkLst>
        <pc:spChg chg="add mod">
          <ac:chgData name="Jennifer Koh" userId="f9e5c760-747b-4877-856a-bb6123371f09" providerId="ADAL" clId="{0DCC7193-8C08-4C99-8BAF-A7A4DAE92E9F}" dt="2024-06-17T22:30:36.411" v="45" actId="1076"/>
          <ac:spMkLst>
            <pc:docMk/>
            <pc:sldMk cId="3379817359" sldId="294"/>
            <ac:spMk id="2" creationId="{A6385846-6276-DAAB-5C19-6DDF42A79488}"/>
          </ac:spMkLst>
        </pc:spChg>
        <pc:spChg chg="add mod">
          <ac:chgData name="Jennifer Koh" userId="f9e5c760-747b-4877-856a-bb6123371f09" providerId="ADAL" clId="{0DCC7193-8C08-4C99-8BAF-A7A4DAE92E9F}" dt="2024-06-17T22:28:09.207" v="31" actId="1076"/>
          <ac:spMkLst>
            <pc:docMk/>
            <pc:sldMk cId="3379817359" sldId="294"/>
            <ac:spMk id="3" creationId="{88BAB93A-27DA-3656-4EE6-993644F59631}"/>
          </ac:spMkLst>
        </pc:spChg>
        <pc:spChg chg="mod">
          <ac:chgData name="Jennifer Koh" userId="f9e5c760-747b-4877-856a-bb6123371f09" providerId="ADAL" clId="{0DCC7193-8C08-4C99-8BAF-A7A4DAE92E9F}" dt="2024-06-12T23:16:36.493" v="11" actId="1076"/>
          <ac:spMkLst>
            <pc:docMk/>
            <pc:sldMk cId="3379817359" sldId="294"/>
            <ac:spMk id="3" creationId="{EDEE329B-9419-B7A4-CEF8-760CDDE1B470}"/>
          </ac:spMkLst>
        </pc:spChg>
        <pc:spChg chg="add mod">
          <ac:chgData name="Jennifer Koh" userId="f9e5c760-747b-4877-856a-bb6123371f09" providerId="ADAL" clId="{0DCC7193-8C08-4C99-8BAF-A7A4DAE92E9F}" dt="2024-06-17T22:30:32.034" v="44" actId="1076"/>
          <ac:spMkLst>
            <pc:docMk/>
            <pc:sldMk cId="3379817359" sldId="294"/>
            <ac:spMk id="4" creationId="{230172E2-04DD-F492-06DF-DA14ABD3F885}"/>
          </ac:spMkLst>
        </pc:spChg>
        <pc:spChg chg="mod">
          <ac:chgData name="Jennifer Koh" userId="f9e5c760-747b-4877-856a-bb6123371f09" providerId="ADAL" clId="{0DCC7193-8C08-4C99-8BAF-A7A4DAE92E9F}" dt="2024-06-12T23:16:21.621" v="8" actId="1076"/>
          <ac:spMkLst>
            <pc:docMk/>
            <pc:sldMk cId="3379817359" sldId="294"/>
            <ac:spMk id="4" creationId="{9ACBCA66-B375-BB5C-91A5-A8050A427DBD}"/>
          </ac:spMkLst>
        </pc:spChg>
        <pc:spChg chg="mod">
          <ac:chgData name="Jennifer Koh" userId="f9e5c760-747b-4877-856a-bb6123371f09" providerId="ADAL" clId="{0DCC7193-8C08-4C99-8BAF-A7A4DAE92E9F}" dt="2024-06-12T23:16:32.613" v="10" actId="1076"/>
          <ac:spMkLst>
            <pc:docMk/>
            <pc:sldMk cId="3379817359" sldId="294"/>
            <ac:spMk id="5" creationId="{6AD89BB5-181D-ECC9-C0D1-129BF9BC457C}"/>
          </ac:spMkLst>
        </pc:spChg>
        <pc:spChg chg="add mod">
          <ac:chgData name="Jennifer Koh" userId="f9e5c760-747b-4877-856a-bb6123371f09" providerId="ADAL" clId="{0DCC7193-8C08-4C99-8BAF-A7A4DAE92E9F}" dt="2024-06-17T22:28:58.600" v="37" actId="1076"/>
          <ac:spMkLst>
            <pc:docMk/>
            <pc:sldMk cId="3379817359" sldId="294"/>
            <ac:spMk id="5" creationId="{90B89BC9-FBC8-8DAE-F5CD-9E835DCFC7B3}"/>
          </ac:spMkLst>
        </pc:spChg>
        <pc:spChg chg="mod">
          <ac:chgData name="Jennifer Koh" userId="f9e5c760-747b-4877-856a-bb6123371f09" providerId="ADAL" clId="{0DCC7193-8C08-4C99-8BAF-A7A4DAE92E9F}" dt="2024-06-12T23:16:26.731" v="9" actId="1076"/>
          <ac:spMkLst>
            <pc:docMk/>
            <pc:sldMk cId="3379817359" sldId="294"/>
            <ac:spMk id="6" creationId="{149626B4-5B5A-CD18-D796-27C2786BA13A}"/>
          </ac:spMkLst>
        </pc:spChg>
        <pc:grpChg chg="add del mod">
          <ac:chgData name="Jennifer Koh" userId="f9e5c760-747b-4877-856a-bb6123371f09" providerId="ADAL" clId="{0DCC7193-8C08-4C99-8BAF-A7A4DAE92E9F}" dt="2024-06-13T23:16:35.993" v="15" actId="478"/>
          <ac:grpSpMkLst>
            <pc:docMk/>
            <pc:sldMk cId="3379817359" sldId="294"/>
            <ac:grpSpMk id="10" creationId="{371BC5BD-2F6A-76CD-9151-15DF991C4E8E}"/>
          </ac:grpSpMkLst>
        </pc:grpChg>
        <pc:grpChg chg="mod">
          <ac:chgData name="Jennifer Koh" userId="f9e5c760-747b-4877-856a-bb6123371f09" providerId="ADAL" clId="{0DCC7193-8C08-4C99-8BAF-A7A4DAE92E9F}" dt="2024-06-12T23:16:44.023" v="12" actId="164"/>
          <ac:grpSpMkLst>
            <pc:docMk/>
            <pc:sldMk cId="3379817359" sldId="294"/>
            <ac:grpSpMk id="13" creationId="{71C1C5B6-919F-1EE3-4231-7378BE3F633F}"/>
          </ac:grpSpMkLst>
        </pc:grpChg>
        <pc:picChg chg="add mod ord">
          <ac:chgData name="Jennifer Koh" userId="f9e5c760-747b-4877-856a-bb6123371f09" providerId="ADAL" clId="{0DCC7193-8C08-4C99-8BAF-A7A4DAE92E9F}" dt="2024-06-12T23:16:44.023" v="12" actId="164"/>
          <ac:picMkLst>
            <pc:docMk/>
            <pc:sldMk cId="3379817359" sldId="294"/>
            <ac:picMk id="7" creationId="{CEEB6EC5-E98A-C6C6-214F-27153EA6D2F3}"/>
          </ac:picMkLst>
        </pc:picChg>
        <pc:picChg chg="add mod ord">
          <ac:chgData name="Jennifer Koh" userId="f9e5c760-747b-4877-856a-bb6123371f09" providerId="ADAL" clId="{0DCC7193-8C08-4C99-8BAF-A7A4DAE92E9F}" dt="2024-06-17T22:30:10.277" v="43" actId="1076"/>
          <ac:picMkLst>
            <pc:docMk/>
            <pc:sldMk cId="3379817359" sldId="294"/>
            <ac:picMk id="8" creationId="{7670533F-F2E9-AD44-0CBC-EA7E8081FA8A}"/>
          </ac:picMkLst>
        </pc:picChg>
        <pc:picChg chg="del">
          <ac:chgData name="Jennifer Koh" userId="f9e5c760-747b-4877-856a-bb6123371f09" providerId="ADAL" clId="{0DCC7193-8C08-4C99-8BAF-A7A4DAE92E9F}" dt="2024-06-12T23:14:57.715" v="0" actId="478"/>
          <ac:picMkLst>
            <pc:docMk/>
            <pc:sldMk cId="3379817359" sldId="294"/>
            <ac:picMk id="8" creationId="{9C8FD8B0-35E9-C07C-0274-20B8BC578D07}"/>
          </ac:picMkLst>
        </pc:picChg>
      </pc:sldChg>
      <pc:sldChg chg="addSp delSp modSp mod modNotesTx">
        <pc:chgData name="Jennifer Koh" userId="f9e5c760-747b-4877-856a-bb6123371f09" providerId="ADAL" clId="{0DCC7193-8C08-4C99-8BAF-A7A4DAE92E9F}" dt="2024-06-27T01:16:05.884" v="268" actId="164"/>
        <pc:sldMkLst>
          <pc:docMk/>
          <pc:sldMk cId="3937723648" sldId="295"/>
        </pc:sldMkLst>
        <pc:spChg chg="mod topLvl">
          <ac:chgData name="Jennifer Koh" userId="f9e5c760-747b-4877-856a-bb6123371f09" providerId="ADAL" clId="{0DCC7193-8C08-4C99-8BAF-A7A4DAE92E9F}" dt="2024-06-27T01:14:26.057" v="258" actId="165"/>
          <ac:spMkLst>
            <pc:docMk/>
            <pc:sldMk cId="3937723648" sldId="295"/>
            <ac:spMk id="5" creationId="{30644BF8-9CDC-1B73-18BC-F3044AE9BB66}"/>
          </ac:spMkLst>
        </pc:spChg>
        <pc:spChg chg="mod topLvl">
          <ac:chgData name="Jennifer Koh" userId="f9e5c760-747b-4877-856a-bb6123371f09" providerId="ADAL" clId="{0DCC7193-8C08-4C99-8BAF-A7A4DAE92E9F}" dt="2024-06-27T01:16:05.884" v="268" actId="164"/>
          <ac:spMkLst>
            <pc:docMk/>
            <pc:sldMk cId="3937723648" sldId="295"/>
            <ac:spMk id="15" creationId="{DFC2AA91-2819-B788-A701-2EE54B8E0905}"/>
          </ac:spMkLst>
        </pc:spChg>
        <pc:spChg chg="mod">
          <ac:chgData name="Jennifer Koh" userId="f9e5c760-747b-4877-856a-bb6123371f09" providerId="ADAL" clId="{0DCC7193-8C08-4C99-8BAF-A7A4DAE92E9F}" dt="2024-06-27T01:14:26.057" v="258" actId="165"/>
          <ac:spMkLst>
            <pc:docMk/>
            <pc:sldMk cId="3937723648" sldId="295"/>
            <ac:spMk id="16" creationId="{40D41150-F1F3-FDD6-3824-CFCF2CE654C0}"/>
          </ac:spMkLst>
        </pc:spChg>
        <pc:spChg chg="mod topLvl">
          <ac:chgData name="Jennifer Koh" userId="f9e5c760-747b-4877-856a-bb6123371f09" providerId="ADAL" clId="{0DCC7193-8C08-4C99-8BAF-A7A4DAE92E9F}" dt="2024-06-27T01:16:05.884" v="268" actId="164"/>
          <ac:spMkLst>
            <pc:docMk/>
            <pc:sldMk cId="3937723648" sldId="295"/>
            <ac:spMk id="17" creationId="{1BD3EA5B-0EF6-E05C-9A51-B6B288D06381}"/>
          </ac:spMkLst>
        </pc:spChg>
        <pc:grpChg chg="del">
          <ac:chgData name="Jennifer Koh" userId="f9e5c760-747b-4877-856a-bb6123371f09" providerId="ADAL" clId="{0DCC7193-8C08-4C99-8BAF-A7A4DAE92E9F}" dt="2024-06-27T01:14:26.057" v="258" actId="165"/>
          <ac:grpSpMkLst>
            <pc:docMk/>
            <pc:sldMk cId="3937723648" sldId="295"/>
            <ac:grpSpMk id="2" creationId="{65823B20-1E4B-AA87-9A91-6042D4FD00CE}"/>
          </ac:grpSpMkLst>
        </pc:grpChg>
        <pc:grpChg chg="mod topLvl">
          <ac:chgData name="Jennifer Koh" userId="f9e5c760-747b-4877-856a-bb6123371f09" providerId="ADAL" clId="{0DCC7193-8C08-4C99-8BAF-A7A4DAE92E9F}" dt="2024-06-27T01:15:51.452" v="267" actId="164"/>
          <ac:grpSpMkLst>
            <pc:docMk/>
            <pc:sldMk cId="3937723648" sldId="295"/>
            <ac:grpSpMk id="20" creationId="{5D50693A-BB6C-57C2-FB0C-ED623652073F}"/>
          </ac:grpSpMkLst>
        </pc:grpChg>
        <pc:grpChg chg="mod">
          <ac:chgData name="Jennifer Koh" userId="f9e5c760-747b-4877-856a-bb6123371f09" providerId="ADAL" clId="{0DCC7193-8C08-4C99-8BAF-A7A4DAE92E9F}" dt="2024-06-27T01:14:26.057" v="258" actId="165"/>
          <ac:grpSpMkLst>
            <pc:docMk/>
            <pc:sldMk cId="3937723648" sldId="295"/>
            <ac:grpSpMk id="22" creationId="{709BD357-6B52-A9A6-9ECD-485F29A88E0D}"/>
          </ac:grpSpMkLst>
        </pc:grpChg>
        <pc:grpChg chg="mod">
          <ac:chgData name="Jennifer Koh" userId="f9e5c760-747b-4877-856a-bb6123371f09" providerId="ADAL" clId="{0DCC7193-8C08-4C99-8BAF-A7A4DAE92E9F}" dt="2024-06-27T01:14:26.057" v="258" actId="165"/>
          <ac:grpSpMkLst>
            <pc:docMk/>
            <pc:sldMk cId="3937723648" sldId="295"/>
            <ac:grpSpMk id="25" creationId="{B94130EC-AA94-C093-FEB4-5EE89F650DA7}"/>
          </ac:grpSpMkLst>
        </pc:grpChg>
        <pc:grpChg chg="mod">
          <ac:chgData name="Jennifer Koh" userId="f9e5c760-747b-4877-856a-bb6123371f09" providerId="ADAL" clId="{0DCC7193-8C08-4C99-8BAF-A7A4DAE92E9F}" dt="2024-06-27T01:14:53.315" v="259" actId="165"/>
          <ac:grpSpMkLst>
            <pc:docMk/>
            <pc:sldMk cId="3937723648" sldId="295"/>
            <ac:grpSpMk id="26" creationId="{64A38040-9DD1-A1B2-3B1D-1641D0862AAC}"/>
          </ac:grpSpMkLst>
        </pc:grpChg>
        <pc:grpChg chg="mod">
          <ac:chgData name="Jennifer Koh" userId="f9e5c760-747b-4877-856a-bb6123371f09" providerId="ADAL" clId="{0DCC7193-8C08-4C99-8BAF-A7A4DAE92E9F}" dt="2024-06-27T01:14:26.057" v="258" actId="165"/>
          <ac:grpSpMkLst>
            <pc:docMk/>
            <pc:sldMk cId="3937723648" sldId="295"/>
            <ac:grpSpMk id="27" creationId="{4C7B79C2-E55B-E042-8132-ED99DC9051FB}"/>
          </ac:grpSpMkLst>
        </pc:grpChg>
        <pc:grpChg chg="add del mod">
          <ac:chgData name="Jennifer Koh" userId="f9e5c760-747b-4877-856a-bb6123371f09" providerId="ADAL" clId="{0DCC7193-8C08-4C99-8BAF-A7A4DAE92E9F}" dt="2024-06-27T01:09:18.938" v="235" actId="478"/>
          <ac:grpSpMkLst>
            <pc:docMk/>
            <pc:sldMk cId="3937723648" sldId="295"/>
            <ac:grpSpMk id="28" creationId="{B9F3E07C-186B-8CF4-908E-070CD24CA7C1}"/>
          </ac:grpSpMkLst>
        </pc:grpChg>
        <pc:grpChg chg="add del mod topLvl">
          <ac:chgData name="Jennifer Koh" userId="f9e5c760-747b-4877-856a-bb6123371f09" providerId="ADAL" clId="{0DCC7193-8C08-4C99-8BAF-A7A4DAE92E9F}" dt="2024-06-27T01:15:17.131" v="262" actId="164"/>
          <ac:grpSpMkLst>
            <pc:docMk/>
            <pc:sldMk cId="3937723648" sldId="295"/>
            <ac:grpSpMk id="29" creationId="{7AB6AD67-25F6-79C6-1A8E-63F8783C3C92}"/>
          </ac:grpSpMkLst>
        </pc:grpChg>
        <pc:grpChg chg="del mod topLvl">
          <ac:chgData name="Jennifer Koh" userId="f9e5c760-747b-4877-856a-bb6123371f09" providerId="ADAL" clId="{0DCC7193-8C08-4C99-8BAF-A7A4DAE92E9F}" dt="2024-06-27T01:14:53.315" v="259" actId="165"/>
          <ac:grpSpMkLst>
            <pc:docMk/>
            <pc:sldMk cId="3937723648" sldId="295"/>
            <ac:grpSpMk id="31" creationId="{5548263D-3F77-07E8-F975-2DB264355C79}"/>
          </ac:grpSpMkLst>
        </pc:grpChg>
        <pc:grpChg chg="mod topLvl">
          <ac:chgData name="Jennifer Koh" userId="f9e5c760-747b-4877-856a-bb6123371f09" providerId="ADAL" clId="{0DCC7193-8C08-4C99-8BAF-A7A4DAE92E9F}" dt="2024-06-27T01:16:05.884" v="268" actId="164"/>
          <ac:grpSpMkLst>
            <pc:docMk/>
            <pc:sldMk cId="3937723648" sldId="295"/>
            <ac:grpSpMk id="32" creationId="{2EBBE245-170D-CAD2-038D-E3455E07309D}"/>
          </ac:grpSpMkLst>
        </pc:grpChg>
        <pc:grpChg chg="del mod topLvl">
          <ac:chgData name="Jennifer Koh" userId="f9e5c760-747b-4877-856a-bb6123371f09" providerId="ADAL" clId="{0DCC7193-8C08-4C99-8BAF-A7A4DAE92E9F}" dt="2024-06-27T01:15:43.459" v="266" actId="165"/>
          <ac:grpSpMkLst>
            <pc:docMk/>
            <pc:sldMk cId="3937723648" sldId="295"/>
            <ac:grpSpMk id="34" creationId="{61E74731-EC32-098B-9671-9A47193C59CE}"/>
          </ac:grpSpMkLst>
        </pc:grpChg>
        <pc:grpChg chg="del mod topLvl">
          <ac:chgData name="Jennifer Koh" userId="f9e5c760-747b-4877-856a-bb6123371f09" providerId="ADAL" clId="{0DCC7193-8C08-4C99-8BAF-A7A4DAE92E9F}" dt="2024-06-27T01:15:34.233" v="265" actId="165"/>
          <ac:grpSpMkLst>
            <pc:docMk/>
            <pc:sldMk cId="3937723648" sldId="295"/>
            <ac:grpSpMk id="35" creationId="{3D7E8BDF-A15C-112E-E48B-E556B680B965}"/>
          </ac:grpSpMkLst>
        </pc:grpChg>
        <pc:grpChg chg="add mod">
          <ac:chgData name="Jennifer Koh" userId="f9e5c760-747b-4877-856a-bb6123371f09" providerId="ADAL" clId="{0DCC7193-8C08-4C99-8BAF-A7A4DAE92E9F}" dt="2024-06-27T01:16:05.884" v="268" actId="164"/>
          <ac:grpSpMkLst>
            <pc:docMk/>
            <pc:sldMk cId="3937723648" sldId="295"/>
            <ac:grpSpMk id="39" creationId="{5363ACC0-58AC-233E-EC92-165CE2EB4AC2}"/>
          </ac:grpSpMkLst>
        </pc:grpChg>
        <pc:grpChg chg="add mod">
          <ac:chgData name="Jennifer Koh" userId="f9e5c760-747b-4877-856a-bb6123371f09" providerId="ADAL" clId="{0DCC7193-8C08-4C99-8BAF-A7A4DAE92E9F}" dt="2024-06-27T01:16:05.884" v="268" actId="164"/>
          <ac:grpSpMkLst>
            <pc:docMk/>
            <pc:sldMk cId="3937723648" sldId="295"/>
            <ac:grpSpMk id="40" creationId="{04CC7BAA-8E75-FC73-9DA4-3EDD9C793A13}"/>
          </ac:grpSpMkLst>
        </pc:grpChg>
        <pc:grpChg chg="add mod">
          <ac:chgData name="Jennifer Koh" userId="f9e5c760-747b-4877-856a-bb6123371f09" providerId="ADAL" clId="{0DCC7193-8C08-4C99-8BAF-A7A4DAE92E9F}" dt="2024-06-27T01:16:05.884" v="268" actId="164"/>
          <ac:grpSpMkLst>
            <pc:docMk/>
            <pc:sldMk cId="3937723648" sldId="295"/>
            <ac:grpSpMk id="41" creationId="{ABBF4B6C-D8BA-AAFB-EC52-578B1431C8C1}"/>
          </ac:grpSpMkLst>
        </pc:grpChg>
        <pc:picChg chg="add del mod">
          <ac:chgData name="Jennifer Koh" userId="f9e5c760-747b-4877-856a-bb6123371f09" providerId="ADAL" clId="{0DCC7193-8C08-4C99-8BAF-A7A4DAE92E9F}" dt="2024-06-27T00:52:43.102" v="174" actId="478"/>
          <ac:picMkLst>
            <pc:docMk/>
            <pc:sldMk cId="3937723648" sldId="295"/>
            <ac:picMk id="3" creationId="{45AF2056-5ED2-6735-4B53-43963A7B0BC7}"/>
          </ac:picMkLst>
        </pc:picChg>
        <pc:picChg chg="mod">
          <ac:chgData name="Jennifer Koh" userId="f9e5c760-747b-4877-856a-bb6123371f09" providerId="ADAL" clId="{0DCC7193-8C08-4C99-8BAF-A7A4DAE92E9F}" dt="2024-06-27T01:14:53.315" v="259" actId="165"/>
          <ac:picMkLst>
            <pc:docMk/>
            <pc:sldMk cId="3937723648" sldId="295"/>
            <ac:picMk id="4" creationId="{CE4535FE-8452-743C-85A4-3D8FF49F67C4}"/>
          </ac:picMkLst>
        </pc:picChg>
        <pc:picChg chg="mod">
          <ac:chgData name="Jennifer Koh" userId="f9e5c760-747b-4877-856a-bb6123371f09" providerId="ADAL" clId="{0DCC7193-8C08-4C99-8BAF-A7A4DAE92E9F}" dt="2024-06-27T01:14:26.057" v="258" actId="165"/>
          <ac:picMkLst>
            <pc:docMk/>
            <pc:sldMk cId="3937723648" sldId="295"/>
            <ac:picMk id="6" creationId="{B5FBB495-35F8-DE89-2181-D328C9E2B92E}"/>
          </ac:picMkLst>
        </pc:picChg>
        <pc:picChg chg="mod topLvl">
          <ac:chgData name="Jennifer Koh" userId="f9e5c760-747b-4877-856a-bb6123371f09" providerId="ADAL" clId="{0DCC7193-8C08-4C99-8BAF-A7A4DAE92E9F}" dt="2024-06-27T01:15:17.131" v="262" actId="164"/>
          <ac:picMkLst>
            <pc:docMk/>
            <pc:sldMk cId="3937723648" sldId="295"/>
            <ac:picMk id="7" creationId="{06FF156D-7B0C-6779-32C5-EA5351475B3D}"/>
          </ac:picMkLst>
        </pc:picChg>
        <pc:picChg chg="mod">
          <ac:chgData name="Jennifer Koh" userId="f9e5c760-747b-4877-856a-bb6123371f09" providerId="ADAL" clId="{0DCC7193-8C08-4C99-8BAF-A7A4DAE92E9F}" dt="2024-06-27T01:14:53.315" v="259" actId="165"/>
          <ac:picMkLst>
            <pc:docMk/>
            <pc:sldMk cId="3937723648" sldId="295"/>
            <ac:picMk id="8" creationId="{68934F26-376A-9891-CED9-761E7F82C50D}"/>
          </ac:picMkLst>
        </pc:picChg>
        <pc:picChg chg="mod">
          <ac:chgData name="Jennifer Koh" userId="f9e5c760-747b-4877-856a-bb6123371f09" providerId="ADAL" clId="{0DCC7193-8C08-4C99-8BAF-A7A4DAE92E9F}" dt="2024-06-27T01:14:26.057" v="258" actId="165"/>
          <ac:picMkLst>
            <pc:docMk/>
            <pc:sldMk cId="3937723648" sldId="295"/>
            <ac:picMk id="9" creationId="{4AB0F745-1B80-9727-149F-E645FC7BCE7E}"/>
          </ac:picMkLst>
        </pc:picChg>
        <pc:picChg chg="mod">
          <ac:chgData name="Jennifer Koh" userId="f9e5c760-747b-4877-856a-bb6123371f09" providerId="ADAL" clId="{0DCC7193-8C08-4C99-8BAF-A7A4DAE92E9F}" dt="2024-06-27T01:14:53.315" v="259" actId="165"/>
          <ac:picMkLst>
            <pc:docMk/>
            <pc:sldMk cId="3937723648" sldId="295"/>
            <ac:picMk id="10" creationId="{EF631447-E6DE-6D46-B7F2-5D8946CC4831}"/>
          </ac:picMkLst>
        </pc:picChg>
        <pc:picChg chg="add del mod">
          <ac:chgData name="Jennifer Koh" userId="f9e5c760-747b-4877-856a-bb6123371f09" providerId="ADAL" clId="{0DCC7193-8C08-4C99-8BAF-A7A4DAE92E9F}" dt="2024-06-27T00:52:56.509" v="187" actId="478"/>
          <ac:picMkLst>
            <pc:docMk/>
            <pc:sldMk cId="3937723648" sldId="295"/>
            <ac:picMk id="11" creationId="{7692E964-A765-E8AC-A7A0-F83B6C507073}"/>
          </ac:picMkLst>
        </pc:picChg>
        <pc:picChg chg="mod modCrop">
          <ac:chgData name="Jennifer Koh" userId="f9e5c760-747b-4877-856a-bb6123371f09" providerId="ADAL" clId="{0DCC7193-8C08-4C99-8BAF-A7A4DAE92E9F}" dt="2024-06-27T01:15:43.459" v="266" actId="165"/>
          <ac:picMkLst>
            <pc:docMk/>
            <pc:sldMk cId="3937723648" sldId="295"/>
            <ac:picMk id="12" creationId="{93AC6676-3E40-018C-9EAD-0F7DBAFE4D0A}"/>
          </ac:picMkLst>
        </pc:picChg>
        <pc:picChg chg="add mod">
          <ac:chgData name="Jennifer Koh" userId="f9e5c760-747b-4877-856a-bb6123371f09" providerId="ADAL" clId="{0DCC7193-8C08-4C99-8BAF-A7A4DAE92E9F}" dt="2024-06-27T00:55:21.924" v="203" actId="1076"/>
          <ac:picMkLst>
            <pc:docMk/>
            <pc:sldMk cId="3937723648" sldId="295"/>
            <ac:picMk id="13" creationId="{A3A99DD5-E6C4-BEB3-EFF4-5C51850786DF}"/>
          </ac:picMkLst>
        </pc:picChg>
        <pc:picChg chg="del mod modCrop">
          <ac:chgData name="Jennifer Koh" userId="f9e5c760-747b-4877-856a-bb6123371f09" providerId="ADAL" clId="{0DCC7193-8C08-4C99-8BAF-A7A4DAE92E9F}" dt="2024-06-27T00:52:40.574" v="173" actId="478"/>
          <ac:picMkLst>
            <pc:docMk/>
            <pc:sldMk cId="3937723648" sldId="295"/>
            <ac:picMk id="14" creationId="{161643A6-7BE3-1CA6-5356-D37972D726F1}"/>
          </ac:picMkLst>
        </pc:picChg>
        <pc:picChg chg="add mod">
          <ac:chgData name="Jennifer Koh" userId="f9e5c760-747b-4877-856a-bb6123371f09" providerId="ADAL" clId="{0DCC7193-8C08-4C99-8BAF-A7A4DAE92E9F}" dt="2024-06-27T00:55:21.924" v="203" actId="1076"/>
          <ac:picMkLst>
            <pc:docMk/>
            <pc:sldMk cId="3937723648" sldId="295"/>
            <ac:picMk id="18" creationId="{CB0B4879-AE1A-95F3-54E3-C753E5D42E68}"/>
          </ac:picMkLst>
        </pc:picChg>
        <pc:picChg chg="mod">
          <ac:chgData name="Jennifer Koh" userId="f9e5c760-747b-4877-856a-bb6123371f09" providerId="ADAL" clId="{0DCC7193-8C08-4C99-8BAF-A7A4DAE92E9F}" dt="2024-06-27T01:15:43.459" v="266" actId="165"/>
          <ac:picMkLst>
            <pc:docMk/>
            <pc:sldMk cId="3937723648" sldId="295"/>
            <ac:picMk id="19" creationId="{A8CC626B-DD52-3E3C-AB13-F38A2D32E2B1}"/>
          </ac:picMkLst>
        </pc:picChg>
        <pc:picChg chg="mod">
          <ac:chgData name="Jennifer Koh" userId="f9e5c760-747b-4877-856a-bb6123371f09" providerId="ADAL" clId="{0DCC7193-8C08-4C99-8BAF-A7A4DAE92E9F}" dt="2024-06-27T01:14:26.057" v="258" actId="165"/>
          <ac:picMkLst>
            <pc:docMk/>
            <pc:sldMk cId="3937723648" sldId="295"/>
            <ac:picMk id="21" creationId="{BA3548FE-C462-39C8-0132-8C2C7C55C818}"/>
          </ac:picMkLst>
        </pc:picChg>
        <pc:picChg chg="add mod modCrop">
          <ac:chgData name="Jennifer Koh" userId="f9e5c760-747b-4877-856a-bb6123371f09" providerId="ADAL" clId="{0DCC7193-8C08-4C99-8BAF-A7A4DAE92E9F}" dt="2024-06-27T00:55:21.924" v="203" actId="1076"/>
          <ac:picMkLst>
            <pc:docMk/>
            <pc:sldMk cId="3937723648" sldId="295"/>
            <ac:picMk id="23" creationId="{89029C0B-EB68-E3C6-6420-51A315FE71CA}"/>
          </ac:picMkLst>
        </pc:picChg>
        <pc:picChg chg="mod">
          <ac:chgData name="Jennifer Koh" userId="f9e5c760-747b-4877-856a-bb6123371f09" providerId="ADAL" clId="{0DCC7193-8C08-4C99-8BAF-A7A4DAE92E9F}" dt="2024-06-27T01:14:26.057" v="258" actId="165"/>
          <ac:picMkLst>
            <pc:docMk/>
            <pc:sldMk cId="3937723648" sldId="295"/>
            <ac:picMk id="24" creationId="{CE0708B0-097C-04BD-4856-117FD5AE7775}"/>
          </ac:picMkLst>
        </pc:picChg>
        <pc:picChg chg="mod topLvl">
          <ac:chgData name="Jennifer Koh" userId="f9e5c760-747b-4877-856a-bb6123371f09" providerId="ADAL" clId="{0DCC7193-8C08-4C99-8BAF-A7A4DAE92E9F}" dt="2024-06-27T01:15:51.452" v="267" actId="164"/>
          <ac:picMkLst>
            <pc:docMk/>
            <pc:sldMk cId="3937723648" sldId="295"/>
            <ac:picMk id="33" creationId="{36BD6335-5DC3-CC72-1219-26217DE2AC11}"/>
          </ac:picMkLst>
        </pc:picChg>
        <pc:picChg chg="add del mod modCrop">
          <ac:chgData name="Jennifer Koh" userId="f9e5c760-747b-4877-856a-bb6123371f09" providerId="ADAL" clId="{0DCC7193-8C08-4C99-8BAF-A7A4DAE92E9F}" dt="2024-06-27T01:11:53.917" v="243" actId="478"/>
          <ac:picMkLst>
            <pc:docMk/>
            <pc:sldMk cId="3937723648" sldId="295"/>
            <ac:picMk id="36" creationId="{3A69D223-6028-D66B-03FC-54A2DACD388C}"/>
          </ac:picMkLst>
        </pc:picChg>
        <pc:picChg chg="add mod modCrop">
          <ac:chgData name="Jennifer Koh" userId="f9e5c760-747b-4877-856a-bb6123371f09" providerId="ADAL" clId="{0DCC7193-8C08-4C99-8BAF-A7A4DAE92E9F}" dt="2024-06-27T01:15:51.452" v="267" actId="164"/>
          <ac:picMkLst>
            <pc:docMk/>
            <pc:sldMk cId="3937723648" sldId="295"/>
            <ac:picMk id="38" creationId="{833DFC4E-FE2C-E2E1-A9F2-A7417D3F14BC}"/>
          </ac:picMkLst>
        </pc:picChg>
      </pc:sldChg>
      <pc:sldChg chg="addSp delSp modSp mod">
        <pc:chgData name="Jennifer Koh" userId="f9e5c760-747b-4877-856a-bb6123371f09" providerId="ADAL" clId="{0DCC7193-8C08-4C99-8BAF-A7A4DAE92E9F}" dt="2024-06-27T01:25:32.778" v="287" actId="164"/>
        <pc:sldMkLst>
          <pc:docMk/>
          <pc:sldMk cId="2604945875" sldId="297"/>
        </pc:sldMkLst>
        <pc:spChg chg="mod topLvl">
          <ac:chgData name="Jennifer Koh" userId="f9e5c760-747b-4877-856a-bb6123371f09" providerId="ADAL" clId="{0DCC7193-8C08-4C99-8BAF-A7A4DAE92E9F}" dt="2024-06-27T01:17:05.943" v="271" actId="165"/>
          <ac:spMkLst>
            <pc:docMk/>
            <pc:sldMk cId="2604945875" sldId="297"/>
            <ac:spMk id="5" creationId="{90BCF09B-CD4E-9B7D-F3A1-0C28F5226AD0}"/>
          </ac:spMkLst>
        </pc:spChg>
        <pc:spChg chg="mod topLvl">
          <ac:chgData name="Jennifer Koh" userId="f9e5c760-747b-4877-856a-bb6123371f09" providerId="ADAL" clId="{0DCC7193-8C08-4C99-8BAF-A7A4DAE92E9F}" dt="2024-06-27T01:17:05.943" v="271" actId="165"/>
          <ac:spMkLst>
            <pc:docMk/>
            <pc:sldMk cId="2604945875" sldId="297"/>
            <ac:spMk id="15" creationId="{67C6C9C7-D0E6-934A-5269-FC15D85DB932}"/>
          </ac:spMkLst>
        </pc:spChg>
        <pc:spChg chg="mod topLvl">
          <ac:chgData name="Jennifer Koh" userId="f9e5c760-747b-4877-856a-bb6123371f09" providerId="ADAL" clId="{0DCC7193-8C08-4C99-8BAF-A7A4DAE92E9F}" dt="2024-06-27T01:17:05.943" v="271" actId="165"/>
          <ac:spMkLst>
            <pc:docMk/>
            <pc:sldMk cId="2604945875" sldId="297"/>
            <ac:spMk id="16" creationId="{9DD75E8F-49F1-8B67-7DFB-DEC162692E8C}"/>
          </ac:spMkLst>
        </pc:spChg>
        <pc:spChg chg="mod topLvl">
          <ac:chgData name="Jennifer Koh" userId="f9e5c760-747b-4877-856a-bb6123371f09" providerId="ADAL" clId="{0DCC7193-8C08-4C99-8BAF-A7A4DAE92E9F}" dt="2024-06-27T01:24:53.129" v="285" actId="165"/>
          <ac:spMkLst>
            <pc:docMk/>
            <pc:sldMk cId="2604945875" sldId="297"/>
            <ac:spMk id="17" creationId="{6BA7909A-4798-D081-D1F6-E313E64B150F}"/>
          </ac:spMkLst>
        </pc:spChg>
        <pc:grpChg chg="mod topLvl">
          <ac:chgData name="Jennifer Koh" userId="f9e5c760-747b-4877-856a-bb6123371f09" providerId="ADAL" clId="{0DCC7193-8C08-4C99-8BAF-A7A4DAE92E9F}" dt="2024-06-27T01:25:32.778" v="287" actId="164"/>
          <ac:grpSpMkLst>
            <pc:docMk/>
            <pc:sldMk cId="2604945875" sldId="297"/>
            <ac:grpSpMk id="3" creationId="{18D09954-AC9A-BAAF-7CC9-91547CBAD7B3}"/>
          </ac:grpSpMkLst>
        </pc:grpChg>
        <pc:grpChg chg="add del mod">
          <ac:chgData name="Jennifer Koh" userId="f9e5c760-747b-4877-856a-bb6123371f09" providerId="ADAL" clId="{0DCC7193-8C08-4C99-8BAF-A7A4DAE92E9F}" dt="2024-06-27T01:00:01.220" v="216" actId="478"/>
          <ac:grpSpMkLst>
            <pc:docMk/>
            <pc:sldMk cId="2604945875" sldId="297"/>
            <ac:grpSpMk id="4" creationId="{62D4F59A-0C49-F150-BFC2-CC54FFFEA775}"/>
          </ac:grpSpMkLst>
        </pc:grpChg>
        <pc:grpChg chg="add mod">
          <ac:chgData name="Jennifer Koh" userId="f9e5c760-747b-4877-856a-bb6123371f09" providerId="ADAL" clId="{0DCC7193-8C08-4C99-8BAF-A7A4DAE92E9F}" dt="2024-06-27T01:25:32.778" v="287" actId="164"/>
          <ac:grpSpMkLst>
            <pc:docMk/>
            <pc:sldMk cId="2604945875" sldId="297"/>
            <ac:grpSpMk id="22" creationId="{C973307B-762B-E648-3350-4F75F8D5B679}"/>
          </ac:grpSpMkLst>
        </pc:grpChg>
        <pc:grpChg chg="add mod">
          <ac:chgData name="Jennifer Koh" userId="f9e5c760-747b-4877-856a-bb6123371f09" providerId="ADAL" clId="{0DCC7193-8C08-4C99-8BAF-A7A4DAE92E9F}" dt="2024-06-27T01:25:32.778" v="287" actId="164"/>
          <ac:grpSpMkLst>
            <pc:docMk/>
            <pc:sldMk cId="2604945875" sldId="297"/>
            <ac:grpSpMk id="24" creationId="{564DDE79-95D7-424E-AC25-3DB68B3949D0}"/>
          </ac:grpSpMkLst>
        </pc:grpChg>
        <pc:grpChg chg="del mod topLvl">
          <ac:chgData name="Jennifer Koh" userId="f9e5c760-747b-4877-856a-bb6123371f09" providerId="ADAL" clId="{0DCC7193-8C08-4C99-8BAF-A7A4DAE92E9F}" dt="2024-06-27T01:24:53.129" v="285" actId="165"/>
          <ac:grpSpMkLst>
            <pc:docMk/>
            <pc:sldMk cId="2604945875" sldId="297"/>
            <ac:grpSpMk id="35" creationId="{A1539289-15A3-4577-84F8-A5A4C6DA5EE6}"/>
          </ac:grpSpMkLst>
        </pc:grpChg>
        <pc:grpChg chg="del mod">
          <ac:chgData name="Jennifer Koh" userId="f9e5c760-747b-4877-856a-bb6123371f09" providerId="ADAL" clId="{0DCC7193-8C08-4C99-8BAF-A7A4DAE92E9F}" dt="2024-06-27T01:18:33.567" v="276" actId="478"/>
          <ac:grpSpMkLst>
            <pc:docMk/>
            <pc:sldMk cId="2604945875" sldId="297"/>
            <ac:grpSpMk id="38" creationId="{EEB4AE30-A2D8-6394-F193-C48ED80C73F8}"/>
          </ac:grpSpMkLst>
        </pc:grpChg>
        <pc:grpChg chg="del mod topLvl">
          <ac:chgData name="Jennifer Koh" userId="f9e5c760-747b-4877-856a-bb6123371f09" providerId="ADAL" clId="{0DCC7193-8C08-4C99-8BAF-A7A4DAE92E9F}" dt="2024-06-27T01:24:39.012" v="284" actId="165"/>
          <ac:grpSpMkLst>
            <pc:docMk/>
            <pc:sldMk cId="2604945875" sldId="297"/>
            <ac:grpSpMk id="39" creationId="{002860CC-0CE8-B6EE-5D18-B48B3FA9D38C}"/>
          </ac:grpSpMkLst>
        </pc:grpChg>
        <pc:grpChg chg="mod topLvl">
          <ac:chgData name="Jennifer Koh" userId="f9e5c760-747b-4877-856a-bb6123371f09" providerId="ADAL" clId="{0DCC7193-8C08-4C99-8BAF-A7A4DAE92E9F}" dt="2024-06-27T01:25:32.778" v="287" actId="164"/>
          <ac:grpSpMkLst>
            <pc:docMk/>
            <pc:sldMk cId="2604945875" sldId="297"/>
            <ac:grpSpMk id="42" creationId="{4C396F94-BECC-68E3-024A-49E7CCC3816A}"/>
          </ac:grpSpMkLst>
        </pc:grpChg>
        <pc:grpChg chg="del mod">
          <ac:chgData name="Jennifer Koh" userId="f9e5c760-747b-4877-856a-bb6123371f09" providerId="ADAL" clId="{0DCC7193-8C08-4C99-8BAF-A7A4DAE92E9F}" dt="2024-06-27T01:17:05.943" v="271" actId="165"/>
          <ac:grpSpMkLst>
            <pc:docMk/>
            <pc:sldMk cId="2604945875" sldId="297"/>
            <ac:grpSpMk id="43" creationId="{ED8097C3-5838-8487-654E-D8F11F0F7169}"/>
          </ac:grpSpMkLst>
        </pc:grpChg>
        <pc:picChg chg="add del mod">
          <ac:chgData name="Jennifer Koh" userId="f9e5c760-747b-4877-856a-bb6123371f09" providerId="ADAL" clId="{0DCC7193-8C08-4C99-8BAF-A7A4DAE92E9F}" dt="2024-06-27T00:58:47.524" v="213" actId="21"/>
          <ac:picMkLst>
            <pc:docMk/>
            <pc:sldMk cId="2604945875" sldId="297"/>
            <ac:picMk id="2" creationId="{0A0D7C0B-D10D-EF49-EA55-34D666AE7CC4}"/>
          </ac:picMkLst>
        </pc:picChg>
        <pc:picChg chg="mod">
          <ac:chgData name="Jennifer Koh" userId="f9e5c760-747b-4877-856a-bb6123371f09" providerId="ADAL" clId="{0DCC7193-8C08-4C99-8BAF-A7A4DAE92E9F}" dt="2024-06-27T00:59:57.166" v="215" actId="1076"/>
          <ac:picMkLst>
            <pc:docMk/>
            <pc:sldMk cId="2604945875" sldId="297"/>
            <ac:picMk id="6" creationId="{4AAACC18-80EA-EC12-B749-828A8D37782A}"/>
          </ac:picMkLst>
        </pc:picChg>
        <pc:picChg chg="mod">
          <ac:chgData name="Jennifer Koh" userId="f9e5c760-747b-4877-856a-bb6123371f09" providerId="ADAL" clId="{0DCC7193-8C08-4C99-8BAF-A7A4DAE92E9F}" dt="2024-06-27T01:17:05.943" v="271" actId="165"/>
          <ac:picMkLst>
            <pc:docMk/>
            <pc:sldMk cId="2604945875" sldId="297"/>
            <ac:picMk id="7" creationId="{A7A3E74D-BEB4-0836-1805-7C28392484D9}"/>
          </ac:picMkLst>
        </pc:picChg>
        <pc:picChg chg="mod">
          <ac:chgData name="Jennifer Koh" userId="f9e5c760-747b-4877-856a-bb6123371f09" providerId="ADAL" clId="{0DCC7193-8C08-4C99-8BAF-A7A4DAE92E9F}" dt="2024-06-27T01:17:05.943" v="271" actId="165"/>
          <ac:picMkLst>
            <pc:docMk/>
            <pc:sldMk cId="2604945875" sldId="297"/>
            <ac:picMk id="8" creationId="{366067CA-0949-593D-09C8-FDC6E805E45E}"/>
          </ac:picMkLst>
        </pc:picChg>
        <pc:picChg chg="mod">
          <ac:chgData name="Jennifer Koh" userId="f9e5c760-747b-4877-856a-bb6123371f09" providerId="ADAL" clId="{0DCC7193-8C08-4C99-8BAF-A7A4DAE92E9F}" dt="2024-06-27T00:59:57.166" v="215" actId="1076"/>
          <ac:picMkLst>
            <pc:docMk/>
            <pc:sldMk cId="2604945875" sldId="297"/>
            <ac:picMk id="9" creationId="{78A6B59E-3CEE-03B4-8D1E-9D4C97240DB4}"/>
          </ac:picMkLst>
        </pc:picChg>
        <pc:picChg chg="add del mod">
          <ac:chgData name="Jennifer Koh" userId="f9e5c760-747b-4877-856a-bb6123371f09" providerId="ADAL" clId="{0DCC7193-8C08-4C99-8BAF-A7A4DAE92E9F}" dt="2024-06-27T01:00:01.220" v="216" actId="478"/>
          <ac:picMkLst>
            <pc:docMk/>
            <pc:sldMk cId="2604945875" sldId="297"/>
            <ac:picMk id="10" creationId="{37390E1C-A4A9-90BC-DE42-7FE2B5AA9D5F}"/>
          </ac:picMkLst>
        </pc:picChg>
        <pc:picChg chg="mod">
          <ac:chgData name="Jennifer Koh" userId="f9e5c760-747b-4877-856a-bb6123371f09" providerId="ADAL" clId="{0DCC7193-8C08-4C99-8BAF-A7A4DAE92E9F}" dt="2024-06-27T01:17:05.943" v="271" actId="165"/>
          <ac:picMkLst>
            <pc:docMk/>
            <pc:sldMk cId="2604945875" sldId="297"/>
            <ac:picMk id="11" creationId="{D7D9AB9C-4244-694D-E703-CF60EEE8E28B}"/>
          </ac:picMkLst>
        </pc:picChg>
        <pc:picChg chg="add del mod">
          <ac:chgData name="Jennifer Koh" userId="f9e5c760-747b-4877-856a-bb6123371f09" providerId="ADAL" clId="{0DCC7193-8C08-4C99-8BAF-A7A4DAE92E9F}" dt="2024-06-27T01:02:13.780" v="228" actId="21"/>
          <ac:picMkLst>
            <pc:docMk/>
            <pc:sldMk cId="2604945875" sldId="297"/>
            <ac:picMk id="12" creationId="{61BF5965-C6A5-74C5-9091-C725C6296FEC}"/>
          </ac:picMkLst>
        </pc:picChg>
        <pc:picChg chg="mod">
          <ac:chgData name="Jennifer Koh" userId="f9e5c760-747b-4877-856a-bb6123371f09" providerId="ADAL" clId="{0DCC7193-8C08-4C99-8BAF-A7A4DAE92E9F}" dt="2024-06-27T01:17:05.943" v="271" actId="165"/>
          <ac:picMkLst>
            <pc:docMk/>
            <pc:sldMk cId="2604945875" sldId="297"/>
            <ac:picMk id="13" creationId="{DEFC7279-5ACC-E7A5-9BEF-3DFD1BE109EA}"/>
          </ac:picMkLst>
        </pc:picChg>
        <pc:picChg chg="add del mod">
          <ac:chgData name="Jennifer Koh" userId="f9e5c760-747b-4877-856a-bb6123371f09" providerId="ADAL" clId="{0DCC7193-8C08-4C99-8BAF-A7A4DAE92E9F}" dt="2024-06-27T01:03:32.105" v="234" actId="478"/>
          <ac:picMkLst>
            <pc:docMk/>
            <pc:sldMk cId="2604945875" sldId="297"/>
            <ac:picMk id="14" creationId="{3F9D262F-B1E9-5C5C-7805-A5B0B0E4FDF9}"/>
          </ac:picMkLst>
        </pc:picChg>
        <pc:picChg chg="mod">
          <ac:chgData name="Jennifer Koh" userId="f9e5c760-747b-4877-856a-bb6123371f09" providerId="ADAL" clId="{0DCC7193-8C08-4C99-8BAF-A7A4DAE92E9F}" dt="2024-06-27T01:17:05.943" v="271" actId="165"/>
          <ac:picMkLst>
            <pc:docMk/>
            <pc:sldMk cId="2604945875" sldId="297"/>
            <ac:picMk id="18" creationId="{0B873025-8413-5255-BF19-6EA763348371}"/>
          </ac:picMkLst>
        </pc:picChg>
        <pc:picChg chg="add mod modCrop">
          <ac:chgData name="Jennifer Koh" userId="f9e5c760-747b-4877-856a-bb6123371f09" providerId="ADAL" clId="{0DCC7193-8C08-4C99-8BAF-A7A4DAE92E9F}" dt="2024-06-27T01:25:20.654" v="286" actId="164"/>
          <ac:picMkLst>
            <pc:docMk/>
            <pc:sldMk cId="2604945875" sldId="297"/>
            <ac:picMk id="19" creationId="{FCC23630-68E7-5CBE-5C91-9F82DF6614DE}"/>
          </ac:picMkLst>
        </pc:picChg>
        <pc:picChg chg="add mod modCrop">
          <ac:chgData name="Jennifer Koh" userId="f9e5c760-747b-4877-856a-bb6123371f09" providerId="ADAL" clId="{0DCC7193-8C08-4C99-8BAF-A7A4DAE92E9F}" dt="2024-06-27T01:25:20.654" v="286" actId="164"/>
          <ac:picMkLst>
            <pc:docMk/>
            <pc:sldMk cId="2604945875" sldId="297"/>
            <ac:picMk id="21" creationId="{2AD5A6B1-3419-7967-F347-0BB10430962B}"/>
          </ac:picMkLst>
        </pc:picChg>
        <pc:picChg chg="mod">
          <ac:chgData name="Jennifer Koh" userId="f9e5c760-747b-4877-856a-bb6123371f09" providerId="ADAL" clId="{0DCC7193-8C08-4C99-8BAF-A7A4DAE92E9F}" dt="2024-06-27T01:17:05.943" v="271" actId="165"/>
          <ac:picMkLst>
            <pc:docMk/>
            <pc:sldMk cId="2604945875" sldId="297"/>
            <ac:picMk id="23" creationId="{766FA859-00A9-8CE9-154E-6E47BF98254A}"/>
          </ac:picMkLst>
        </pc:picChg>
        <pc:picChg chg="mod topLvl modCrop">
          <ac:chgData name="Jennifer Koh" userId="f9e5c760-747b-4877-856a-bb6123371f09" providerId="ADAL" clId="{0DCC7193-8C08-4C99-8BAF-A7A4DAE92E9F}" dt="2024-06-27T01:25:20.654" v="286" actId="164"/>
          <ac:picMkLst>
            <pc:docMk/>
            <pc:sldMk cId="2604945875" sldId="297"/>
            <ac:picMk id="30" creationId="{55ECAA2F-EB2B-1A8E-DFA5-60D16030FA94}"/>
          </ac:picMkLst>
        </pc:picChg>
        <pc:picChg chg="mod topLvl">
          <ac:chgData name="Jennifer Koh" userId="f9e5c760-747b-4877-856a-bb6123371f09" providerId="ADAL" clId="{0DCC7193-8C08-4C99-8BAF-A7A4DAE92E9F}" dt="2024-06-27T01:25:20.654" v="286" actId="164"/>
          <ac:picMkLst>
            <pc:docMk/>
            <pc:sldMk cId="2604945875" sldId="297"/>
            <ac:picMk id="33" creationId="{9066F30C-FEF7-0ED1-36E3-82D8C02B0BF9}"/>
          </ac:picMkLst>
        </pc:picChg>
        <pc:picChg chg="del">
          <ac:chgData name="Jennifer Koh" userId="f9e5c760-747b-4877-856a-bb6123371f09" providerId="ADAL" clId="{0DCC7193-8C08-4C99-8BAF-A7A4DAE92E9F}" dt="2024-06-27T00:56:57.561" v="204" actId="478"/>
          <ac:picMkLst>
            <pc:docMk/>
            <pc:sldMk cId="2604945875" sldId="297"/>
            <ac:picMk id="36" creationId="{8D846603-6A2C-848F-B668-84B091EFF9D6}"/>
          </ac:picMkLst>
        </pc:picChg>
        <pc:picChg chg="del mod">
          <ac:chgData name="Jennifer Koh" userId="f9e5c760-747b-4877-856a-bb6123371f09" providerId="ADAL" clId="{0DCC7193-8C08-4C99-8BAF-A7A4DAE92E9F}" dt="2024-06-27T01:18:33.567" v="276" actId="478"/>
          <ac:picMkLst>
            <pc:docMk/>
            <pc:sldMk cId="2604945875" sldId="297"/>
            <ac:picMk id="37" creationId="{7E85B4C9-A5F2-0FFC-011E-34C019A13430}"/>
          </ac:picMkLst>
        </pc:picChg>
        <pc:picChg chg="mod">
          <ac:chgData name="Jennifer Koh" userId="f9e5c760-747b-4877-856a-bb6123371f09" providerId="ADAL" clId="{0DCC7193-8C08-4C99-8BAF-A7A4DAE92E9F}" dt="2024-06-27T01:17:05.943" v="271" actId="165"/>
          <ac:picMkLst>
            <pc:docMk/>
            <pc:sldMk cId="2604945875" sldId="297"/>
            <ac:picMk id="40" creationId="{40C4D7EC-4209-6B7A-3EBC-A62379FB70D6}"/>
          </ac:picMkLst>
        </pc:picChg>
        <pc:picChg chg="mod">
          <ac:chgData name="Jennifer Koh" userId="f9e5c760-747b-4877-856a-bb6123371f09" providerId="ADAL" clId="{0DCC7193-8C08-4C99-8BAF-A7A4DAE92E9F}" dt="2024-06-27T01:17:05.943" v="271" actId="165"/>
          <ac:picMkLst>
            <pc:docMk/>
            <pc:sldMk cId="2604945875" sldId="297"/>
            <ac:picMk id="41" creationId="{440F6605-50A7-1B32-94B3-430FA18F7EB4}"/>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23E3FFB5-5CFD-4967-A5D5-2A48AB51B05F}" type="datetimeFigureOut">
              <a:rPr lang="en-AU" smtClean="0"/>
              <a:t>27/01/2025</a:t>
            </a:fld>
            <a:endParaRPr lang="en-AU"/>
          </a:p>
        </p:txBody>
      </p:sp>
      <p:sp>
        <p:nvSpPr>
          <p:cNvPr id="4" name="Slide Image Placeholder 3"/>
          <p:cNvSpPr>
            <a:spLocks noGrp="1" noRot="1" noChangeAspect="1"/>
          </p:cNvSpPr>
          <p:nvPr>
            <p:ph type="sldImg" idx="2"/>
          </p:nvPr>
        </p:nvSpPr>
        <p:spPr>
          <a:xfrm>
            <a:off x="422275" y="1241425"/>
            <a:ext cx="5953125" cy="3349625"/>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85267D71-ABA9-4BD6-8C54-30F5A979EA5B}" type="slidenum">
              <a:rPr lang="en-AU" smtClean="0"/>
              <a:t>‹#›</a:t>
            </a:fld>
            <a:endParaRPr lang="en-AU"/>
          </a:p>
        </p:txBody>
      </p:sp>
    </p:spTree>
    <p:extLst>
      <p:ext uri="{BB962C8B-B14F-4D97-AF65-F5344CB8AC3E}">
        <p14:creationId xmlns:p14="http://schemas.microsoft.com/office/powerpoint/2010/main" val="32534136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S1. No impact of storage time or temperature on overall peptide and protein recovery.</a:t>
            </a:r>
            <a:r>
              <a:rPr lang="en-AU" sz="1800" dirty="0">
                <a:effectLst/>
                <a:latin typeface="Calibri" panose="020F0502020204030204" pitchFamily="34" charset="0"/>
                <a:ea typeface="PMingLiU" panose="02020500000000000000" pitchFamily="18" charset="-120"/>
                <a:cs typeface="Times New Roman" panose="02020603050405020304" pitchFamily="18" charset="0"/>
              </a:rPr>
              <a:t>  </a:t>
            </a:r>
            <a:r>
              <a:rPr lang="en-AU" sz="1800" b="1" dirty="0">
                <a:effectLst/>
                <a:latin typeface="Calibri" panose="020F0502020204030204" pitchFamily="34" charset="0"/>
                <a:ea typeface="PMingLiU" panose="02020500000000000000" pitchFamily="18" charset="-120"/>
                <a:cs typeface="Calibri" panose="020F0502020204030204" pitchFamily="34" charset="0"/>
              </a:rPr>
              <a:t>A) </a:t>
            </a:r>
            <a:r>
              <a:rPr lang="en-AU" sz="1800" dirty="0">
                <a:effectLst/>
                <a:latin typeface="Calibri" panose="020F0502020204030204" pitchFamily="34" charset="0"/>
                <a:ea typeface="PMingLiU" panose="02020500000000000000" pitchFamily="18" charset="-120"/>
                <a:cs typeface="Calibri" panose="020F0502020204030204" pitchFamily="34" charset="0"/>
              </a:rPr>
              <a:t>Peptide yield (µg of peptides per mm</a:t>
            </a:r>
            <a:r>
              <a:rPr lang="en-AU" sz="1800" baseline="30000" dirty="0">
                <a:effectLst/>
                <a:latin typeface="Calibri" panose="020F0502020204030204" pitchFamily="34" charset="0"/>
                <a:ea typeface="PMingLiU" panose="02020500000000000000" pitchFamily="18" charset="-120"/>
                <a:cs typeface="Calibri" panose="020F0502020204030204" pitchFamily="34" charset="0"/>
              </a:rPr>
              <a:t>2</a:t>
            </a:r>
            <a:r>
              <a:rPr lang="en-AU" sz="1800" dirty="0">
                <a:effectLst/>
                <a:latin typeface="Calibri" panose="020F0502020204030204" pitchFamily="34" charset="0"/>
                <a:ea typeface="PMingLiU" panose="02020500000000000000" pitchFamily="18" charset="-120"/>
                <a:cs typeface="Times New Roman" panose="02020603050405020304" pitchFamily="18" charset="0"/>
              </a:rPr>
              <a:t> of tissue</a:t>
            </a:r>
            <a:r>
              <a:rPr lang="en-AU" sz="1800" dirty="0">
                <a:effectLst/>
                <a:latin typeface="Calibri" panose="020F0502020204030204" pitchFamily="34" charset="0"/>
                <a:ea typeface="PMingLiU" panose="02020500000000000000" pitchFamily="18" charset="-120"/>
                <a:cs typeface="Calibri" panose="020F0502020204030204" pitchFamily="34" charset="0"/>
              </a:rPr>
              <a:t>);</a:t>
            </a:r>
            <a:r>
              <a:rPr lang="en-AU" sz="1800" b="1" dirty="0">
                <a:effectLst/>
                <a:latin typeface="Calibri" panose="020F0502020204030204" pitchFamily="34" charset="0"/>
                <a:ea typeface="PMingLiU" panose="02020500000000000000" pitchFamily="18" charset="-120"/>
                <a:cs typeface="Calibri" panose="020F0502020204030204" pitchFamily="34" charset="0"/>
              </a:rPr>
              <a:t> B) </a:t>
            </a:r>
            <a:r>
              <a:rPr lang="en-AU" sz="1800" dirty="0">
                <a:effectLst/>
                <a:latin typeface="Calibri" panose="020F0502020204030204" pitchFamily="34" charset="0"/>
                <a:ea typeface="PMingLiU" panose="02020500000000000000" pitchFamily="18" charset="-120"/>
                <a:cs typeface="Calibri" panose="020F0502020204030204" pitchFamily="34" charset="0"/>
              </a:rPr>
              <a:t>digestion efficiency (the percentage of peptides ending in arginine [R] or lysine [K]);</a:t>
            </a:r>
            <a:r>
              <a:rPr lang="en-AU" sz="1800" b="1" dirty="0">
                <a:effectLst/>
                <a:latin typeface="Calibri" panose="020F0502020204030204" pitchFamily="34" charset="0"/>
                <a:ea typeface="PMingLiU" panose="02020500000000000000" pitchFamily="18" charset="-120"/>
                <a:cs typeface="Calibri" panose="020F0502020204030204" pitchFamily="34" charset="0"/>
              </a:rPr>
              <a:t> C) </a:t>
            </a:r>
            <a:r>
              <a:rPr lang="en-AU" sz="1800" dirty="0">
                <a:effectLst/>
                <a:latin typeface="Calibri" panose="020F0502020204030204" pitchFamily="34" charset="0"/>
                <a:ea typeface="PMingLiU" panose="02020500000000000000" pitchFamily="18" charset="-120"/>
                <a:cs typeface="Calibri" panose="020F0502020204030204" pitchFamily="34" charset="0"/>
              </a:rPr>
              <a:t>numbers of proteins identified; and</a:t>
            </a:r>
            <a:r>
              <a:rPr lang="en-AU" sz="1800" b="1" dirty="0">
                <a:effectLst/>
                <a:latin typeface="Calibri" panose="020F0502020204030204" pitchFamily="34" charset="0"/>
                <a:ea typeface="PMingLiU" panose="02020500000000000000" pitchFamily="18" charset="-120"/>
                <a:cs typeface="Calibri" panose="020F0502020204030204" pitchFamily="34" charset="0"/>
              </a:rPr>
              <a:t> D)</a:t>
            </a:r>
            <a:r>
              <a:rPr lang="en-AU" sz="1800" dirty="0">
                <a:effectLst/>
                <a:latin typeface="Calibri" panose="020F0502020204030204" pitchFamily="34" charset="0"/>
                <a:ea typeface="PMingLiU" panose="02020500000000000000" pitchFamily="18" charset="-120"/>
                <a:cs typeface="Times New Roman" panose="02020603050405020304" pitchFamily="18" charset="0"/>
              </a:rPr>
              <a:t> number of </a:t>
            </a:r>
            <a:r>
              <a:rPr lang="en-AU" sz="1800" dirty="0">
                <a:effectLst/>
                <a:latin typeface="Calibri" panose="020F0502020204030204" pitchFamily="34" charset="0"/>
                <a:ea typeface="PMingLiU" panose="02020500000000000000" pitchFamily="18" charset="-120"/>
                <a:cs typeface="Calibri" panose="020F0502020204030204" pitchFamily="34" charset="0"/>
              </a:rPr>
              <a:t>peptides identified. The data is from DDA analysis of rat kidney FFPE sections. Samples of each storage type of each week were represented in the average of the triplicate ± SD and </a:t>
            </a:r>
            <a:r>
              <a:rPr lang="en-AU" sz="1800" i="1" dirty="0">
                <a:effectLst/>
                <a:latin typeface="Calibri" panose="020F0502020204030204" pitchFamily="34" charset="0"/>
                <a:ea typeface="PMingLiU" panose="02020500000000000000" pitchFamily="18" charset="-120"/>
                <a:cs typeface="Calibri" panose="020F0502020204030204" pitchFamily="34" charset="0"/>
              </a:rPr>
              <a:t>p</a:t>
            </a:r>
            <a:r>
              <a:rPr lang="en-AU" sz="1800" dirty="0">
                <a:effectLst/>
                <a:latin typeface="Calibri" panose="020F0502020204030204" pitchFamily="34" charset="0"/>
                <a:ea typeface="PMingLiU" panose="02020500000000000000" pitchFamily="18" charset="-120"/>
                <a:cs typeface="Calibri" panose="020F0502020204030204" pitchFamily="34" charset="0"/>
              </a:rPr>
              <a:t> &lt; 0.001 (**).</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85267D71-ABA9-4BD6-8C54-30F5A979EA5B}" type="slidenum">
              <a:rPr lang="en-AU" smtClean="0"/>
              <a:t>1</a:t>
            </a:fld>
            <a:endParaRPr lang="en-AU"/>
          </a:p>
        </p:txBody>
      </p:sp>
    </p:spTree>
    <p:extLst>
      <p:ext uri="{BB962C8B-B14F-4D97-AF65-F5344CB8AC3E}">
        <p14:creationId xmlns:p14="http://schemas.microsoft.com/office/powerpoint/2010/main" val="32122214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S2. No impact of FFPE section storage time or temperature on common post-translational modifications. </a:t>
            </a:r>
            <a:r>
              <a:rPr lang="en-AU" sz="1800" dirty="0">
                <a:effectLst/>
                <a:latin typeface="Calibri" panose="020F0502020204030204" pitchFamily="34" charset="0"/>
                <a:ea typeface="PMingLiU" panose="02020500000000000000" pitchFamily="18" charset="-120"/>
                <a:cs typeface="Times New Roman" panose="02020603050405020304" pitchFamily="18" charset="0"/>
              </a:rPr>
              <a:t>The data is shown</a:t>
            </a:r>
            <a:r>
              <a:rPr lang="en-AU" sz="1800" b="1" dirty="0">
                <a:effectLst/>
                <a:latin typeface="Calibri" panose="020F0502020204030204" pitchFamily="34" charset="0"/>
                <a:ea typeface="PMingLiU" panose="02020500000000000000" pitchFamily="18" charset="-120"/>
                <a:cs typeface="Calibri" panose="020F0502020204030204" pitchFamily="34" charset="0"/>
              </a:rPr>
              <a:t> </a:t>
            </a:r>
            <a:r>
              <a:rPr lang="en-AU" sz="1800" dirty="0">
                <a:effectLst/>
                <a:latin typeface="Calibri" panose="020F0502020204030204" pitchFamily="34" charset="0"/>
                <a:ea typeface="PMingLiU" panose="02020500000000000000" pitchFamily="18" charset="-120"/>
                <a:cs typeface="Times New Roman" panose="02020603050405020304" pitchFamily="18" charset="0"/>
              </a:rPr>
              <a:t>for nine common PTMs</a:t>
            </a:r>
            <a:r>
              <a:rPr lang="en-AU" sz="1800" b="1" dirty="0">
                <a:effectLst/>
                <a:latin typeface="Calibri" panose="020F0502020204030204" pitchFamily="34" charset="0"/>
                <a:ea typeface="PMingLiU" panose="02020500000000000000" pitchFamily="18" charset="-120"/>
                <a:cs typeface="Calibri" panose="020F0502020204030204" pitchFamily="34" charset="0"/>
              </a:rPr>
              <a:t> </a:t>
            </a:r>
            <a:r>
              <a:rPr lang="en-AU" sz="1800" dirty="0">
                <a:effectLst/>
                <a:latin typeface="Calibri" panose="020F0502020204030204" pitchFamily="34" charset="0"/>
                <a:ea typeface="PMingLiU" panose="02020500000000000000" pitchFamily="18" charset="-120"/>
                <a:cs typeface="Calibri" panose="020F0502020204030204" pitchFamily="34" charset="0"/>
              </a:rPr>
              <a:t>that can occur in biological samples identified by DDA analysis of rat kidney FFPE sections. The letter in the bracket indicates the amino acid residue that is affected by the modification. The y-axis represents the percentage of peptides that were affected by the modification. Samples of each storage type of each week were represented in the average of the triplicate ± SD and </a:t>
            </a:r>
            <a:r>
              <a:rPr lang="en-AU" sz="1800" i="1" dirty="0">
                <a:effectLst/>
                <a:latin typeface="Calibri" panose="020F0502020204030204" pitchFamily="34" charset="0"/>
                <a:ea typeface="PMingLiU" panose="02020500000000000000" pitchFamily="18" charset="-120"/>
                <a:cs typeface="Calibri" panose="020F0502020204030204" pitchFamily="34" charset="0"/>
              </a:rPr>
              <a:t>p</a:t>
            </a:r>
            <a:r>
              <a:rPr lang="en-AU" sz="1800" dirty="0">
                <a:effectLst/>
                <a:latin typeface="Calibri" panose="020F0502020204030204" pitchFamily="34" charset="0"/>
                <a:ea typeface="PMingLiU" panose="02020500000000000000" pitchFamily="18" charset="-120"/>
                <a:cs typeface="Calibri" panose="020F0502020204030204" pitchFamily="34" charset="0"/>
              </a:rPr>
              <a:t> &lt; 0.05 (*).</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85267D71-ABA9-4BD6-8C54-30F5A979EA5B}" type="slidenum">
              <a:rPr lang="en-AU" smtClean="0"/>
              <a:t>2</a:t>
            </a:fld>
            <a:endParaRPr lang="en-AU"/>
          </a:p>
        </p:txBody>
      </p:sp>
    </p:spTree>
    <p:extLst>
      <p:ext uri="{BB962C8B-B14F-4D97-AF65-F5344CB8AC3E}">
        <p14:creationId xmlns:p14="http://schemas.microsoft.com/office/powerpoint/2010/main" val="33098678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04DBFA46-1A7E-8461-CDA2-88442F9BE69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xmlns="" id="{C76CD9FE-4783-E832-A58A-EDF8D308238D}"/>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xmlns="" id="{8EF25681-A62F-6048-33DF-D4557DF7B965}"/>
              </a:ext>
            </a:extLst>
          </p:cNvPr>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S3. DIA analysis of rat liver FFPE sections (number of MS runs = 99): A)</a:t>
            </a:r>
            <a:r>
              <a:rPr lang="en-AU" sz="1800" dirty="0">
                <a:effectLst/>
                <a:latin typeface="Calibri" panose="020F0502020204030204" pitchFamily="34" charset="0"/>
                <a:ea typeface="PMingLiU" panose="02020500000000000000" pitchFamily="18" charset="-120"/>
                <a:cs typeface="Calibri" panose="020F0502020204030204" pitchFamily="34" charset="0"/>
              </a:rPr>
              <a:t> unsupervised hierarchical clustering heatmap of the peptide intensity z-score (total number of peptides = 37,104) showed no grouping of samples according to their storage time or temperature;</a:t>
            </a:r>
            <a:r>
              <a:rPr lang="en-AU" sz="1800" b="1" dirty="0">
                <a:effectLst/>
                <a:latin typeface="Calibri" panose="020F0502020204030204" pitchFamily="34" charset="0"/>
                <a:ea typeface="PMingLiU" panose="02020500000000000000" pitchFamily="18" charset="-120"/>
                <a:cs typeface="Calibri" panose="020F0502020204030204" pitchFamily="34" charset="0"/>
              </a:rPr>
              <a:t> B) </a:t>
            </a:r>
            <a:r>
              <a:rPr lang="en-AU" sz="1800" dirty="0">
                <a:effectLst/>
                <a:latin typeface="Calibri" panose="020F0502020204030204" pitchFamily="34" charset="0"/>
                <a:ea typeface="PMingLiU" panose="02020500000000000000" pitchFamily="18" charset="-120"/>
                <a:cs typeface="Calibri" panose="020F0502020204030204" pitchFamily="34" charset="0"/>
              </a:rPr>
              <a:t>Pearson correlation showed good correlation among the samples; and</a:t>
            </a:r>
            <a:r>
              <a:rPr lang="en-AU" sz="1800" b="1" dirty="0">
                <a:effectLst/>
                <a:latin typeface="Calibri" panose="020F0502020204030204" pitchFamily="34" charset="0"/>
                <a:ea typeface="PMingLiU" panose="02020500000000000000" pitchFamily="18" charset="-120"/>
                <a:cs typeface="Calibri" panose="020F0502020204030204" pitchFamily="34" charset="0"/>
              </a:rPr>
              <a:t> C) </a:t>
            </a:r>
            <a:r>
              <a:rPr lang="en-AU" sz="1800" dirty="0">
                <a:effectLst/>
                <a:latin typeface="Calibri" panose="020F0502020204030204" pitchFamily="34" charset="0"/>
                <a:ea typeface="PMingLiU" panose="02020500000000000000" pitchFamily="18" charset="-120"/>
                <a:cs typeface="Calibri" panose="020F0502020204030204" pitchFamily="34" charset="0"/>
              </a:rPr>
              <a:t>principal component analysis showed no clustering of samples.</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a:extLst>
              <a:ext uri="{FF2B5EF4-FFF2-40B4-BE49-F238E27FC236}">
                <a16:creationId xmlns:a16="http://schemas.microsoft.com/office/drawing/2014/main" xmlns="" id="{80034955-C36C-C6FE-E61B-E7B6EA6829E3}"/>
              </a:ext>
            </a:extLst>
          </p:cNvPr>
          <p:cNvSpPr>
            <a:spLocks noGrp="1"/>
          </p:cNvSpPr>
          <p:nvPr>
            <p:ph type="sldNum" sz="quarter" idx="5"/>
          </p:nvPr>
        </p:nvSpPr>
        <p:spPr/>
        <p:txBody>
          <a:bodyPr/>
          <a:lstStyle/>
          <a:p>
            <a:fld id="{85267D71-ABA9-4BD6-8C54-30F5A979EA5B}" type="slidenum">
              <a:rPr lang="en-AU" smtClean="0"/>
              <a:t>3</a:t>
            </a:fld>
            <a:endParaRPr lang="en-AU"/>
          </a:p>
        </p:txBody>
      </p:sp>
    </p:spTree>
    <p:extLst>
      <p:ext uri="{BB962C8B-B14F-4D97-AF65-F5344CB8AC3E}">
        <p14:creationId xmlns:p14="http://schemas.microsoft.com/office/powerpoint/2010/main" val="205096230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661D6366-D5A3-5557-2700-ECAEB7FD2AE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xmlns="" id="{878280FD-A723-F2EA-8A68-89A104EB306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xmlns="" id="{456A5E3A-F785-B8B5-0A57-BB5F87F2C013}"/>
              </a:ext>
            </a:extLst>
          </p:cNvPr>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S4. DIA analysis of rat liver FFPE sections (number of MS runs = 99)</a:t>
            </a:r>
            <a:r>
              <a:rPr lang="en-AU" sz="1800" dirty="0">
                <a:effectLst/>
                <a:latin typeface="Calibri" panose="020F0502020204030204" pitchFamily="34" charset="0"/>
                <a:ea typeface="PMingLiU" panose="02020500000000000000" pitchFamily="18" charset="-120"/>
                <a:cs typeface="Calibri" panose="020F0502020204030204" pitchFamily="34" charset="0"/>
              </a:rPr>
              <a:t>: </a:t>
            </a:r>
            <a:r>
              <a:rPr lang="en-AU" sz="1800" b="1" dirty="0">
                <a:effectLst/>
                <a:latin typeface="Calibri" panose="020F0502020204030204" pitchFamily="34" charset="0"/>
                <a:ea typeface="PMingLiU" panose="02020500000000000000" pitchFamily="18" charset="-120"/>
                <a:cs typeface="Calibri" panose="020F0502020204030204" pitchFamily="34" charset="0"/>
              </a:rPr>
              <a:t>A) </a:t>
            </a:r>
            <a:r>
              <a:rPr lang="en-AU" sz="1800" dirty="0">
                <a:effectLst/>
                <a:latin typeface="Calibri" panose="020F0502020204030204" pitchFamily="34" charset="0"/>
                <a:ea typeface="PMingLiU" panose="02020500000000000000" pitchFamily="18" charset="-120"/>
                <a:cs typeface="Calibri" panose="020F0502020204030204" pitchFamily="34" charset="0"/>
              </a:rPr>
              <a:t>unsupervised hierarchical clustering heatmap of the ratio of modified peptides to their unmodified counterparts (number of peptides = 7,212) showed no grouping of samples according to their storage time or temperature; </a:t>
            </a:r>
            <a:r>
              <a:rPr lang="en-AU" sz="1800" b="1" dirty="0">
                <a:effectLst/>
                <a:latin typeface="Calibri" panose="020F0502020204030204" pitchFamily="34" charset="0"/>
                <a:ea typeface="PMingLiU" panose="02020500000000000000" pitchFamily="18" charset="-120"/>
                <a:cs typeface="Calibri" panose="020F0502020204030204" pitchFamily="34" charset="0"/>
              </a:rPr>
              <a:t>B) </a:t>
            </a:r>
            <a:r>
              <a:rPr lang="en-AU" sz="1800" dirty="0">
                <a:effectLst/>
                <a:latin typeface="Calibri" panose="020F0502020204030204" pitchFamily="34" charset="0"/>
                <a:ea typeface="PMingLiU" panose="02020500000000000000" pitchFamily="18" charset="-120"/>
                <a:cs typeface="Calibri" panose="020F0502020204030204" pitchFamily="34" charset="0"/>
              </a:rPr>
              <a:t>Pearson correlation showed good correlation among the samples; and</a:t>
            </a:r>
            <a:r>
              <a:rPr lang="en-AU" sz="1800" b="1" dirty="0">
                <a:effectLst/>
                <a:latin typeface="Calibri" panose="020F0502020204030204" pitchFamily="34" charset="0"/>
                <a:ea typeface="PMingLiU" panose="02020500000000000000" pitchFamily="18" charset="-120"/>
                <a:cs typeface="Calibri" panose="020F0502020204030204" pitchFamily="34" charset="0"/>
              </a:rPr>
              <a:t> C) </a:t>
            </a:r>
            <a:r>
              <a:rPr lang="en-AU" sz="1800" dirty="0">
                <a:effectLst/>
                <a:latin typeface="Calibri" panose="020F0502020204030204" pitchFamily="34" charset="0"/>
                <a:ea typeface="PMingLiU" panose="02020500000000000000" pitchFamily="18" charset="-120"/>
                <a:cs typeface="Calibri" panose="020F0502020204030204" pitchFamily="34" charset="0"/>
              </a:rPr>
              <a:t>principal component analysis showed partial clustering.</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a:extLst>
              <a:ext uri="{FF2B5EF4-FFF2-40B4-BE49-F238E27FC236}">
                <a16:creationId xmlns:a16="http://schemas.microsoft.com/office/drawing/2014/main" xmlns="" id="{0C1E36CB-7459-4E11-8B75-019B081534BD}"/>
              </a:ext>
            </a:extLst>
          </p:cNvPr>
          <p:cNvSpPr>
            <a:spLocks noGrp="1"/>
          </p:cNvSpPr>
          <p:nvPr>
            <p:ph type="sldNum" sz="quarter" idx="5"/>
          </p:nvPr>
        </p:nvSpPr>
        <p:spPr/>
        <p:txBody>
          <a:bodyPr/>
          <a:lstStyle/>
          <a:p>
            <a:fld id="{85267D71-ABA9-4BD6-8C54-30F5A979EA5B}" type="slidenum">
              <a:rPr lang="en-AU" smtClean="0"/>
              <a:t>4</a:t>
            </a:fld>
            <a:endParaRPr lang="en-AU"/>
          </a:p>
        </p:txBody>
      </p:sp>
    </p:spTree>
    <p:extLst>
      <p:ext uri="{BB962C8B-B14F-4D97-AF65-F5344CB8AC3E}">
        <p14:creationId xmlns:p14="http://schemas.microsoft.com/office/powerpoint/2010/main" val="17889626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4815E6CD-BE4B-22B5-2285-BA4962EB6F7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xmlns="" id="{1A69ED09-6759-A6E1-0530-5E3D8DC353E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xmlns="" id="{CA507818-5D0A-6302-F54C-B82EEE952C1B}"/>
              </a:ext>
            </a:extLst>
          </p:cNvPr>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a:t>
            </a:r>
            <a:r>
              <a:rPr lang="en-AU" sz="1800" b="1" dirty="0">
                <a:solidFill>
                  <a:srgbClr val="FF0000"/>
                </a:solidFill>
                <a:effectLst/>
                <a:latin typeface="Calibri" panose="020F0502020204030204" pitchFamily="34" charset="0"/>
                <a:ea typeface="PMingLiU" panose="02020500000000000000" pitchFamily="18" charset="-120"/>
                <a:cs typeface="Calibri" panose="020F0502020204030204" pitchFamily="34" charset="0"/>
              </a:rPr>
              <a:t>S5.</a:t>
            </a:r>
            <a:r>
              <a:rPr lang="en-AU" sz="1800" b="1" dirty="0">
                <a:effectLst/>
                <a:latin typeface="Calibri" panose="020F0502020204030204" pitchFamily="34" charset="0"/>
                <a:ea typeface="PMingLiU" panose="02020500000000000000" pitchFamily="18" charset="-120"/>
                <a:cs typeface="Calibri" panose="020F0502020204030204" pitchFamily="34" charset="0"/>
              </a:rPr>
              <a:t> FFPE-specific post-translational modifications in rat liver FFPE sections.</a:t>
            </a:r>
            <a:r>
              <a:rPr lang="en-AU" sz="1800" dirty="0">
                <a:effectLst/>
                <a:latin typeface="Calibri" panose="020F0502020204030204" pitchFamily="34" charset="0"/>
                <a:ea typeface="PMingLiU" panose="02020500000000000000" pitchFamily="18" charset="-120"/>
                <a:cs typeface="Calibri" panose="020F0502020204030204" pitchFamily="34" charset="0"/>
              </a:rPr>
              <a:t> Nine PTMs that have been reported to be associated with FFPE samples were monitored for quantitative changes using DIA data. Samples were grouped by the storage temperature (control, RT or -80°C) and from week 1 to week 48 (left to right).</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a:extLst>
              <a:ext uri="{FF2B5EF4-FFF2-40B4-BE49-F238E27FC236}">
                <a16:creationId xmlns:a16="http://schemas.microsoft.com/office/drawing/2014/main" xmlns="" id="{22B4973A-19DF-BC12-7846-F76C8D8EB3FE}"/>
              </a:ext>
            </a:extLst>
          </p:cNvPr>
          <p:cNvSpPr>
            <a:spLocks noGrp="1"/>
          </p:cNvSpPr>
          <p:nvPr>
            <p:ph type="sldNum" sz="quarter" idx="5"/>
          </p:nvPr>
        </p:nvSpPr>
        <p:spPr/>
        <p:txBody>
          <a:bodyPr/>
          <a:lstStyle/>
          <a:p>
            <a:fld id="{85267D71-ABA9-4BD6-8C54-30F5A979EA5B}" type="slidenum">
              <a:rPr lang="en-AU" smtClean="0"/>
              <a:t>5</a:t>
            </a:fld>
            <a:endParaRPr lang="en-AU"/>
          </a:p>
        </p:txBody>
      </p:sp>
    </p:spTree>
    <p:extLst>
      <p:ext uri="{BB962C8B-B14F-4D97-AF65-F5344CB8AC3E}">
        <p14:creationId xmlns:p14="http://schemas.microsoft.com/office/powerpoint/2010/main" val="545323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S6. No impact of FFPE tissue block age on overall peptide and protein recovery. A) </a:t>
            </a:r>
            <a:r>
              <a:rPr lang="en-AU" sz="1800" dirty="0">
                <a:effectLst/>
                <a:latin typeface="Calibri" panose="020F0502020204030204" pitchFamily="34" charset="0"/>
                <a:ea typeface="PMingLiU" panose="02020500000000000000" pitchFamily="18" charset="-120"/>
                <a:cs typeface="Calibri" panose="020F0502020204030204" pitchFamily="34" charset="0"/>
              </a:rPr>
              <a:t>Peptide yield;</a:t>
            </a:r>
            <a:r>
              <a:rPr lang="en-AU" sz="1800" b="1" dirty="0">
                <a:effectLst/>
                <a:latin typeface="Calibri" panose="020F0502020204030204" pitchFamily="34" charset="0"/>
                <a:ea typeface="PMingLiU" panose="02020500000000000000" pitchFamily="18" charset="-120"/>
                <a:cs typeface="Calibri" panose="020F0502020204030204" pitchFamily="34" charset="0"/>
              </a:rPr>
              <a:t> B) </a:t>
            </a:r>
            <a:r>
              <a:rPr lang="en-AU" sz="1800" dirty="0">
                <a:effectLst/>
                <a:latin typeface="Calibri" panose="020F0502020204030204" pitchFamily="34" charset="0"/>
                <a:ea typeface="PMingLiU" panose="02020500000000000000" pitchFamily="18" charset="-120"/>
                <a:cs typeface="Calibri" panose="020F0502020204030204" pitchFamily="34" charset="0"/>
              </a:rPr>
              <a:t>proteins quantified; and</a:t>
            </a:r>
            <a:r>
              <a:rPr lang="en-AU" sz="1800" b="1" dirty="0">
                <a:effectLst/>
                <a:latin typeface="Calibri" panose="020F0502020204030204" pitchFamily="34" charset="0"/>
                <a:ea typeface="PMingLiU" panose="02020500000000000000" pitchFamily="18" charset="-120"/>
                <a:cs typeface="Calibri" panose="020F0502020204030204" pitchFamily="34" charset="0"/>
              </a:rPr>
              <a:t> C)</a:t>
            </a:r>
            <a:r>
              <a:rPr lang="en-AU" sz="1800" dirty="0">
                <a:effectLst/>
                <a:latin typeface="Calibri" panose="020F0502020204030204" pitchFamily="34" charset="0"/>
                <a:ea typeface="PMingLiU" panose="02020500000000000000" pitchFamily="18" charset="-120"/>
                <a:cs typeface="Calibri" panose="020F0502020204030204" pitchFamily="34" charset="0"/>
              </a:rPr>
              <a:t> peptides quantified. The data is from DIA analysis of 77 FFPE sections prepared from oropharyngeal tumour blocks aged from 4 to 13 years.</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85267D71-ABA9-4BD6-8C54-30F5A979EA5B}" type="slidenum">
              <a:rPr lang="en-AU" smtClean="0"/>
              <a:t>6</a:t>
            </a:fld>
            <a:endParaRPr lang="en-AU"/>
          </a:p>
        </p:txBody>
      </p:sp>
    </p:spTree>
    <p:extLst>
      <p:ext uri="{BB962C8B-B14F-4D97-AF65-F5344CB8AC3E}">
        <p14:creationId xmlns:p14="http://schemas.microsoft.com/office/powerpoint/2010/main" val="34947701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S7. FFPE-specific post-translational modifications in FFPE sections (n = 77) prepared from oropharyngeal tumour blocks aged from 4 to 13 years.</a:t>
            </a:r>
            <a:r>
              <a:rPr lang="en-AU" sz="1800" dirty="0">
                <a:effectLst/>
                <a:latin typeface="Calibri" panose="020F0502020204030204" pitchFamily="34" charset="0"/>
                <a:ea typeface="PMingLiU" panose="02020500000000000000" pitchFamily="18" charset="-120"/>
                <a:cs typeface="Calibri" panose="020F0502020204030204" pitchFamily="34" charset="0"/>
              </a:rPr>
              <a:t> Nine PTMs that have been reported to be associated with FFPE samples were monitored using DIA analysis. Samples were grouped by the age of the FFPE blocks, from 4 to 13 years (left to right).</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85267D71-ABA9-4BD6-8C54-30F5A979EA5B}" type="slidenum">
              <a:rPr lang="en-AU" smtClean="0"/>
              <a:t>7</a:t>
            </a:fld>
            <a:endParaRPr lang="en-AU"/>
          </a:p>
        </p:txBody>
      </p:sp>
    </p:spTree>
    <p:extLst>
      <p:ext uri="{BB962C8B-B14F-4D97-AF65-F5344CB8AC3E}">
        <p14:creationId xmlns:p14="http://schemas.microsoft.com/office/powerpoint/2010/main" val="188144279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200000"/>
              </a:lnSpc>
            </a:pPr>
            <a:r>
              <a:rPr lang="en-AU" sz="1800" b="1" dirty="0">
                <a:effectLst/>
                <a:latin typeface="Calibri" panose="020F0502020204030204" pitchFamily="34" charset="0"/>
                <a:ea typeface="PMingLiU" panose="02020500000000000000" pitchFamily="18" charset="-120"/>
                <a:cs typeface="Calibri" panose="020F0502020204030204" pitchFamily="34" charset="0"/>
              </a:rPr>
              <a:t>Figure S8. DIA analysis of FFPE sections (n = 77) prepared from oropharyngeal tumour blocks aged from 4 to 13 years: A) </a:t>
            </a:r>
            <a:r>
              <a:rPr lang="en-AU" sz="1800" dirty="0">
                <a:effectLst/>
                <a:latin typeface="Calibri" panose="020F0502020204030204" pitchFamily="34" charset="0"/>
                <a:ea typeface="PMingLiU" panose="02020500000000000000" pitchFamily="18" charset="-120"/>
                <a:cs typeface="Calibri" panose="020F0502020204030204" pitchFamily="34" charset="0"/>
              </a:rPr>
              <a:t>unsupervised hierarchical clustering heatmap of the peptide intensity z-score (number of peptides = 81,016) and</a:t>
            </a:r>
            <a:r>
              <a:rPr lang="en-AU" sz="1800" b="1" dirty="0">
                <a:effectLst/>
                <a:latin typeface="Calibri" panose="020F0502020204030204" pitchFamily="34" charset="0"/>
                <a:ea typeface="PMingLiU" panose="02020500000000000000" pitchFamily="18" charset="-120"/>
                <a:cs typeface="Calibri" panose="020F0502020204030204" pitchFamily="34" charset="0"/>
              </a:rPr>
              <a:t> B) </a:t>
            </a:r>
            <a:r>
              <a:rPr lang="en-AU" sz="1800" dirty="0">
                <a:effectLst/>
                <a:latin typeface="Calibri" panose="020F0502020204030204" pitchFamily="34" charset="0"/>
                <a:ea typeface="PMingLiU" panose="02020500000000000000" pitchFamily="18" charset="-120"/>
                <a:cs typeface="Calibri" panose="020F0502020204030204" pitchFamily="34" charset="0"/>
              </a:rPr>
              <a:t>principal component analysis showed no grouping of samples according to their block age.</a:t>
            </a:r>
            <a:endParaRPr lang="en-AU" sz="1800" dirty="0">
              <a:effectLst/>
              <a:latin typeface="Calibri" panose="020F0502020204030204" pitchFamily="34" charset="0"/>
              <a:ea typeface="PMingLiU" panose="02020500000000000000" pitchFamily="18" charset="-12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85267D71-ABA9-4BD6-8C54-30F5A979EA5B}" type="slidenum">
              <a:rPr lang="en-AU" smtClean="0"/>
              <a:t>8</a:t>
            </a:fld>
            <a:endParaRPr lang="en-AU"/>
          </a:p>
        </p:txBody>
      </p:sp>
    </p:spTree>
    <p:extLst>
      <p:ext uri="{BB962C8B-B14F-4D97-AF65-F5344CB8AC3E}">
        <p14:creationId xmlns:p14="http://schemas.microsoft.com/office/powerpoint/2010/main" val="7612890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AE03B07-B269-4F85-A8D6-266EEAF17C7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xmlns="" id="{4B491025-C9BE-448C-BFE1-5A6503CB538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xmlns="" id="{053F1D36-9369-4B98-AEA5-4B3C1345483F}"/>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5" name="Footer Placeholder 4">
            <a:extLst>
              <a:ext uri="{FF2B5EF4-FFF2-40B4-BE49-F238E27FC236}">
                <a16:creationId xmlns:a16="http://schemas.microsoft.com/office/drawing/2014/main" xmlns="" id="{BC0D70B4-F684-479A-AF1A-CE044F40B4D1}"/>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E80B9FF7-E156-46B6-94F4-BF1DAAD71759}"/>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21440158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A673230-0B6C-462D-9912-AF67B4FEFCE5}"/>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xmlns="" id="{2DD0ACF2-593F-4CB6-AA5E-A599CE5729D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924F551A-D3F7-440A-9639-E3F105255502}"/>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5" name="Footer Placeholder 4">
            <a:extLst>
              <a:ext uri="{FF2B5EF4-FFF2-40B4-BE49-F238E27FC236}">
                <a16:creationId xmlns:a16="http://schemas.microsoft.com/office/drawing/2014/main" xmlns="" id="{5E690BF8-A479-4EBA-B53A-402CB620B420}"/>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1976BB6F-EC04-43B3-83DA-F6CF4F0643C2}"/>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41774926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553C77DF-FDF3-483B-BE82-5547CB8E25DC}"/>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xmlns="" id="{F3F86B23-03B0-43FB-9744-BFB2361D327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0F1703A9-844E-450E-95B7-8931289E0D01}"/>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5" name="Footer Placeholder 4">
            <a:extLst>
              <a:ext uri="{FF2B5EF4-FFF2-40B4-BE49-F238E27FC236}">
                <a16:creationId xmlns:a16="http://schemas.microsoft.com/office/drawing/2014/main" xmlns="" id="{DB4552B9-B636-44DF-ABDC-1ECCD04D58F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9B51EA9F-17C3-4979-BEDB-6AB4B9631972}"/>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15112955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5A68A0D-A13B-495C-AD8E-C3AC09DE141A}"/>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xmlns="" id="{A6FB85C6-B8BB-4CFD-84F2-5C5DFC374C9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20D760D2-17D7-402C-A751-25C44937E4B9}"/>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5" name="Footer Placeholder 4">
            <a:extLst>
              <a:ext uri="{FF2B5EF4-FFF2-40B4-BE49-F238E27FC236}">
                <a16:creationId xmlns:a16="http://schemas.microsoft.com/office/drawing/2014/main" xmlns="" id="{A8F0311C-40A1-4D2B-95E4-2B1C41B106AF}"/>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118171A1-DAE9-44A4-A3D3-C48C529FE6E8}"/>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4270554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9A2E9A2-162F-4C61-B68A-7E7991E9A72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xmlns="" id="{A57B24D5-AAE1-49CF-8AD8-85860D1E0F0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xmlns="" id="{664A718F-93D8-4C8A-BEE9-8F72B2D98FF4}"/>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5" name="Footer Placeholder 4">
            <a:extLst>
              <a:ext uri="{FF2B5EF4-FFF2-40B4-BE49-F238E27FC236}">
                <a16:creationId xmlns:a16="http://schemas.microsoft.com/office/drawing/2014/main" xmlns="" id="{D566D5EC-24B8-425F-8503-506ACB5B807D}"/>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26DC733B-9C7D-4BA8-89FB-75CA7B555963}"/>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3605358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27A125C-21AA-48A9-AA58-5B0AB07C058F}"/>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xmlns="" id="{B52CC6BD-75A1-42F1-80EA-6BBA9DE983E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xmlns="" id="{647EF352-E08E-43E6-AA50-2911A83F8EF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xmlns="" id="{DB6A1428-03B1-4FE4-AD65-B8F0F1624336}"/>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6" name="Footer Placeholder 5">
            <a:extLst>
              <a:ext uri="{FF2B5EF4-FFF2-40B4-BE49-F238E27FC236}">
                <a16:creationId xmlns:a16="http://schemas.microsoft.com/office/drawing/2014/main" xmlns="" id="{09D54EED-DE5A-4202-A533-F9CFC814674B}"/>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xmlns="" id="{B04FE6EE-E56A-4D65-8C8D-5058BD7FAB8E}"/>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18721282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3F53353-AB73-403E-80C8-A2B50E16123C}"/>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xmlns="" id="{5D82842B-050F-4CD1-884A-201B85C4D87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xmlns="" id="{14800A2B-8422-43C2-8558-2E46C07D7CC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xmlns="" id="{7A16EF02-6527-4A58-8D54-6FC886DEA4F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xmlns="" id="{F47BC674-3899-449D-9AAC-315CEBBBE0B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xmlns="" id="{241A705C-1AEC-40B3-A56B-9B19C29A6D4C}"/>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8" name="Footer Placeholder 7">
            <a:extLst>
              <a:ext uri="{FF2B5EF4-FFF2-40B4-BE49-F238E27FC236}">
                <a16:creationId xmlns:a16="http://schemas.microsoft.com/office/drawing/2014/main" xmlns="" id="{D829DDDD-4203-46E3-BDC1-E5EDEBE3B20B}"/>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xmlns="" id="{39965AB6-ED33-4DD3-A22C-F41CEA25D0A7}"/>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25931368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F4B526B-A3BE-4841-B96B-0D6558B3D227}"/>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xmlns="" id="{242DDE1F-943A-4E53-BDB7-D0369FE82CA7}"/>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4" name="Footer Placeholder 3">
            <a:extLst>
              <a:ext uri="{FF2B5EF4-FFF2-40B4-BE49-F238E27FC236}">
                <a16:creationId xmlns:a16="http://schemas.microsoft.com/office/drawing/2014/main" xmlns="" id="{BD29E3D7-4EA0-4E68-8A76-24D7C3833B37}"/>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xmlns="" id="{EEA82231-2480-47AD-BDA8-FB560A8425C9}"/>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8030101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109F1A60-DBE3-49C2-99F0-1067A45B8046}"/>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3" name="Footer Placeholder 2">
            <a:extLst>
              <a:ext uri="{FF2B5EF4-FFF2-40B4-BE49-F238E27FC236}">
                <a16:creationId xmlns:a16="http://schemas.microsoft.com/office/drawing/2014/main" xmlns="" id="{F2BF49CE-6C9C-4819-B02F-7E61AC3B48B8}"/>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xmlns="" id="{D229056B-0C4C-4154-A88A-6C5FF3F3AB42}"/>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11208116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9AAB846-93EA-4EE0-B38F-5183F2725E1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xmlns="" id="{C1618F2F-372C-4924-A9E0-1D7366A20A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xmlns="" id="{CD99FE6F-3ECA-495C-B51E-0EE646C8F8B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DC4A25A9-C8F1-46E2-93DF-345B2CBE3B12}"/>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6" name="Footer Placeholder 5">
            <a:extLst>
              <a:ext uri="{FF2B5EF4-FFF2-40B4-BE49-F238E27FC236}">
                <a16:creationId xmlns:a16="http://schemas.microsoft.com/office/drawing/2014/main" xmlns="" id="{E079222C-4957-4A68-8F3A-9AC0413BBDF9}"/>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xmlns="" id="{05C43668-7C0E-4D1D-AA4C-C5EA6D6A7F3D}"/>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17691215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6F5A3BBD-9CD7-41E5-8FA6-EFDA2491F33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xmlns="" id="{0B655C84-F010-4A46-9D7A-0305C2BD379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xmlns="" id="{E0CCEB86-1AC6-4F9A-9A20-368F6E7967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63977034-04CA-4A99-B71C-F1E16523A594}"/>
              </a:ext>
            </a:extLst>
          </p:cNvPr>
          <p:cNvSpPr>
            <a:spLocks noGrp="1"/>
          </p:cNvSpPr>
          <p:nvPr>
            <p:ph type="dt" sz="half" idx="10"/>
          </p:nvPr>
        </p:nvSpPr>
        <p:spPr/>
        <p:txBody>
          <a:bodyPr/>
          <a:lstStyle/>
          <a:p>
            <a:fld id="{BE839E25-93AE-45F8-A77D-48EB41A8F92E}" type="datetimeFigureOut">
              <a:rPr lang="en-AU" smtClean="0"/>
              <a:t>27/01/2025</a:t>
            </a:fld>
            <a:endParaRPr lang="en-AU"/>
          </a:p>
        </p:txBody>
      </p:sp>
      <p:sp>
        <p:nvSpPr>
          <p:cNvPr id="6" name="Footer Placeholder 5">
            <a:extLst>
              <a:ext uri="{FF2B5EF4-FFF2-40B4-BE49-F238E27FC236}">
                <a16:creationId xmlns:a16="http://schemas.microsoft.com/office/drawing/2014/main" xmlns="" id="{96424D3B-FBB8-49D3-B6B7-916A27A0BF17}"/>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xmlns="" id="{FD5056E4-4AFE-44AE-B610-F1D0C0813850}"/>
              </a:ext>
            </a:extLst>
          </p:cNvPr>
          <p:cNvSpPr>
            <a:spLocks noGrp="1"/>
          </p:cNvSpPr>
          <p:nvPr>
            <p:ph type="sldNum" sz="quarter" idx="12"/>
          </p:nvPr>
        </p:nvSpPr>
        <p:spPr/>
        <p:txBody>
          <a:bodyPr/>
          <a:lstStyle/>
          <a:p>
            <a:fld id="{D364ED10-1B78-40CA-98A3-8B45E75C0BE7}" type="slidenum">
              <a:rPr lang="en-AU" smtClean="0"/>
              <a:t>‹#›</a:t>
            </a:fld>
            <a:endParaRPr lang="en-AU"/>
          </a:p>
        </p:txBody>
      </p:sp>
    </p:spTree>
    <p:extLst>
      <p:ext uri="{BB962C8B-B14F-4D97-AF65-F5344CB8AC3E}">
        <p14:creationId xmlns:p14="http://schemas.microsoft.com/office/powerpoint/2010/main" val="11277739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B3F9B388-E9EF-42BE-A989-E8E4C962E07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xmlns="" id="{4955EB9F-6F16-46CA-AF75-E32112078D2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57699971-60D6-4767-B540-7C12919BE58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E839E25-93AE-45F8-A77D-48EB41A8F92E}" type="datetimeFigureOut">
              <a:rPr lang="en-AU" smtClean="0"/>
              <a:t>27/01/2025</a:t>
            </a:fld>
            <a:endParaRPr lang="en-AU"/>
          </a:p>
        </p:txBody>
      </p:sp>
      <p:sp>
        <p:nvSpPr>
          <p:cNvPr id="5" name="Footer Placeholder 4">
            <a:extLst>
              <a:ext uri="{FF2B5EF4-FFF2-40B4-BE49-F238E27FC236}">
                <a16:creationId xmlns:a16="http://schemas.microsoft.com/office/drawing/2014/main" xmlns="" id="{D2D91180-4104-4798-9C88-F5C6824E80E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xmlns="" id="{6B7356EB-71AC-4F97-8223-FF8ECA946DD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64ED10-1B78-40CA-98A3-8B45E75C0BE7}" type="slidenum">
              <a:rPr lang="en-AU" smtClean="0"/>
              <a:t>‹#›</a:t>
            </a:fld>
            <a:endParaRPr lang="en-AU"/>
          </a:p>
        </p:txBody>
      </p:sp>
    </p:spTree>
    <p:extLst>
      <p:ext uri="{BB962C8B-B14F-4D97-AF65-F5344CB8AC3E}">
        <p14:creationId xmlns:p14="http://schemas.microsoft.com/office/powerpoint/2010/main" val="38622267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6.xml"/><Relationship Id="rId6" Type="http://schemas.openxmlformats.org/officeDocument/2006/relationships/image" Target="../media/image6.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s>
</file>

<file path=ppt/slides/_rels/slide4.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1.png"/><Relationship Id="rId7" Type="http://schemas.openxmlformats.org/officeDocument/2006/relationships/image" Target="../media/image15.png"/><Relationship Id="rId2" Type="http://schemas.openxmlformats.org/officeDocument/2006/relationships/notesSlide" Target="../notesSlides/notesSlide4.xml"/><Relationship Id="rId1" Type="http://schemas.openxmlformats.org/officeDocument/2006/relationships/slideLayout" Target="../slideLayouts/slideLayout6.xml"/><Relationship Id="rId6" Type="http://schemas.openxmlformats.org/officeDocument/2006/relationships/image" Target="../media/image14.png"/><Relationship Id="rId11" Type="http://schemas.openxmlformats.org/officeDocument/2006/relationships/image" Target="../media/image10.png"/><Relationship Id="rId5" Type="http://schemas.openxmlformats.org/officeDocument/2006/relationships/image" Target="../media/image13.png"/><Relationship Id="rId10" Type="http://schemas.openxmlformats.org/officeDocument/2006/relationships/image" Target="../media/image16.png"/><Relationship Id="rId4" Type="http://schemas.openxmlformats.org/officeDocument/2006/relationships/image" Target="../media/image12.png"/><Relationship Id="rId9"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8.xml"/><Relationship Id="rId1" Type="http://schemas.openxmlformats.org/officeDocument/2006/relationships/slideLayout" Target="../slideLayouts/slideLayout6.xml"/><Relationship Id="rId4" Type="http://schemas.openxmlformats.org/officeDocument/2006/relationships/image" Target="../media/image2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group of colorful lines&#10;&#10;Description automatically generated">
            <a:extLst>
              <a:ext uri="{FF2B5EF4-FFF2-40B4-BE49-F238E27FC236}">
                <a16:creationId xmlns:a16="http://schemas.microsoft.com/office/drawing/2014/main" xmlns="" id="{7670533F-F2E9-AD44-0CBC-EA7E8081FA8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71104" y="71349"/>
            <a:ext cx="10236729" cy="6781814"/>
          </a:xfrm>
          <a:prstGeom prst="rect">
            <a:avLst/>
          </a:prstGeom>
        </p:spPr>
      </p:pic>
      <p:sp>
        <p:nvSpPr>
          <p:cNvPr id="2" name="TextBox 1">
            <a:extLst>
              <a:ext uri="{FF2B5EF4-FFF2-40B4-BE49-F238E27FC236}">
                <a16:creationId xmlns:a16="http://schemas.microsoft.com/office/drawing/2014/main" xmlns="" id="{A6385846-6276-DAAB-5C19-6DDF42A79488}"/>
              </a:ext>
            </a:extLst>
          </p:cNvPr>
          <p:cNvSpPr txBox="1"/>
          <p:nvPr/>
        </p:nvSpPr>
        <p:spPr>
          <a:xfrm>
            <a:off x="871104" y="71349"/>
            <a:ext cx="436294" cy="369332"/>
          </a:xfrm>
          <a:prstGeom prst="rect">
            <a:avLst/>
          </a:prstGeom>
          <a:noFill/>
        </p:spPr>
        <p:txBody>
          <a:bodyPr wrap="square" rtlCol="0">
            <a:spAutoFit/>
          </a:bodyPr>
          <a:lstStyle/>
          <a:p>
            <a:r>
              <a:rPr lang="en-AU" b="1" dirty="0"/>
              <a:t>A)</a:t>
            </a:r>
          </a:p>
        </p:txBody>
      </p:sp>
      <p:sp>
        <p:nvSpPr>
          <p:cNvPr id="3" name="TextBox 2">
            <a:extLst>
              <a:ext uri="{FF2B5EF4-FFF2-40B4-BE49-F238E27FC236}">
                <a16:creationId xmlns:a16="http://schemas.microsoft.com/office/drawing/2014/main" xmlns="" id="{88BAB93A-27DA-3656-4EE6-993644F59631}"/>
              </a:ext>
            </a:extLst>
          </p:cNvPr>
          <p:cNvSpPr txBox="1"/>
          <p:nvPr/>
        </p:nvSpPr>
        <p:spPr>
          <a:xfrm>
            <a:off x="4962660" y="71349"/>
            <a:ext cx="436294" cy="369332"/>
          </a:xfrm>
          <a:prstGeom prst="rect">
            <a:avLst/>
          </a:prstGeom>
          <a:noFill/>
        </p:spPr>
        <p:txBody>
          <a:bodyPr wrap="square" rtlCol="0">
            <a:spAutoFit/>
          </a:bodyPr>
          <a:lstStyle/>
          <a:p>
            <a:r>
              <a:rPr lang="en-AU" b="1" dirty="0"/>
              <a:t>B)</a:t>
            </a:r>
          </a:p>
        </p:txBody>
      </p:sp>
      <p:sp>
        <p:nvSpPr>
          <p:cNvPr id="4" name="TextBox 3">
            <a:extLst>
              <a:ext uri="{FF2B5EF4-FFF2-40B4-BE49-F238E27FC236}">
                <a16:creationId xmlns:a16="http://schemas.microsoft.com/office/drawing/2014/main" xmlns="" id="{230172E2-04DD-F492-06DF-DA14ABD3F885}"/>
              </a:ext>
            </a:extLst>
          </p:cNvPr>
          <p:cNvSpPr txBox="1"/>
          <p:nvPr/>
        </p:nvSpPr>
        <p:spPr>
          <a:xfrm>
            <a:off x="917872" y="3429000"/>
            <a:ext cx="436294" cy="369332"/>
          </a:xfrm>
          <a:prstGeom prst="rect">
            <a:avLst/>
          </a:prstGeom>
          <a:noFill/>
        </p:spPr>
        <p:txBody>
          <a:bodyPr wrap="square" rtlCol="0">
            <a:spAutoFit/>
          </a:bodyPr>
          <a:lstStyle/>
          <a:p>
            <a:r>
              <a:rPr lang="en-AU" b="1" dirty="0"/>
              <a:t>C)</a:t>
            </a:r>
          </a:p>
        </p:txBody>
      </p:sp>
      <p:sp>
        <p:nvSpPr>
          <p:cNvPr id="5" name="TextBox 4">
            <a:extLst>
              <a:ext uri="{FF2B5EF4-FFF2-40B4-BE49-F238E27FC236}">
                <a16:creationId xmlns:a16="http://schemas.microsoft.com/office/drawing/2014/main" xmlns="" id="{90B89BC9-FBC8-8DAE-F5CD-9E835DCFC7B3}"/>
              </a:ext>
            </a:extLst>
          </p:cNvPr>
          <p:cNvSpPr txBox="1"/>
          <p:nvPr/>
        </p:nvSpPr>
        <p:spPr>
          <a:xfrm>
            <a:off x="4962660" y="3429000"/>
            <a:ext cx="436294" cy="369332"/>
          </a:xfrm>
          <a:prstGeom prst="rect">
            <a:avLst/>
          </a:prstGeom>
          <a:noFill/>
        </p:spPr>
        <p:txBody>
          <a:bodyPr wrap="square" rtlCol="0">
            <a:spAutoFit/>
          </a:bodyPr>
          <a:lstStyle/>
          <a:p>
            <a:r>
              <a:rPr lang="en-AU" b="1" dirty="0"/>
              <a:t>D)</a:t>
            </a:r>
          </a:p>
        </p:txBody>
      </p:sp>
      <p:sp>
        <p:nvSpPr>
          <p:cNvPr id="6" name="Title 3">
            <a:extLst>
              <a:ext uri="{FF2B5EF4-FFF2-40B4-BE49-F238E27FC236}">
                <a16:creationId xmlns:a16="http://schemas.microsoft.com/office/drawing/2014/main" xmlns="" id="{13BE5911-D9A5-2D8D-4D5D-9454D5D6B17A}"/>
              </a:ext>
            </a:extLst>
          </p:cNvPr>
          <p:cNvSpPr txBox="1">
            <a:spLocks/>
          </p:cNvSpPr>
          <p:nvPr/>
        </p:nvSpPr>
        <p:spPr>
          <a:xfrm>
            <a:off x="10221438" y="32276"/>
            <a:ext cx="1970562"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1</a:t>
            </a:r>
          </a:p>
        </p:txBody>
      </p:sp>
    </p:spTree>
    <p:extLst>
      <p:ext uri="{BB962C8B-B14F-4D97-AF65-F5344CB8AC3E}">
        <p14:creationId xmlns:p14="http://schemas.microsoft.com/office/powerpoint/2010/main" val="33798173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oup of colorful lines&#10;&#10;Description automatically generated">
            <a:extLst>
              <a:ext uri="{FF2B5EF4-FFF2-40B4-BE49-F238E27FC236}">
                <a16:creationId xmlns:a16="http://schemas.microsoft.com/office/drawing/2014/main" xmlns="" id="{8E2A258D-B8C8-0797-E1FE-B5A9D5E0D56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455383" y="0"/>
            <a:ext cx="9281234" cy="6858000"/>
          </a:xfrm>
          <a:prstGeom prst="rect">
            <a:avLst/>
          </a:prstGeom>
        </p:spPr>
      </p:pic>
      <p:sp>
        <p:nvSpPr>
          <p:cNvPr id="2" name="Title 3">
            <a:extLst>
              <a:ext uri="{FF2B5EF4-FFF2-40B4-BE49-F238E27FC236}">
                <a16:creationId xmlns:a16="http://schemas.microsoft.com/office/drawing/2014/main" xmlns="" id="{7A006F79-AB70-3CCF-8D9D-EB58CD5065DB}"/>
              </a:ext>
            </a:extLst>
          </p:cNvPr>
          <p:cNvSpPr txBox="1">
            <a:spLocks/>
          </p:cNvSpPr>
          <p:nvPr/>
        </p:nvSpPr>
        <p:spPr>
          <a:xfrm>
            <a:off x="10110651" y="32276"/>
            <a:ext cx="2081349"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S2</a:t>
            </a:r>
          </a:p>
        </p:txBody>
      </p:sp>
    </p:spTree>
    <p:extLst>
      <p:ext uri="{BB962C8B-B14F-4D97-AF65-F5344CB8AC3E}">
        <p14:creationId xmlns:p14="http://schemas.microsoft.com/office/powerpoint/2010/main" val="2864408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BE769C81-23B4-975E-C240-D26BC09A78F3}"/>
            </a:ext>
          </a:extLst>
        </p:cNvPr>
        <p:cNvGrpSpPr/>
        <p:nvPr/>
      </p:nvGrpSpPr>
      <p:grpSpPr>
        <a:xfrm>
          <a:off x="0" y="0"/>
          <a:ext cx="0" cy="0"/>
          <a:chOff x="0" y="0"/>
          <a:chExt cx="0" cy="0"/>
        </a:xfrm>
      </p:grpSpPr>
      <p:grpSp>
        <p:nvGrpSpPr>
          <p:cNvPr id="43" name="Group 42">
            <a:extLst>
              <a:ext uri="{FF2B5EF4-FFF2-40B4-BE49-F238E27FC236}">
                <a16:creationId xmlns:a16="http://schemas.microsoft.com/office/drawing/2014/main" xmlns="" id="{EF4189BE-62C0-52F6-A2C0-CB75D5A24FCB}"/>
              </a:ext>
            </a:extLst>
          </p:cNvPr>
          <p:cNvGrpSpPr/>
          <p:nvPr/>
        </p:nvGrpSpPr>
        <p:grpSpPr>
          <a:xfrm>
            <a:off x="147536" y="-44858"/>
            <a:ext cx="10672072" cy="6836324"/>
            <a:chOff x="147536" y="-44858"/>
            <a:chExt cx="10672072" cy="6836324"/>
          </a:xfrm>
        </p:grpSpPr>
        <p:pic>
          <p:nvPicPr>
            <p:cNvPr id="37" name="Picture 36" descr="A screen shot of a computer screen&#10;&#10;Description automatically generated">
              <a:extLst>
                <a:ext uri="{FF2B5EF4-FFF2-40B4-BE49-F238E27FC236}">
                  <a16:creationId xmlns:a16="http://schemas.microsoft.com/office/drawing/2014/main" xmlns="" id="{BAF3A9CF-062D-617E-13C5-D8C396113EC8}"/>
                </a:ext>
              </a:extLst>
            </p:cNvPr>
            <p:cNvPicPr>
              <a:picLocks noChangeAspect="1"/>
            </p:cNvPicPr>
            <p:nvPr/>
          </p:nvPicPr>
          <p:blipFill>
            <a:blip r:embed="rId3" cstate="print">
              <a:extLst>
                <a:ext uri="{28A0092B-C50C-407E-A947-70E740481C1C}">
                  <a14:useLocalDpi xmlns:a14="http://schemas.microsoft.com/office/drawing/2010/main" val="0"/>
                </a:ext>
              </a:extLst>
            </a:blip>
            <a:srcRect l="15256" t="20317" r="27485"/>
            <a:stretch/>
          </p:blipFill>
          <p:spPr>
            <a:xfrm>
              <a:off x="673596" y="66534"/>
              <a:ext cx="3474358" cy="4230000"/>
            </a:xfrm>
            <a:prstGeom prst="rect">
              <a:avLst/>
            </a:prstGeom>
          </p:spPr>
        </p:pic>
        <p:pic>
          <p:nvPicPr>
            <p:cNvPr id="14" name="Picture 13" descr="A yellow and blue squares&#10;&#10;Description automatically generated">
              <a:extLst>
                <a:ext uri="{FF2B5EF4-FFF2-40B4-BE49-F238E27FC236}">
                  <a16:creationId xmlns:a16="http://schemas.microsoft.com/office/drawing/2014/main" xmlns="" id="{576F9A3B-7062-9951-C58A-8342BE0F7496}"/>
                </a:ext>
              </a:extLst>
            </p:cNvPr>
            <p:cNvPicPr>
              <a:picLocks noChangeAspect="1"/>
            </p:cNvPicPr>
            <p:nvPr/>
          </p:nvPicPr>
          <p:blipFill>
            <a:blip r:embed="rId4" cstate="print">
              <a:extLst>
                <a:ext uri="{28A0092B-C50C-407E-A947-70E740481C1C}">
                  <a14:useLocalDpi xmlns:a14="http://schemas.microsoft.com/office/drawing/2010/main" val="0"/>
                </a:ext>
              </a:extLst>
            </a:blip>
            <a:srcRect l="15006" t="17279" r="28897" b="18997"/>
            <a:stretch/>
          </p:blipFill>
          <p:spPr>
            <a:xfrm>
              <a:off x="5967702" y="32276"/>
              <a:ext cx="3510000" cy="3502539"/>
            </a:xfrm>
            <a:prstGeom prst="rect">
              <a:avLst/>
            </a:prstGeom>
          </p:spPr>
        </p:pic>
        <p:sp>
          <p:nvSpPr>
            <p:cNvPr id="15" name="TextBox 14">
              <a:extLst>
                <a:ext uri="{FF2B5EF4-FFF2-40B4-BE49-F238E27FC236}">
                  <a16:creationId xmlns:a16="http://schemas.microsoft.com/office/drawing/2014/main" xmlns="" id="{A686B434-8B60-0426-084A-4631F809AF85}"/>
                </a:ext>
              </a:extLst>
            </p:cNvPr>
            <p:cNvSpPr txBox="1"/>
            <p:nvPr/>
          </p:nvSpPr>
          <p:spPr>
            <a:xfrm>
              <a:off x="147536" y="-44858"/>
              <a:ext cx="436294" cy="369332"/>
            </a:xfrm>
            <a:prstGeom prst="rect">
              <a:avLst/>
            </a:prstGeom>
            <a:noFill/>
          </p:spPr>
          <p:txBody>
            <a:bodyPr wrap="square" rtlCol="0">
              <a:spAutoFit/>
            </a:bodyPr>
            <a:lstStyle/>
            <a:p>
              <a:r>
                <a:rPr lang="en-AU" b="1" dirty="0"/>
                <a:t>A)</a:t>
              </a:r>
            </a:p>
          </p:txBody>
        </p:sp>
        <p:pic>
          <p:nvPicPr>
            <p:cNvPr id="7" name="Picture 6" descr="A close-up of a screen&#10;&#10;Description automatically generated">
              <a:extLst>
                <a:ext uri="{FF2B5EF4-FFF2-40B4-BE49-F238E27FC236}">
                  <a16:creationId xmlns:a16="http://schemas.microsoft.com/office/drawing/2014/main" xmlns="" id="{A07F03A1-F125-42C9-854F-BEFBA0370D06}"/>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76387" t="24424" r="-5" b="20996"/>
            <a:stretch/>
          </p:blipFill>
          <p:spPr>
            <a:xfrm>
              <a:off x="4490090" y="1320167"/>
              <a:ext cx="1223546" cy="2388363"/>
            </a:xfrm>
            <a:prstGeom prst="rect">
              <a:avLst/>
            </a:prstGeom>
          </p:spPr>
        </p:pic>
        <p:grpSp>
          <p:nvGrpSpPr>
            <p:cNvPr id="29" name="Group 28">
              <a:extLst>
                <a:ext uri="{FF2B5EF4-FFF2-40B4-BE49-F238E27FC236}">
                  <a16:creationId xmlns:a16="http://schemas.microsoft.com/office/drawing/2014/main" xmlns="" id="{AF02479A-086F-F5B9-8214-7094B91328FE}"/>
                </a:ext>
              </a:extLst>
            </p:cNvPr>
            <p:cNvGrpSpPr/>
            <p:nvPr/>
          </p:nvGrpSpPr>
          <p:grpSpPr>
            <a:xfrm>
              <a:off x="4147954" y="113390"/>
              <a:ext cx="1183002" cy="1083516"/>
              <a:chOff x="4364255" y="136966"/>
              <a:chExt cx="1183002" cy="1083516"/>
            </a:xfrm>
          </p:grpSpPr>
          <p:pic>
            <p:nvPicPr>
              <p:cNvPr id="4" name="Picture 3" descr="A close-up of a screen&#10;&#10;Description automatically generated">
                <a:extLst>
                  <a:ext uri="{FF2B5EF4-FFF2-40B4-BE49-F238E27FC236}">
                    <a16:creationId xmlns:a16="http://schemas.microsoft.com/office/drawing/2014/main" xmlns="" id="{B4183119-95CE-BD6A-7A06-AE5CD34896AE}"/>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76387" t="10438" r="-5" b="74602"/>
              <a:stretch/>
            </p:blipFill>
            <p:spPr>
              <a:xfrm>
                <a:off x="4364255" y="587518"/>
                <a:ext cx="1183002" cy="632964"/>
              </a:xfrm>
              <a:prstGeom prst="rect">
                <a:avLst/>
              </a:prstGeom>
            </p:spPr>
          </p:pic>
          <p:pic>
            <p:nvPicPr>
              <p:cNvPr id="8" name="Picture 7" descr="A close-up of a screen&#10;&#10;Description automatically generated">
                <a:extLst>
                  <a:ext uri="{FF2B5EF4-FFF2-40B4-BE49-F238E27FC236}">
                    <a16:creationId xmlns:a16="http://schemas.microsoft.com/office/drawing/2014/main" xmlns="" id="{04699CA4-54E6-D560-4901-F49C86EDBFC6}"/>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69860" t="1086" r="10467" b="89353"/>
              <a:stretch/>
            </p:blipFill>
            <p:spPr>
              <a:xfrm>
                <a:off x="4364256" y="136966"/>
                <a:ext cx="985425" cy="404559"/>
              </a:xfrm>
              <a:prstGeom prst="rect">
                <a:avLst/>
              </a:prstGeom>
            </p:spPr>
          </p:pic>
        </p:grpSp>
        <p:sp>
          <p:nvSpPr>
            <p:cNvPr id="16" name="TextBox 15">
              <a:extLst>
                <a:ext uri="{FF2B5EF4-FFF2-40B4-BE49-F238E27FC236}">
                  <a16:creationId xmlns:a16="http://schemas.microsoft.com/office/drawing/2014/main" xmlns="" id="{19FA973C-B153-2E64-D0FA-11012CFABB6F}"/>
                </a:ext>
              </a:extLst>
            </p:cNvPr>
            <p:cNvSpPr txBox="1"/>
            <p:nvPr/>
          </p:nvSpPr>
          <p:spPr>
            <a:xfrm>
              <a:off x="5590397" y="-44858"/>
              <a:ext cx="391334" cy="369332"/>
            </a:xfrm>
            <a:prstGeom prst="rect">
              <a:avLst/>
            </a:prstGeom>
            <a:noFill/>
          </p:spPr>
          <p:txBody>
            <a:bodyPr wrap="square" rtlCol="0">
              <a:spAutoFit/>
            </a:bodyPr>
            <a:lstStyle/>
            <a:p>
              <a:r>
                <a:rPr lang="en-AU" b="1" dirty="0"/>
                <a:t>B)</a:t>
              </a:r>
            </a:p>
          </p:txBody>
        </p:sp>
        <p:grpSp>
          <p:nvGrpSpPr>
            <p:cNvPr id="27" name="Group 26">
              <a:extLst>
                <a:ext uri="{FF2B5EF4-FFF2-40B4-BE49-F238E27FC236}">
                  <a16:creationId xmlns:a16="http://schemas.microsoft.com/office/drawing/2014/main" xmlns="" id="{04CDBB49-AC0B-A7A5-8A64-EC7CD411AF12}"/>
                </a:ext>
              </a:extLst>
            </p:cNvPr>
            <p:cNvGrpSpPr>
              <a:grpSpLocks noChangeAspect="1"/>
            </p:cNvGrpSpPr>
            <p:nvPr/>
          </p:nvGrpSpPr>
          <p:grpSpPr>
            <a:xfrm>
              <a:off x="6011528" y="51422"/>
              <a:ext cx="4808080" cy="4286694"/>
              <a:chOff x="5134226" y="785651"/>
              <a:chExt cx="4006734" cy="3572245"/>
            </a:xfrm>
          </p:grpSpPr>
          <p:pic>
            <p:nvPicPr>
              <p:cNvPr id="9" name="Picture 8" descr="A yellow and blue squares&#10;&#10;Description automatically generated">
                <a:extLst>
                  <a:ext uri="{FF2B5EF4-FFF2-40B4-BE49-F238E27FC236}">
                    <a16:creationId xmlns:a16="http://schemas.microsoft.com/office/drawing/2014/main" xmlns="" id="{7E8EE9A9-EF29-3733-86A7-FA5B074CFB3F}"/>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73801" t="14375" r="-159" b="70986"/>
              <a:stretch/>
            </p:blipFill>
            <p:spPr>
              <a:xfrm>
                <a:off x="8021389" y="1169233"/>
                <a:ext cx="1119571" cy="531628"/>
              </a:xfrm>
              <a:prstGeom prst="rect">
                <a:avLst/>
              </a:prstGeom>
            </p:spPr>
          </p:pic>
          <p:grpSp>
            <p:nvGrpSpPr>
              <p:cNvPr id="25" name="Group 24">
                <a:extLst>
                  <a:ext uri="{FF2B5EF4-FFF2-40B4-BE49-F238E27FC236}">
                    <a16:creationId xmlns:a16="http://schemas.microsoft.com/office/drawing/2014/main" xmlns="" id="{9DB2097E-D554-BFCB-548C-FEC0FD23B750}"/>
                  </a:ext>
                </a:extLst>
              </p:cNvPr>
              <p:cNvGrpSpPr/>
              <p:nvPr/>
            </p:nvGrpSpPr>
            <p:grpSpPr>
              <a:xfrm>
                <a:off x="5134226" y="785651"/>
                <a:ext cx="3713002" cy="3572245"/>
                <a:chOff x="5134226" y="785651"/>
                <a:chExt cx="3713002" cy="3572245"/>
              </a:xfrm>
            </p:grpSpPr>
            <p:pic>
              <p:nvPicPr>
                <p:cNvPr id="21" name="Picture 20" descr="A close-up of a screen&#10;&#10;Description automatically generated">
                  <a:extLst>
                    <a:ext uri="{FF2B5EF4-FFF2-40B4-BE49-F238E27FC236}">
                      <a16:creationId xmlns:a16="http://schemas.microsoft.com/office/drawing/2014/main" xmlns="" id="{7A95A1D5-F846-8B18-2E2D-63599688EBB4}"/>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69860" t="1086" r="10467" b="89353"/>
                <a:stretch/>
              </p:blipFill>
              <p:spPr>
                <a:xfrm>
                  <a:off x="8019134" y="785651"/>
                  <a:ext cx="828094" cy="339968"/>
                </a:xfrm>
                <a:prstGeom prst="rect">
                  <a:avLst/>
                </a:prstGeom>
              </p:spPr>
            </p:pic>
            <p:pic>
              <p:nvPicPr>
                <p:cNvPr id="24" name="Picture 23" descr="A yellow and blue squares&#10;&#10;Description automatically generated">
                  <a:extLst>
                    <a:ext uri="{FF2B5EF4-FFF2-40B4-BE49-F238E27FC236}">
                      <a16:creationId xmlns:a16="http://schemas.microsoft.com/office/drawing/2014/main" xmlns="" id="{EF5E2EEA-6C93-329E-0D7A-FED3A44D8780}"/>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456" t="81785" r="91508" b="-22"/>
                <a:stretch/>
              </p:blipFill>
              <p:spPr>
                <a:xfrm>
                  <a:off x="5134226" y="3695516"/>
                  <a:ext cx="298824" cy="662380"/>
                </a:xfrm>
                <a:prstGeom prst="rect">
                  <a:avLst/>
                </a:prstGeom>
              </p:spPr>
            </p:pic>
          </p:grpSp>
        </p:grpSp>
        <p:sp>
          <p:nvSpPr>
            <p:cNvPr id="17" name="TextBox 16">
              <a:extLst>
                <a:ext uri="{FF2B5EF4-FFF2-40B4-BE49-F238E27FC236}">
                  <a16:creationId xmlns:a16="http://schemas.microsoft.com/office/drawing/2014/main" xmlns="" id="{8FEB6126-FAC6-BA77-BBAE-AA025CD63DAA}"/>
                </a:ext>
              </a:extLst>
            </p:cNvPr>
            <p:cNvSpPr txBox="1"/>
            <p:nvPr/>
          </p:nvSpPr>
          <p:spPr>
            <a:xfrm>
              <a:off x="147536" y="4343649"/>
              <a:ext cx="436294" cy="369332"/>
            </a:xfrm>
            <a:prstGeom prst="rect">
              <a:avLst/>
            </a:prstGeom>
            <a:noFill/>
          </p:spPr>
          <p:txBody>
            <a:bodyPr wrap="square" rtlCol="0">
              <a:spAutoFit/>
            </a:bodyPr>
            <a:lstStyle/>
            <a:p>
              <a:r>
                <a:rPr lang="en-AU" b="1" dirty="0"/>
                <a:t>C)</a:t>
              </a:r>
            </a:p>
          </p:txBody>
        </p:sp>
        <p:grpSp>
          <p:nvGrpSpPr>
            <p:cNvPr id="35" name="Group 34">
              <a:extLst>
                <a:ext uri="{FF2B5EF4-FFF2-40B4-BE49-F238E27FC236}">
                  <a16:creationId xmlns:a16="http://schemas.microsoft.com/office/drawing/2014/main" xmlns="" id="{16823DF0-C906-116E-9956-E353F8021C04}"/>
                </a:ext>
              </a:extLst>
            </p:cNvPr>
            <p:cNvGrpSpPr/>
            <p:nvPr/>
          </p:nvGrpSpPr>
          <p:grpSpPr>
            <a:xfrm>
              <a:off x="694332" y="4334758"/>
              <a:ext cx="8957464" cy="2456708"/>
              <a:chOff x="694332" y="4334758"/>
              <a:chExt cx="8957464" cy="2456708"/>
            </a:xfrm>
          </p:grpSpPr>
          <p:pic>
            <p:nvPicPr>
              <p:cNvPr id="34" name="Picture 33" descr="A screenshot of a graph&#10;&#10;Description automatically generated">
                <a:extLst>
                  <a:ext uri="{FF2B5EF4-FFF2-40B4-BE49-F238E27FC236}">
                    <a16:creationId xmlns:a16="http://schemas.microsoft.com/office/drawing/2014/main" xmlns="" id="{8DD1AB65-8065-B232-487A-26E7DDC8F700}"/>
                  </a:ext>
                </a:extLst>
              </p:cNvPr>
              <p:cNvPicPr>
                <a:picLocks noChangeAspect="1"/>
              </p:cNvPicPr>
              <p:nvPr/>
            </p:nvPicPr>
            <p:blipFill>
              <a:blip r:embed="rId7" cstate="print">
                <a:extLst>
                  <a:ext uri="{28A0092B-C50C-407E-A947-70E740481C1C}">
                    <a14:useLocalDpi xmlns:a14="http://schemas.microsoft.com/office/drawing/2010/main" val="0"/>
                  </a:ext>
                </a:extLst>
              </a:blip>
              <a:srcRect r="31027"/>
              <a:stretch/>
            </p:blipFill>
            <p:spPr>
              <a:xfrm>
                <a:off x="5793726" y="4334758"/>
                <a:ext cx="2557696" cy="2437200"/>
              </a:xfrm>
              <a:prstGeom prst="rect">
                <a:avLst/>
              </a:prstGeom>
            </p:spPr>
          </p:pic>
          <p:pic>
            <p:nvPicPr>
              <p:cNvPr id="30" name="Picture 29" descr="A screenshot of a graph&#10;&#10;Description automatically generated">
                <a:extLst>
                  <a:ext uri="{FF2B5EF4-FFF2-40B4-BE49-F238E27FC236}">
                    <a16:creationId xmlns:a16="http://schemas.microsoft.com/office/drawing/2014/main" xmlns="" id="{C4364322-7906-3279-1DB3-BEF002C6A9EC}"/>
                  </a:ext>
                </a:extLst>
              </p:cNvPr>
              <p:cNvPicPr>
                <a:picLocks noChangeAspect="1"/>
              </p:cNvPicPr>
              <p:nvPr/>
            </p:nvPicPr>
            <p:blipFill>
              <a:blip r:embed="rId8" cstate="print">
                <a:extLst>
                  <a:ext uri="{28A0092B-C50C-407E-A947-70E740481C1C}">
                    <a14:useLocalDpi xmlns:a14="http://schemas.microsoft.com/office/drawing/2010/main" val="0"/>
                  </a:ext>
                </a:extLst>
              </a:blip>
              <a:srcRect r="30233"/>
              <a:stretch/>
            </p:blipFill>
            <p:spPr>
              <a:xfrm>
                <a:off x="3229320" y="4344512"/>
                <a:ext cx="2587114" cy="2437200"/>
              </a:xfrm>
              <a:prstGeom prst="rect">
                <a:avLst/>
              </a:prstGeom>
            </p:spPr>
          </p:pic>
          <p:pic>
            <p:nvPicPr>
              <p:cNvPr id="23" name="Picture 22" descr="A screenshot of a graph&#10;&#10;Description automatically generated">
                <a:extLst>
                  <a:ext uri="{FF2B5EF4-FFF2-40B4-BE49-F238E27FC236}">
                    <a16:creationId xmlns:a16="http://schemas.microsoft.com/office/drawing/2014/main" xmlns="" id="{653BA792-3517-5B19-C805-F8F8353E2701}"/>
                  </a:ext>
                </a:extLst>
              </p:cNvPr>
              <p:cNvPicPr>
                <a:picLocks noChangeAspect="1"/>
              </p:cNvPicPr>
              <p:nvPr/>
            </p:nvPicPr>
            <p:blipFill>
              <a:blip r:embed="rId9" cstate="print">
                <a:extLst>
                  <a:ext uri="{28A0092B-C50C-407E-A947-70E740481C1C}">
                    <a14:useLocalDpi xmlns:a14="http://schemas.microsoft.com/office/drawing/2010/main" val="0"/>
                  </a:ext>
                </a:extLst>
              </a:blip>
              <a:srcRect r="31324"/>
              <a:stretch/>
            </p:blipFill>
            <p:spPr>
              <a:xfrm>
                <a:off x="694332" y="4355667"/>
                <a:ext cx="2545200" cy="2435799"/>
              </a:xfrm>
              <a:prstGeom prst="rect">
                <a:avLst/>
              </a:prstGeom>
            </p:spPr>
          </p:pic>
          <p:pic>
            <p:nvPicPr>
              <p:cNvPr id="33" name="Picture 32" descr="A screenshot of a graph&#10;&#10;Description automatically generated">
                <a:extLst>
                  <a:ext uri="{FF2B5EF4-FFF2-40B4-BE49-F238E27FC236}">
                    <a16:creationId xmlns:a16="http://schemas.microsoft.com/office/drawing/2014/main" xmlns="" id="{4DE0EFE5-C404-9E91-D273-DD079F4BBFDF}"/>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69890" t="-797" r="-854" b="23076"/>
              <a:stretch/>
            </p:blipFill>
            <p:spPr>
              <a:xfrm>
                <a:off x="8319790" y="4343649"/>
                <a:ext cx="1332006" cy="2273655"/>
              </a:xfrm>
              <a:prstGeom prst="rect">
                <a:avLst/>
              </a:prstGeom>
            </p:spPr>
          </p:pic>
        </p:grpSp>
      </p:grpSp>
      <p:sp>
        <p:nvSpPr>
          <p:cNvPr id="42" name="Title 3">
            <a:extLst>
              <a:ext uri="{FF2B5EF4-FFF2-40B4-BE49-F238E27FC236}">
                <a16:creationId xmlns:a16="http://schemas.microsoft.com/office/drawing/2014/main" xmlns="" id="{4A282469-FAA5-937A-2BDF-0926B2D76ECC}"/>
              </a:ext>
            </a:extLst>
          </p:cNvPr>
          <p:cNvSpPr txBox="1">
            <a:spLocks/>
          </p:cNvSpPr>
          <p:nvPr/>
        </p:nvSpPr>
        <p:spPr>
          <a:xfrm>
            <a:off x="10110651" y="32276"/>
            <a:ext cx="2081349"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S3</a:t>
            </a:r>
          </a:p>
        </p:txBody>
      </p:sp>
    </p:spTree>
    <p:extLst>
      <p:ext uri="{BB962C8B-B14F-4D97-AF65-F5344CB8AC3E}">
        <p14:creationId xmlns:p14="http://schemas.microsoft.com/office/powerpoint/2010/main" val="8765068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52F78774-889B-F08A-AA39-80D35E31F367}"/>
            </a:ext>
          </a:extLst>
        </p:cNvPr>
        <p:cNvGrpSpPr/>
        <p:nvPr/>
      </p:nvGrpSpPr>
      <p:grpSpPr>
        <a:xfrm>
          <a:off x="0" y="0"/>
          <a:ext cx="0" cy="0"/>
          <a:chOff x="0" y="0"/>
          <a:chExt cx="0" cy="0"/>
        </a:xfrm>
      </p:grpSpPr>
      <p:pic>
        <p:nvPicPr>
          <p:cNvPr id="10" name="Picture 9" descr="A screen shot of a computer screen&#10;&#10;Description automatically generated">
            <a:extLst>
              <a:ext uri="{FF2B5EF4-FFF2-40B4-BE49-F238E27FC236}">
                <a16:creationId xmlns:a16="http://schemas.microsoft.com/office/drawing/2014/main" xmlns="" id="{8BFF8798-A4AC-4E6B-E244-49F1C851A1C9}"/>
              </a:ext>
            </a:extLst>
          </p:cNvPr>
          <p:cNvPicPr>
            <a:picLocks noChangeAspect="1"/>
          </p:cNvPicPr>
          <p:nvPr/>
        </p:nvPicPr>
        <p:blipFill>
          <a:blip r:embed="rId3" cstate="print">
            <a:extLst>
              <a:ext uri="{28A0092B-C50C-407E-A947-70E740481C1C}">
                <a14:useLocalDpi xmlns:a14="http://schemas.microsoft.com/office/drawing/2010/main" val="0"/>
              </a:ext>
            </a:extLst>
          </a:blip>
          <a:srcRect l="15727" t="20173" r="27474" b="786"/>
          <a:stretch/>
        </p:blipFill>
        <p:spPr>
          <a:xfrm>
            <a:off x="672552" y="51422"/>
            <a:ext cx="3466800" cy="4312670"/>
          </a:xfrm>
          <a:prstGeom prst="rect">
            <a:avLst/>
          </a:prstGeom>
        </p:spPr>
      </p:pic>
      <p:pic>
        <p:nvPicPr>
          <p:cNvPr id="6" name="Picture 5" descr="A screen shot of a computer screen&#10;&#10;Description automatically generated">
            <a:extLst>
              <a:ext uri="{FF2B5EF4-FFF2-40B4-BE49-F238E27FC236}">
                <a16:creationId xmlns:a16="http://schemas.microsoft.com/office/drawing/2014/main" xmlns="" id="{21594CED-7EA0-55E8-0DCA-D6978950A065}"/>
              </a:ext>
            </a:extLst>
          </p:cNvPr>
          <p:cNvPicPr>
            <a:picLocks noChangeAspect="1"/>
          </p:cNvPicPr>
          <p:nvPr/>
        </p:nvPicPr>
        <p:blipFill>
          <a:blip r:embed="rId4" cstate="print">
            <a:extLst>
              <a:ext uri="{28A0092B-C50C-407E-A947-70E740481C1C}">
                <a14:useLocalDpi xmlns:a14="http://schemas.microsoft.com/office/drawing/2010/main" val="0"/>
              </a:ext>
            </a:extLst>
          </a:blip>
          <a:srcRect l="15082" t="17105" r="28621" b="19250"/>
          <a:stretch/>
        </p:blipFill>
        <p:spPr>
          <a:xfrm>
            <a:off x="5986347" y="53919"/>
            <a:ext cx="3494444" cy="3470400"/>
          </a:xfrm>
          <a:prstGeom prst="rect">
            <a:avLst/>
          </a:prstGeom>
        </p:spPr>
      </p:pic>
      <p:sp>
        <p:nvSpPr>
          <p:cNvPr id="15" name="TextBox 14">
            <a:extLst>
              <a:ext uri="{FF2B5EF4-FFF2-40B4-BE49-F238E27FC236}">
                <a16:creationId xmlns:a16="http://schemas.microsoft.com/office/drawing/2014/main" xmlns="" id="{F1F913F5-E49D-B9FD-3AB8-1AB61B51C40D}"/>
              </a:ext>
            </a:extLst>
          </p:cNvPr>
          <p:cNvSpPr txBox="1"/>
          <p:nvPr/>
        </p:nvSpPr>
        <p:spPr>
          <a:xfrm>
            <a:off x="147536" y="-44858"/>
            <a:ext cx="436294" cy="369332"/>
          </a:xfrm>
          <a:prstGeom prst="rect">
            <a:avLst/>
          </a:prstGeom>
          <a:noFill/>
        </p:spPr>
        <p:txBody>
          <a:bodyPr wrap="square" rtlCol="0">
            <a:spAutoFit/>
          </a:bodyPr>
          <a:lstStyle/>
          <a:p>
            <a:r>
              <a:rPr lang="en-AU" b="1" dirty="0"/>
              <a:t>A)</a:t>
            </a:r>
          </a:p>
        </p:txBody>
      </p:sp>
      <p:sp>
        <p:nvSpPr>
          <p:cNvPr id="16" name="TextBox 15">
            <a:extLst>
              <a:ext uri="{FF2B5EF4-FFF2-40B4-BE49-F238E27FC236}">
                <a16:creationId xmlns:a16="http://schemas.microsoft.com/office/drawing/2014/main" xmlns="" id="{B8170AAF-A1E4-F938-4DD9-DABD2927ED0D}"/>
              </a:ext>
            </a:extLst>
          </p:cNvPr>
          <p:cNvSpPr txBox="1"/>
          <p:nvPr/>
        </p:nvSpPr>
        <p:spPr>
          <a:xfrm>
            <a:off x="5590397" y="-44858"/>
            <a:ext cx="391334" cy="369332"/>
          </a:xfrm>
          <a:prstGeom prst="rect">
            <a:avLst/>
          </a:prstGeom>
          <a:noFill/>
        </p:spPr>
        <p:txBody>
          <a:bodyPr wrap="square" rtlCol="0">
            <a:spAutoFit/>
          </a:bodyPr>
          <a:lstStyle/>
          <a:p>
            <a:r>
              <a:rPr lang="en-AU" b="1" dirty="0"/>
              <a:t>B)</a:t>
            </a:r>
          </a:p>
        </p:txBody>
      </p:sp>
      <p:sp>
        <p:nvSpPr>
          <p:cNvPr id="17" name="TextBox 16">
            <a:extLst>
              <a:ext uri="{FF2B5EF4-FFF2-40B4-BE49-F238E27FC236}">
                <a16:creationId xmlns:a16="http://schemas.microsoft.com/office/drawing/2014/main" xmlns="" id="{EEDB2A39-D908-0551-F1F8-7D43DDDEA7D4}"/>
              </a:ext>
            </a:extLst>
          </p:cNvPr>
          <p:cNvSpPr txBox="1"/>
          <p:nvPr/>
        </p:nvSpPr>
        <p:spPr>
          <a:xfrm>
            <a:off x="147536" y="4343649"/>
            <a:ext cx="436294" cy="369332"/>
          </a:xfrm>
          <a:prstGeom prst="rect">
            <a:avLst/>
          </a:prstGeom>
          <a:noFill/>
        </p:spPr>
        <p:txBody>
          <a:bodyPr wrap="square" rtlCol="0">
            <a:spAutoFit/>
          </a:bodyPr>
          <a:lstStyle/>
          <a:p>
            <a:r>
              <a:rPr lang="en-AU" b="1" dirty="0"/>
              <a:t>C)</a:t>
            </a:r>
          </a:p>
        </p:txBody>
      </p:sp>
      <p:grpSp>
        <p:nvGrpSpPr>
          <p:cNvPr id="28" name="Group 27">
            <a:extLst>
              <a:ext uri="{FF2B5EF4-FFF2-40B4-BE49-F238E27FC236}">
                <a16:creationId xmlns:a16="http://schemas.microsoft.com/office/drawing/2014/main" xmlns="" id="{7F9B5729-EC8D-9E74-0D64-28FC781731DF}"/>
              </a:ext>
            </a:extLst>
          </p:cNvPr>
          <p:cNvGrpSpPr/>
          <p:nvPr/>
        </p:nvGrpSpPr>
        <p:grpSpPr>
          <a:xfrm>
            <a:off x="729687" y="51422"/>
            <a:ext cx="10097679" cy="6760442"/>
            <a:chOff x="729687" y="51422"/>
            <a:chExt cx="10097679" cy="6760442"/>
          </a:xfrm>
        </p:grpSpPr>
        <p:pic>
          <p:nvPicPr>
            <p:cNvPr id="27" name="Picture 26" descr="A screenshot of a graph&#10;&#10;Description automatically generated">
              <a:extLst>
                <a:ext uri="{FF2B5EF4-FFF2-40B4-BE49-F238E27FC236}">
                  <a16:creationId xmlns:a16="http://schemas.microsoft.com/office/drawing/2014/main" xmlns="" id="{87906B06-1FA1-4F40-5DD5-DF3B256BFA80}"/>
                </a:ext>
              </a:extLst>
            </p:cNvPr>
            <p:cNvPicPr>
              <a:picLocks noChangeAspect="1"/>
            </p:cNvPicPr>
            <p:nvPr/>
          </p:nvPicPr>
          <p:blipFill>
            <a:blip r:embed="rId5" cstate="print">
              <a:extLst>
                <a:ext uri="{28A0092B-C50C-407E-A947-70E740481C1C}">
                  <a14:useLocalDpi xmlns:a14="http://schemas.microsoft.com/office/drawing/2010/main" val="0"/>
                </a:ext>
              </a:extLst>
            </a:blip>
            <a:srcRect r="30825"/>
            <a:stretch/>
          </p:blipFill>
          <p:spPr>
            <a:xfrm>
              <a:off x="5801803" y="4374664"/>
              <a:ext cx="2562182" cy="2437200"/>
            </a:xfrm>
            <a:prstGeom prst="rect">
              <a:avLst/>
            </a:prstGeom>
          </p:spPr>
        </p:pic>
        <p:pic>
          <p:nvPicPr>
            <p:cNvPr id="25" name="Picture 24" descr="A screenshot of a graph&#10;&#10;Description automatically generated">
              <a:extLst>
                <a:ext uri="{FF2B5EF4-FFF2-40B4-BE49-F238E27FC236}">
                  <a16:creationId xmlns:a16="http://schemas.microsoft.com/office/drawing/2014/main" xmlns="" id="{1603CC21-0953-756C-2933-87B5A86D0EAA}"/>
                </a:ext>
              </a:extLst>
            </p:cNvPr>
            <p:cNvPicPr>
              <a:picLocks noChangeAspect="1"/>
            </p:cNvPicPr>
            <p:nvPr/>
          </p:nvPicPr>
          <p:blipFill>
            <a:blip r:embed="rId6" cstate="print">
              <a:extLst>
                <a:ext uri="{28A0092B-C50C-407E-A947-70E740481C1C}">
                  <a14:useLocalDpi xmlns:a14="http://schemas.microsoft.com/office/drawing/2010/main" val="0"/>
                </a:ext>
              </a:extLst>
            </a:blip>
            <a:srcRect r="31145"/>
            <a:stretch/>
          </p:blipFill>
          <p:spPr>
            <a:xfrm>
              <a:off x="3275871" y="4369378"/>
              <a:ext cx="2550300" cy="2437200"/>
            </a:xfrm>
            <a:prstGeom prst="rect">
              <a:avLst/>
            </a:prstGeom>
          </p:spPr>
        </p:pic>
        <p:pic>
          <p:nvPicPr>
            <p:cNvPr id="14" name="Picture 13" descr="A screenshot of a graph&#10;&#10;Description automatically generated">
              <a:extLst>
                <a:ext uri="{FF2B5EF4-FFF2-40B4-BE49-F238E27FC236}">
                  <a16:creationId xmlns:a16="http://schemas.microsoft.com/office/drawing/2014/main" xmlns="" id="{C6FA936F-721B-8C1F-0E33-2C1EC2E4351E}"/>
                </a:ext>
              </a:extLst>
            </p:cNvPr>
            <p:cNvPicPr>
              <a:picLocks noChangeAspect="1"/>
            </p:cNvPicPr>
            <p:nvPr/>
          </p:nvPicPr>
          <p:blipFill>
            <a:blip r:embed="rId7" cstate="print">
              <a:extLst>
                <a:ext uri="{28A0092B-C50C-407E-A947-70E740481C1C}">
                  <a14:useLocalDpi xmlns:a14="http://schemas.microsoft.com/office/drawing/2010/main" val="0"/>
                </a:ext>
              </a:extLst>
            </a:blip>
            <a:srcRect r="31466"/>
            <a:stretch/>
          </p:blipFill>
          <p:spPr>
            <a:xfrm>
              <a:off x="729687" y="4369378"/>
              <a:ext cx="2541388" cy="2437200"/>
            </a:xfrm>
            <a:prstGeom prst="rect">
              <a:avLst/>
            </a:prstGeom>
          </p:spPr>
        </p:pic>
        <p:grpSp>
          <p:nvGrpSpPr>
            <p:cNvPr id="24" name="Group 23">
              <a:extLst>
                <a:ext uri="{FF2B5EF4-FFF2-40B4-BE49-F238E27FC236}">
                  <a16:creationId xmlns:a16="http://schemas.microsoft.com/office/drawing/2014/main" xmlns="" id="{753E0260-6AE8-F432-6754-594FCEDE9D6E}"/>
                </a:ext>
              </a:extLst>
            </p:cNvPr>
            <p:cNvGrpSpPr/>
            <p:nvPr/>
          </p:nvGrpSpPr>
          <p:grpSpPr>
            <a:xfrm>
              <a:off x="4141979" y="51422"/>
              <a:ext cx="6685387" cy="6565882"/>
              <a:chOff x="4141979" y="51422"/>
              <a:chExt cx="6685387" cy="6565882"/>
            </a:xfrm>
          </p:grpSpPr>
          <p:grpSp>
            <p:nvGrpSpPr>
              <p:cNvPr id="3" name="Group 2">
                <a:extLst>
                  <a:ext uri="{FF2B5EF4-FFF2-40B4-BE49-F238E27FC236}">
                    <a16:creationId xmlns:a16="http://schemas.microsoft.com/office/drawing/2014/main" xmlns="" id="{F69EC248-A56E-C4D8-CC98-6BBB47ABAE48}"/>
                  </a:ext>
                </a:extLst>
              </p:cNvPr>
              <p:cNvGrpSpPr/>
              <p:nvPr/>
            </p:nvGrpSpPr>
            <p:grpSpPr>
              <a:xfrm>
                <a:off x="6031868" y="51422"/>
                <a:ext cx="4795498" cy="4276524"/>
                <a:chOff x="6031868" y="51422"/>
                <a:chExt cx="4795498" cy="4276524"/>
              </a:xfrm>
            </p:grpSpPr>
            <p:pic>
              <p:nvPicPr>
                <p:cNvPr id="13" name="Picture 12" descr="A yellow and blue squares&#10;&#10;Description automatically generated">
                  <a:extLst>
                    <a:ext uri="{FF2B5EF4-FFF2-40B4-BE49-F238E27FC236}">
                      <a16:creationId xmlns:a16="http://schemas.microsoft.com/office/drawing/2014/main" xmlns="" id="{12E6280F-03CD-B61E-BA21-40FB239B1AC0}"/>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73801" t="14375" r="-159" b="70986"/>
                <a:stretch/>
              </p:blipFill>
              <p:spPr>
                <a:xfrm>
                  <a:off x="9483881" y="511720"/>
                  <a:ext cx="1343485" cy="637954"/>
                </a:xfrm>
                <a:prstGeom prst="rect">
                  <a:avLst/>
                </a:prstGeom>
              </p:spPr>
            </p:pic>
            <p:pic>
              <p:nvPicPr>
                <p:cNvPr id="18" name="Picture 17" descr="A close-up of a screen&#10;&#10;Description automatically generated">
                  <a:extLst>
                    <a:ext uri="{FF2B5EF4-FFF2-40B4-BE49-F238E27FC236}">
                      <a16:creationId xmlns:a16="http://schemas.microsoft.com/office/drawing/2014/main" xmlns="" id="{B6FCC32D-6174-37D8-56E5-C7DAF0F57079}"/>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69860" t="1086" r="10467" b="89353"/>
                <a:stretch/>
              </p:blipFill>
              <p:spPr>
                <a:xfrm>
                  <a:off x="9480791" y="51422"/>
                  <a:ext cx="993713" cy="407962"/>
                </a:xfrm>
                <a:prstGeom prst="rect">
                  <a:avLst/>
                </a:prstGeom>
              </p:spPr>
            </p:pic>
            <p:pic>
              <p:nvPicPr>
                <p:cNvPr id="23" name="Picture 22" descr="A yellow and blue squares&#10;&#10;Description automatically generated">
                  <a:extLst>
                    <a:ext uri="{FF2B5EF4-FFF2-40B4-BE49-F238E27FC236}">
                      <a16:creationId xmlns:a16="http://schemas.microsoft.com/office/drawing/2014/main" xmlns="" id="{CD0C0CA0-6F74-896D-02C6-0BEF74B720AF}"/>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456" t="81785" r="91508" b="-22"/>
                <a:stretch/>
              </p:blipFill>
              <p:spPr>
                <a:xfrm>
                  <a:off x="6031868" y="3533090"/>
                  <a:ext cx="358589" cy="794856"/>
                </a:xfrm>
                <a:prstGeom prst="rect">
                  <a:avLst/>
                </a:prstGeom>
              </p:spPr>
            </p:pic>
          </p:grpSp>
          <p:grpSp>
            <p:nvGrpSpPr>
              <p:cNvPr id="42" name="Group 41">
                <a:extLst>
                  <a:ext uri="{FF2B5EF4-FFF2-40B4-BE49-F238E27FC236}">
                    <a16:creationId xmlns:a16="http://schemas.microsoft.com/office/drawing/2014/main" xmlns="" id="{A19CA5D8-1E6C-E19D-39B2-73C56AE31699}"/>
                  </a:ext>
                </a:extLst>
              </p:cNvPr>
              <p:cNvGrpSpPr/>
              <p:nvPr/>
            </p:nvGrpSpPr>
            <p:grpSpPr>
              <a:xfrm>
                <a:off x="4141979" y="113390"/>
                <a:ext cx="1571657" cy="3595140"/>
                <a:chOff x="4141979" y="113390"/>
                <a:chExt cx="1571657" cy="3595140"/>
              </a:xfrm>
            </p:grpSpPr>
            <p:pic>
              <p:nvPicPr>
                <p:cNvPr id="41" name="Picture 40" descr="A close-up of a chart&#10;&#10;Description automatically generated">
                  <a:extLst>
                    <a:ext uri="{FF2B5EF4-FFF2-40B4-BE49-F238E27FC236}">
                      <a16:creationId xmlns:a16="http://schemas.microsoft.com/office/drawing/2014/main" xmlns="" id="{93C8A674-EAE5-3265-A053-1449030A8A12}"/>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80182" t="28690" r="107" b="59880"/>
                <a:stretch/>
              </p:blipFill>
              <p:spPr>
                <a:xfrm>
                  <a:off x="4156750" y="569430"/>
                  <a:ext cx="1165411" cy="603624"/>
                </a:xfrm>
                <a:prstGeom prst="rect">
                  <a:avLst/>
                </a:prstGeom>
              </p:spPr>
            </p:pic>
            <p:pic>
              <p:nvPicPr>
                <p:cNvPr id="7" name="Picture 6" descr="A close-up of a screen&#10;&#10;Description automatically generated">
                  <a:extLst>
                    <a:ext uri="{FF2B5EF4-FFF2-40B4-BE49-F238E27FC236}">
                      <a16:creationId xmlns:a16="http://schemas.microsoft.com/office/drawing/2014/main" xmlns="" id="{5A5BC612-2FEE-672A-D6AD-C65DB6B1E104}"/>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76387" t="24424" r="-5" b="20996"/>
                <a:stretch/>
              </p:blipFill>
              <p:spPr>
                <a:xfrm>
                  <a:off x="4490090" y="1320167"/>
                  <a:ext cx="1223546" cy="2388363"/>
                </a:xfrm>
                <a:prstGeom prst="rect">
                  <a:avLst/>
                </a:prstGeom>
              </p:spPr>
            </p:pic>
            <p:pic>
              <p:nvPicPr>
                <p:cNvPr id="8" name="Picture 7" descr="A close-up of a screen&#10;&#10;Description automatically generated">
                  <a:extLst>
                    <a:ext uri="{FF2B5EF4-FFF2-40B4-BE49-F238E27FC236}">
                      <a16:creationId xmlns:a16="http://schemas.microsoft.com/office/drawing/2014/main" xmlns="" id="{5481FF5D-743D-A976-F22E-652FB83A7FE6}"/>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69860" t="1086" r="10467" b="89353"/>
                <a:stretch/>
              </p:blipFill>
              <p:spPr>
                <a:xfrm>
                  <a:off x="4141979" y="113390"/>
                  <a:ext cx="985425" cy="404559"/>
                </a:xfrm>
                <a:prstGeom prst="rect">
                  <a:avLst/>
                </a:prstGeom>
              </p:spPr>
            </p:pic>
          </p:grpSp>
          <p:pic>
            <p:nvPicPr>
              <p:cNvPr id="33" name="Picture 32" descr="A screenshot of a graph&#10;&#10;Description automatically generated">
                <a:extLst>
                  <a:ext uri="{FF2B5EF4-FFF2-40B4-BE49-F238E27FC236}">
                    <a16:creationId xmlns:a16="http://schemas.microsoft.com/office/drawing/2014/main" xmlns="" id="{99F7FD2A-C0A7-0AC6-75B9-B535450CD8A4}"/>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69890" t="-797" r="-854" b="23076"/>
              <a:stretch/>
            </p:blipFill>
            <p:spPr>
              <a:xfrm>
                <a:off x="8319790" y="4343649"/>
                <a:ext cx="1332006" cy="2273655"/>
              </a:xfrm>
              <a:prstGeom prst="rect">
                <a:avLst/>
              </a:prstGeom>
            </p:spPr>
          </p:pic>
        </p:grpSp>
      </p:grpSp>
      <p:sp>
        <p:nvSpPr>
          <p:cNvPr id="31" name="Title 3">
            <a:extLst>
              <a:ext uri="{FF2B5EF4-FFF2-40B4-BE49-F238E27FC236}">
                <a16:creationId xmlns:a16="http://schemas.microsoft.com/office/drawing/2014/main" xmlns="" id="{D77C69F7-7855-1AB1-0DD5-293AB55D047E}"/>
              </a:ext>
            </a:extLst>
          </p:cNvPr>
          <p:cNvSpPr txBox="1">
            <a:spLocks/>
          </p:cNvSpPr>
          <p:nvPr/>
        </p:nvSpPr>
        <p:spPr>
          <a:xfrm>
            <a:off x="10110651" y="32276"/>
            <a:ext cx="2081349"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S4</a:t>
            </a:r>
          </a:p>
        </p:txBody>
      </p:sp>
    </p:spTree>
    <p:extLst>
      <p:ext uri="{BB962C8B-B14F-4D97-AF65-F5344CB8AC3E}">
        <p14:creationId xmlns:p14="http://schemas.microsoft.com/office/powerpoint/2010/main" val="18387338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2A4BB05B-70FD-F6D7-AF5F-B3514BDA454B}"/>
            </a:ext>
          </a:extLst>
        </p:cNvPr>
        <p:cNvGrpSpPr/>
        <p:nvPr/>
      </p:nvGrpSpPr>
      <p:grpSpPr>
        <a:xfrm>
          <a:off x="0" y="0"/>
          <a:ext cx="0" cy="0"/>
          <a:chOff x="0" y="0"/>
          <a:chExt cx="0" cy="0"/>
        </a:xfrm>
      </p:grpSpPr>
      <p:pic>
        <p:nvPicPr>
          <p:cNvPr id="26" name="Picture 25" descr="A group of rows of colorful lines&#10;&#10;Description automatically generated with medium confidence">
            <a:extLst>
              <a:ext uri="{FF2B5EF4-FFF2-40B4-BE49-F238E27FC236}">
                <a16:creationId xmlns:a16="http://schemas.microsoft.com/office/drawing/2014/main" xmlns="" id="{B77D5203-6E37-1FDE-3322-CC6A7AAB2301}"/>
              </a:ext>
            </a:extLst>
          </p:cNvPr>
          <p:cNvPicPr>
            <a:picLocks noChangeAspect="1"/>
          </p:cNvPicPr>
          <p:nvPr/>
        </p:nvPicPr>
        <p:blipFill>
          <a:blip r:embed="rId3" cstate="print">
            <a:extLst>
              <a:ext uri="{28A0092B-C50C-407E-A947-70E740481C1C}">
                <a14:useLocalDpi xmlns:a14="http://schemas.microsoft.com/office/drawing/2010/main" val="0"/>
              </a:ext>
            </a:extLst>
          </a:blip>
          <a:srcRect l="2708" t="2233" r="2084" b="4911"/>
          <a:stretch/>
        </p:blipFill>
        <p:spPr>
          <a:xfrm>
            <a:off x="1307796" y="160058"/>
            <a:ext cx="9576408" cy="6537884"/>
          </a:xfrm>
          <a:prstGeom prst="rect">
            <a:avLst/>
          </a:prstGeom>
        </p:spPr>
      </p:pic>
      <p:sp>
        <p:nvSpPr>
          <p:cNvPr id="28" name="Title 3">
            <a:extLst>
              <a:ext uri="{FF2B5EF4-FFF2-40B4-BE49-F238E27FC236}">
                <a16:creationId xmlns:a16="http://schemas.microsoft.com/office/drawing/2014/main" xmlns="" id="{A47900C7-3793-59F4-FB48-D8D1119E9812}"/>
              </a:ext>
            </a:extLst>
          </p:cNvPr>
          <p:cNvSpPr txBox="1">
            <a:spLocks/>
          </p:cNvSpPr>
          <p:nvPr/>
        </p:nvSpPr>
        <p:spPr>
          <a:xfrm>
            <a:off x="10110651" y="32276"/>
            <a:ext cx="2081349"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S5</a:t>
            </a:r>
          </a:p>
        </p:txBody>
      </p:sp>
    </p:spTree>
    <p:extLst>
      <p:ext uri="{BB962C8B-B14F-4D97-AF65-F5344CB8AC3E}">
        <p14:creationId xmlns:p14="http://schemas.microsoft.com/office/powerpoint/2010/main" val="28040189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xmlns="" id="{6711406F-B061-8CCB-7673-205F212CC49B}"/>
              </a:ext>
            </a:extLst>
          </p:cNvPr>
          <p:cNvGrpSpPr/>
          <p:nvPr/>
        </p:nvGrpSpPr>
        <p:grpSpPr>
          <a:xfrm>
            <a:off x="1060780" y="2021911"/>
            <a:ext cx="10070440" cy="2814178"/>
            <a:chOff x="1060780" y="1178314"/>
            <a:chExt cx="10070440" cy="2814178"/>
          </a:xfrm>
        </p:grpSpPr>
        <p:pic>
          <p:nvPicPr>
            <p:cNvPr id="5" name="Picture 4" descr="A picture containing text, font, line, diagram&#10;&#10;Description automatically generated">
              <a:extLst>
                <a:ext uri="{FF2B5EF4-FFF2-40B4-BE49-F238E27FC236}">
                  <a16:creationId xmlns:a16="http://schemas.microsoft.com/office/drawing/2014/main" xmlns="" id="{D36646BF-0A66-2B37-8F5F-42D545FD97C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60780" y="1202962"/>
              <a:ext cx="10070440" cy="2789530"/>
            </a:xfrm>
            <a:prstGeom prst="rect">
              <a:avLst/>
            </a:prstGeom>
          </p:spPr>
        </p:pic>
        <p:grpSp>
          <p:nvGrpSpPr>
            <p:cNvPr id="11" name="Group 10">
              <a:extLst>
                <a:ext uri="{FF2B5EF4-FFF2-40B4-BE49-F238E27FC236}">
                  <a16:creationId xmlns:a16="http://schemas.microsoft.com/office/drawing/2014/main" xmlns="" id="{60ABBE3B-88B5-809E-6E50-189478EC83A9}"/>
                </a:ext>
              </a:extLst>
            </p:cNvPr>
            <p:cNvGrpSpPr/>
            <p:nvPr/>
          </p:nvGrpSpPr>
          <p:grpSpPr>
            <a:xfrm>
              <a:off x="1116582" y="1178314"/>
              <a:ext cx="6862249" cy="399390"/>
              <a:chOff x="795948" y="2009587"/>
              <a:chExt cx="6862249" cy="399390"/>
            </a:xfrm>
          </p:grpSpPr>
          <p:sp>
            <p:nvSpPr>
              <p:cNvPr id="7" name="TextBox 6">
                <a:extLst>
                  <a:ext uri="{FF2B5EF4-FFF2-40B4-BE49-F238E27FC236}">
                    <a16:creationId xmlns:a16="http://schemas.microsoft.com/office/drawing/2014/main" xmlns="" id="{58E80A0B-A374-05D8-EA3F-2268E42743CE}"/>
                  </a:ext>
                </a:extLst>
              </p:cNvPr>
              <p:cNvSpPr txBox="1"/>
              <p:nvPr/>
            </p:nvSpPr>
            <p:spPr>
              <a:xfrm>
                <a:off x="795948" y="2009587"/>
                <a:ext cx="436294" cy="369332"/>
              </a:xfrm>
              <a:prstGeom prst="rect">
                <a:avLst/>
              </a:prstGeom>
              <a:noFill/>
            </p:spPr>
            <p:txBody>
              <a:bodyPr wrap="square" rtlCol="0">
                <a:spAutoFit/>
              </a:bodyPr>
              <a:lstStyle/>
              <a:p>
                <a:r>
                  <a:rPr lang="en-AU" b="1" dirty="0"/>
                  <a:t>A)</a:t>
                </a:r>
              </a:p>
            </p:txBody>
          </p:sp>
          <p:sp>
            <p:nvSpPr>
              <p:cNvPr id="8" name="TextBox 7">
                <a:extLst>
                  <a:ext uri="{FF2B5EF4-FFF2-40B4-BE49-F238E27FC236}">
                    <a16:creationId xmlns:a16="http://schemas.microsoft.com/office/drawing/2014/main" xmlns="" id="{655FFA7C-E3AE-C641-5AA7-BA17A5ABEA69}"/>
                  </a:ext>
                </a:extLst>
              </p:cNvPr>
              <p:cNvSpPr txBox="1"/>
              <p:nvPr/>
            </p:nvSpPr>
            <p:spPr>
              <a:xfrm>
                <a:off x="3947889" y="2009587"/>
                <a:ext cx="436294" cy="369332"/>
              </a:xfrm>
              <a:prstGeom prst="rect">
                <a:avLst/>
              </a:prstGeom>
              <a:noFill/>
            </p:spPr>
            <p:txBody>
              <a:bodyPr wrap="square" rtlCol="0">
                <a:spAutoFit/>
              </a:bodyPr>
              <a:lstStyle/>
              <a:p>
                <a:r>
                  <a:rPr lang="en-AU" b="1" dirty="0"/>
                  <a:t>B)</a:t>
                </a:r>
              </a:p>
            </p:txBody>
          </p:sp>
          <p:sp>
            <p:nvSpPr>
              <p:cNvPr id="9" name="TextBox 8">
                <a:extLst>
                  <a:ext uri="{FF2B5EF4-FFF2-40B4-BE49-F238E27FC236}">
                    <a16:creationId xmlns:a16="http://schemas.microsoft.com/office/drawing/2014/main" xmlns="" id="{33BAF9EB-3B1C-6C5D-394B-45E6CE90B6E4}"/>
                  </a:ext>
                </a:extLst>
              </p:cNvPr>
              <p:cNvSpPr txBox="1"/>
              <p:nvPr/>
            </p:nvSpPr>
            <p:spPr>
              <a:xfrm>
                <a:off x="7221903" y="2039645"/>
                <a:ext cx="436294" cy="369332"/>
              </a:xfrm>
              <a:prstGeom prst="rect">
                <a:avLst/>
              </a:prstGeom>
              <a:noFill/>
            </p:spPr>
            <p:txBody>
              <a:bodyPr wrap="square" rtlCol="0">
                <a:spAutoFit/>
              </a:bodyPr>
              <a:lstStyle/>
              <a:p>
                <a:r>
                  <a:rPr lang="en-AU" b="1" dirty="0"/>
                  <a:t>C)</a:t>
                </a:r>
              </a:p>
            </p:txBody>
          </p:sp>
        </p:grpSp>
      </p:grpSp>
      <p:sp>
        <p:nvSpPr>
          <p:cNvPr id="2" name="Title 3">
            <a:extLst>
              <a:ext uri="{FF2B5EF4-FFF2-40B4-BE49-F238E27FC236}">
                <a16:creationId xmlns:a16="http://schemas.microsoft.com/office/drawing/2014/main" xmlns="" id="{4871C192-E8C2-9607-A8D4-C3DEBF59FEF8}"/>
              </a:ext>
            </a:extLst>
          </p:cNvPr>
          <p:cNvSpPr txBox="1">
            <a:spLocks/>
          </p:cNvSpPr>
          <p:nvPr/>
        </p:nvSpPr>
        <p:spPr>
          <a:xfrm>
            <a:off x="10110651" y="32276"/>
            <a:ext cx="2081349"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S6</a:t>
            </a:r>
          </a:p>
        </p:txBody>
      </p:sp>
    </p:spTree>
    <p:extLst>
      <p:ext uri="{BB962C8B-B14F-4D97-AF65-F5344CB8AC3E}">
        <p14:creationId xmlns:p14="http://schemas.microsoft.com/office/powerpoint/2010/main" val="12144624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 name="Picture 56" descr="A group of colorful lines&#10;&#10;Description automatically generated with medium confidence">
            <a:extLst>
              <a:ext uri="{FF2B5EF4-FFF2-40B4-BE49-F238E27FC236}">
                <a16:creationId xmlns:a16="http://schemas.microsoft.com/office/drawing/2014/main" xmlns="" id="{482FEB16-E586-6ADA-B4B3-3BB4D017B49C}"/>
              </a:ext>
            </a:extLst>
          </p:cNvPr>
          <p:cNvPicPr>
            <a:picLocks noChangeAspect="1"/>
          </p:cNvPicPr>
          <p:nvPr/>
        </p:nvPicPr>
        <p:blipFill>
          <a:blip r:embed="rId3" cstate="print">
            <a:extLst>
              <a:ext uri="{28A0092B-C50C-407E-A947-70E740481C1C}">
                <a14:useLocalDpi xmlns:a14="http://schemas.microsoft.com/office/drawing/2010/main" val="0"/>
              </a:ext>
            </a:extLst>
          </a:blip>
          <a:srcRect l="1874" t="1636" r="2292" b="4911"/>
          <a:stretch/>
        </p:blipFill>
        <p:spPr>
          <a:xfrm>
            <a:off x="1276313" y="139042"/>
            <a:ext cx="9639374" cy="6579917"/>
          </a:xfrm>
          <a:prstGeom prst="rect">
            <a:avLst/>
          </a:prstGeom>
        </p:spPr>
      </p:pic>
      <p:sp>
        <p:nvSpPr>
          <p:cNvPr id="58" name="Title 3">
            <a:extLst>
              <a:ext uri="{FF2B5EF4-FFF2-40B4-BE49-F238E27FC236}">
                <a16:creationId xmlns:a16="http://schemas.microsoft.com/office/drawing/2014/main" xmlns="" id="{0B2916CC-356A-289E-4326-035D690B21D1}"/>
              </a:ext>
            </a:extLst>
          </p:cNvPr>
          <p:cNvSpPr txBox="1">
            <a:spLocks/>
          </p:cNvSpPr>
          <p:nvPr/>
        </p:nvSpPr>
        <p:spPr>
          <a:xfrm>
            <a:off x="10110651" y="32276"/>
            <a:ext cx="2081349"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S7</a:t>
            </a:r>
          </a:p>
        </p:txBody>
      </p:sp>
    </p:spTree>
    <p:extLst>
      <p:ext uri="{BB962C8B-B14F-4D97-AF65-F5344CB8AC3E}">
        <p14:creationId xmlns:p14="http://schemas.microsoft.com/office/powerpoint/2010/main" val="26549495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xmlns="" id="{1A088499-8EC5-ABAA-4D56-450662D1F3D3}"/>
              </a:ext>
            </a:extLst>
          </p:cNvPr>
          <p:cNvGrpSpPr/>
          <p:nvPr/>
        </p:nvGrpSpPr>
        <p:grpSpPr>
          <a:xfrm>
            <a:off x="67920" y="122604"/>
            <a:ext cx="12056160" cy="6612793"/>
            <a:chOff x="34403" y="208775"/>
            <a:chExt cx="12056160" cy="6612793"/>
          </a:xfrm>
        </p:grpSpPr>
        <p:sp>
          <p:nvSpPr>
            <p:cNvPr id="15" name="TextBox 14">
              <a:extLst>
                <a:ext uri="{FF2B5EF4-FFF2-40B4-BE49-F238E27FC236}">
                  <a16:creationId xmlns:a16="http://schemas.microsoft.com/office/drawing/2014/main" xmlns="" id="{3DD57495-D499-4512-80A9-FA54D5E3025B}"/>
                </a:ext>
              </a:extLst>
            </p:cNvPr>
            <p:cNvSpPr txBox="1"/>
            <p:nvPr/>
          </p:nvSpPr>
          <p:spPr>
            <a:xfrm>
              <a:off x="34403" y="208775"/>
              <a:ext cx="436294" cy="369332"/>
            </a:xfrm>
            <a:prstGeom prst="rect">
              <a:avLst/>
            </a:prstGeom>
            <a:noFill/>
          </p:spPr>
          <p:txBody>
            <a:bodyPr wrap="square" rtlCol="0">
              <a:spAutoFit/>
            </a:bodyPr>
            <a:lstStyle/>
            <a:p>
              <a:r>
                <a:rPr lang="en-AU" b="1" dirty="0"/>
                <a:t>A)</a:t>
              </a:r>
            </a:p>
          </p:txBody>
        </p:sp>
        <p:sp>
          <p:nvSpPr>
            <p:cNvPr id="16" name="TextBox 15">
              <a:extLst>
                <a:ext uri="{FF2B5EF4-FFF2-40B4-BE49-F238E27FC236}">
                  <a16:creationId xmlns:a16="http://schemas.microsoft.com/office/drawing/2014/main" xmlns="" id="{B543B9CF-F920-413F-8484-75C3A8D70917}"/>
                </a:ext>
              </a:extLst>
            </p:cNvPr>
            <p:cNvSpPr txBox="1"/>
            <p:nvPr/>
          </p:nvSpPr>
          <p:spPr>
            <a:xfrm>
              <a:off x="7065583" y="208775"/>
              <a:ext cx="391334" cy="369332"/>
            </a:xfrm>
            <a:prstGeom prst="rect">
              <a:avLst/>
            </a:prstGeom>
            <a:noFill/>
          </p:spPr>
          <p:txBody>
            <a:bodyPr wrap="square" rtlCol="0">
              <a:spAutoFit/>
            </a:bodyPr>
            <a:lstStyle/>
            <a:p>
              <a:r>
                <a:rPr lang="en-AU" b="1" dirty="0"/>
                <a:t>B)</a:t>
              </a:r>
            </a:p>
          </p:txBody>
        </p:sp>
        <p:grpSp>
          <p:nvGrpSpPr>
            <p:cNvPr id="11" name="Group 10">
              <a:extLst>
                <a:ext uri="{FF2B5EF4-FFF2-40B4-BE49-F238E27FC236}">
                  <a16:creationId xmlns:a16="http://schemas.microsoft.com/office/drawing/2014/main" xmlns="" id="{685B8C23-E769-B15F-0D21-A4800E2F53FC}"/>
                </a:ext>
              </a:extLst>
            </p:cNvPr>
            <p:cNvGrpSpPr/>
            <p:nvPr/>
          </p:nvGrpSpPr>
          <p:grpSpPr>
            <a:xfrm>
              <a:off x="252550" y="593821"/>
              <a:ext cx="6813033" cy="6227747"/>
              <a:chOff x="570118" y="573349"/>
              <a:chExt cx="6813033" cy="6227747"/>
            </a:xfrm>
          </p:grpSpPr>
          <p:pic>
            <p:nvPicPr>
              <p:cNvPr id="4" name="Picture 3" descr="A picture containing text, screenshot, design&#10;&#10;Description automatically generated">
                <a:extLst>
                  <a:ext uri="{FF2B5EF4-FFF2-40B4-BE49-F238E27FC236}">
                    <a16:creationId xmlns:a16="http://schemas.microsoft.com/office/drawing/2014/main" xmlns="" id="{3FD27B03-EE0D-D13E-D6BF-51DB89583FC0}"/>
                  </a:ext>
                </a:extLst>
              </p:cNvPr>
              <p:cNvPicPr>
                <a:picLocks noChangeAspect="1"/>
              </p:cNvPicPr>
              <p:nvPr/>
            </p:nvPicPr>
            <p:blipFill rotWithShape="1">
              <a:blip r:embed="rId3">
                <a:extLst>
                  <a:ext uri="{28A0092B-C50C-407E-A947-70E740481C1C}">
                    <a14:useLocalDpi xmlns:a14="http://schemas.microsoft.com/office/drawing/2010/main" val="0"/>
                  </a:ext>
                </a:extLst>
              </a:blip>
              <a:srcRect r="27298" b="3"/>
              <a:stretch/>
            </p:blipFill>
            <p:spPr>
              <a:xfrm>
                <a:off x="570118" y="593821"/>
                <a:ext cx="5181753" cy="6207275"/>
              </a:xfrm>
              <a:prstGeom prst="rect">
                <a:avLst/>
              </a:prstGeom>
            </p:spPr>
          </p:pic>
          <p:pic>
            <p:nvPicPr>
              <p:cNvPr id="6" name="Picture 5" descr="A picture containing text, screenshot, design&#10;&#10;Description automatically generated">
                <a:extLst>
                  <a:ext uri="{FF2B5EF4-FFF2-40B4-BE49-F238E27FC236}">
                    <a16:creationId xmlns:a16="http://schemas.microsoft.com/office/drawing/2014/main" xmlns="" id="{29CA9F86-AA38-432D-FF76-F22568684EE3}"/>
                  </a:ext>
                </a:extLst>
              </p:cNvPr>
              <p:cNvPicPr>
                <a:picLocks noChangeAspect="1"/>
              </p:cNvPicPr>
              <p:nvPr/>
            </p:nvPicPr>
            <p:blipFill rotWithShape="1">
              <a:blip r:embed="rId3">
                <a:extLst>
                  <a:ext uri="{28A0092B-C50C-407E-A947-70E740481C1C}">
                    <a14:useLocalDpi xmlns:a14="http://schemas.microsoft.com/office/drawing/2010/main" val="0"/>
                  </a:ext>
                </a:extLst>
              </a:blip>
              <a:srcRect l="82606" t="43219" r="2154" b="30146"/>
              <a:stretch/>
            </p:blipFill>
            <p:spPr>
              <a:xfrm>
                <a:off x="5907995" y="2055110"/>
                <a:ext cx="1319029" cy="2007629"/>
              </a:xfrm>
              <a:prstGeom prst="rect">
                <a:avLst/>
              </a:prstGeom>
            </p:spPr>
          </p:pic>
          <p:pic>
            <p:nvPicPr>
              <p:cNvPr id="10" name="Picture 9" descr="A picture containing text, screenshot, design&#10;&#10;Description automatically generated">
                <a:extLst>
                  <a:ext uri="{FF2B5EF4-FFF2-40B4-BE49-F238E27FC236}">
                    <a16:creationId xmlns:a16="http://schemas.microsoft.com/office/drawing/2014/main" xmlns="" id="{7DDB3CE2-E730-2ADD-B13D-CE492CEBEE57}"/>
                  </a:ext>
                </a:extLst>
              </p:cNvPr>
              <p:cNvPicPr>
                <a:picLocks noChangeAspect="1"/>
              </p:cNvPicPr>
              <p:nvPr/>
            </p:nvPicPr>
            <p:blipFill rotWithShape="1">
              <a:blip r:embed="rId3">
                <a:extLst>
                  <a:ext uri="{28A0092B-C50C-407E-A947-70E740481C1C}">
                    <a14:useLocalDpi xmlns:a14="http://schemas.microsoft.com/office/drawing/2010/main" val="0"/>
                  </a:ext>
                </a:extLst>
              </a:blip>
              <a:srcRect l="72671" r="10090" b="92063"/>
              <a:stretch/>
            </p:blipFill>
            <p:spPr>
              <a:xfrm>
                <a:off x="5751870" y="573349"/>
                <a:ext cx="1404306" cy="563087"/>
              </a:xfrm>
              <a:prstGeom prst="rect">
                <a:avLst/>
              </a:prstGeom>
            </p:spPr>
          </p:pic>
          <p:pic>
            <p:nvPicPr>
              <p:cNvPr id="7" name="Picture 6" descr="A picture containing text, screenshot, design&#10;&#10;Description automatically generated">
                <a:extLst>
                  <a:ext uri="{FF2B5EF4-FFF2-40B4-BE49-F238E27FC236}">
                    <a16:creationId xmlns:a16="http://schemas.microsoft.com/office/drawing/2014/main" xmlns="" id="{32A180A5-627A-0BA3-398D-41C4DCC3F04B}"/>
                  </a:ext>
                </a:extLst>
              </p:cNvPr>
              <p:cNvPicPr>
                <a:picLocks noChangeAspect="1"/>
              </p:cNvPicPr>
              <p:nvPr/>
            </p:nvPicPr>
            <p:blipFill rotWithShape="1">
              <a:blip r:embed="rId3">
                <a:extLst>
                  <a:ext uri="{28A0092B-C50C-407E-A947-70E740481C1C}">
                    <a14:useLocalDpi xmlns:a14="http://schemas.microsoft.com/office/drawing/2010/main" val="0"/>
                  </a:ext>
                </a:extLst>
              </a:blip>
              <a:srcRect l="78622" t="17611" r="17" b="69257"/>
              <a:stretch/>
            </p:blipFill>
            <p:spPr>
              <a:xfrm>
                <a:off x="5751870" y="1073387"/>
                <a:ext cx="1631281" cy="873360"/>
              </a:xfrm>
              <a:prstGeom prst="rect">
                <a:avLst/>
              </a:prstGeom>
            </p:spPr>
          </p:pic>
        </p:grpSp>
        <p:grpSp>
          <p:nvGrpSpPr>
            <p:cNvPr id="13" name="Group 12">
              <a:extLst>
                <a:ext uri="{FF2B5EF4-FFF2-40B4-BE49-F238E27FC236}">
                  <a16:creationId xmlns:a16="http://schemas.microsoft.com/office/drawing/2014/main" xmlns="" id="{59CCF91B-C8F4-D1F9-7974-15CAE0F67172}"/>
                </a:ext>
              </a:extLst>
            </p:cNvPr>
            <p:cNvGrpSpPr/>
            <p:nvPr/>
          </p:nvGrpSpPr>
          <p:grpSpPr>
            <a:xfrm>
              <a:off x="7261250" y="875364"/>
              <a:ext cx="4829313" cy="4640580"/>
              <a:chOff x="7261250" y="875364"/>
              <a:chExt cx="4829313" cy="4640580"/>
            </a:xfrm>
          </p:grpSpPr>
          <p:pic>
            <p:nvPicPr>
              <p:cNvPr id="8" name="Picture 5">
                <a:extLst>
                  <a:ext uri="{FF2B5EF4-FFF2-40B4-BE49-F238E27FC236}">
                    <a16:creationId xmlns:a16="http://schemas.microsoft.com/office/drawing/2014/main" xmlns="" id="{497AD407-0C04-B1DA-19E2-68A812AF7064}"/>
                  </a:ext>
                </a:extLst>
              </p:cNvPr>
              <p:cNvPicPr>
                <a:picLocks noChangeAspect="1"/>
              </p:cNvPicPr>
              <p:nvPr/>
            </p:nvPicPr>
            <p:blipFill rotWithShape="1">
              <a:blip r:embed="rId4"/>
              <a:srcRect r="18434"/>
              <a:stretch/>
            </p:blipFill>
            <p:spPr>
              <a:xfrm>
                <a:off x="7261250" y="875364"/>
                <a:ext cx="4829313" cy="4640580"/>
              </a:xfrm>
              <a:prstGeom prst="rect">
                <a:avLst/>
              </a:prstGeom>
            </p:spPr>
          </p:pic>
          <p:pic>
            <p:nvPicPr>
              <p:cNvPr id="12" name="Picture 5">
                <a:extLst>
                  <a:ext uri="{FF2B5EF4-FFF2-40B4-BE49-F238E27FC236}">
                    <a16:creationId xmlns:a16="http://schemas.microsoft.com/office/drawing/2014/main" xmlns="" id="{7937285E-CE1A-91F6-7072-C59673AB0308}"/>
                  </a:ext>
                </a:extLst>
              </p:cNvPr>
              <p:cNvPicPr>
                <a:picLocks noChangeAspect="1"/>
              </p:cNvPicPr>
              <p:nvPr/>
            </p:nvPicPr>
            <p:blipFill rotWithShape="1">
              <a:blip r:embed="rId4"/>
              <a:srcRect l="82040" b="62566"/>
              <a:stretch/>
            </p:blipFill>
            <p:spPr>
              <a:xfrm>
                <a:off x="10734303" y="982831"/>
                <a:ext cx="1205147" cy="1968775"/>
              </a:xfrm>
              <a:prstGeom prst="rect">
                <a:avLst/>
              </a:prstGeom>
            </p:spPr>
          </p:pic>
        </p:grpSp>
      </p:grpSp>
      <p:sp>
        <p:nvSpPr>
          <p:cNvPr id="2" name="Title 3">
            <a:extLst>
              <a:ext uri="{FF2B5EF4-FFF2-40B4-BE49-F238E27FC236}">
                <a16:creationId xmlns:a16="http://schemas.microsoft.com/office/drawing/2014/main" xmlns="" id="{38A23A88-2AAA-7362-6302-28FA0BFA71A6}"/>
              </a:ext>
            </a:extLst>
          </p:cNvPr>
          <p:cNvSpPr txBox="1">
            <a:spLocks/>
          </p:cNvSpPr>
          <p:nvPr/>
        </p:nvSpPr>
        <p:spPr>
          <a:xfrm>
            <a:off x="10110651" y="32276"/>
            <a:ext cx="2081349" cy="3693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AU" sz="2400" b="1" dirty="0"/>
              <a:t>Supp. Figure S8</a:t>
            </a:r>
          </a:p>
        </p:txBody>
      </p:sp>
    </p:spTree>
    <p:extLst>
      <p:ext uri="{BB962C8B-B14F-4D97-AF65-F5344CB8AC3E}">
        <p14:creationId xmlns:p14="http://schemas.microsoft.com/office/powerpoint/2010/main" val="19744228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497</TotalTime>
  <Words>653</Words>
  <Application>Microsoft Office PowerPoint</Application>
  <PresentationFormat>Widescreen</PresentationFormat>
  <Paragraphs>39</Paragraphs>
  <Slides>8</Slides>
  <Notes>8</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8</vt:i4>
      </vt:variant>
    </vt:vector>
  </HeadingPairs>
  <TitlesOfParts>
    <vt:vector size="14" baseType="lpstr">
      <vt:lpstr>PMingLiU</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 1: IDA All – Clustered heatmap</dc:title>
  <dc:creator>Jennifer Koh</dc:creator>
  <cp:lastModifiedBy>Victor,Maria Flora</cp:lastModifiedBy>
  <cp:revision>133</cp:revision>
  <cp:lastPrinted>2024-12-02T01:57:34Z</cp:lastPrinted>
  <dcterms:created xsi:type="dcterms:W3CDTF">2022-02-15T01:31:48Z</dcterms:created>
  <dcterms:modified xsi:type="dcterms:W3CDTF">2025-01-27T06:59: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NXPowerLiteLastOptimized">
    <vt:lpwstr>6718124</vt:lpwstr>
  </property>
  <property fmtid="{D5CDD505-2E9C-101B-9397-08002B2CF9AE}" pid="3" name="NXPowerLiteSettings">
    <vt:lpwstr>E9000F7008E001</vt:lpwstr>
  </property>
  <property fmtid="{D5CDD505-2E9C-101B-9397-08002B2CF9AE}" pid="4" name="NXPowerLiteVersion">
    <vt:lpwstr>D9.1.2</vt:lpwstr>
  </property>
</Properties>
</file>